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20"/>
  </p:notesMasterIdLst>
  <p:sldIdLst>
    <p:sldId id="614" r:id="rId2"/>
    <p:sldId id="615" r:id="rId3"/>
    <p:sldId id="273" r:id="rId4"/>
    <p:sldId id="651" r:id="rId5"/>
    <p:sldId id="652" r:id="rId6"/>
    <p:sldId id="653" r:id="rId7"/>
    <p:sldId id="654" r:id="rId8"/>
    <p:sldId id="655" r:id="rId9"/>
    <p:sldId id="637" r:id="rId10"/>
    <p:sldId id="638" r:id="rId11"/>
    <p:sldId id="642" r:id="rId12"/>
    <p:sldId id="643" r:id="rId13"/>
    <p:sldId id="644" r:id="rId14"/>
    <p:sldId id="646" r:id="rId15"/>
    <p:sldId id="650" r:id="rId16"/>
    <p:sldId id="649" r:id="rId17"/>
    <p:sldId id="648" r:id="rId18"/>
    <p:sldId id="647" r:id="rId19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01CFE96-BE86-4FC6-AE52-3B5BEE4FDF49}" v="181" dt="2024-02-12T23:47:37.70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614" autoAdjust="0"/>
    <p:restoredTop sz="94660"/>
  </p:normalViewPr>
  <p:slideViewPr>
    <p:cSldViewPr snapToGrid="0">
      <p:cViewPr varScale="1">
        <p:scale>
          <a:sx n="90" d="100"/>
          <a:sy n="90" d="100"/>
        </p:scale>
        <p:origin x="72" y="9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microsoft.com/office/2015/10/relationships/revisionInfo" Target="revisionInfo.xml"/><Relationship Id="rId3" Type="http://schemas.openxmlformats.org/officeDocument/2006/relationships/slide" Target="slides/slide2.xml"/><Relationship Id="rId21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microsoft.com/office/2016/11/relationships/changesInfo" Target="changesInfos/changesInfo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notesMaster" Target="notesMasters/notesMaster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健 有村" userId="845497175cb2f617" providerId="LiveId" clId="{601CFE96-BE86-4FC6-AE52-3B5BEE4FDF49}"/>
    <pc:docChg chg="custSel modSld">
      <pc:chgData name="健 有村" userId="845497175cb2f617" providerId="LiveId" clId="{601CFE96-BE86-4FC6-AE52-3B5BEE4FDF49}" dt="2024-02-12T23:47:37.701" v="227" actId="16480"/>
      <pc:docMkLst>
        <pc:docMk/>
      </pc:docMkLst>
      <pc:sldChg chg="addSp delSp modSp mod">
        <pc:chgData name="健 有村" userId="845497175cb2f617" providerId="LiveId" clId="{601CFE96-BE86-4FC6-AE52-3B5BEE4FDF49}" dt="2024-02-12T23:07:38.544" v="44" actId="478"/>
        <pc:sldMkLst>
          <pc:docMk/>
          <pc:sldMk cId="0" sldId="273"/>
        </pc:sldMkLst>
        <pc:spChg chg="del">
          <ac:chgData name="健 有村" userId="845497175cb2f617" providerId="LiveId" clId="{601CFE96-BE86-4FC6-AE52-3B5BEE4FDF49}" dt="2024-02-12T23:00:53.244" v="2" actId="478"/>
          <ac:spMkLst>
            <pc:docMk/>
            <pc:sldMk cId="0" sldId="273"/>
            <ac:spMk id="6" creationId="{488F2A22-DD13-A344-63EE-3B707663E3DF}"/>
          </ac:spMkLst>
        </pc:spChg>
        <pc:spChg chg="del">
          <ac:chgData name="健 有村" userId="845497175cb2f617" providerId="LiveId" clId="{601CFE96-BE86-4FC6-AE52-3B5BEE4FDF49}" dt="2024-02-12T23:00:53.244" v="2" actId="478"/>
          <ac:spMkLst>
            <pc:docMk/>
            <pc:sldMk cId="0" sldId="273"/>
            <ac:spMk id="7" creationId="{12882598-980D-05EA-DB1C-AFDD0D315940}"/>
          </ac:spMkLst>
        </pc:spChg>
        <pc:spChg chg="del">
          <ac:chgData name="健 有村" userId="845497175cb2f617" providerId="LiveId" clId="{601CFE96-BE86-4FC6-AE52-3B5BEE4FDF49}" dt="2024-02-12T23:00:53.244" v="2" actId="478"/>
          <ac:spMkLst>
            <pc:docMk/>
            <pc:sldMk cId="0" sldId="273"/>
            <ac:spMk id="8" creationId="{AEFFCD33-9DF3-86F1-F554-F06A65A9033C}"/>
          </ac:spMkLst>
        </pc:spChg>
        <pc:spChg chg="del mod">
          <ac:chgData name="健 有村" userId="845497175cb2f617" providerId="LiveId" clId="{601CFE96-BE86-4FC6-AE52-3B5BEE4FDF49}" dt="2024-02-12T23:04:20.795" v="29" actId="21"/>
          <ac:spMkLst>
            <pc:docMk/>
            <pc:sldMk cId="0" sldId="273"/>
            <ac:spMk id="10" creationId="{8BF3C505-B0AB-4BD5-CC25-84B4936150E0}"/>
          </ac:spMkLst>
        </pc:spChg>
        <pc:spChg chg="add mod">
          <ac:chgData name="健 有村" userId="845497175cb2f617" providerId="LiveId" clId="{601CFE96-BE86-4FC6-AE52-3B5BEE4FDF49}" dt="2024-02-12T23:04:17.224" v="28" actId="1076"/>
          <ac:spMkLst>
            <pc:docMk/>
            <pc:sldMk cId="0" sldId="273"/>
            <ac:spMk id="12" creationId="{93A019F2-80FA-282F-37CF-DE8F92EF67FD}"/>
          </ac:spMkLst>
        </pc:spChg>
        <pc:spChg chg="add mod">
          <ac:chgData name="健 有村" userId="845497175cb2f617" providerId="LiveId" clId="{601CFE96-BE86-4FC6-AE52-3B5BEE4FDF49}" dt="2024-02-12T23:05:39.629" v="34" actId="1076"/>
          <ac:spMkLst>
            <pc:docMk/>
            <pc:sldMk cId="0" sldId="273"/>
            <ac:spMk id="13" creationId="{DD17B9F7-FA33-F56D-D853-1F393E4B41FF}"/>
          </ac:spMkLst>
        </pc:spChg>
        <pc:spChg chg="del">
          <ac:chgData name="健 有村" userId="845497175cb2f617" providerId="LiveId" clId="{601CFE96-BE86-4FC6-AE52-3B5BEE4FDF49}" dt="2024-02-12T23:00:53.244" v="2" actId="478"/>
          <ac:spMkLst>
            <pc:docMk/>
            <pc:sldMk cId="0" sldId="273"/>
            <ac:spMk id="14" creationId="{1E6054F4-0257-BB5F-DFBE-94548D7E0C1C}"/>
          </ac:spMkLst>
        </pc:spChg>
        <pc:spChg chg="del">
          <ac:chgData name="健 有村" userId="845497175cb2f617" providerId="LiveId" clId="{601CFE96-BE86-4FC6-AE52-3B5BEE4FDF49}" dt="2024-02-12T23:00:53.244" v="2" actId="478"/>
          <ac:spMkLst>
            <pc:docMk/>
            <pc:sldMk cId="0" sldId="273"/>
            <ac:spMk id="16" creationId="{402E1CCC-A6B5-7961-1E47-833AC90AD236}"/>
          </ac:spMkLst>
        </pc:spChg>
        <pc:spChg chg="del">
          <ac:chgData name="健 有村" userId="845497175cb2f617" providerId="LiveId" clId="{601CFE96-BE86-4FC6-AE52-3B5BEE4FDF49}" dt="2024-02-12T23:00:53.244" v="2" actId="478"/>
          <ac:spMkLst>
            <pc:docMk/>
            <pc:sldMk cId="0" sldId="273"/>
            <ac:spMk id="17" creationId="{334E64A0-8BF8-9506-8CAC-B31B25AFC4CE}"/>
          </ac:spMkLst>
        </pc:spChg>
        <pc:spChg chg="del mod">
          <ac:chgData name="健 有村" userId="845497175cb2f617" providerId="LiveId" clId="{601CFE96-BE86-4FC6-AE52-3B5BEE4FDF49}" dt="2024-02-12T23:07:38.544" v="44" actId="478"/>
          <ac:spMkLst>
            <pc:docMk/>
            <pc:sldMk cId="0" sldId="273"/>
            <ac:spMk id="18" creationId="{8AC179A9-DF4E-486A-1B77-946830D2DCF3}"/>
          </ac:spMkLst>
        </pc:spChg>
        <pc:spChg chg="add mod">
          <ac:chgData name="健 有村" userId="845497175cb2f617" providerId="LiveId" clId="{601CFE96-BE86-4FC6-AE52-3B5BEE4FDF49}" dt="2024-02-12T23:05:26.603" v="32" actId="1076"/>
          <ac:spMkLst>
            <pc:docMk/>
            <pc:sldMk cId="0" sldId="273"/>
            <ac:spMk id="19" creationId="{27FB0E14-9FDF-F29A-E2B7-4F0D3E4D0A71}"/>
          </ac:spMkLst>
        </pc:spChg>
        <pc:spChg chg="add mod">
          <ac:chgData name="健 有村" userId="845497175cb2f617" providerId="LiveId" clId="{601CFE96-BE86-4FC6-AE52-3B5BEE4FDF49}" dt="2024-02-12T23:05:26.603" v="32" actId="1076"/>
          <ac:spMkLst>
            <pc:docMk/>
            <pc:sldMk cId="0" sldId="273"/>
            <ac:spMk id="20" creationId="{1A3A66FF-D077-2DE7-513A-EA6E8B267C13}"/>
          </ac:spMkLst>
        </pc:spChg>
        <pc:spChg chg="add mod">
          <ac:chgData name="健 有村" userId="845497175cb2f617" providerId="LiveId" clId="{601CFE96-BE86-4FC6-AE52-3B5BEE4FDF49}" dt="2024-02-12T23:05:26.603" v="32" actId="1076"/>
          <ac:spMkLst>
            <pc:docMk/>
            <pc:sldMk cId="0" sldId="273"/>
            <ac:spMk id="21" creationId="{559B75D8-E446-E8A0-E901-C1782B2970FE}"/>
          </ac:spMkLst>
        </pc:spChg>
        <pc:spChg chg="add mod">
          <ac:chgData name="健 有村" userId="845497175cb2f617" providerId="LiveId" clId="{601CFE96-BE86-4FC6-AE52-3B5BEE4FDF49}" dt="2024-02-12T23:05:26.603" v="32" actId="1076"/>
          <ac:spMkLst>
            <pc:docMk/>
            <pc:sldMk cId="0" sldId="273"/>
            <ac:spMk id="22" creationId="{3B7FFEB4-516B-A7E1-8812-45C9156A7891}"/>
          </ac:spMkLst>
        </pc:spChg>
        <pc:spChg chg="add mod">
          <ac:chgData name="健 有村" userId="845497175cb2f617" providerId="LiveId" clId="{601CFE96-BE86-4FC6-AE52-3B5BEE4FDF49}" dt="2024-02-12T23:05:26.603" v="32" actId="1076"/>
          <ac:spMkLst>
            <pc:docMk/>
            <pc:sldMk cId="0" sldId="273"/>
            <ac:spMk id="23" creationId="{4241914D-68D9-435B-BBF1-4BF4287BE254}"/>
          </ac:spMkLst>
        </pc:spChg>
        <pc:spChg chg="add mod">
          <ac:chgData name="健 有村" userId="845497175cb2f617" providerId="LiveId" clId="{601CFE96-BE86-4FC6-AE52-3B5BEE4FDF49}" dt="2024-02-12T23:05:26.603" v="32" actId="1076"/>
          <ac:spMkLst>
            <pc:docMk/>
            <pc:sldMk cId="0" sldId="273"/>
            <ac:spMk id="24" creationId="{88238B6D-DD67-ABCB-55A0-F54954EEA6F3}"/>
          </ac:spMkLst>
        </pc:spChg>
        <pc:spChg chg="add mod">
          <ac:chgData name="健 有村" userId="845497175cb2f617" providerId="LiveId" clId="{601CFE96-BE86-4FC6-AE52-3B5BEE4FDF49}" dt="2024-02-12T23:05:26.603" v="32" actId="1076"/>
          <ac:spMkLst>
            <pc:docMk/>
            <pc:sldMk cId="0" sldId="273"/>
            <ac:spMk id="25" creationId="{6DAFB587-A883-93D1-F51A-1420DD980936}"/>
          </ac:spMkLst>
        </pc:spChg>
        <pc:spChg chg="add mod">
          <ac:chgData name="健 有村" userId="845497175cb2f617" providerId="LiveId" clId="{601CFE96-BE86-4FC6-AE52-3B5BEE4FDF49}" dt="2024-02-12T23:05:26.603" v="32" actId="1076"/>
          <ac:spMkLst>
            <pc:docMk/>
            <pc:sldMk cId="0" sldId="273"/>
            <ac:spMk id="26" creationId="{3E3EB8DD-8F6A-F096-2E16-3A89EB4E2279}"/>
          </ac:spMkLst>
        </pc:spChg>
        <pc:spChg chg="add mod">
          <ac:chgData name="健 有村" userId="845497175cb2f617" providerId="LiveId" clId="{601CFE96-BE86-4FC6-AE52-3B5BEE4FDF49}" dt="2024-02-12T23:05:26.603" v="32" actId="1076"/>
          <ac:spMkLst>
            <pc:docMk/>
            <pc:sldMk cId="0" sldId="273"/>
            <ac:spMk id="27" creationId="{28F5866D-2F14-4056-4673-945F41A295CC}"/>
          </ac:spMkLst>
        </pc:spChg>
        <pc:spChg chg="add mod">
          <ac:chgData name="健 有村" userId="845497175cb2f617" providerId="LiveId" clId="{601CFE96-BE86-4FC6-AE52-3B5BEE4FDF49}" dt="2024-02-12T23:06:40.860" v="36"/>
          <ac:spMkLst>
            <pc:docMk/>
            <pc:sldMk cId="0" sldId="273"/>
            <ac:spMk id="28" creationId="{88E20E2A-763D-193E-7005-C83B63FABD22}"/>
          </ac:spMkLst>
        </pc:spChg>
        <pc:spChg chg="add mod">
          <ac:chgData name="健 有村" userId="845497175cb2f617" providerId="LiveId" clId="{601CFE96-BE86-4FC6-AE52-3B5BEE4FDF49}" dt="2024-02-12T23:07:07.153" v="39" actId="1076"/>
          <ac:spMkLst>
            <pc:docMk/>
            <pc:sldMk cId="0" sldId="273"/>
            <ac:spMk id="29" creationId="{57E66AEC-8505-7289-0EE6-7F98D010940B}"/>
          </ac:spMkLst>
        </pc:spChg>
        <pc:spChg chg="add mod">
          <ac:chgData name="健 有村" userId="845497175cb2f617" providerId="LiveId" clId="{601CFE96-BE86-4FC6-AE52-3B5BEE4FDF49}" dt="2024-02-12T23:07:07.153" v="39" actId="1076"/>
          <ac:spMkLst>
            <pc:docMk/>
            <pc:sldMk cId="0" sldId="273"/>
            <ac:spMk id="30" creationId="{A722DF3B-A79C-BC1A-1131-568D18CA2F44}"/>
          </ac:spMkLst>
        </pc:spChg>
        <pc:spChg chg="add mod">
          <ac:chgData name="健 有村" userId="845497175cb2f617" providerId="LiveId" clId="{601CFE96-BE86-4FC6-AE52-3B5BEE4FDF49}" dt="2024-02-12T23:07:33.516" v="42" actId="1076"/>
          <ac:spMkLst>
            <pc:docMk/>
            <pc:sldMk cId="0" sldId="273"/>
            <ac:spMk id="31" creationId="{D98FC3FB-D6DF-0680-B8E3-4179B5042A9C}"/>
          </ac:spMkLst>
        </pc:spChg>
        <pc:spChg chg="del mod">
          <ac:chgData name="健 有村" userId="845497175cb2f617" providerId="LiveId" clId="{601CFE96-BE86-4FC6-AE52-3B5BEE4FDF49}" dt="2024-02-12T23:05:29.330" v="33" actId="478"/>
          <ac:spMkLst>
            <pc:docMk/>
            <pc:sldMk cId="0" sldId="273"/>
            <ac:spMk id="58377" creationId="{787B4159-9A24-9C6B-54D8-51EB2BC0FB00}"/>
          </ac:spMkLst>
        </pc:spChg>
        <pc:spChg chg="del mod">
          <ac:chgData name="健 有村" userId="845497175cb2f617" providerId="LiveId" clId="{601CFE96-BE86-4FC6-AE52-3B5BEE4FDF49}" dt="2024-02-12T23:07:36.844" v="43" actId="478"/>
          <ac:spMkLst>
            <pc:docMk/>
            <pc:sldMk cId="0" sldId="273"/>
            <ac:spMk id="58378" creationId="{7BFBE196-094E-FA9A-EAFE-6B9568A48BD9}"/>
          </ac:spMkLst>
        </pc:spChg>
        <pc:spChg chg="del mod">
          <ac:chgData name="健 有村" userId="845497175cb2f617" providerId="LiveId" clId="{601CFE96-BE86-4FC6-AE52-3B5BEE4FDF49}" dt="2024-02-12T23:06:45.617" v="37" actId="478"/>
          <ac:spMkLst>
            <pc:docMk/>
            <pc:sldMk cId="0" sldId="273"/>
            <ac:spMk id="58381" creationId="{FDC6263E-BBAE-13C6-2246-6F38A9EDE864}"/>
          </ac:spMkLst>
        </pc:spChg>
        <pc:spChg chg="del">
          <ac:chgData name="健 有村" userId="845497175cb2f617" providerId="LiveId" clId="{601CFE96-BE86-4FC6-AE52-3B5BEE4FDF49}" dt="2024-02-12T23:01:02.527" v="4" actId="478"/>
          <ac:spMkLst>
            <pc:docMk/>
            <pc:sldMk cId="0" sldId="273"/>
            <ac:spMk id="58382" creationId="{DFE4862D-0C7B-0723-287B-010C551BF579}"/>
          </ac:spMkLst>
        </pc:spChg>
        <pc:picChg chg="mod">
          <ac:chgData name="健 有村" userId="845497175cb2f617" providerId="LiveId" clId="{601CFE96-BE86-4FC6-AE52-3B5BEE4FDF49}" dt="2024-02-12T23:03:50.865" v="25" actId="1076"/>
          <ac:picMkLst>
            <pc:docMk/>
            <pc:sldMk cId="0" sldId="273"/>
            <ac:picMk id="2" creationId="{6B2DF8D8-59E4-4677-2BDA-DA81934F7490}"/>
          </ac:picMkLst>
        </pc:picChg>
        <pc:picChg chg="del">
          <ac:chgData name="健 有村" userId="845497175cb2f617" providerId="LiveId" clId="{601CFE96-BE86-4FC6-AE52-3B5BEE4FDF49}" dt="2024-02-12T23:00:57.178" v="3" actId="478"/>
          <ac:picMkLst>
            <pc:docMk/>
            <pc:sldMk cId="0" sldId="273"/>
            <ac:picMk id="3" creationId="{1D33BA9F-25E9-DC8C-D408-B32276364C24}"/>
          </ac:picMkLst>
        </pc:picChg>
        <pc:picChg chg="del">
          <ac:chgData name="健 有村" userId="845497175cb2f617" providerId="LiveId" clId="{601CFE96-BE86-4FC6-AE52-3B5BEE4FDF49}" dt="2024-02-12T23:00:53.244" v="2" actId="478"/>
          <ac:picMkLst>
            <pc:docMk/>
            <pc:sldMk cId="0" sldId="273"/>
            <ac:picMk id="4" creationId="{C0F8890E-D55A-FD5A-4F31-563461171715}"/>
          </ac:picMkLst>
        </pc:picChg>
        <pc:picChg chg="del">
          <ac:chgData name="健 有村" userId="845497175cb2f617" providerId="LiveId" clId="{601CFE96-BE86-4FC6-AE52-3B5BEE4FDF49}" dt="2024-02-12T23:00:53.244" v="2" actId="478"/>
          <ac:picMkLst>
            <pc:docMk/>
            <pc:sldMk cId="0" sldId="273"/>
            <ac:picMk id="5" creationId="{7DEA53E0-EFC9-EC63-D3EE-ACD43EDA7E9D}"/>
          </ac:picMkLst>
        </pc:picChg>
        <pc:picChg chg="del">
          <ac:chgData name="健 有村" userId="845497175cb2f617" providerId="LiveId" clId="{601CFE96-BE86-4FC6-AE52-3B5BEE4FDF49}" dt="2024-02-12T23:00:53.244" v="2" actId="478"/>
          <ac:picMkLst>
            <pc:docMk/>
            <pc:sldMk cId="0" sldId="273"/>
            <ac:picMk id="9" creationId="{1ADAC768-0E7D-2B47-7402-D670FC8A5BEE}"/>
          </ac:picMkLst>
        </pc:picChg>
        <pc:picChg chg="add mod">
          <ac:chgData name="健 有村" userId="845497175cb2f617" providerId="LiveId" clId="{601CFE96-BE86-4FC6-AE52-3B5BEE4FDF49}" dt="2024-02-12T23:04:03.372" v="26"/>
          <ac:picMkLst>
            <pc:docMk/>
            <pc:sldMk cId="0" sldId="273"/>
            <ac:picMk id="11" creationId="{CF6BF1CB-CD12-FD24-B0C2-73FF5196D9BB}"/>
          </ac:picMkLst>
        </pc:picChg>
        <pc:picChg chg="del">
          <ac:chgData name="健 有村" userId="845497175cb2f617" providerId="LiveId" clId="{601CFE96-BE86-4FC6-AE52-3B5BEE4FDF49}" dt="2024-02-12T23:00:53.244" v="2" actId="478"/>
          <ac:picMkLst>
            <pc:docMk/>
            <pc:sldMk cId="0" sldId="273"/>
            <ac:picMk id="15" creationId="{A463C926-21C0-0334-9C06-118ED04BB2D2}"/>
          </ac:picMkLst>
        </pc:picChg>
      </pc:sldChg>
      <pc:sldChg chg="modSp">
        <pc:chgData name="健 有村" userId="845497175cb2f617" providerId="LiveId" clId="{601CFE96-BE86-4FC6-AE52-3B5BEE4FDF49}" dt="2024-02-12T23:45:51.791" v="226" actId="16480"/>
        <pc:sldMkLst>
          <pc:docMk/>
          <pc:sldMk cId="2082351721" sldId="643"/>
        </pc:sldMkLst>
        <pc:picChg chg="mod">
          <ac:chgData name="健 有村" userId="845497175cb2f617" providerId="LiveId" clId="{601CFE96-BE86-4FC6-AE52-3B5BEE4FDF49}" dt="2024-02-12T23:45:51.791" v="226" actId="16480"/>
          <ac:picMkLst>
            <pc:docMk/>
            <pc:sldMk cId="2082351721" sldId="643"/>
            <ac:picMk id="11" creationId="{CE69E172-204C-3A9C-9FEF-D3C00EC15674}"/>
          </ac:picMkLst>
        </pc:picChg>
      </pc:sldChg>
      <pc:sldChg chg="modSp">
        <pc:chgData name="健 有村" userId="845497175cb2f617" providerId="LiveId" clId="{601CFE96-BE86-4FC6-AE52-3B5BEE4FDF49}" dt="2024-02-12T23:45:43.985" v="225" actId="16480"/>
        <pc:sldMkLst>
          <pc:docMk/>
          <pc:sldMk cId="1756491928" sldId="644"/>
        </pc:sldMkLst>
        <pc:picChg chg="mod">
          <ac:chgData name="健 有村" userId="845497175cb2f617" providerId="LiveId" clId="{601CFE96-BE86-4FC6-AE52-3B5BEE4FDF49}" dt="2024-02-12T23:45:43.985" v="225" actId="16480"/>
          <ac:picMkLst>
            <pc:docMk/>
            <pc:sldMk cId="1756491928" sldId="644"/>
            <ac:picMk id="17" creationId="{C0EB30A8-2B98-DADF-4F16-FD01A4EC146C}"/>
          </ac:picMkLst>
        </pc:picChg>
      </pc:sldChg>
      <pc:sldChg chg="modSp">
        <pc:chgData name="健 有村" userId="845497175cb2f617" providerId="LiveId" clId="{601CFE96-BE86-4FC6-AE52-3B5BEE4FDF49}" dt="2024-02-12T23:45:36.669" v="224" actId="16480"/>
        <pc:sldMkLst>
          <pc:docMk/>
          <pc:sldMk cId="1792851320" sldId="646"/>
        </pc:sldMkLst>
        <pc:picChg chg="mod">
          <ac:chgData name="健 有村" userId="845497175cb2f617" providerId="LiveId" clId="{601CFE96-BE86-4FC6-AE52-3B5BEE4FDF49}" dt="2024-02-12T23:45:36.669" v="224" actId="16480"/>
          <ac:picMkLst>
            <pc:docMk/>
            <pc:sldMk cId="1792851320" sldId="646"/>
            <ac:picMk id="19" creationId="{D4C68862-0108-4329-7EB4-6C778F9F7C36}"/>
          </ac:picMkLst>
        </pc:picChg>
      </pc:sldChg>
      <pc:sldChg chg="modSp">
        <pc:chgData name="健 有村" userId="845497175cb2f617" providerId="LiveId" clId="{601CFE96-BE86-4FC6-AE52-3B5BEE4FDF49}" dt="2024-02-12T23:47:37.701" v="227" actId="16480"/>
        <pc:sldMkLst>
          <pc:docMk/>
          <pc:sldMk cId="3247386846" sldId="648"/>
        </pc:sldMkLst>
        <pc:picChg chg="mod">
          <ac:chgData name="健 有村" userId="845497175cb2f617" providerId="LiveId" clId="{601CFE96-BE86-4FC6-AE52-3B5BEE4FDF49}" dt="2024-02-12T23:47:37.701" v="227" actId="16480"/>
          <ac:picMkLst>
            <pc:docMk/>
            <pc:sldMk cId="3247386846" sldId="648"/>
            <ac:picMk id="13" creationId="{4B4D32F6-24A1-94CD-D048-0210B0B7A8CF}"/>
          </ac:picMkLst>
        </pc:picChg>
      </pc:sldChg>
      <pc:sldChg chg="modSp">
        <pc:chgData name="健 有村" userId="845497175cb2f617" providerId="LiveId" clId="{601CFE96-BE86-4FC6-AE52-3B5BEE4FDF49}" dt="2024-02-12T23:45:22.385" v="223" actId="16480"/>
        <pc:sldMkLst>
          <pc:docMk/>
          <pc:sldMk cId="3354405518" sldId="649"/>
        </pc:sldMkLst>
        <pc:picChg chg="mod">
          <ac:chgData name="健 有村" userId="845497175cb2f617" providerId="LiveId" clId="{601CFE96-BE86-4FC6-AE52-3B5BEE4FDF49}" dt="2024-02-12T23:45:22.385" v="223" actId="16480"/>
          <ac:picMkLst>
            <pc:docMk/>
            <pc:sldMk cId="3354405518" sldId="649"/>
            <ac:picMk id="14" creationId="{6C39FBDF-D5C0-80F0-FC3D-7EFF3C0BA848}"/>
          </ac:picMkLst>
        </pc:picChg>
      </pc:sldChg>
      <pc:sldChg chg="addSp delSp modSp mod">
        <pc:chgData name="健 有村" userId="845497175cb2f617" providerId="LiveId" clId="{601CFE96-BE86-4FC6-AE52-3B5BEE4FDF49}" dt="2024-02-12T23:14:21.492" v="78" actId="1076"/>
        <pc:sldMkLst>
          <pc:docMk/>
          <pc:sldMk cId="0" sldId="651"/>
        </pc:sldMkLst>
        <pc:spChg chg="del">
          <ac:chgData name="健 有村" userId="845497175cb2f617" providerId="LiveId" clId="{601CFE96-BE86-4FC6-AE52-3B5BEE4FDF49}" dt="2024-02-12T23:07:48.896" v="45" actId="478"/>
          <ac:spMkLst>
            <pc:docMk/>
            <pc:sldMk cId="0" sldId="651"/>
            <ac:spMk id="6" creationId="{488F2A22-DD13-A344-63EE-3B707663E3DF}"/>
          </ac:spMkLst>
        </pc:spChg>
        <pc:spChg chg="del">
          <ac:chgData name="健 有村" userId="845497175cb2f617" providerId="LiveId" clId="{601CFE96-BE86-4FC6-AE52-3B5BEE4FDF49}" dt="2024-02-12T23:07:48.896" v="45" actId="478"/>
          <ac:spMkLst>
            <pc:docMk/>
            <pc:sldMk cId="0" sldId="651"/>
            <ac:spMk id="7" creationId="{12882598-980D-05EA-DB1C-AFDD0D315940}"/>
          </ac:spMkLst>
        </pc:spChg>
        <pc:spChg chg="del">
          <ac:chgData name="健 有村" userId="845497175cb2f617" providerId="LiveId" clId="{601CFE96-BE86-4FC6-AE52-3B5BEE4FDF49}" dt="2024-02-12T23:07:52.596" v="46" actId="478"/>
          <ac:spMkLst>
            <pc:docMk/>
            <pc:sldMk cId="0" sldId="651"/>
            <ac:spMk id="8" creationId="{AEFFCD33-9DF3-86F1-F554-F06A65A9033C}"/>
          </ac:spMkLst>
        </pc:spChg>
        <pc:spChg chg="del mod">
          <ac:chgData name="健 有村" userId="845497175cb2f617" providerId="LiveId" clId="{601CFE96-BE86-4FC6-AE52-3B5BEE4FDF49}" dt="2024-02-12T23:14:09.287" v="76" actId="478"/>
          <ac:spMkLst>
            <pc:docMk/>
            <pc:sldMk cId="0" sldId="651"/>
            <ac:spMk id="10" creationId="{8BF3C505-B0AB-4BD5-CC25-84B4936150E0}"/>
          </ac:spMkLst>
        </pc:spChg>
        <pc:spChg chg="add mod">
          <ac:chgData name="健 有村" userId="845497175cb2f617" providerId="LiveId" clId="{601CFE96-BE86-4FC6-AE52-3B5BEE4FDF49}" dt="2024-02-12T23:09:22.696" v="57"/>
          <ac:spMkLst>
            <pc:docMk/>
            <pc:sldMk cId="0" sldId="651"/>
            <ac:spMk id="11" creationId="{9A127670-151F-393E-D62C-5E45070C7305}"/>
          </ac:spMkLst>
        </pc:spChg>
        <pc:spChg chg="add mod">
          <ac:chgData name="健 有村" userId="845497175cb2f617" providerId="LiveId" clId="{601CFE96-BE86-4FC6-AE52-3B5BEE4FDF49}" dt="2024-02-12T23:09:22.696" v="57"/>
          <ac:spMkLst>
            <pc:docMk/>
            <pc:sldMk cId="0" sldId="651"/>
            <ac:spMk id="12" creationId="{B0FE402E-9506-0B77-C466-FBA8F7253B8D}"/>
          </ac:spMkLst>
        </pc:spChg>
        <pc:spChg chg="add mod">
          <ac:chgData name="健 有村" userId="845497175cb2f617" providerId="LiveId" clId="{601CFE96-BE86-4FC6-AE52-3B5BEE4FDF49}" dt="2024-02-12T23:09:22.696" v="57"/>
          <ac:spMkLst>
            <pc:docMk/>
            <pc:sldMk cId="0" sldId="651"/>
            <ac:spMk id="13" creationId="{4E5E3501-FCEF-A121-A65C-8F82EE2606CD}"/>
          </ac:spMkLst>
        </pc:spChg>
        <pc:spChg chg="del">
          <ac:chgData name="健 有村" userId="845497175cb2f617" providerId="LiveId" clId="{601CFE96-BE86-4FC6-AE52-3B5BEE4FDF49}" dt="2024-02-12T23:07:52.596" v="46" actId="478"/>
          <ac:spMkLst>
            <pc:docMk/>
            <pc:sldMk cId="0" sldId="651"/>
            <ac:spMk id="14" creationId="{1E6054F4-0257-BB5F-DFBE-94548D7E0C1C}"/>
          </ac:spMkLst>
        </pc:spChg>
        <pc:spChg chg="del">
          <ac:chgData name="健 有村" userId="845497175cb2f617" providerId="LiveId" clId="{601CFE96-BE86-4FC6-AE52-3B5BEE4FDF49}" dt="2024-02-12T23:07:48.896" v="45" actId="478"/>
          <ac:spMkLst>
            <pc:docMk/>
            <pc:sldMk cId="0" sldId="651"/>
            <ac:spMk id="16" creationId="{402E1CCC-A6B5-7961-1E47-833AC90AD236}"/>
          </ac:spMkLst>
        </pc:spChg>
        <pc:spChg chg="del">
          <ac:chgData name="健 有村" userId="845497175cb2f617" providerId="LiveId" clId="{601CFE96-BE86-4FC6-AE52-3B5BEE4FDF49}" dt="2024-02-12T23:07:48.896" v="45" actId="478"/>
          <ac:spMkLst>
            <pc:docMk/>
            <pc:sldMk cId="0" sldId="651"/>
            <ac:spMk id="17" creationId="{334E64A0-8BF8-9506-8CAC-B31B25AFC4CE}"/>
          </ac:spMkLst>
        </pc:spChg>
        <pc:spChg chg="del mod">
          <ac:chgData name="健 有村" userId="845497175cb2f617" providerId="LiveId" clId="{601CFE96-BE86-4FC6-AE52-3B5BEE4FDF49}" dt="2024-02-12T23:13:55.008" v="75" actId="478"/>
          <ac:spMkLst>
            <pc:docMk/>
            <pc:sldMk cId="0" sldId="651"/>
            <ac:spMk id="18" creationId="{8AC179A9-DF4E-486A-1B77-946830D2DCF3}"/>
          </ac:spMkLst>
        </pc:spChg>
        <pc:spChg chg="add mod">
          <ac:chgData name="健 有村" userId="845497175cb2f617" providerId="LiveId" clId="{601CFE96-BE86-4FC6-AE52-3B5BEE4FDF49}" dt="2024-02-12T23:09:22.696" v="57"/>
          <ac:spMkLst>
            <pc:docMk/>
            <pc:sldMk cId="0" sldId="651"/>
            <ac:spMk id="19" creationId="{FDE1E6A4-F03C-3BBB-5BB6-383197F7AB48}"/>
          </ac:spMkLst>
        </pc:spChg>
        <pc:spChg chg="add mod">
          <ac:chgData name="健 有村" userId="845497175cb2f617" providerId="LiveId" clId="{601CFE96-BE86-4FC6-AE52-3B5BEE4FDF49}" dt="2024-02-12T23:09:22.696" v="57"/>
          <ac:spMkLst>
            <pc:docMk/>
            <pc:sldMk cId="0" sldId="651"/>
            <ac:spMk id="20" creationId="{D0CACF94-6070-CEFC-44BB-A441BDD0E623}"/>
          </ac:spMkLst>
        </pc:spChg>
        <pc:spChg chg="add mod">
          <ac:chgData name="健 有村" userId="845497175cb2f617" providerId="LiveId" clId="{601CFE96-BE86-4FC6-AE52-3B5BEE4FDF49}" dt="2024-02-12T23:09:22.696" v="57"/>
          <ac:spMkLst>
            <pc:docMk/>
            <pc:sldMk cId="0" sldId="651"/>
            <ac:spMk id="21" creationId="{3DCFC982-9775-FEFB-630B-4A0E7F4F99B5}"/>
          </ac:spMkLst>
        </pc:spChg>
        <pc:spChg chg="add mod">
          <ac:chgData name="健 有村" userId="845497175cb2f617" providerId="LiveId" clId="{601CFE96-BE86-4FC6-AE52-3B5BEE4FDF49}" dt="2024-02-12T23:09:22.696" v="57"/>
          <ac:spMkLst>
            <pc:docMk/>
            <pc:sldMk cId="0" sldId="651"/>
            <ac:spMk id="22" creationId="{9D590655-8039-C983-AF98-3840138812CF}"/>
          </ac:spMkLst>
        </pc:spChg>
        <pc:spChg chg="add mod">
          <ac:chgData name="健 有村" userId="845497175cb2f617" providerId="LiveId" clId="{601CFE96-BE86-4FC6-AE52-3B5BEE4FDF49}" dt="2024-02-12T23:09:22.696" v="57"/>
          <ac:spMkLst>
            <pc:docMk/>
            <pc:sldMk cId="0" sldId="651"/>
            <ac:spMk id="23" creationId="{FC6A712F-6D5D-8A2C-3C68-0A73C49DF040}"/>
          </ac:spMkLst>
        </pc:spChg>
        <pc:spChg chg="add mod">
          <ac:chgData name="健 有村" userId="845497175cb2f617" providerId="LiveId" clId="{601CFE96-BE86-4FC6-AE52-3B5BEE4FDF49}" dt="2024-02-12T23:09:22.696" v="57"/>
          <ac:spMkLst>
            <pc:docMk/>
            <pc:sldMk cId="0" sldId="651"/>
            <ac:spMk id="24" creationId="{B03B82D0-1DB7-CDF3-158D-B63871EC3B34}"/>
          </ac:spMkLst>
        </pc:spChg>
        <pc:spChg chg="add mod">
          <ac:chgData name="健 有村" userId="845497175cb2f617" providerId="LiveId" clId="{601CFE96-BE86-4FC6-AE52-3B5BEE4FDF49}" dt="2024-02-12T23:09:22.696" v="57"/>
          <ac:spMkLst>
            <pc:docMk/>
            <pc:sldMk cId="0" sldId="651"/>
            <ac:spMk id="25" creationId="{D989A994-37BC-4F7E-F6D7-B2CC5493A639}"/>
          </ac:spMkLst>
        </pc:spChg>
        <pc:spChg chg="add mod">
          <ac:chgData name="健 有村" userId="845497175cb2f617" providerId="LiveId" clId="{601CFE96-BE86-4FC6-AE52-3B5BEE4FDF49}" dt="2024-02-12T23:09:22.696" v="57"/>
          <ac:spMkLst>
            <pc:docMk/>
            <pc:sldMk cId="0" sldId="651"/>
            <ac:spMk id="26" creationId="{76AAE4EC-9F8D-EA11-368B-FC0FA0654D76}"/>
          </ac:spMkLst>
        </pc:spChg>
        <pc:spChg chg="add mod">
          <ac:chgData name="健 有村" userId="845497175cb2f617" providerId="LiveId" clId="{601CFE96-BE86-4FC6-AE52-3B5BEE4FDF49}" dt="2024-02-12T23:09:22.696" v="57"/>
          <ac:spMkLst>
            <pc:docMk/>
            <pc:sldMk cId="0" sldId="651"/>
            <ac:spMk id="27" creationId="{CEEAFF90-8D5F-1498-C2DB-98E63D831DFA}"/>
          </ac:spMkLst>
        </pc:spChg>
        <pc:spChg chg="add mod">
          <ac:chgData name="健 有村" userId="845497175cb2f617" providerId="LiveId" clId="{601CFE96-BE86-4FC6-AE52-3B5BEE4FDF49}" dt="2024-02-12T23:09:22.696" v="57"/>
          <ac:spMkLst>
            <pc:docMk/>
            <pc:sldMk cId="0" sldId="651"/>
            <ac:spMk id="28" creationId="{9261FEA7-8967-A696-1717-774FE8B5B418}"/>
          </ac:spMkLst>
        </pc:spChg>
        <pc:spChg chg="add del mod">
          <ac:chgData name="健 有村" userId="845497175cb2f617" providerId="LiveId" clId="{601CFE96-BE86-4FC6-AE52-3B5BEE4FDF49}" dt="2024-02-12T23:10:02.887" v="63" actId="478"/>
          <ac:spMkLst>
            <pc:docMk/>
            <pc:sldMk cId="0" sldId="651"/>
            <ac:spMk id="29" creationId="{EFB5FC4A-5BD2-4A26-4A52-8D551EA4C4B6}"/>
          </ac:spMkLst>
        </pc:spChg>
        <pc:spChg chg="add mod">
          <ac:chgData name="健 有村" userId="845497175cb2f617" providerId="LiveId" clId="{601CFE96-BE86-4FC6-AE52-3B5BEE4FDF49}" dt="2024-02-12T23:09:48.125" v="61" actId="1076"/>
          <ac:spMkLst>
            <pc:docMk/>
            <pc:sldMk cId="0" sldId="651"/>
            <ac:spMk id="30" creationId="{F2046509-8524-33BC-3866-7DA0C6EB144E}"/>
          </ac:spMkLst>
        </pc:spChg>
        <pc:spChg chg="add mod">
          <ac:chgData name="健 有村" userId="845497175cb2f617" providerId="LiveId" clId="{601CFE96-BE86-4FC6-AE52-3B5BEE4FDF49}" dt="2024-02-12T23:09:48.125" v="61" actId="1076"/>
          <ac:spMkLst>
            <pc:docMk/>
            <pc:sldMk cId="0" sldId="651"/>
            <ac:spMk id="31" creationId="{5DA82ED2-4396-FF76-B39C-2B2EB37616DD}"/>
          </ac:spMkLst>
        </pc:spChg>
        <pc:spChg chg="add mod">
          <ac:chgData name="健 有村" userId="845497175cb2f617" providerId="LiveId" clId="{601CFE96-BE86-4FC6-AE52-3B5BEE4FDF49}" dt="2024-02-12T23:09:48.125" v="61" actId="1076"/>
          <ac:spMkLst>
            <pc:docMk/>
            <pc:sldMk cId="0" sldId="651"/>
            <ac:spMk id="32" creationId="{40CAC06B-0EFC-0F1A-DD0E-EE560F070DD5}"/>
          </ac:spMkLst>
        </pc:spChg>
        <pc:spChg chg="add mod">
          <ac:chgData name="健 有村" userId="845497175cb2f617" providerId="LiveId" clId="{601CFE96-BE86-4FC6-AE52-3B5BEE4FDF49}" dt="2024-02-12T23:09:48.125" v="61" actId="1076"/>
          <ac:spMkLst>
            <pc:docMk/>
            <pc:sldMk cId="0" sldId="651"/>
            <ac:spMk id="33" creationId="{786B20BB-8868-E4FE-E198-A9DC3D79904E}"/>
          </ac:spMkLst>
        </pc:spChg>
        <pc:spChg chg="add mod">
          <ac:chgData name="健 有村" userId="845497175cb2f617" providerId="LiveId" clId="{601CFE96-BE86-4FC6-AE52-3B5BEE4FDF49}" dt="2024-02-12T23:09:48.125" v="61" actId="1076"/>
          <ac:spMkLst>
            <pc:docMk/>
            <pc:sldMk cId="0" sldId="651"/>
            <ac:spMk id="34" creationId="{FFDE4A29-CBB1-705A-3908-BC683010A959}"/>
          </ac:spMkLst>
        </pc:spChg>
        <pc:spChg chg="add mod">
          <ac:chgData name="健 有村" userId="845497175cb2f617" providerId="LiveId" clId="{601CFE96-BE86-4FC6-AE52-3B5BEE4FDF49}" dt="2024-02-12T23:09:48.125" v="61" actId="1076"/>
          <ac:spMkLst>
            <pc:docMk/>
            <pc:sldMk cId="0" sldId="651"/>
            <ac:spMk id="35" creationId="{C8D5DA48-EC68-D5BB-5F61-2A35D716779B}"/>
          </ac:spMkLst>
        </pc:spChg>
        <pc:spChg chg="add mod">
          <ac:chgData name="健 有村" userId="845497175cb2f617" providerId="LiveId" clId="{601CFE96-BE86-4FC6-AE52-3B5BEE4FDF49}" dt="2024-02-12T23:09:48.125" v="61" actId="1076"/>
          <ac:spMkLst>
            <pc:docMk/>
            <pc:sldMk cId="0" sldId="651"/>
            <ac:spMk id="36" creationId="{5B19AF19-5B88-C375-86BF-3A6522451871}"/>
          </ac:spMkLst>
        </pc:spChg>
        <pc:spChg chg="add mod">
          <ac:chgData name="健 有村" userId="845497175cb2f617" providerId="LiveId" clId="{601CFE96-BE86-4FC6-AE52-3B5BEE4FDF49}" dt="2024-02-12T23:09:56.328" v="62" actId="1076"/>
          <ac:spMkLst>
            <pc:docMk/>
            <pc:sldMk cId="0" sldId="651"/>
            <ac:spMk id="37" creationId="{DAA11407-F5CA-AC3D-F380-3B87E256D684}"/>
          </ac:spMkLst>
        </pc:spChg>
        <pc:spChg chg="add mod">
          <ac:chgData name="健 有村" userId="845497175cb2f617" providerId="LiveId" clId="{601CFE96-BE86-4FC6-AE52-3B5BEE4FDF49}" dt="2024-02-12T23:09:48.125" v="61" actId="1076"/>
          <ac:spMkLst>
            <pc:docMk/>
            <pc:sldMk cId="0" sldId="651"/>
            <ac:spMk id="38" creationId="{09F2A593-FE87-D289-D44F-9600D5A483AA}"/>
          </ac:spMkLst>
        </pc:spChg>
        <pc:spChg chg="add mod">
          <ac:chgData name="健 有村" userId="845497175cb2f617" providerId="LiveId" clId="{601CFE96-BE86-4FC6-AE52-3B5BEE4FDF49}" dt="2024-02-12T23:09:48.125" v="61" actId="1076"/>
          <ac:spMkLst>
            <pc:docMk/>
            <pc:sldMk cId="0" sldId="651"/>
            <ac:spMk id="39" creationId="{B897C2EB-73AE-4215-FBB6-AC899CE51750}"/>
          </ac:spMkLst>
        </pc:spChg>
        <pc:spChg chg="add mod">
          <ac:chgData name="健 有村" userId="845497175cb2f617" providerId="LiveId" clId="{601CFE96-BE86-4FC6-AE52-3B5BEE4FDF49}" dt="2024-02-12T23:09:48.125" v="61" actId="1076"/>
          <ac:spMkLst>
            <pc:docMk/>
            <pc:sldMk cId="0" sldId="651"/>
            <ac:spMk id="40" creationId="{368E38BF-FC7D-5477-C31A-03AF2692CDF6}"/>
          </ac:spMkLst>
        </pc:spChg>
        <pc:spChg chg="add mod">
          <ac:chgData name="健 有村" userId="845497175cb2f617" providerId="LiveId" clId="{601CFE96-BE86-4FC6-AE52-3B5BEE4FDF49}" dt="2024-02-12T23:09:48.125" v="61" actId="1076"/>
          <ac:spMkLst>
            <pc:docMk/>
            <pc:sldMk cId="0" sldId="651"/>
            <ac:spMk id="41" creationId="{8B9A9BA4-7BA6-49DA-3747-43F9257BE0AF}"/>
          </ac:spMkLst>
        </pc:spChg>
        <pc:spChg chg="add mod">
          <ac:chgData name="健 有村" userId="845497175cb2f617" providerId="LiveId" clId="{601CFE96-BE86-4FC6-AE52-3B5BEE4FDF49}" dt="2024-02-12T23:10:17.497" v="65" actId="1076"/>
          <ac:spMkLst>
            <pc:docMk/>
            <pc:sldMk cId="0" sldId="651"/>
            <ac:spMk id="42" creationId="{93DE11AF-661B-52DC-AB72-B1C2794F4D0E}"/>
          </ac:spMkLst>
        </pc:spChg>
        <pc:spChg chg="add mod">
          <ac:chgData name="健 有村" userId="845497175cb2f617" providerId="LiveId" clId="{601CFE96-BE86-4FC6-AE52-3B5BEE4FDF49}" dt="2024-02-12T23:14:21.492" v="78" actId="1076"/>
          <ac:spMkLst>
            <pc:docMk/>
            <pc:sldMk cId="0" sldId="651"/>
            <ac:spMk id="43" creationId="{EA088187-24A8-490C-D8CE-6F37058029AD}"/>
          </ac:spMkLst>
        </pc:spChg>
        <pc:spChg chg="del">
          <ac:chgData name="健 有村" userId="845497175cb2f617" providerId="LiveId" clId="{601CFE96-BE86-4FC6-AE52-3B5BEE4FDF49}" dt="2024-02-12T23:07:48.896" v="45" actId="478"/>
          <ac:spMkLst>
            <pc:docMk/>
            <pc:sldMk cId="0" sldId="651"/>
            <ac:spMk id="58377" creationId="{787B4159-9A24-9C6B-54D8-51EB2BC0FB00}"/>
          </ac:spMkLst>
        </pc:spChg>
        <pc:spChg chg="del">
          <ac:chgData name="健 有村" userId="845497175cb2f617" providerId="LiveId" clId="{601CFE96-BE86-4FC6-AE52-3B5BEE4FDF49}" dt="2024-02-12T23:07:57.678" v="47" actId="478"/>
          <ac:spMkLst>
            <pc:docMk/>
            <pc:sldMk cId="0" sldId="651"/>
            <ac:spMk id="58378" creationId="{7BFBE196-094E-FA9A-EAFE-6B9568A48BD9}"/>
          </ac:spMkLst>
        </pc:spChg>
        <pc:spChg chg="del">
          <ac:chgData name="健 有村" userId="845497175cb2f617" providerId="LiveId" clId="{601CFE96-BE86-4FC6-AE52-3B5BEE4FDF49}" dt="2024-02-12T23:07:48.896" v="45" actId="478"/>
          <ac:spMkLst>
            <pc:docMk/>
            <pc:sldMk cId="0" sldId="651"/>
            <ac:spMk id="58381" creationId="{FDC6263E-BBAE-13C6-2246-6F38A9EDE864}"/>
          </ac:spMkLst>
        </pc:spChg>
        <pc:spChg chg="del">
          <ac:chgData name="健 有村" userId="845497175cb2f617" providerId="LiveId" clId="{601CFE96-BE86-4FC6-AE52-3B5BEE4FDF49}" dt="2024-02-12T23:07:48.896" v="45" actId="478"/>
          <ac:spMkLst>
            <pc:docMk/>
            <pc:sldMk cId="0" sldId="651"/>
            <ac:spMk id="58382" creationId="{DFE4862D-0C7B-0723-287B-010C551BF579}"/>
          </ac:spMkLst>
        </pc:spChg>
        <pc:picChg chg="del">
          <ac:chgData name="健 有村" userId="845497175cb2f617" providerId="LiveId" clId="{601CFE96-BE86-4FC6-AE52-3B5BEE4FDF49}" dt="2024-02-12T23:07:48.896" v="45" actId="478"/>
          <ac:picMkLst>
            <pc:docMk/>
            <pc:sldMk cId="0" sldId="651"/>
            <ac:picMk id="2" creationId="{6B2DF8D8-59E4-4677-2BDA-DA81934F7490}"/>
          </ac:picMkLst>
        </pc:picChg>
        <pc:picChg chg="mod">
          <ac:chgData name="健 有村" userId="845497175cb2f617" providerId="LiveId" clId="{601CFE96-BE86-4FC6-AE52-3B5BEE4FDF49}" dt="2024-02-12T23:09:26.596" v="59" actId="1076"/>
          <ac:picMkLst>
            <pc:docMk/>
            <pc:sldMk cId="0" sldId="651"/>
            <ac:picMk id="3" creationId="{1D33BA9F-25E9-DC8C-D408-B32276364C24}"/>
          </ac:picMkLst>
        </pc:picChg>
        <pc:picChg chg="del">
          <ac:chgData name="健 有村" userId="845497175cb2f617" providerId="LiveId" clId="{601CFE96-BE86-4FC6-AE52-3B5BEE4FDF49}" dt="2024-02-12T23:07:48.896" v="45" actId="478"/>
          <ac:picMkLst>
            <pc:docMk/>
            <pc:sldMk cId="0" sldId="651"/>
            <ac:picMk id="4" creationId="{C0F8890E-D55A-FD5A-4F31-563461171715}"/>
          </ac:picMkLst>
        </pc:picChg>
        <pc:picChg chg="del">
          <ac:chgData name="健 有村" userId="845497175cb2f617" providerId="LiveId" clId="{601CFE96-BE86-4FC6-AE52-3B5BEE4FDF49}" dt="2024-02-12T23:07:52.596" v="46" actId="478"/>
          <ac:picMkLst>
            <pc:docMk/>
            <pc:sldMk cId="0" sldId="651"/>
            <ac:picMk id="5" creationId="{7DEA53E0-EFC9-EC63-D3EE-ACD43EDA7E9D}"/>
          </ac:picMkLst>
        </pc:picChg>
        <pc:picChg chg="del">
          <ac:chgData name="健 有村" userId="845497175cb2f617" providerId="LiveId" clId="{601CFE96-BE86-4FC6-AE52-3B5BEE4FDF49}" dt="2024-02-12T23:07:48.896" v="45" actId="478"/>
          <ac:picMkLst>
            <pc:docMk/>
            <pc:sldMk cId="0" sldId="651"/>
            <ac:picMk id="9" creationId="{1ADAC768-0E7D-2B47-7402-D670FC8A5BEE}"/>
          </ac:picMkLst>
        </pc:picChg>
        <pc:picChg chg="del">
          <ac:chgData name="健 有村" userId="845497175cb2f617" providerId="LiveId" clId="{601CFE96-BE86-4FC6-AE52-3B5BEE4FDF49}" dt="2024-02-12T23:07:52.596" v="46" actId="478"/>
          <ac:picMkLst>
            <pc:docMk/>
            <pc:sldMk cId="0" sldId="651"/>
            <ac:picMk id="15" creationId="{A463C926-21C0-0334-9C06-118ED04BB2D2}"/>
          </ac:picMkLst>
        </pc:picChg>
      </pc:sldChg>
      <pc:sldChg chg="addSp delSp modSp mod">
        <pc:chgData name="健 有村" userId="845497175cb2f617" providerId="LiveId" clId="{601CFE96-BE86-4FC6-AE52-3B5BEE4FDF49}" dt="2024-02-12T23:24:12.905" v="120" actId="16480"/>
        <pc:sldMkLst>
          <pc:docMk/>
          <pc:sldMk cId="0" sldId="652"/>
        </pc:sldMkLst>
        <pc:spChg chg="del">
          <ac:chgData name="健 有村" userId="845497175cb2f617" providerId="LiveId" clId="{601CFE96-BE86-4FC6-AE52-3B5BEE4FDF49}" dt="2024-02-12T23:11:02.482" v="67" actId="478"/>
          <ac:spMkLst>
            <pc:docMk/>
            <pc:sldMk cId="0" sldId="652"/>
            <ac:spMk id="6" creationId="{488F2A22-DD13-A344-63EE-3B707663E3DF}"/>
          </ac:spMkLst>
        </pc:spChg>
        <pc:spChg chg="del">
          <ac:chgData name="健 有村" userId="845497175cb2f617" providerId="LiveId" clId="{601CFE96-BE86-4FC6-AE52-3B5BEE4FDF49}" dt="2024-02-12T23:11:04.135" v="68" actId="478"/>
          <ac:spMkLst>
            <pc:docMk/>
            <pc:sldMk cId="0" sldId="652"/>
            <ac:spMk id="7" creationId="{12882598-980D-05EA-DB1C-AFDD0D315940}"/>
          </ac:spMkLst>
        </pc:spChg>
        <pc:spChg chg="del">
          <ac:chgData name="健 有村" userId="845497175cb2f617" providerId="LiveId" clId="{601CFE96-BE86-4FC6-AE52-3B5BEE4FDF49}" dt="2024-02-12T23:11:12.202" v="72" actId="478"/>
          <ac:spMkLst>
            <pc:docMk/>
            <pc:sldMk cId="0" sldId="652"/>
            <ac:spMk id="8" creationId="{AEFFCD33-9DF3-86F1-F554-F06A65A9033C}"/>
          </ac:spMkLst>
        </pc:spChg>
        <pc:spChg chg="add mod">
          <ac:chgData name="健 有村" userId="845497175cb2f617" providerId="LiveId" clId="{601CFE96-BE86-4FC6-AE52-3B5BEE4FDF49}" dt="2024-02-12T23:19:59.565" v="84"/>
          <ac:spMkLst>
            <pc:docMk/>
            <pc:sldMk cId="0" sldId="652"/>
            <ac:spMk id="11" creationId="{7525BF0F-4AED-1437-9538-3B59D00F8C3F}"/>
          </ac:spMkLst>
        </pc:spChg>
        <pc:spChg chg="add mod">
          <ac:chgData name="健 有村" userId="845497175cb2f617" providerId="LiveId" clId="{601CFE96-BE86-4FC6-AE52-3B5BEE4FDF49}" dt="2024-02-12T23:19:59.565" v="84"/>
          <ac:spMkLst>
            <pc:docMk/>
            <pc:sldMk cId="0" sldId="652"/>
            <ac:spMk id="12" creationId="{596E68A3-AD7A-A32B-E124-53452A073681}"/>
          </ac:spMkLst>
        </pc:spChg>
        <pc:spChg chg="add mod">
          <ac:chgData name="健 有村" userId="845497175cb2f617" providerId="LiveId" clId="{601CFE96-BE86-4FC6-AE52-3B5BEE4FDF49}" dt="2024-02-12T23:19:59.565" v="84"/>
          <ac:spMkLst>
            <pc:docMk/>
            <pc:sldMk cId="0" sldId="652"/>
            <ac:spMk id="13" creationId="{08F101DF-AADB-8EEA-C9A0-5025B4BE725D}"/>
          </ac:spMkLst>
        </pc:spChg>
        <pc:spChg chg="del">
          <ac:chgData name="健 有村" userId="845497175cb2f617" providerId="LiveId" clId="{601CFE96-BE86-4FC6-AE52-3B5BEE4FDF49}" dt="2024-02-12T23:11:12.202" v="72" actId="478"/>
          <ac:spMkLst>
            <pc:docMk/>
            <pc:sldMk cId="0" sldId="652"/>
            <ac:spMk id="14" creationId="{1E6054F4-0257-BB5F-DFBE-94548D7E0C1C}"/>
          </ac:spMkLst>
        </pc:spChg>
        <pc:spChg chg="del">
          <ac:chgData name="健 有村" userId="845497175cb2f617" providerId="LiveId" clId="{601CFE96-BE86-4FC6-AE52-3B5BEE4FDF49}" dt="2024-02-12T23:11:04.983" v="69" actId="478"/>
          <ac:spMkLst>
            <pc:docMk/>
            <pc:sldMk cId="0" sldId="652"/>
            <ac:spMk id="16" creationId="{402E1CCC-A6B5-7961-1E47-833AC90AD236}"/>
          </ac:spMkLst>
        </pc:spChg>
        <pc:spChg chg="del">
          <ac:chgData name="健 有村" userId="845497175cb2f617" providerId="LiveId" clId="{601CFE96-BE86-4FC6-AE52-3B5BEE4FDF49}" dt="2024-02-12T23:11:05.866" v="70" actId="478"/>
          <ac:spMkLst>
            <pc:docMk/>
            <pc:sldMk cId="0" sldId="652"/>
            <ac:spMk id="17" creationId="{334E64A0-8BF8-9506-8CAC-B31B25AFC4CE}"/>
          </ac:spMkLst>
        </pc:spChg>
        <pc:spChg chg="del">
          <ac:chgData name="健 有村" userId="845497175cb2f617" providerId="LiveId" clId="{601CFE96-BE86-4FC6-AE52-3B5BEE4FDF49}" dt="2024-02-12T23:10:50.924" v="66" actId="478"/>
          <ac:spMkLst>
            <pc:docMk/>
            <pc:sldMk cId="0" sldId="652"/>
            <ac:spMk id="18" creationId="{8AC179A9-DF4E-486A-1B77-946830D2DCF3}"/>
          </ac:spMkLst>
        </pc:spChg>
        <pc:spChg chg="add mod">
          <ac:chgData name="健 有村" userId="845497175cb2f617" providerId="LiveId" clId="{601CFE96-BE86-4FC6-AE52-3B5BEE4FDF49}" dt="2024-02-12T23:19:59.565" v="84"/>
          <ac:spMkLst>
            <pc:docMk/>
            <pc:sldMk cId="0" sldId="652"/>
            <ac:spMk id="19" creationId="{5E997D0E-3112-4459-73A5-7ED396585502}"/>
          </ac:spMkLst>
        </pc:spChg>
        <pc:spChg chg="add mod">
          <ac:chgData name="健 有村" userId="845497175cb2f617" providerId="LiveId" clId="{601CFE96-BE86-4FC6-AE52-3B5BEE4FDF49}" dt="2024-02-12T23:19:59.565" v="84"/>
          <ac:spMkLst>
            <pc:docMk/>
            <pc:sldMk cId="0" sldId="652"/>
            <ac:spMk id="20" creationId="{4E0EBABB-E934-EE4C-3C92-A1C71C6225E6}"/>
          </ac:spMkLst>
        </pc:spChg>
        <pc:spChg chg="add mod">
          <ac:chgData name="健 有村" userId="845497175cb2f617" providerId="LiveId" clId="{601CFE96-BE86-4FC6-AE52-3B5BEE4FDF49}" dt="2024-02-12T23:19:59.565" v="84"/>
          <ac:spMkLst>
            <pc:docMk/>
            <pc:sldMk cId="0" sldId="652"/>
            <ac:spMk id="21" creationId="{C92A13EF-50DF-123E-69E5-6D297DBBB352}"/>
          </ac:spMkLst>
        </pc:spChg>
        <pc:spChg chg="add mod">
          <ac:chgData name="健 有村" userId="845497175cb2f617" providerId="LiveId" clId="{601CFE96-BE86-4FC6-AE52-3B5BEE4FDF49}" dt="2024-02-12T23:19:59.565" v="84"/>
          <ac:spMkLst>
            <pc:docMk/>
            <pc:sldMk cId="0" sldId="652"/>
            <ac:spMk id="22" creationId="{501E8EE6-72FA-5C75-61B8-9DCA4A7106FB}"/>
          </ac:spMkLst>
        </pc:spChg>
        <pc:spChg chg="add mod">
          <ac:chgData name="健 有村" userId="845497175cb2f617" providerId="LiveId" clId="{601CFE96-BE86-4FC6-AE52-3B5BEE4FDF49}" dt="2024-02-12T23:19:59.565" v="84"/>
          <ac:spMkLst>
            <pc:docMk/>
            <pc:sldMk cId="0" sldId="652"/>
            <ac:spMk id="23" creationId="{338BA090-3C36-09E7-A5A4-6DF10768EDA8}"/>
          </ac:spMkLst>
        </pc:spChg>
        <pc:spChg chg="add mod">
          <ac:chgData name="健 有村" userId="845497175cb2f617" providerId="LiveId" clId="{601CFE96-BE86-4FC6-AE52-3B5BEE4FDF49}" dt="2024-02-12T23:19:59.565" v="84"/>
          <ac:spMkLst>
            <pc:docMk/>
            <pc:sldMk cId="0" sldId="652"/>
            <ac:spMk id="24" creationId="{FD98E200-AF5B-A480-557C-01B14CB7DF90}"/>
          </ac:spMkLst>
        </pc:spChg>
        <pc:spChg chg="add mod">
          <ac:chgData name="健 有村" userId="845497175cb2f617" providerId="LiveId" clId="{601CFE96-BE86-4FC6-AE52-3B5BEE4FDF49}" dt="2024-02-12T23:19:59.565" v="84"/>
          <ac:spMkLst>
            <pc:docMk/>
            <pc:sldMk cId="0" sldId="652"/>
            <ac:spMk id="25" creationId="{09B17ED1-41D9-9AC1-04FA-E022D4DF9DF4}"/>
          </ac:spMkLst>
        </pc:spChg>
        <pc:spChg chg="add mod">
          <ac:chgData name="健 有村" userId="845497175cb2f617" providerId="LiveId" clId="{601CFE96-BE86-4FC6-AE52-3B5BEE4FDF49}" dt="2024-02-12T23:19:59.565" v="84"/>
          <ac:spMkLst>
            <pc:docMk/>
            <pc:sldMk cId="0" sldId="652"/>
            <ac:spMk id="26" creationId="{A5DF4047-EFE4-43DD-2AC5-82025694A928}"/>
          </ac:spMkLst>
        </pc:spChg>
        <pc:spChg chg="add mod">
          <ac:chgData name="健 有村" userId="845497175cb2f617" providerId="LiveId" clId="{601CFE96-BE86-4FC6-AE52-3B5BEE4FDF49}" dt="2024-02-12T23:19:59.565" v="84"/>
          <ac:spMkLst>
            <pc:docMk/>
            <pc:sldMk cId="0" sldId="652"/>
            <ac:spMk id="27" creationId="{C6BBB5F4-AC1A-C935-C816-6B03DA17845A}"/>
          </ac:spMkLst>
        </pc:spChg>
        <pc:spChg chg="add mod">
          <ac:chgData name="健 有村" userId="845497175cb2f617" providerId="LiveId" clId="{601CFE96-BE86-4FC6-AE52-3B5BEE4FDF49}" dt="2024-02-12T23:19:59.565" v="84"/>
          <ac:spMkLst>
            <pc:docMk/>
            <pc:sldMk cId="0" sldId="652"/>
            <ac:spMk id="28" creationId="{169CF270-24A1-CE0E-9277-9B61B617F3D0}"/>
          </ac:spMkLst>
        </pc:spChg>
        <pc:spChg chg="add mod">
          <ac:chgData name="健 有村" userId="845497175cb2f617" providerId="LiveId" clId="{601CFE96-BE86-4FC6-AE52-3B5BEE4FDF49}" dt="2024-02-12T23:19:59.565" v="84"/>
          <ac:spMkLst>
            <pc:docMk/>
            <pc:sldMk cId="0" sldId="652"/>
            <ac:spMk id="29" creationId="{9B5DE730-DD5D-2041-F118-274A3919D6C4}"/>
          </ac:spMkLst>
        </pc:spChg>
        <pc:spChg chg="add mod">
          <ac:chgData name="健 有村" userId="845497175cb2f617" providerId="LiveId" clId="{601CFE96-BE86-4FC6-AE52-3B5BEE4FDF49}" dt="2024-02-12T23:21:59.564" v="99" actId="1076"/>
          <ac:spMkLst>
            <pc:docMk/>
            <pc:sldMk cId="0" sldId="652"/>
            <ac:spMk id="30" creationId="{4295CC42-4274-4255-7378-6BA4C021D96C}"/>
          </ac:spMkLst>
        </pc:spChg>
        <pc:spChg chg="add mod">
          <ac:chgData name="健 有村" userId="845497175cb2f617" providerId="LiveId" clId="{601CFE96-BE86-4FC6-AE52-3B5BEE4FDF49}" dt="2024-02-12T23:20:30.629" v="88" actId="1076"/>
          <ac:spMkLst>
            <pc:docMk/>
            <pc:sldMk cId="0" sldId="652"/>
            <ac:spMk id="31" creationId="{F6D906FD-E1BB-61AE-67FC-C8B578B69F0D}"/>
          </ac:spMkLst>
        </pc:spChg>
        <pc:spChg chg="add mod">
          <ac:chgData name="健 有村" userId="845497175cb2f617" providerId="LiveId" clId="{601CFE96-BE86-4FC6-AE52-3B5BEE4FDF49}" dt="2024-02-12T23:20:30.629" v="88" actId="1076"/>
          <ac:spMkLst>
            <pc:docMk/>
            <pc:sldMk cId="0" sldId="652"/>
            <ac:spMk id="32" creationId="{AEB4DCEC-9F2D-C5AB-A96A-DB69908CC4AD}"/>
          </ac:spMkLst>
        </pc:spChg>
        <pc:spChg chg="add mod">
          <ac:chgData name="健 有村" userId="845497175cb2f617" providerId="LiveId" clId="{601CFE96-BE86-4FC6-AE52-3B5BEE4FDF49}" dt="2024-02-12T23:20:30.629" v="88" actId="1076"/>
          <ac:spMkLst>
            <pc:docMk/>
            <pc:sldMk cId="0" sldId="652"/>
            <ac:spMk id="33" creationId="{32F86DF8-CDA7-BF80-DCAF-96B265B70E8F}"/>
          </ac:spMkLst>
        </pc:spChg>
        <pc:spChg chg="add mod">
          <ac:chgData name="健 有村" userId="845497175cb2f617" providerId="LiveId" clId="{601CFE96-BE86-4FC6-AE52-3B5BEE4FDF49}" dt="2024-02-12T23:20:30.629" v="88" actId="1076"/>
          <ac:spMkLst>
            <pc:docMk/>
            <pc:sldMk cId="0" sldId="652"/>
            <ac:spMk id="34" creationId="{BF63F29A-17C5-7C7C-0938-7EF94A544D46}"/>
          </ac:spMkLst>
        </pc:spChg>
        <pc:spChg chg="add mod">
          <ac:chgData name="健 有村" userId="845497175cb2f617" providerId="LiveId" clId="{601CFE96-BE86-4FC6-AE52-3B5BEE4FDF49}" dt="2024-02-12T23:21:38.750" v="95" actId="1076"/>
          <ac:spMkLst>
            <pc:docMk/>
            <pc:sldMk cId="0" sldId="652"/>
            <ac:spMk id="35" creationId="{65930E23-735E-132A-A161-4D5714325FFC}"/>
          </ac:spMkLst>
        </pc:spChg>
        <pc:spChg chg="add mod">
          <ac:chgData name="健 有村" userId="845497175cb2f617" providerId="LiveId" clId="{601CFE96-BE86-4FC6-AE52-3B5BEE4FDF49}" dt="2024-02-12T23:21:35.168" v="94" actId="1076"/>
          <ac:spMkLst>
            <pc:docMk/>
            <pc:sldMk cId="0" sldId="652"/>
            <ac:spMk id="36" creationId="{BDD675A0-FE05-1CD9-A23E-34C42E470C57}"/>
          </ac:spMkLst>
        </pc:spChg>
        <pc:spChg chg="add mod">
          <ac:chgData name="健 有村" userId="845497175cb2f617" providerId="LiveId" clId="{601CFE96-BE86-4FC6-AE52-3B5BEE4FDF49}" dt="2024-02-12T23:21:27.509" v="93" actId="1076"/>
          <ac:spMkLst>
            <pc:docMk/>
            <pc:sldMk cId="0" sldId="652"/>
            <ac:spMk id="37" creationId="{8EA5FF96-101B-B726-E381-C3F32219AFBA}"/>
          </ac:spMkLst>
        </pc:spChg>
        <pc:spChg chg="add mod">
          <ac:chgData name="健 有村" userId="845497175cb2f617" providerId="LiveId" clId="{601CFE96-BE86-4FC6-AE52-3B5BEE4FDF49}" dt="2024-02-12T23:21:22.212" v="92" actId="1076"/>
          <ac:spMkLst>
            <pc:docMk/>
            <pc:sldMk cId="0" sldId="652"/>
            <ac:spMk id="38" creationId="{A8FA56C9-AEAC-343D-DE28-720BB48C0126}"/>
          </ac:spMkLst>
        </pc:spChg>
        <pc:spChg chg="add mod">
          <ac:chgData name="健 有村" userId="845497175cb2f617" providerId="LiveId" clId="{601CFE96-BE86-4FC6-AE52-3B5BEE4FDF49}" dt="2024-02-12T23:21:47.452" v="98" actId="1076"/>
          <ac:spMkLst>
            <pc:docMk/>
            <pc:sldMk cId="0" sldId="652"/>
            <ac:spMk id="39" creationId="{1829E3E9-57A3-022B-1D42-006D071A5146}"/>
          </ac:spMkLst>
        </pc:spChg>
        <pc:spChg chg="add mod">
          <ac:chgData name="健 有村" userId="845497175cb2f617" providerId="LiveId" clId="{601CFE96-BE86-4FC6-AE52-3B5BEE4FDF49}" dt="2024-02-12T23:21:17.639" v="91" actId="1076"/>
          <ac:spMkLst>
            <pc:docMk/>
            <pc:sldMk cId="0" sldId="652"/>
            <ac:spMk id="40" creationId="{14316BA1-509A-5B14-B838-98EFCE5268C2}"/>
          </ac:spMkLst>
        </pc:spChg>
        <pc:spChg chg="add mod">
          <ac:chgData name="健 有村" userId="845497175cb2f617" providerId="LiveId" clId="{601CFE96-BE86-4FC6-AE52-3B5BEE4FDF49}" dt="2024-02-12T23:20:49.571" v="90" actId="1076"/>
          <ac:spMkLst>
            <pc:docMk/>
            <pc:sldMk cId="0" sldId="652"/>
            <ac:spMk id="41" creationId="{0913F22B-5359-CAF6-451B-B7030E9EEA58}"/>
          </ac:spMkLst>
        </pc:spChg>
        <pc:spChg chg="add mod">
          <ac:chgData name="健 有村" userId="845497175cb2f617" providerId="LiveId" clId="{601CFE96-BE86-4FC6-AE52-3B5BEE4FDF49}" dt="2024-02-12T23:20:42.193" v="89" actId="1076"/>
          <ac:spMkLst>
            <pc:docMk/>
            <pc:sldMk cId="0" sldId="652"/>
            <ac:spMk id="42" creationId="{EF85B832-D571-F6C8-EED1-A7A26D5637A9}"/>
          </ac:spMkLst>
        </pc:spChg>
        <pc:spChg chg="add mod">
          <ac:chgData name="健 有村" userId="845497175cb2f617" providerId="LiveId" clId="{601CFE96-BE86-4FC6-AE52-3B5BEE4FDF49}" dt="2024-02-12T23:23:00.911" v="107" actId="1076"/>
          <ac:spMkLst>
            <pc:docMk/>
            <pc:sldMk cId="0" sldId="652"/>
            <ac:spMk id="43" creationId="{D1B3D840-66C7-8F9F-9CBA-6A3A8D3B2C2B}"/>
          </ac:spMkLst>
        </pc:spChg>
        <pc:spChg chg="del">
          <ac:chgData name="健 有村" userId="845497175cb2f617" providerId="LiveId" clId="{601CFE96-BE86-4FC6-AE52-3B5BEE4FDF49}" dt="2024-02-12T23:10:50.924" v="66" actId="478"/>
          <ac:spMkLst>
            <pc:docMk/>
            <pc:sldMk cId="0" sldId="652"/>
            <ac:spMk id="58377" creationId="{787B4159-9A24-9C6B-54D8-51EB2BC0FB00}"/>
          </ac:spMkLst>
        </pc:spChg>
        <pc:spChg chg="del">
          <ac:chgData name="健 有村" userId="845497175cb2f617" providerId="LiveId" clId="{601CFE96-BE86-4FC6-AE52-3B5BEE4FDF49}" dt="2024-02-12T23:10:50.924" v="66" actId="478"/>
          <ac:spMkLst>
            <pc:docMk/>
            <pc:sldMk cId="0" sldId="652"/>
            <ac:spMk id="58378" creationId="{7BFBE196-094E-FA9A-EAFE-6B9568A48BD9}"/>
          </ac:spMkLst>
        </pc:spChg>
        <pc:spChg chg="del">
          <ac:chgData name="健 有村" userId="845497175cb2f617" providerId="LiveId" clId="{601CFE96-BE86-4FC6-AE52-3B5BEE4FDF49}" dt="2024-02-12T23:10:50.924" v="66" actId="478"/>
          <ac:spMkLst>
            <pc:docMk/>
            <pc:sldMk cId="0" sldId="652"/>
            <ac:spMk id="58381" creationId="{FDC6263E-BBAE-13C6-2246-6F38A9EDE864}"/>
          </ac:spMkLst>
        </pc:spChg>
        <pc:spChg chg="del">
          <ac:chgData name="健 有村" userId="845497175cb2f617" providerId="LiveId" clId="{601CFE96-BE86-4FC6-AE52-3B5BEE4FDF49}" dt="2024-02-12T23:11:06.904" v="71" actId="478"/>
          <ac:spMkLst>
            <pc:docMk/>
            <pc:sldMk cId="0" sldId="652"/>
            <ac:spMk id="58382" creationId="{DFE4862D-0C7B-0723-287B-010C551BF579}"/>
          </ac:spMkLst>
        </pc:spChg>
        <pc:picChg chg="del">
          <ac:chgData name="健 有村" userId="845497175cb2f617" providerId="LiveId" clId="{601CFE96-BE86-4FC6-AE52-3B5BEE4FDF49}" dt="2024-02-12T23:10:50.924" v="66" actId="478"/>
          <ac:picMkLst>
            <pc:docMk/>
            <pc:sldMk cId="0" sldId="652"/>
            <ac:picMk id="2" creationId="{6B2DF8D8-59E4-4677-2BDA-DA81934F7490}"/>
          </ac:picMkLst>
        </pc:picChg>
        <pc:picChg chg="del">
          <ac:chgData name="健 有村" userId="845497175cb2f617" providerId="LiveId" clId="{601CFE96-BE86-4FC6-AE52-3B5BEE4FDF49}" dt="2024-02-12T23:10:50.924" v="66" actId="478"/>
          <ac:picMkLst>
            <pc:docMk/>
            <pc:sldMk cId="0" sldId="652"/>
            <ac:picMk id="3" creationId="{1D33BA9F-25E9-DC8C-D408-B32276364C24}"/>
          </ac:picMkLst>
        </pc:picChg>
        <pc:picChg chg="mod">
          <ac:chgData name="健 有村" userId="845497175cb2f617" providerId="LiveId" clId="{601CFE96-BE86-4FC6-AE52-3B5BEE4FDF49}" dt="2024-02-12T23:24:12.905" v="120" actId="16480"/>
          <ac:picMkLst>
            <pc:docMk/>
            <pc:sldMk cId="0" sldId="652"/>
            <ac:picMk id="4" creationId="{C0F8890E-D55A-FD5A-4F31-563461171715}"/>
          </ac:picMkLst>
        </pc:picChg>
        <pc:picChg chg="del">
          <ac:chgData name="健 有村" userId="845497175cb2f617" providerId="LiveId" clId="{601CFE96-BE86-4FC6-AE52-3B5BEE4FDF49}" dt="2024-02-12T23:11:12.202" v="72" actId="478"/>
          <ac:picMkLst>
            <pc:docMk/>
            <pc:sldMk cId="0" sldId="652"/>
            <ac:picMk id="5" creationId="{7DEA53E0-EFC9-EC63-D3EE-ACD43EDA7E9D}"/>
          </ac:picMkLst>
        </pc:picChg>
        <pc:picChg chg="del">
          <ac:chgData name="健 有村" userId="845497175cb2f617" providerId="LiveId" clId="{601CFE96-BE86-4FC6-AE52-3B5BEE4FDF49}" dt="2024-02-12T23:11:13.288" v="73" actId="478"/>
          <ac:picMkLst>
            <pc:docMk/>
            <pc:sldMk cId="0" sldId="652"/>
            <ac:picMk id="9" creationId="{1ADAC768-0E7D-2B47-7402-D670FC8A5BEE}"/>
          </ac:picMkLst>
        </pc:picChg>
        <pc:picChg chg="del">
          <ac:chgData name="健 有村" userId="845497175cb2f617" providerId="LiveId" clId="{601CFE96-BE86-4FC6-AE52-3B5BEE4FDF49}" dt="2024-02-12T23:11:12.202" v="72" actId="478"/>
          <ac:picMkLst>
            <pc:docMk/>
            <pc:sldMk cId="0" sldId="652"/>
            <ac:picMk id="15" creationId="{A463C926-21C0-0334-9C06-118ED04BB2D2}"/>
          </ac:picMkLst>
        </pc:picChg>
      </pc:sldChg>
      <pc:sldChg chg="addSp delSp modSp mod">
        <pc:chgData name="健 有村" userId="845497175cb2f617" providerId="LiveId" clId="{601CFE96-BE86-4FC6-AE52-3B5BEE4FDF49}" dt="2024-02-12T23:27:17.334" v="141" actId="1076"/>
        <pc:sldMkLst>
          <pc:docMk/>
          <pc:sldMk cId="0" sldId="653"/>
        </pc:sldMkLst>
        <pc:spChg chg="del">
          <ac:chgData name="健 有村" userId="845497175cb2f617" providerId="LiveId" clId="{601CFE96-BE86-4FC6-AE52-3B5BEE4FDF49}" dt="2024-02-12T23:23:15.440" v="110" actId="478"/>
          <ac:spMkLst>
            <pc:docMk/>
            <pc:sldMk cId="0" sldId="653"/>
            <ac:spMk id="6" creationId="{488F2A22-DD13-A344-63EE-3B707663E3DF}"/>
          </ac:spMkLst>
        </pc:spChg>
        <pc:spChg chg="del">
          <ac:chgData name="健 有村" userId="845497175cb2f617" providerId="LiveId" clId="{601CFE96-BE86-4FC6-AE52-3B5BEE4FDF49}" dt="2024-02-12T23:23:21.852" v="115" actId="478"/>
          <ac:spMkLst>
            <pc:docMk/>
            <pc:sldMk cId="0" sldId="653"/>
            <ac:spMk id="7" creationId="{12882598-980D-05EA-DB1C-AFDD0D315940}"/>
          </ac:spMkLst>
        </pc:spChg>
        <pc:spChg chg="del mod">
          <ac:chgData name="健 有村" userId="845497175cb2f617" providerId="LiveId" clId="{601CFE96-BE86-4FC6-AE52-3B5BEE4FDF49}" dt="2024-02-12T23:26:28.085" v="134" actId="478"/>
          <ac:spMkLst>
            <pc:docMk/>
            <pc:sldMk cId="0" sldId="653"/>
            <ac:spMk id="8" creationId="{AEFFCD33-9DF3-86F1-F554-F06A65A9033C}"/>
          </ac:spMkLst>
        </pc:spChg>
        <pc:spChg chg="add mod">
          <ac:chgData name="健 有村" userId="845497175cb2f617" providerId="LiveId" clId="{601CFE96-BE86-4FC6-AE52-3B5BEE4FDF49}" dt="2024-02-12T23:27:17.334" v="141" actId="1076"/>
          <ac:spMkLst>
            <pc:docMk/>
            <pc:sldMk cId="0" sldId="653"/>
            <ac:spMk id="11" creationId="{DF5065EB-1978-B3C5-F76F-5E77E28F3424}"/>
          </ac:spMkLst>
        </pc:spChg>
        <pc:spChg chg="add del mod">
          <ac:chgData name="健 有村" userId="845497175cb2f617" providerId="LiveId" clId="{601CFE96-BE86-4FC6-AE52-3B5BEE4FDF49}" dt="2024-02-12T23:26:18.212" v="133" actId="478"/>
          <ac:spMkLst>
            <pc:docMk/>
            <pc:sldMk cId="0" sldId="653"/>
            <ac:spMk id="12" creationId="{694F57E3-C7C2-67AF-B379-9EE646783D6D}"/>
          </ac:spMkLst>
        </pc:spChg>
        <pc:spChg chg="add del mod">
          <ac:chgData name="健 有村" userId="845497175cb2f617" providerId="LiveId" clId="{601CFE96-BE86-4FC6-AE52-3B5BEE4FDF49}" dt="2024-02-12T23:26:50.585" v="138" actId="478"/>
          <ac:spMkLst>
            <pc:docMk/>
            <pc:sldMk cId="0" sldId="653"/>
            <ac:spMk id="13" creationId="{EBF3D0F1-84A7-D36E-26D0-9F52514B7FB0}"/>
          </ac:spMkLst>
        </pc:spChg>
        <pc:spChg chg="del">
          <ac:chgData name="健 有村" userId="845497175cb2f617" providerId="LiveId" clId="{601CFE96-BE86-4FC6-AE52-3B5BEE4FDF49}" dt="2024-02-12T23:23:19.065" v="114" actId="478"/>
          <ac:spMkLst>
            <pc:docMk/>
            <pc:sldMk cId="0" sldId="653"/>
            <ac:spMk id="14" creationId="{1E6054F4-0257-BB5F-DFBE-94548D7E0C1C}"/>
          </ac:spMkLst>
        </pc:spChg>
        <pc:spChg chg="del">
          <ac:chgData name="健 有村" userId="845497175cb2f617" providerId="LiveId" clId="{601CFE96-BE86-4FC6-AE52-3B5BEE4FDF49}" dt="2024-02-12T23:23:19.065" v="114" actId="478"/>
          <ac:spMkLst>
            <pc:docMk/>
            <pc:sldMk cId="0" sldId="653"/>
            <ac:spMk id="16" creationId="{402E1CCC-A6B5-7961-1E47-833AC90AD236}"/>
          </ac:spMkLst>
        </pc:spChg>
        <pc:spChg chg="del">
          <ac:chgData name="健 有村" userId="845497175cb2f617" providerId="LiveId" clId="{601CFE96-BE86-4FC6-AE52-3B5BEE4FDF49}" dt="2024-02-12T23:23:19.065" v="114" actId="478"/>
          <ac:spMkLst>
            <pc:docMk/>
            <pc:sldMk cId="0" sldId="653"/>
            <ac:spMk id="17" creationId="{334E64A0-8BF8-9506-8CAC-B31B25AFC4CE}"/>
          </ac:spMkLst>
        </pc:spChg>
        <pc:spChg chg="del">
          <ac:chgData name="健 有村" userId="845497175cb2f617" providerId="LiveId" clId="{601CFE96-BE86-4FC6-AE52-3B5BEE4FDF49}" dt="2024-02-12T23:23:11.830" v="108" actId="478"/>
          <ac:spMkLst>
            <pc:docMk/>
            <pc:sldMk cId="0" sldId="653"/>
            <ac:spMk id="18" creationId="{8AC179A9-DF4E-486A-1B77-946830D2DCF3}"/>
          </ac:spMkLst>
        </pc:spChg>
        <pc:spChg chg="add mod">
          <ac:chgData name="健 有村" userId="845497175cb2f617" providerId="LiveId" clId="{601CFE96-BE86-4FC6-AE52-3B5BEE4FDF49}" dt="2024-02-12T23:25:24.116" v="122" actId="1076"/>
          <ac:spMkLst>
            <pc:docMk/>
            <pc:sldMk cId="0" sldId="653"/>
            <ac:spMk id="19" creationId="{3C399493-D608-CCA3-66D0-3AD8EA5AD85C}"/>
          </ac:spMkLst>
        </pc:spChg>
        <pc:spChg chg="add mod">
          <ac:chgData name="健 有村" userId="845497175cb2f617" providerId="LiveId" clId="{601CFE96-BE86-4FC6-AE52-3B5BEE4FDF49}" dt="2024-02-12T23:25:24.116" v="122" actId="1076"/>
          <ac:spMkLst>
            <pc:docMk/>
            <pc:sldMk cId="0" sldId="653"/>
            <ac:spMk id="20" creationId="{8AB64E9B-D264-6A0F-4E43-A9E1F71873B3}"/>
          </ac:spMkLst>
        </pc:spChg>
        <pc:spChg chg="add mod">
          <ac:chgData name="健 有村" userId="845497175cb2f617" providerId="LiveId" clId="{601CFE96-BE86-4FC6-AE52-3B5BEE4FDF49}" dt="2024-02-12T23:25:24.116" v="122" actId="1076"/>
          <ac:spMkLst>
            <pc:docMk/>
            <pc:sldMk cId="0" sldId="653"/>
            <ac:spMk id="21" creationId="{903D8738-C04F-FE57-849E-B398E955E4B9}"/>
          </ac:spMkLst>
        </pc:spChg>
        <pc:spChg chg="add mod">
          <ac:chgData name="健 有村" userId="845497175cb2f617" providerId="LiveId" clId="{601CFE96-BE86-4FC6-AE52-3B5BEE4FDF49}" dt="2024-02-12T23:25:47.279" v="126" actId="1076"/>
          <ac:spMkLst>
            <pc:docMk/>
            <pc:sldMk cId="0" sldId="653"/>
            <ac:spMk id="22" creationId="{4E9CEB30-D61A-A8E2-0FFE-74F3241AA30D}"/>
          </ac:spMkLst>
        </pc:spChg>
        <pc:spChg chg="add mod">
          <ac:chgData name="健 有村" userId="845497175cb2f617" providerId="LiveId" clId="{601CFE96-BE86-4FC6-AE52-3B5BEE4FDF49}" dt="2024-02-12T23:25:52.048" v="127" actId="1076"/>
          <ac:spMkLst>
            <pc:docMk/>
            <pc:sldMk cId="0" sldId="653"/>
            <ac:spMk id="23" creationId="{744CC600-8969-EE86-C253-D7C5471A8670}"/>
          </ac:spMkLst>
        </pc:spChg>
        <pc:spChg chg="add mod">
          <ac:chgData name="健 有村" userId="845497175cb2f617" providerId="LiveId" clId="{601CFE96-BE86-4FC6-AE52-3B5BEE4FDF49}" dt="2024-02-12T23:25:57.826" v="128" actId="1076"/>
          <ac:spMkLst>
            <pc:docMk/>
            <pc:sldMk cId="0" sldId="653"/>
            <ac:spMk id="24" creationId="{C4BBD316-9BC6-58D4-7594-86324DE94247}"/>
          </ac:spMkLst>
        </pc:spChg>
        <pc:spChg chg="add mod">
          <ac:chgData name="健 有村" userId="845497175cb2f617" providerId="LiveId" clId="{601CFE96-BE86-4FC6-AE52-3B5BEE4FDF49}" dt="2024-02-12T23:26:02.968" v="129" actId="1076"/>
          <ac:spMkLst>
            <pc:docMk/>
            <pc:sldMk cId="0" sldId="653"/>
            <ac:spMk id="25" creationId="{231F2EAF-13FA-CD34-3183-8C27295B1ED7}"/>
          </ac:spMkLst>
        </pc:spChg>
        <pc:spChg chg="add mod">
          <ac:chgData name="健 有村" userId="845497175cb2f617" providerId="LiveId" clId="{601CFE96-BE86-4FC6-AE52-3B5BEE4FDF49}" dt="2024-02-12T23:25:41.861" v="125" actId="1076"/>
          <ac:spMkLst>
            <pc:docMk/>
            <pc:sldMk cId="0" sldId="653"/>
            <ac:spMk id="26" creationId="{5F97B13A-447C-E6D6-7035-A69DA747C58A}"/>
          </ac:spMkLst>
        </pc:spChg>
        <pc:spChg chg="add mod">
          <ac:chgData name="健 有村" userId="845497175cb2f617" providerId="LiveId" clId="{601CFE96-BE86-4FC6-AE52-3B5BEE4FDF49}" dt="2024-02-12T23:26:12.378" v="132" actId="1076"/>
          <ac:spMkLst>
            <pc:docMk/>
            <pc:sldMk cId="0" sldId="653"/>
            <ac:spMk id="27" creationId="{78BF8D5F-B9E2-3FAB-26AC-7B6B00D51D81}"/>
          </ac:spMkLst>
        </pc:spChg>
        <pc:spChg chg="add mod">
          <ac:chgData name="健 有村" userId="845497175cb2f617" providerId="LiveId" clId="{601CFE96-BE86-4FC6-AE52-3B5BEE4FDF49}" dt="2024-02-12T23:25:24.116" v="122" actId="1076"/>
          <ac:spMkLst>
            <pc:docMk/>
            <pc:sldMk cId="0" sldId="653"/>
            <ac:spMk id="28" creationId="{FD5AC384-7249-DBFC-5B47-AF21D4F4CD57}"/>
          </ac:spMkLst>
        </pc:spChg>
        <pc:spChg chg="add mod">
          <ac:chgData name="健 有村" userId="845497175cb2f617" providerId="LiveId" clId="{601CFE96-BE86-4FC6-AE52-3B5BEE4FDF49}" dt="2024-02-12T23:25:24.116" v="122" actId="1076"/>
          <ac:spMkLst>
            <pc:docMk/>
            <pc:sldMk cId="0" sldId="653"/>
            <ac:spMk id="29" creationId="{4FEFC079-F923-2CA2-16DC-37C9FCCC4304}"/>
          </ac:spMkLst>
        </pc:spChg>
        <pc:spChg chg="add mod">
          <ac:chgData name="健 有村" userId="845497175cb2f617" providerId="LiveId" clId="{601CFE96-BE86-4FC6-AE52-3B5BEE4FDF49}" dt="2024-02-12T23:26:39.690" v="137" actId="1076"/>
          <ac:spMkLst>
            <pc:docMk/>
            <pc:sldMk cId="0" sldId="653"/>
            <ac:spMk id="30" creationId="{3121B95D-59F1-66CC-07DC-4FBA93B64234}"/>
          </ac:spMkLst>
        </pc:spChg>
        <pc:spChg chg="add mod">
          <ac:chgData name="健 有村" userId="845497175cb2f617" providerId="LiveId" clId="{601CFE96-BE86-4FC6-AE52-3B5BEE4FDF49}" dt="2024-02-12T23:27:03.165" v="140" actId="1076"/>
          <ac:spMkLst>
            <pc:docMk/>
            <pc:sldMk cId="0" sldId="653"/>
            <ac:spMk id="31" creationId="{24AE7B42-C560-2BDD-A8A0-353C40E27836}"/>
          </ac:spMkLst>
        </pc:spChg>
        <pc:spChg chg="del">
          <ac:chgData name="健 有村" userId="845497175cb2f617" providerId="LiveId" clId="{601CFE96-BE86-4FC6-AE52-3B5BEE4FDF49}" dt="2024-02-12T23:23:11.830" v="108" actId="478"/>
          <ac:spMkLst>
            <pc:docMk/>
            <pc:sldMk cId="0" sldId="653"/>
            <ac:spMk id="58377" creationId="{787B4159-9A24-9C6B-54D8-51EB2BC0FB00}"/>
          </ac:spMkLst>
        </pc:spChg>
        <pc:spChg chg="del">
          <ac:chgData name="健 有村" userId="845497175cb2f617" providerId="LiveId" clId="{601CFE96-BE86-4FC6-AE52-3B5BEE4FDF49}" dt="2024-02-12T23:23:11.830" v="108" actId="478"/>
          <ac:spMkLst>
            <pc:docMk/>
            <pc:sldMk cId="0" sldId="653"/>
            <ac:spMk id="58378" creationId="{7BFBE196-094E-FA9A-EAFE-6B9568A48BD9}"/>
          </ac:spMkLst>
        </pc:spChg>
        <pc:spChg chg="del">
          <ac:chgData name="健 有村" userId="845497175cb2f617" providerId="LiveId" clId="{601CFE96-BE86-4FC6-AE52-3B5BEE4FDF49}" dt="2024-02-12T23:23:11.830" v="108" actId="478"/>
          <ac:spMkLst>
            <pc:docMk/>
            <pc:sldMk cId="0" sldId="653"/>
            <ac:spMk id="58381" creationId="{FDC6263E-BBAE-13C6-2246-6F38A9EDE864}"/>
          </ac:spMkLst>
        </pc:spChg>
        <pc:spChg chg="del">
          <ac:chgData name="健 有村" userId="845497175cb2f617" providerId="LiveId" clId="{601CFE96-BE86-4FC6-AE52-3B5BEE4FDF49}" dt="2024-02-12T23:23:14.432" v="109" actId="478"/>
          <ac:spMkLst>
            <pc:docMk/>
            <pc:sldMk cId="0" sldId="653"/>
            <ac:spMk id="58382" creationId="{DFE4862D-0C7B-0723-287B-010C551BF579}"/>
          </ac:spMkLst>
        </pc:spChg>
        <pc:picChg chg="del">
          <ac:chgData name="健 有村" userId="845497175cb2f617" providerId="LiveId" clId="{601CFE96-BE86-4FC6-AE52-3B5BEE4FDF49}" dt="2024-02-12T23:23:11.830" v="108" actId="478"/>
          <ac:picMkLst>
            <pc:docMk/>
            <pc:sldMk cId="0" sldId="653"/>
            <ac:picMk id="2" creationId="{6B2DF8D8-59E4-4677-2BDA-DA81934F7490}"/>
          </ac:picMkLst>
        </pc:picChg>
        <pc:picChg chg="del">
          <ac:chgData name="健 有村" userId="845497175cb2f617" providerId="LiveId" clId="{601CFE96-BE86-4FC6-AE52-3B5BEE4FDF49}" dt="2024-02-12T23:23:11.830" v="108" actId="478"/>
          <ac:picMkLst>
            <pc:docMk/>
            <pc:sldMk cId="0" sldId="653"/>
            <ac:picMk id="3" creationId="{1D33BA9F-25E9-DC8C-D408-B32276364C24}"/>
          </ac:picMkLst>
        </pc:picChg>
        <pc:picChg chg="del">
          <ac:chgData name="健 有村" userId="845497175cb2f617" providerId="LiveId" clId="{601CFE96-BE86-4FC6-AE52-3B5BEE4FDF49}" dt="2024-02-12T23:23:16.510" v="111" actId="478"/>
          <ac:picMkLst>
            <pc:docMk/>
            <pc:sldMk cId="0" sldId="653"/>
            <ac:picMk id="4" creationId="{C0F8890E-D55A-FD5A-4F31-563461171715}"/>
          </ac:picMkLst>
        </pc:picChg>
        <pc:picChg chg="mod">
          <ac:chgData name="健 有村" userId="845497175cb2f617" providerId="LiveId" clId="{601CFE96-BE86-4FC6-AE52-3B5BEE4FDF49}" dt="2024-02-12T23:26:32.563" v="136" actId="1076"/>
          <ac:picMkLst>
            <pc:docMk/>
            <pc:sldMk cId="0" sldId="653"/>
            <ac:picMk id="5" creationId="{7DEA53E0-EFC9-EC63-D3EE-ACD43EDA7E9D}"/>
          </ac:picMkLst>
        </pc:picChg>
        <pc:picChg chg="del">
          <ac:chgData name="健 有村" userId="845497175cb2f617" providerId="LiveId" clId="{601CFE96-BE86-4FC6-AE52-3B5BEE4FDF49}" dt="2024-02-12T23:23:16.940" v="112" actId="478"/>
          <ac:picMkLst>
            <pc:docMk/>
            <pc:sldMk cId="0" sldId="653"/>
            <ac:picMk id="9" creationId="{1ADAC768-0E7D-2B47-7402-D670FC8A5BEE}"/>
          </ac:picMkLst>
        </pc:picChg>
        <pc:picChg chg="del">
          <ac:chgData name="健 有村" userId="845497175cb2f617" providerId="LiveId" clId="{601CFE96-BE86-4FC6-AE52-3B5BEE4FDF49}" dt="2024-02-12T23:23:17.490" v="113" actId="478"/>
          <ac:picMkLst>
            <pc:docMk/>
            <pc:sldMk cId="0" sldId="653"/>
            <ac:picMk id="15" creationId="{A463C926-21C0-0334-9C06-118ED04BB2D2}"/>
          </ac:picMkLst>
        </pc:picChg>
      </pc:sldChg>
      <pc:sldChg chg="addSp delSp modSp mod">
        <pc:chgData name="健 有村" userId="845497175cb2f617" providerId="LiveId" clId="{601CFE96-BE86-4FC6-AE52-3B5BEE4FDF49}" dt="2024-02-12T23:43:28.665" v="222" actId="1076"/>
        <pc:sldMkLst>
          <pc:docMk/>
          <pc:sldMk cId="0" sldId="654"/>
        </pc:sldMkLst>
        <pc:spChg chg="del">
          <ac:chgData name="健 有村" userId="845497175cb2f617" providerId="LiveId" clId="{601CFE96-BE86-4FC6-AE52-3B5BEE4FDF49}" dt="2024-02-12T23:27:22.642" v="142" actId="478"/>
          <ac:spMkLst>
            <pc:docMk/>
            <pc:sldMk cId="0" sldId="654"/>
            <ac:spMk id="6" creationId="{488F2A22-DD13-A344-63EE-3B707663E3DF}"/>
          </ac:spMkLst>
        </pc:spChg>
        <pc:spChg chg="del">
          <ac:chgData name="健 有村" userId="845497175cb2f617" providerId="LiveId" clId="{601CFE96-BE86-4FC6-AE52-3B5BEE4FDF49}" dt="2024-02-12T23:27:24.611" v="143" actId="478"/>
          <ac:spMkLst>
            <pc:docMk/>
            <pc:sldMk cId="0" sldId="654"/>
            <ac:spMk id="7" creationId="{12882598-980D-05EA-DB1C-AFDD0D315940}"/>
          </ac:spMkLst>
        </pc:spChg>
        <pc:spChg chg="del">
          <ac:chgData name="健 有村" userId="845497175cb2f617" providerId="LiveId" clId="{601CFE96-BE86-4FC6-AE52-3B5BEE4FDF49}" dt="2024-02-12T23:27:22.642" v="142" actId="478"/>
          <ac:spMkLst>
            <pc:docMk/>
            <pc:sldMk cId="0" sldId="654"/>
            <ac:spMk id="8" creationId="{AEFFCD33-9DF3-86F1-F554-F06A65A9033C}"/>
          </ac:spMkLst>
        </pc:spChg>
        <pc:spChg chg="mod">
          <ac:chgData name="健 有村" userId="845497175cb2f617" providerId="LiveId" clId="{601CFE96-BE86-4FC6-AE52-3B5BEE4FDF49}" dt="2024-02-12T23:28:00.589" v="154" actId="1076"/>
          <ac:spMkLst>
            <pc:docMk/>
            <pc:sldMk cId="0" sldId="654"/>
            <ac:spMk id="10" creationId="{8BF3C505-B0AB-4BD5-CC25-84B4936150E0}"/>
          </ac:spMkLst>
        </pc:spChg>
        <pc:spChg chg="add del mod">
          <ac:chgData name="健 有村" userId="845497175cb2f617" providerId="LiveId" clId="{601CFE96-BE86-4FC6-AE52-3B5BEE4FDF49}" dt="2024-02-12T23:38:58.340" v="187" actId="478"/>
          <ac:spMkLst>
            <pc:docMk/>
            <pc:sldMk cId="0" sldId="654"/>
            <ac:spMk id="11" creationId="{1C6A33AA-EB86-A4FB-4E3C-20DC58C2F1C6}"/>
          </ac:spMkLst>
        </pc:spChg>
        <pc:spChg chg="add del mod">
          <ac:chgData name="健 有村" userId="845497175cb2f617" providerId="LiveId" clId="{601CFE96-BE86-4FC6-AE52-3B5BEE4FDF49}" dt="2024-02-12T23:38:58.340" v="187" actId="478"/>
          <ac:spMkLst>
            <pc:docMk/>
            <pc:sldMk cId="0" sldId="654"/>
            <ac:spMk id="12" creationId="{8FA26523-90F7-74F1-74AB-11FB7EC1840C}"/>
          </ac:spMkLst>
        </pc:spChg>
        <pc:spChg chg="add del mod">
          <ac:chgData name="健 有村" userId="845497175cb2f617" providerId="LiveId" clId="{601CFE96-BE86-4FC6-AE52-3B5BEE4FDF49}" dt="2024-02-12T23:38:58.340" v="187" actId="478"/>
          <ac:spMkLst>
            <pc:docMk/>
            <pc:sldMk cId="0" sldId="654"/>
            <ac:spMk id="13" creationId="{A438B978-BB59-8A68-02C0-BB50AF5E29B5}"/>
          </ac:spMkLst>
        </pc:spChg>
        <pc:spChg chg="mod">
          <ac:chgData name="健 有村" userId="845497175cb2f617" providerId="LiveId" clId="{601CFE96-BE86-4FC6-AE52-3B5BEE4FDF49}" dt="2024-02-12T23:43:28.665" v="222" actId="1076"/>
          <ac:spMkLst>
            <pc:docMk/>
            <pc:sldMk cId="0" sldId="654"/>
            <ac:spMk id="14" creationId="{1E6054F4-0257-BB5F-DFBE-94548D7E0C1C}"/>
          </ac:spMkLst>
        </pc:spChg>
        <pc:spChg chg="del mod">
          <ac:chgData name="健 有村" userId="845497175cb2f617" providerId="LiveId" clId="{601CFE96-BE86-4FC6-AE52-3B5BEE4FDF49}" dt="2024-02-12T23:27:33.341" v="148" actId="478"/>
          <ac:spMkLst>
            <pc:docMk/>
            <pc:sldMk cId="0" sldId="654"/>
            <ac:spMk id="16" creationId="{402E1CCC-A6B5-7961-1E47-833AC90AD236}"/>
          </ac:spMkLst>
        </pc:spChg>
        <pc:spChg chg="del">
          <ac:chgData name="健 有村" userId="845497175cb2f617" providerId="LiveId" clId="{601CFE96-BE86-4FC6-AE52-3B5BEE4FDF49}" dt="2024-02-12T23:27:31.829" v="146" actId="478"/>
          <ac:spMkLst>
            <pc:docMk/>
            <pc:sldMk cId="0" sldId="654"/>
            <ac:spMk id="17" creationId="{334E64A0-8BF8-9506-8CAC-B31B25AFC4CE}"/>
          </ac:spMkLst>
        </pc:spChg>
        <pc:spChg chg="del">
          <ac:chgData name="健 有村" userId="845497175cb2f617" providerId="LiveId" clId="{601CFE96-BE86-4FC6-AE52-3B5BEE4FDF49}" dt="2024-02-12T23:27:22.642" v="142" actId="478"/>
          <ac:spMkLst>
            <pc:docMk/>
            <pc:sldMk cId="0" sldId="654"/>
            <ac:spMk id="18" creationId="{8AC179A9-DF4E-486A-1B77-946830D2DCF3}"/>
          </ac:spMkLst>
        </pc:spChg>
        <pc:spChg chg="add del mod">
          <ac:chgData name="健 有村" userId="845497175cb2f617" providerId="LiveId" clId="{601CFE96-BE86-4FC6-AE52-3B5BEE4FDF49}" dt="2024-02-12T23:38:58.340" v="187" actId="478"/>
          <ac:spMkLst>
            <pc:docMk/>
            <pc:sldMk cId="0" sldId="654"/>
            <ac:spMk id="19" creationId="{CE4BD8BA-E306-2C74-35AF-82999783A55A}"/>
          </ac:spMkLst>
        </pc:spChg>
        <pc:spChg chg="add del mod">
          <ac:chgData name="健 有村" userId="845497175cb2f617" providerId="LiveId" clId="{601CFE96-BE86-4FC6-AE52-3B5BEE4FDF49}" dt="2024-02-12T23:38:58.340" v="187" actId="478"/>
          <ac:spMkLst>
            <pc:docMk/>
            <pc:sldMk cId="0" sldId="654"/>
            <ac:spMk id="20" creationId="{B3B6D737-E5DD-D273-6534-5EF7B384DD82}"/>
          </ac:spMkLst>
        </pc:spChg>
        <pc:spChg chg="add del mod">
          <ac:chgData name="健 有村" userId="845497175cb2f617" providerId="LiveId" clId="{601CFE96-BE86-4FC6-AE52-3B5BEE4FDF49}" dt="2024-02-12T23:38:58.340" v="187" actId="478"/>
          <ac:spMkLst>
            <pc:docMk/>
            <pc:sldMk cId="0" sldId="654"/>
            <ac:spMk id="21" creationId="{E6C43078-7109-782E-CA66-9039A656989A}"/>
          </ac:spMkLst>
        </pc:spChg>
        <pc:spChg chg="add del mod">
          <ac:chgData name="健 有村" userId="845497175cb2f617" providerId="LiveId" clId="{601CFE96-BE86-4FC6-AE52-3B5BEE4FDF49}" dt="2024-02-12T23:38:58.340" v="187" actId="478"/>
          <ac:spMkLst>
            <pc:docMk/>
            <pc:sldMk cId="0" sldId="654"/>
            <ac:spMk id="22" creationId="{E06F21F6-BF21-2297-D26F-1B87ABA3044B}"/>
          </ac:spMkLst>
        </pc:spChg>
        <pc:spChg chg="add del mod">
          <ac:chgData name="健 有村" userId="845497175cb2f617" providerId="LiveId" clId="{601CFE96-BE86-4FC6-AE52-3B5BEE4FDF49}" dt="2024-02-12T23:38:58.340" v="187" actId="478"/>
          <ac:spMkLst>
            <pc:docMk/>
            <pc:sldMk cId="0" sldId="654"/>
            <ac:spMk id="23" creationId="{33EBBF48-EC16-ACBC-E2A9-99A635618A70}"/>
          </ac:spMkLst>
        </pc:spChg>
        <pc:spChg chg="add del mod">
          <ac:chgData name="健 有村" userId="845497175cb2f617" providerId="LiveId" clId="{601CFE96-BE86-4FC6-AE52-3B5BEE4FDF49}" dt="2024-02-12T23:38:58.340" v="187" actId="478"/>
          <ac:spMkLst>
            <pc:docMk/>
            <pc:sldMk cId="0" sldId="654"/>
            <ac:spMk id="24" creationId="{C2B3092E-D87A-C643-714E-38E7E825E352}"/>
          </ac:spMkLst>
        </pc:spChg>
        <pc:spChg chg="add del mod">
          <ac:chgData name="健 有村" userId="845497175cb2f617" providerId="LiveId" clId="{601CFE96-BE86-4FC6-AE52-3B5BEE4FDF49}" dt="2024-02-12T23:38:58.340" v="187" actId="478"/>
          <ac:spMkLst>
            <pc:docMk/>
            <pc:sldMk cId="0" sldId="654"/>
            <ac:spMk id="25" creationId="{5C59B169-E9D2-FD7D-6243-7EAC5714DA6A}"/>
          </ac:spMkLst>
        </pc:spChg>
        <pc:spChg chg="add del mod">
          <ac:chgData name="健 有村" userId="845497175cb2f617" providerId="LiveId" clId="{601CFE96-BE86-4FC6-AE52-3B5BEE4FDF49}" dt="2024-02-12T23:38:58.340" v="187" actId="478"/>
          <ac:spMkLst>
            <pc:docMk/>
            <pc:sldMk cId="0" sldId="654"/>
            <ac:spMk id="26" creationId="{4B623162-C9FE-4DD4-5325-C7CE95C30E80}"/>
          </ac:spMkLst>
        </pc:spChg>
        <pc:spChg chg="add del mod">
          <ac:chgData name="健 有村" userId="845497175cb2f617" providerId="LiveId" clId="{601CFE96-BE86-4FC6-AE52-3B5BEE4FDF49}" dt="2024-02-12T23:38:58.340" v="187" actId="478"/>
          <ac:spMkLst>
            <pc:docMk/>
            <pc:sldMk cId="0" sldId="654"/>
            <ac:spMk id="27" creationId="{0A0724AE-8CE4-6A87-2081-27B5BE320A2B}"/>
          </ac:spMkLst>
        </pc:spChg>
        <pc:spChg chg="add del mod">
          <ac:chgData name="健 有村" userId="845497175cb2f617" providerId="LiveId" clId="{601CFE96-BE86-4FC6-AE52-3B5BEE4FDF49}" dt="2024-02-12T23:35:59.285" v="171" actId="478"/>
          <ac:spMkLst>
            <pc:docMk/>
            <pc:sldMk cId="0" sldId="654"/>
            <ac:spMk id="28" creationId="{FD274B14-5F1F-2305-4B45-02FA39B6E196}"/>
          </ac:spMkLst>
        </pc:spChg>
        <pc:spChg chg="add mod">
          <ac:chgData name="健 有村" userId="845497175cb2f617" providerId="LiveId" clId="{601CFE96-BE86-4FC6-AE52-3B5BEE4FDF49}" dt="2024-02-12T23:39:20.207" v="189" actId="1076"/>
          <ac:spMkLst>
            <pc:docMk/>
            <pc:sldMk cId="0" sldId="654"/>
            <ac:spMk id="29" creationId="{EBB524C8-B651-045F-D8AA-872C0FF77629}"/>
          </ac:spMkLst>
        </pc:spChg>
        <pc:spChg chg="add mod">
          <ac:chgData name="健 有村" userId="845497175cb2f617" providerId="LiveId" clId="{601CFE96-BE86-4FC6-AE52-3B5BEE4FDF49}" dt="2024-02-12T23:39:20.207" v="189" actId="1076"/>
          <ac:spMkLst>
            <pc:docMk/>
            <pc:sldMk cId="0" sldId="654"/>
            <ac:spMk id="30" creationId="{6C1479B7-A39F-8610-F0E4-9A9C5360AC85}"/>
          </ac:spMkLst>
        </pc:spChg>
        <pc:spChg chg="add mod">
          <ac:chgData name="健 有村" userId="845497175cb2f617" providerId="LiveId" clId="{601CFE96-BE86-4FC6-AE52-3B5BEE4FDF49}" dt="2024-02-12T23:39:20.207" v="189" actId="1076"/>
          <ac:spMkLst>
            <pc:docMk/>
            <pc:sldMk cId="0" sldId="654"/>
            <ac:spMk id="31" creationId="{AC056766-72B8-05D2-4BA0-8AC9C0C7DFE9}"/>
          </ac:spMkLst>
        </pc:spChg>
        <pc:spChg chg="add mod">
          <ac:chgData name="健 有村" userId="845497175cb2f617" providerId="LiveId" clId="{601CFE96-BE86-4FC6-AE52-3B5BEE4FDF49}" dt="2024-02-12T23:41:33.718" v="216" actId="1076"/>
          <ac:spMkLst>
            <pc:docMk/>
            <pc:sldMk cId="0" sldId="654"/>
            <ac:spMk id="32" creationId="{EF9BF1B6-6F6A-216F-04F8-8E88D5985CCB}"/>
          </ac:spMkLst>
        </pc:spChg>
        <pc:spChg chg="add mod">
          <ac:chgData name="健 有村" userId="845497175cb2f617" providerId="LiveId" clId="{601CFE96-BE86-4FC6-AE52-3B5BEE4FDF49}" dt="2024-02-12T23:41:27.181" v="215" actId="1076"/>
          <ac:spMkLst>
            <pc:docMk/>
            <pc:sldMk cId="0" sldId="654"/>
            <ac:spMk id="33" creationId="{A60F4196-9298-6ADF-160A-79C562A25374}"/>
          </ac:spMkLst>
        </pc:spChg>
        <pc:spChg chg="add mod">
          <ac:chgData name="健 有村" userId="845497175cb2f617" providerId="LiveId" clId="{601CFE96-BE86-4FC6-AE52-3B5BEE4FDF49}" dt="2024-02-12T23:39:20.207" v="189" actId="1076"/>
          <ac:spMkLst>
            <pc:docMk/>
            <pc:sldMk cId="0" sldId="654"/>
            <ac:spMk id="34" creationId="{A28BC106-5B39-F478-BA3D-E37D199D01BE}"/>
          </ac:spMkLst>
        </pc:spChg>
        <pc:spChg chg="add mod">
          <ac:chgData name="健 有村" userId="845497175cb2f617" providerId="LiveId" clId="{601CFE96-BE86-4FC6-AE52-3B5BEE4FDF49}" dt="2024-02-12T23:39:20.207" v="189" actId="1076"/>
          <ac:spMkLst>
            <pc:docMk/>
            <pc:sldMk cId="0" sldId="654"/>
            <ac:spMk id="35" creationId="{9C9A0725-0089-7257-3A69-266BDBF79CDE}"/>
          </ac:spMkLst>
        </pc:spChg>
        <pc:spChg chg="add mod">
          <ac:chgData name="健 有村" userId="845497175cb2f617" providerId="LiveId" clId="{601CFE96-BE86-4FC6-AE52-3B5BEE4FDF49}" dt="2024-02-12T23:39:20.207" v="189" actId="1076"/>
          <ac:spMkLst>
            <pc:docMk/>
            <pc:sldMk cId="0" sldId="654"/>
            <ac:spMk id="36" creationId="{539D840E-A7B7-FFDB-8490-846090766F7C}"/>
          </ac:spMkLst>
        </pc:spChg>
        <pc:spChg chg="add mod">
          <ac:chgData name="健 有村" userId="845497175cb2f617" providerId="LiveId" clId="{601CFE96-BE86-4FC6-AE52-3B5BEE4FDF49}" dt="2024-02-12T23:39:53.055" v="193" actId="1076"/>
          <ac:spMkLst>
            <pc:docMk/>
            <pc:sldMk cId="0" sldId="654"/>
            <ac:spMk id="37" creationId="{ADE52049-6EDC-7B11-1135-1F78DF8F7E51}"/>
          </ac:spMkLst>
        </pc:spChg>
        <pc:spChg chg="add mod">
          <ac:chgData name="健 有村" userId="845497175cb2f617" providerId="LiveId" clId="{601CFE96-BE86-4FC6-AE52-3B5BEE4FDF49}" dt="2024-02-12T23:39:33.172" v="191" actId="1076"/>
          <ac:spMkLst>
            <pc:docMk/>
            <pc:sldMk cId="0" sldId="654"/>
            <ac:spMk id="38" creationId="{68F679D1-50B9-FB3C-27A5-8A31FBB12767}"/>
          </ac:spMkLst>
        </pc:spChg>
        <pc:spChg chg="add mod">
          <ac:chgData name="健 有村" userId="845497175cb2f617" providerId="LiveId" clId="{601CFE96-BE86-4FC6-AE52-3B5BEE4FDF49}" dt="2024-02-12T23:39:29.477" v="190" actId="1076"/>
          <ac:spMkLst>
            <pc:docMk/>
            <pc:sldMk cId="0" sldId="654"/>
            <ac:spMk id="39" creationId="{55B32A40-7B36-6056-A628-552FA2D3A6AD}"/>
          </ac:spMkLst>
        </pc:spChg>
        <pc:spChg chg="add mod">
          <ac:chgData name="健 有村" userId="845497175cb2f617" providerId="LiveId" clId="{601CFE96-BE86-4FC6-AE52-3B5BEE4FDF49}" dt="2024-02-12T23:40:27.963" v="214" actId="1076"/>
          <ac:spMkLst>
            <pc:docMk/>
            <pc:sldMk cId="0" sldId="654"/>
            <ac:spMk id="40" creationId="{52085C58-CB61-2923-DFF1-C05BC0C03A06}"/>
          </ac:spMkLst>
        </pc:spChg>
        <pc:spChg chg="del">
          <ac:chgData name="健 有村" userId="845497175cb2f617" providerId="LiveId" clId="{601CFE96-BE86-4FC6-AE52-3B5BEE4FDF49}" dt="2024-02-12T23:27:22.642" v="142" actId="478"/>
          <ac:spMkLst>
            <pc:docMk/>
            <pc:sldMk cId="0" sldId="654"/>
            <ac:spMk id="58377" creationId="{787B4159-9A24-9C6B-54D8-51EB2BC0FB00}"/>
          </ac:spMkLst>
        </pc:spChg>
        <pc:spChg chg="del">
          <ac:chgData name="健 有村" userId="845497175cb2f617" providerId="LiveId" clId="{601CFE96-BE86-4FC6-AE52-3B5BEE4FDF49}" dt="2024-02-12T23:27:22.642" v="142" actId="478"/>
          <ac:spMkLst>
            <pc:docMk/>
            <pc:sldMk cId="0" sldId="654"/>
            <ac:spMk id="58378" creationId="{7BFBE196-094E-FA9A-EAFE-6B9568A48BD9}"/>
          </ac:spMkLst>
        </pc:spChg>
        <pc:spChg chg="del">
          <ac:chgData name="健 有村" userId="845497175cb2f617" providerId="LiveId" clId="{601CFE96-BE86-4FC6-AE52-3B5BEE4FDF49}" dt="2024-02-12T23:27:22.642" v="142" actId="478"/>
          <ac:spMkLst>
            <pc:docMk/>
            <pc:sldMk cId="0" sldId="654"/>
            <ac:spMk id="58381" creationId="{FDC6263E-BBAE-13C6-2246-6F38A9EDE864}"/>
          </ac:spMkLst>
        </pc:spChg>
        <pc:spChg chg="del">
          <ac:chgData name="健 有村" userId="845497175cb2f617" providerId="LiveId" clId="{601CFE96-BE86-4FC6-AE52-3B5BEE4FDF49}" dt="2024-02-12T23:27:22.642" v="142" actId="478"/>
          <ac:spMkLst>
            <pc:docMk/>
            <pc:sldMk cId="0" sldId="654"/>
            <ac:spMk id="58382" creationId="{DFE4862D-0C7B-0723-287B-010C551BF579}"/>
          </ac:spMkLst>
        </pc:spChg>
        <pc:picChg chg="del">
          <ac:chgData name="健 有村" userId="845497175cb2f617" providerId="LiveId" clId="{601CFE96-BE86-4FC6-AE52-3B5BEE4FDF49}" dt="2024-02-12T23:27:22.642" v="142" actId="478"/>
          <ac:picMkLst>
            <pc:docMk/>
            <pc:sldMk cId="0" sldId="654"/>
            <ac:picMk id="2" creationId="{6B2DF8D8-59E4-4677-2BDA-DA81934F7490}"/>
          </ac:picMkLst>
        </pc:picChg>
        <pc:picChg chg="del">
          <ac:chgData name="健 有村" userId="845497175cb2f617" providerId="LiveId" clId="{601CFE96-BE86-4FC6-AE52-3B5BEE4FDF49}" dt="2024-02-12T23:27:22.642" v="142" actId="478"/>
          <ac:picMkLst>
            <pc:docMk/>
            <pc:sldMk cId="0" sldId="654"/>
            <ac:picMk id="3" creationId="{1D33BA9F-25E9-DC8C-D408-B32276364C24}"/>
          </ac:picMkLst>
        </pc:picChg>
        <pc:picChg chg="del">
          <ac:chgData name="健 有村" userId="845497175cb2f617" providerId="LiveId" clId="{601CFE96-BE86-4FC6-AE52-3B5BEE4FDF49}" dt="2024-02-12T23:27:22.642" v="142" actId="478"/>
          <ac:picMkLst>
            <pc:docMk/>
            <pc:sldMk cId="0" sldId="654"/>
            <ac:picMk id="4" creationId="{C0F8890E-D55A-FD5A-4F31-563461171715}"/>
          </ac:picMkLst>
        </pc:picChg>
        <pc:picChg chg="del">
          <ac:chgData name="健 有村" userId="845497175cb2f617" providerId="LiveId" clId="{601CFE96-BE86-4FC6-AE52-3B5BEE4FDF49}" dt="2024-02-12T23:27:22.642" v="142" actId="478"/>
          <ac:picMkLst>
            <pc:docMk/>
            <pc:sldMk cId="0" sldId="654"/>
            <ac:picMk id="5" creationId="{7DEA53E0-EFC9-EC63-D3EE-ACD43EDA7E9D}"/>
          </ac:picMkLst>
        </pc:picChg>
        <pc:picChg chg="mod">
          <ac:chgData name="健 有村" userId="845497175cb2f617" providerId="LiveId" clId="{601CFE96-BE86-4FC6-AE52-3B5BEE4FDF49}" dt="2024-02-12T23:39:34.101" v="192" actId="1076"/>
          <ac:picMkLst>
            <pc:docMk/>
            <pc:sldMk cId="0" sldId="654"/>
            <ac:picMk id="9" creationId="{1ADAC768-0E7D-2B47-7402-D670FC8A5BEE}"/>
          </ac:picMkLst>
        </pc:picChg>
        <pc:picChg chg="del">
          <ac:chgData name="健 有村" userId="845497175cb2f617" providerId="LiveId" clId="{601CFE96-BE86-4FC6-AE52-3B5BEE4FDF49}" dt="2024-02-12T23:27:26.149" v="144" actId="478"/>
          <ac:picMkLst>
            <pc:docMk/>
            <pc:sldMk cId="0" sldId="654"/>
            <ac:picMk id="15" creationId="{A463C926-21C0-0334-9C06-118ED04BB2D2}"/>
          </ac:picMkLst>
        </pc:picChg>
      </pc:sldChg>
      <pc:sldChg chg="addSp delSp modSp mod">
        <pc:chgData name="健 有村" userId="845497175cb2f617" providerId="LiveId" clId="{601CFE96-BE86-4FC6-AE52-3B5BEE4FDF49}" dt="2024-02-12T23:43:21.596" v="221" actId="1076"/>
        <pc:sldMkLst>
          <pc:docMk/>
          <pc:sldMk cId="0" sldId="655"/>
        </pc:sldMkLst>
        <pc:spChg chg="del">
          <ac:chgData name="健 有村" userId="845497175cb2f617" providerId="LiveId" clId="{601CFE96-BE86-4FC6-AE52-3B5BEE4FDF49}" dt="2024-02-12T23:35:13.770" v="159" actId="478"/>
          <ac:spMkLst>
            <pc:docMk/>
            <pc:sldMk cId="0" sldId="655"/>
            <ac:spMk id="6" creationId="{488F2A22-DD13-A344-63EE-3B707663E3DF}"/>
          </ac:spMkLst>
        </pc:spChg>
        <pc:spChg chg="del">
          <ac:chgData name="健 有村" userId="845497175cb2f617" providerId="LiveId" clId="{601CFE96-BE86-4FC6-AE52-3B5BEE4FDF49}" dt="2024-02-12T23:35:16.137" v="160" actId="478"/>
          <ac:spMkLst>
            <pc:docMk/>
            <pc:sldMk cId="0" sldId="655"/>
            <ac:spMk id="7" creationId="{12882598-980D-05EA-DB1C-AFDD0D315940}"/>
          </ac:spMkLst>
        </pc:spChg>
        <pc:spChg chg="del">
          <ac:chgData name="健 有村" userId="845497175cb2f617" providerId="LiveId" clId="{601CFE96-BE86-4FC6-AE52-3B5BEE4FDF49}" dt="2024-02-12T23:35:13.770" v="159" actId="478"/>
          <ac:spMkLst>
            <pc:docMk/>
            <pc:sldMk cId="0" sldId="655"/>
            <ac:spMk id="8" creationId="{AEFFCD33-9DF3-86F1-F554-F06A65A9033C}"/>
          </ac:spMkLst>
        </pc:spChg>
        <pc:spChg chg="mod">
          <ac:chgData name="健 有村" userId="845497175cb2f617" providerId="LiveId" clId="{601CFE96-BE86-4FC6-AE52-3B5BEE4FDF49}" dt="2024-02-12T23:35:42.333" v="169" actId="1076"/>
          <ac:spMkLst>
            <pc:docMk/>
            <pc:sldMk cId="0" sldId="655"/>
            <ac:spMk id="10" creationId="{8BF3C505-B0AB-4BD5-CC25-84B4936150E0}"/>
          </ac:spMkLst>
        </pc:spChg>
        <pc:spChg chg="add mod">
          <ac:chgData name="健 有村" userId="845497175cb2f617" providerId="LiveId" clId="{601CFE96-BE86-4FC6-AE52-3B5BEE4FDF49}" dt="2024-02-12T23:36:14.152" v="172"/>
          <ac:spMkLst>
            <pc:docMk/>
            <pc:sldMk cId="0" sldId="655"/>
            <ac:spMk id="11" creationId="{B82445BC-53DD-0FA2-08A3-B4E8FDAF729B}"/>
          </ac:spMkLst>
        </pc:spChg>
        <pc:spChg chg="add mod">
          <ac:chgData name="健 有村" userId="845497175cb2f617" providerId="LiveId" clId="{601CFE96-BE86-4FC6-AE52-3B5BEE4FDF49}" dt="2024-02-12T23:36:14.152" v="172"/>
          <ac:spMkLst>
            <pc:docMk/>
            <pc:sldMk cId="0" sldId="655"/>
            <ac:spMk id="12" creationId="{7B0DEE38-AEBF-2B9B-E167-7CA38CC9F866}"/>
          </ac:spMkLst>
        </pc:spChg>
        <pc:spChg chg="add mod">
          <ac:chgData name="健 有村" userId="845497175cb2f617" providerId="LiveId" clId="{601CFE96-BE86-4FC6-AE52-3B5BEE4FDF49}" dt="2024-02-12T23:36:14.152" v="172"/>
          <ac:spMkLst>
            <pc:docMk/>
            <pc:sldMk cId="0" sldId="655"/>
            <ac:spMk id="13" creationId="{188649C1-64C2-DB31-3B20-770E7C9F1D3B}"/>
          </ac:spMkLst>
        </pc:spChg>
        <pc:spChg chg="del mod">
          <ac:chgData name="健 有村" userId="845497175cb2f617" providerId="LiveId" clId="{601CFE96-BE86-4FC6-AE52-3B5BEE4FDF49}" dt="2024-02-12T23:35:25.775" v="166" actId="478"/>
          <ac:spMkLst>
            <pc:docMk/>
            <pc:sldMk cId="0" sldId="655"/>
            <ac:spMk id="14" creationId="{1E6054F4-0257-BB5F-DFBE-94548D7E0C1C}"/>
          </ac:spMkLst>
        </pc:spChg>
        <pc:spChg chg="del">
          <ac:chgData name="健 有村" userId="845497175cb2f617" providerId="LiveId" clId="{601CFE96-BE86-4FC6-AE52-3B5BEE4FDF49}" dt="2024-02-12T23:35:18.278" v="161" actId="478"/>
          <ac:spMkLst>
            <pc:docMk/>
            <pc:sldMk cId="0" sldId="655"/>
            <ac:spMk id="16" creationId="{402E1CCC-A6B5-7961-1E47-833AC90AD236}"/>
          </ac:spMkLst>
        </pc:spChg>
        <pc:spChg chg="del">
          <ac:chgData name="健 有村" userId="845497175cb2f617" providerId="LiveId" clId="{601CFE96-BE86-4FC6-AE52-3B5BEE4FDF49}" dt="2024-02-12T23:35:21.441" v="163" actId="478"/>
          <ac:spMkLst>
            <pc:docMk/>
            <pc:sldMk cId="0" sldId="655"/>
            <ac:spMk id="17" creationId="{334E64A0-8BF8-9506-8CAC-B31B25AFC4CE}"/>
          </ac:spMkLst>
        </pc:spChg>
        <pc:spChg chg="del">
          <ac:chgData name="健 有村" userId="845497175cb2f617" providerId="LiveId" clId="{601CFE96-BE86-4FC6-AE52-3B5BEE4FDF49}" dt="2024-02-12T23:35:13.770" v="159" actId="478"/>
          <ac:spMkLst>
            <pc:docMk/>
            <pc:sldMk cId="0" sldId="655"/>
            <ac:spMk id="18" creationId="{8AC179A9-DF4E-486A-1B77-946830D2DCF3}"/>
          </ac:spMkLst>
        </pc:spChg>
        <pc:spChg chg="add mod">
          <ac:chgData name="健 有村" userId="845497175cb2f617" providerId="LiveId" clId="{601CFE96-BE86-4FC6-AE52-3B5BEE4FDF49}" dt="2024-02-12T23:36:14.152" v="172"/>
          <ac:spMkLst>
            <pc:docMk/>
            <pc:sldMk cId="0" sldId="655"/>
            <ac:spMk id="19" creationId="{169D8878-A7C9-EEE3-CE0C-7C82A8980675}"/>
          </ac:spMkLst>
        </pc:spChg>
        <pc:spChg chg="add mod">
          <ac:chgData name="健 有村" userId="845497175cb2f617" providerId="LiveId" clId="{601CFE96-BE86-4FC6-AE52-3B5BEE4FDF49}" dt="2024-02-12T23:36:14.152" v="172"/>
          <ac:spMkLst>
            <pc:docMk/>
            <pc:sldMk cId="0" sldId="655"/>
            <ac:spMk id="20" creationId="{5187438A-B315-5C16-CFD8-130D3960EDFD}"/>
          </ac:spMkLst>
        </pc:spChg>
        <pc:spChg chg="add mod">
          <ac:chgData name="健 有村" userId="845497175cb2f617" providerId="LiveId" clId="{601CFE96-BE86-4FC6-AE52-3B5BEE4FDF49}" dt="2024-02-12T23:36:14.152" v="172"/>
          <ac:spMkLst>
            <pc:docMk/>
            <pc:sldMk cId="0" sldId="655"/>
            <ac:spMk id="21" creationId="{1664D33A-AB50-FE22-E03C-A39A39F81FC3}"/>
          </ac:spMkLst>
        </pc:spChg>
        <pc:spChg chg="add mod">
          <ac:chgData name="健 有村" userId="845497175cb2f617" providerId="LiveId" clId="{601CFE96-BE86-4FC6-AE52-3B5BEE4FDF49}" dt="2024-02-12T23:36:14.152" v="172"/>
          <ac:spMkLst>
            <pc:docMk/>
            <pc:sldMk cId="0" sldId="655"/>
            <ac:spMk id="22" creationId="{83F5559E-F875-500E-E0FB-5C3C8F861A55}"/>
          </ac:spMkLst>
        </pc:spChg>
        <pc:spChg chg="add mod">
          <ac:chgData name="健 有村" userId="845497175cb2f617" providerId="LiveId" clId="{601CFE96-BE86-4FC6-AE52-3B5BEE4FDF49}" dt="2024-02-12T23:36:14.152" v="172"/>
          <ac:spMkLst>
            <pc:docMk/>
            <pc:sldMk cId="0" sldId="655"/>
            <ac:spMk id="23" creationId="{AD698252-BCCA-846E-93ED-21C8D248F919}"/>
          </ac:spMkLst>
        </pc:spChg>
        <pc:spChg chg="add mod">
          <ac:chgData name="健 有村" userId="845497175cb2f617" providerId="LiveId" clId="{601CFE96-BE86-4FC6-AE52-3B5BEE4FDF49}" dt="2024-02-12T23:36:14.152" v="172"/>
          <ac:spMkLst>
            <pc:docMk/>
            <pc:sldMk cId="0" sldId="655"/>
            <ac:spMk id="24" creationId="{11AA875A-BD10-669D-E2A7-058E38BAAFCF}"/>
          </ac:spMkLst>
        </pc:spChg>
        <pc:spChg chg="add mod">
          <ac:chgData name="健 有村" userId="845497175cb2f617" providerId="LiveId" clId="{601CFE96-BE86-4FC6-AE52-3B5BEE4FDF49}" dt="2024-02-12T23:36:14.152" v="172"/>
          <ac:spMkLst>
            <pc:docMk/>
            <pc:sldMk cId="0" sldId="655"/>
            <ac:spMk id="25" creationId="{4C977062-3024-1AC3-3004-76CB9169BAB2}"/>
          </ac:spMkLst>
        </pc:spChg>
        <pc:spChg chg="add mod">
          <ac:chgData name="健 有村" userId="845497175cb2f617" providerId="LiveId" clId="{601CFE96-BE86-4FC6-AE52-3B5BEE4FDF49}" dt="2024-02-12T23:36:14.152" v="172"/>
          <ac:spMkLst>
            <pc:docMk/>
            <pc:sldMk cId="0" sldId="655"/>
            <ac:spMk id="26" creationId="{8A27DCDC-32C0-0720-25F5-85AB30C61155}"/>
          </ac:spMkLst>
        </pc:spChg>
        <pc:spChg chg="add mod">
          <ac:chgData name="健 有村" userId="845497175cb2f617" providerId="LiveId" clId="{601CFE96-BE86-4FC6-AE52-3B5BEE4FDF49}" dt="2024-02-12T23:36:14.152" v="172"/>
          <ac:spMkLst>
            <pc:docMk/>
            <pc:sldMk cId="0" sldId="655"/>
            <ac:spMk id="27" creationId="{B43B0A5D-F3EE-FE8C-6713-8199D0EB6470}"/>
          </ac:spMkLst>
        </pc:spChg>
        <pc:spChg chg="add del mod">
          <ac:chgData name="健 有村" userId="845497175cb2f617" providerId="LiveId" clId="{601CFE96-BE86-4FC6-AE52-3B5BEE4FDF49}" dt="2024-02-12T23:37:29.434" v="184" actId="478"/>
          <ac:spMkLst>
            <pc:docMk/>
            <pc:sldMk cId="0" sldId="655"/>
            <ac:spMk id="28" creationId="{46FB650E-E1EF-9A1D-E13E-74B151C5F703}"/>
          </ac:spMkLst>
        </pc:spChg>
        <pc:spChg chg="add mod">
          <ac:chgData name="健 有村" userId="845497175cb2f617" providerId="LiveId" clId="{601CFE96-BE86-4FC6-AE52-3B5BEE4FDF49}" dt="2024-02-12T23:36:34.499" v="176" actId="1076"/>
          <ac:spMkLst>
            <pc:docMk/>
            <pc:sldMk cId="0" sldId="655"/>
            <ac:spMk id="29" creationId="{36AFDC76-50E6-AA23-4941-CCC512433FDE}"/>
          </ac:spMkLst>
        </pc:spChg>
        <pc:spChg chg="add mod">
          <ac:chgData name="健 有村" userId="845497175cb2f617" providerId="LiveId" clId="{601CFE96-BE86-4FC6-AE52-3B5BEE4FDF49}" dt="2024-02-12T23:36:34.499" v="176" actId="1076"/>
          <ac:spMkLst>
            <pc:docMk/>
            <pc:sldMk cId="0" sldId="655"/>
            <ac:spMk id="30" creationId="{B56CC086-8018-E7C9-6768-60BD34753FA6}"/>
          </ac:spMkLst>
        </pc:spChg>
        <pc:spChg chg="add mod">
          <ac:chgData name="健 有村" userId="845497175cb2f617" providerId="LiveId" clId="{601CFE96-BE86-4FC6-AE52-3B5BEE4FDF49}" dt="2024-02-12T23:36:34.499" v="176" actId="1076"/>
          <ac:spMkLst>
            <pc:docMk/>
            <pc:sldMk cId="0" sldId="655"/>
            <ac:spMk id="31" creationId="{ADBFA29E-BB2E-9BD4-0DB4-7F609F0862CD}"/>
          </ac:spMkLst>
        </pc:spChg>
        <pc:spChg chg="add mod">
          <ac:chgData name="健 有村" userId="845497175cb2f617" providerId="LiveId" clId="{601CFE96-BE86-4FC6-AE52-3B5BEE4FDF49}" dt="2024-02-12T23:37:03.033" v="179" actId="1076"/>
          <ac:spMkLst>
            <pc:docMk/>
            <pc:sldMk cId="0" sldId="655"/>
            <ac:spMk id="32" creationId="{89E9A01D-EEA8-151C-0A4E-B9C7B073711A}"/>
          </ac:spMkLst>
        </pc:spChg>
        <pc:spChg chg="add mod">
          <ac:chgData name="健 有村" userId="845497175cb2f617" providerId="LiveId" clId="{601CFE96-BE86-4FC6-AE52-3B5BEE4FDF49}" dt="2024-02-12T23:37:09.516" v="180" actId="1076"/>
          <ac:spMkLst>
            <pc:docMk/>
            <pc:sldMk cId="0" sldId="655"/>
            <ac:spMk id="33" creationId="{F7527FAF-A9DD-C671-B671-3F84A12A9A47}"/>
          </ac:spMkLst>
        </pc:spChg>
        <pc:spChg chg="add mod">
          <ac:chgData name="健 有村" userId="845497175cb2f617" providerId="LiveId" clId="{601CFE96-BE86-4FC6-AE52-3B5BEE4FDF49}" dt="2024-02-12T23:37:14.048" v="181" actId="1076"/>
          <ac:spMkLst>
            <pc:docMk/>
            <pc:sldMk cId="0" sldId="655"/>
            <ac:spMk id="34" creationId="{6141C39C-96DC-AF52-DDD0-40AD7DED5F24}"/>
          </ac:spMkLst>
        </pc:spChg>
        <pc:spChg chg="add mod">
          <ac:chgData name="健 有村" userId="845497175cb2f617" providerId="LiveId" clId="{601CFE96-BE86-4FC6-AE52-3B5BEE4FDF49}" dt="2024-02-12T23:37:19.910" v="182" actId="1076"/>
          <ac:spMkLst>
            <pc:docMk/>
            <pc:sldMk cId="0" sldId="655"/>
            <ac:spMk id="35" creationId="{DF32C69E-3FB4-33E3-A010-94D8E14EF861}"/>
          </ac:spMkLst>
        </pc:spChg>
        <pc:spChg chg="add mod">
          <ac:chgData name="健 有村" userId="845497175cb2f617" providerId="LiveId" clId="{601CFE96-BE86-4FC6-AE52-3B5BEE4FDF49}" dt="2024-02-12T23:36:58.053" v="178" actId="1076"/>
          <ac:spMkLst>
            <pc:docMk/>
            <pc:sldMk cId="0" sldId="655"/>
            <ac:spMk id="36" creationId="{70D1452E-A5C2-5874-9DFF-2B6F0CC3889B}"/>
          </ac:spMkLst>
        </pc:spChg>
        <pc:spChg chg="add mod">
          <ac:chgData name="健 有村" userId="845497175cb2f617" providerId="LiveId" clId="{601CFE96-BE86-4FC6-AE52-3B5BEE4FDF49}" dt="2024-02-12T23:37:25.011" v="183" actId="1076"/>
          <ac:spMkLst>
            <pc:docMk/>
            <pc:sldMk cId="0" sldId="655"/>
            <ac:spMk id="37" creationId="{2C0EFCAE-0DFF-59BC-F51E-84E71D2BA676}"/>
          </ac:spMkLst>
        </pc:spChg>
        <pc:spChg chg="add mod">
          <ac:chgData name="健 有村" userId="845497175cb2f617" providerId="LiveId" clId="{601CFE96-BE86-4FC6-AE52-3B5BEE4FDF49}" dt="2024-02-12T23:36:46.749" v="177" actId="1076"/>
          <ac:spMkLst>
            <pc:docMk/>
            <pc:sldMk cId="0" sldId="655"/>
            <ac:spMk id="38" creationId="{BD77B7BE-8F01-9A88-7612-C40DCF029C2D}"/>
          </ac:spMkLst>
        </pc:spChg>
        <pc:spChg chg="add mod">
          <ac:chgData name="健 有村" userId="845497175cb2f617" providerId="LiveId" clId="{601CFE96-BE86-4FC6-AE52-3B5BEE4FDF49}" dt="2024-02-12T23:36:46.749" v="177" actId="1076"/>
          <ac:spMkLst>
            <pc:docMk/>
            <pc:sldMk cId="0" sldId="655"/>
            <ac:spMk id="39" creationId="{359AE8A4-BBE8-F0DC-6275-37742AB38AD2}"/>
          </ac:spMkLst>
        </pc:spChg>
        <pc:spChg chg="add mod">
          <ac:chgData name="健 有村" userId="845497175cb2f617" providerId="LiveId" clId="{601CFE96-BE86-4FC6-AE52-3B5BEE4FDF49}" dt="2024-02-12T23:37:45.394" v="186" actId="1076"/>
          <ac:spMkLst>
            <pc:docMk/>
            <pc:sldMk cId="0" sldId="655"/>
            <ac:spMk id="40" creationId="{A4BE0F69-DDD6-D219-82BB-E7DFB85831D9}"/>
          </ac:spMkLst>
        </pc:spChg>
        <pc:spChg chg="add mod">
          <ac:chgData name="健 有村" userId="845497175cb2f617" providerId="LiveId" clId="{601CFE96-BE86-4FC6-AE52-3B5BEE4FDF49}" dt="2024-02-12T23:43:21.596" v="221" actId="1076"/>
          <ac:spMkLst>
            <pc:docMk/>
            <pc:sldMk cId="0" sldId="655"/>
            <ac:spMk id="41" creationId="{A8566B00-B1F9-4F36-0311-D49A1CE4828E}"/>
          </ac:spMkLst>
        </pc:spChg>
        <pc:spChg chg="del">
          <ac:chgData name="健 有村" userId="845497175cb2f617" providerId="LiveId" clId="{601CFE96-BE86-4FC6-AE52-3B5BEE4FDF49}" dt="2024-02-12T23:35:13.770" v="159" actId="478"/>
          <ac:spMkLst>
            <pc:docMk/>
            <pc:sldMk cId="0" sldId="655"/>
            <ac:spMk id="58377" creationId="{787B4159-9A24-9C6B-54D8-51EB2BC0FB00}"/>
          </ac:spMkLst>
        </pc:spChg>
        <pc:spChg chg="del">
          <ac:chgData name="健 有村" userId="845497175cb2f617" providerId="LiveId" clId="{601CFE96-BE86-4FC6-AE52-3B5BEE4FDF49}" dt="2024-02-12T23:35:13.770" v="159" actId="478"/>
          <ac:spMkLst>
            <pc:docMk/>
            <pc:sldMk cId="0" sldId="655"/>
            <ac:spMk id="58378" creationId="{7BFBE196-094E-FA9A-EAFE-6B9568A48BD9}"/>
          </ac:spMkLst>
        </pc:spChg>
        <pc:spChg chg="del">
          <ac:chgData name="健 有村" userId="845497175cb2f617" providerId="LiveId" clId="{601CFE96-BE86-4FC6-AE52-3B5BEE4FDF49}" dt="2024-02-12T23:35:13.770" v="159" actId="478"/>
          <ac:spMkLst>
            <pc:docMk/>
            <pc:sldMk cId="0" sldId="655"/>
            <ac:spMk id="58381" creationId="{FDC6263E-BBAE-13C6-2246-6F38A9EDE864}"/>
          </ac:spMkLst>
        </pc:spChg>
        <pc:spChg chg="del">
          <ac:chgData name="健 有村" userId="845497175cb2f617" providerId="LiveId" clId="{601CFE96-BE86-4FC6-AE52-3B5BEE4FDF49}" dt="2024-02-12T23:35:13.770" v="159" actId="478"/>
          <ac:spMkLst>
            <pc:docMk/>
            <pc:sldMk cId="0" sldId="655"/>
            <ac:spMk id="58382" creationId="{DFE4862D-0C7B-0723-287B-010C551BF579}"/>
          </ac:spMkLst>
        </pc:spChg>
        <pc:picChg chg="del">
          <ac:chgData name="健 有村" userId="845497175cb2f617" providerId="LiveId" clId="{601CFE96-BE86-4FC6-AE52-3B5BEE4FDF49}" dt="2024-02-12T23:35:13.770" v="159" actId="478"/>
          <ac:picMkLst>
            <pc:docMk/>
            <pc:sldMk cId="0" sldId="655"/>
            <ac:picMk id="2" creationId="{6B2DF8D8-59E4-4677-2BDA-DA81934F7490}"/>
          </ac:picMkLst>
        </pc:picChg>
        <pc:picChg chg="del">
          <ac:chgData name="健 有村" userId="845497175cb2f617" providerId="LiveId" clId="{601CFE96-BE86-4FC6-AE52-3B5BEE4FDF49}" dt="2024-02-12T23:35:13.770" v="159" actId="478"/>
          <ac:picMkLst>
            <pc:docMk/>
            <pc:sldMk cId="0" sldId="655"/>
            <ac:picMk id="3" creationId="{1D33BA9F-25E9-DC8C-D408-B32276364C24}"/>
          </ac:picMkLst>
        </pc:picChg>
        <pc:picChg chg="del">
          <ac:chgData name="健 有村" userId="845497175cb2f617" providerId="LiveId" clId="{601CFE96-BE86-4FC6-AE52-3B5BEE4FDF49}" dt="2024-02-12T23:35:13.770" v="159" actId="478"/>
          <ac:picMkLst>
            <pc:docMk/>
            <pc:sldMk cId="0" sldId="655"/>
            <ac:picMk id="4" creationId="{C0F8890E-D55A-FD5A-4F31-563461171715}"/>
          </ac:picMkLst>
        </pc:picChg>
        <pc:picChg chg="del">
          <ac:chgData name="健 有村" userId="845497175cb2f617" providerId="LiveId" clId="{601CFE96-BE86-4FC6-AE52-3B5BEE4FDF49}" dt="2024-02-12T23:35:13.770" v="159" actId="478"/>
          <ac:picMkLst>
            <pc:docMk/>
            <pc:sldMk cId="0" sldId="655"/>
            <ac:picMk id="5" creationId="{7DEA53E0-EFC9-EC63-D3EE-ACD43EDA7E9D}"/>
          </ac:picMkLst>
        </pc:picChg>
        <pc:picChg chg="del">
          <ac:chgData name="健 有村" userId="845497175cb2f617" providerId="LiveId" clId="{601CFE96-BE86-4FC6-AE52-3B5BEE4FDF49}" dt="2024-02-12T23:35:19.172" v="162" actId="478"/>
          <ac:picMkLst>
            <pc:docMk/>
            <pc:sldMk cId="0" sldId="655"/>
            <ac:picMk id="9" creationId="{1ADAC768-0E7D-2B47-7402-D670FC8A5BEE}"/>
          </ac:picMkLst>
        </pc:picChg>
        <pc:picChg chg="mod">
          <ac:chgData name="健 有村" userId="845497175cb2f617" providerId="LiveId" clId="{601CFE96-BE86-4FC6-AE52-3B5BEE4FDF49}" dt="2024-02-12T23:36:19.698" v="174" actId="1076"/>
          <ac:picMkLst>
            <pc:docMk/>
            <pc:sldMk cId="0" sldId="655"/>
            <ac:picMk id="15" creationId="{A463C926-21C0-0334-9C06-118ED04BB2D2}"/>
          </ac:picMkLst>
        </pc:picChg>
      </pc:sldChg>
    </pc:docChg>
  </pc:docChgLst>
  <pc:docChgLst>
    <pc:chgData name="健 有村" userId="845497175cb2f617" providerId="LiveId" clId="{6EF335AB-5A38-4F6C-9B84-EBDC5691CA88}"/>
    <pc:docChg chg="delSld modSld">
      <pc:chgData name="健 有村" userId="845497175cb2f617" providerId="LiveId" clId="{6EF335AB-5A38-4F6C-9B84-EBDC5691CA88}" dt="2024-02-12T02:14:34.300" v="14" actId="2696"/>
      <pc:docMkLst>
        <pc:docMk/>
      </pc:docMkLst>
      <pc:sldChg chg="modSp mod">
        <pc:chgData name="健 有村" userId="845497175cb2f617" providerId="LiveId" clId="{6EF335AB-5A38-4F6C-9B84-EBDC5691CA88}" dt="2024-02-12T02:02:12.297" v="6" actId="6549"/>
        <pc:sldMkLst>
          <pc:docMk/>
          <pc:sldMk cId="0" sldId="614"/>
        </pc:sldMkLst>
        <pc:spChg chg="mod">
          <ac:chgData name="健 有村" userId="845497175cb2f617" providerId="LiveId" clId="{6EF335AB-5A38-4F6C-9B84-EBDC5691CA88}" dt="2024-02-12T02:02:12.297" v="6" actId="6549"/>
          <ac:spMkLst>
            <pc:docMk/>
            <pc:sldMk cId="0" sldId="614"/>
            <ac:spMk id="4" creationId="{A343A0E6-301C-1C40-57EE-E8AAE8773A72}"/>
          </ac:spMkLst>
        </pc:spChg>
      </pc:sldChg>
      <pc:sldChg chg="modSp mod">
        <pc:chgData name="健 有村" userId="845497175cb2f617" providerId="LiveId" clId="{6EF335AB-5A38-4F6C-9B84-EBDC5691CA88}" dt="2024-02-12T02:02:04.692" v="3" actId="6549"/>
        <pc:sldMkLst>
          <pc:docMk/>
          <pc:sldMk cId="1049241923" sldId="615"/>
        </pc:sldMkLst>
        <pc:spChg chg="mod">
          <ac:chgData name="健 有村" userId="845497175cb2f617" providerId="LiveId" clId="{6EF335AB-5A38-4F6C-9B84-EBDC5691CA88}" dt="2024-02-12T02:02:04.692" v="3" actId="6549"/>
          <ac:spMkLst>
            <pc:docMk/>
            <pc:sldMk cId="1049241923" sldId="615"/>
            <ac:spMk id="5" creationId="{76019B3F-B100-9FB4-E000-A2A8D37BFEB3}"/>
          </ac:spMkLst>
        </pc:spChg>
      </pc:sldChg>
      <pc:sldChg chg="modSp mod">
        <pc:chgData name="健 有村" userId="845497175cb2f617" providerId="LiveId" clId="{6EF335AB-5A38-4F6C-9B84-EBDC5691CA88}" dt="2024-02-12T02:04:21.346" v="10" actId="113"/>
        <pc:sldMkLst>
          <pc:docMk/>
          <pc:sldMk cId="0" sldId="637"/>
        </pc:sldMkLst>
        <pc:spChg chg="mod">
          <ac:chgData name="健 有村" userId="845497175cb2f617" providerId="LiveId" clId="{6EF335AB-5A38-4F6C-9B84-EBDC5691CA88}" dt="2024-02-12T02:04:21.346" v="10" actId="113"/>
          <ac:spMkLst>
            <pc:docMk/>
            <pc:sldMk cId="0" sldId="637"/>
            <ac:spMk id="16" creationId="{AA252256-661D-43E3-C7DA-31F25B64B6AD}"/>
          </ac:spMkLst>
        </pc:spChg>
      </pc:sldChg>
      <pc:sldChg chg="modSp mod">
        <pc:chgData name="健 有村" userId="845497175cb2f617" providerId="LiveId" clId="{6EF335AB-5A38-4F6C-9B84-EBDC5691CA88}" dt="2024-02-12T02:05:12.482" v="13" actId="6549"/>
        <pc:sldMkLst>
          <pc:docMk/>
          <pc:sldMk cId="593516481" sldId="638"/>
        </pc:sldMkLst>
        <pc:spChg chg="mod">
          <ac:chgData name="健 有村" userId="845497175cb2f617" providerId="LiveId" clId="{6EF335AB-5A38-4F6C-9B84-EBDC5691CA88}" dt="2024-02-12T02:05:12.482" v="13" actId="6549"/>
          <ac:spMkLst>
            <pc:docMk/>
            <pc:sldMk cId="593516481" sldId="638"/>
            <ac:spMk id="16" creationId="{AA252256-661D-43E3-C7DA-31F25B64B6AD}"/>
          </ac:spMkLst>
        </pc:spChg>
      </pc:sldChg>
      <pc:sldChg chg="del">
        <pc:chgData name="健 有村" userId="845497175cb2f617" providerId="LiveId" clId="{6EF335AB-5A38-4F6C-9B84-EBDC5691CA88}" dt="2024-02-12T02:14:34.300" v="14" actId="2696"/>
        <pc:sldMkLst>
          <pc:docMk/>
          <pc:sldMk cId="4044279571" sldId="645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297CA41-1126-4994-8005-4CBDE3CC3A83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1100745-39D8-43D0-85D0-37CB8170D4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52792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250" name="Slide Image Placeholder 1">
            <a:extLst>
              <a:ext uri="{FF2B5EF4-FFF2-40B4-BE49-F238E27FC236}">
                <a16:creationId xmlns:a16="http://schemas.microsoft.com/office/drawing/2014/main" id="{C9D65120-DE43-C687-C3AC-5BEAAD2CA9BB}"/>
              </a:ext>
            </a:extLst>
          </p:cNvPr>
          <p:cNvSpPr>
            <a:spLocks noGrp="1" noRot="1" noChangeAspect="1" noChangeArrowheads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53251" name="Notes Placeholder 2">
            <a:extLst>
              <a:ext uri="{FF2B5EF4-FFF2-40B4-BE49-F238E27FC236}">
                <a16:creationId xmlns:a16="http://schemas.microsoft.com/office/drawing/2014/main" id="{2B0EBFAE-EEA2-5BBF-0D01-822BD97048AE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ja-JP" altLang="en-US" dirty="0">
              <a:cs typeface="Arial" panose="020B0604020202020204" pitchFamily="34" charset="0"/>
            </a:endParaRPr>
          </a:p>
        </p:txBody>
      </p:sp>
      <p:sp>
        <p:nvSpPr>
          <p:cNvPr id="53252" name="Slide Number Placeholder 3">
            <a:extLst>
              <a:ext uri="{FF2B5EF4-FFF2-40B4-BE49-F238E27FC236}">
                <a16:creationId xmlns:a16="http://schemas.microsoft.com/office/drawing/2014/main" id="{C9740004-E95B-D040-F73C-B81BA6327165}"/>
              </a:ext>
            </a:extLst>
          </p:cNvPr>
          <p:cNvSpPr>
            <a:spLocks noGrp="1" noChangeArrowheads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B6E9BB5F-FFBC-4950-8B56-81DB3CF3009C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610" name="Slide Image Placeholder 1">
            <a:extLst>
              <a:ext uri="{FF2B5EF4-FFF2-40B4-BE49-F238E27FC236}">
                <a16:creationId xmlns:a16="http://schemas.microsoft.com/office/drawing/2014/main" id="{8EEBFADC-50A2-7A8B-3387-668A0BA06EF2}"/>
              </a:ext>
            </a:extLst>
          </p:cNvPr>
          <p:cNvSpPr>
            <a:spLocks noGrp="1" noRot="1" noChangeAspect="1" noChangeArrowheads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68611" name="Notes Placeholder 2">
            <a:extLst>
              <a:ext uri="{FF2B5EF4-FFF2-40B4-BE49-F238E27FC236}">
                <a16:creationId xmlns:a16="http://schemas.microsoft.com/office/drawing/2014/main" id="{7DFE1B2A-685D-52A5-199B-E0EA0FAD7923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200" dirty="0">
                <a:latin typeface="Arial" panose="020B0604020202020204" pitchFamily="34" charset="0"/>
              </a:rPr>
              <a:t>WB after EPPK1 KO</a:t>
            </a:r>
            <a:endParaRPr lang="ja-JP" altLang="en-US" sz="1200" dirty="0">
              <a:latin typeface="Arial" panose="020B0604020202020204" pitchFamily="34" charset="0"/>
            </a:endParaRPr>
          </a:p>
          <a:p>
            <a:endParaRPr lang="ja-JP" altLang="en-US" dirty="0"/>
          </a:p>
        </p:txBody>
      </p:sp>
      <p:sp>
        <p:nvSpPr>
          <p:cNvPr id="68612" name="Slide Number Placeholder 3">
            <a:extLst>
              <a:ext uri="{FF2B5EF4-FFF2-40B4-BE49-F238E27FC236}">
                <a16:creationId xmlns:a16="http://schemas.microsoft.com/office/drawing/2014/main" id="{EFCFDC6A-7A1E-4D4C-39E5-5A90C32AC817}"/>
              </a:ext>
            </a:extLst>
          </p:cNvPr>
          <p:cNvSpPr>
            <a:spLocks noGrp="1" noChangeArrowheads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BCCADFD7-4193-4CAF-89C6-731C0C78E0F6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1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</p:spTree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610" name="Slide Image Placeholder 1">
            <a:extLst>
              <a:ext uri="{FF2B5EF4-FFF2-40B4-BE49-F238E27FC236}">
                <a16:creationId xmlns:a16="http://schemas.microsoft.com/office/drawing/2014/main" id="{8EEBFADC-50A2-7A8B-3387-668A0BA06EF2}"/>
              </a:ext>
            </a:extLst>
          </p:cNvPr>
          <p:cNvSpPr>
            <a:spLocks noGrp="1" noRot="1" noChangeAspect="1" noChangeArrowheads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68611" name="Notes Placeholder 2">
            <a:extLst>
              <a:ext uri="{FF2B5EF4-FFF2-40B4-BE49-F238E27FC236}">
                <a16:creationId xmlns:a16="http://schemas.microsoft.com/office/drawing/2014/main" id="{7DFE1B2A-685D-52A5-199B-E0EA0FAD7923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200" dirty="0">
                <a:latin typeface="Arial" panose="020B0604020202020204" pitchFamily="34" charset="0"/>
              </a:rPr>
              <a:t>WB after EPPK1 KO</a:t>
            </a:r>
            <a:endParaRPr lang="ja-JP" altLang="en-US" sz="1200" dirty="0">
              <a:latin typeface="Arial" panose="020B0604020202020204" pitchFamily="34" charset="0"/>
            </a:endParaRPr>
          </a:p>
          <a:p>
            <a:endParaRPr lang="ja-JP" altLang="en-US" dirty="0"/>
          </a:p>
        </p:txBody>
      </p:sp>
      <p:sp>
        <p:nvSpPr>
          <p:cNvPr id="68612" name="Slide Number Placeholder 3">
            <a:extLst>
              <a:ext uri="{FF2B5EF4-FFF2-40B4-BE49-F238E27FC236}">
                <a16:creationId xmlns:a16="http://schemas.microsoft.com/office/drawing/2014/main" id="{EFCFDC6A-7A1E-4D4C-39E5-5A90C32AC817}"/>
              </a:ext>
            </a:extLst>
          </p:cNvPr>
          <p:cNvSpPr>
            <a:spLocks noGrp="1" noChangeArrowheads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BCCADFD7-4193-4CAF-89C6-731C0C78E0F6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2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628019969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610" name="Slide Image Placeholder 1">
            <a:extLst>
              <a:ext uri="{FF2B5EF4-FFF2-40B4-BE49-F238E27FC236}">
                <a16:creationId xmlns:a16="http://schemas.microsoft.com/office/drawing/2014/main" id="{8EEBFADC-50A2-7A8B-3387-668A0BA06EF2}"/>
              </a:ext>
            </a:extLst>
          </p:cNvPr>
          <p:cNvSpPr>
            <a:spLocks noGrp="1" noRot="1" noChangeAspect="1" noChangeArrowheads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68611" name="Notes Placeholder 2">
            <a:extLst>
              <a:ext uri="{FF2B5EF4-FFF2-40B4-BE49-F238E27FC236}">
                <a16:creationId xmlns:a16="http://schemas.microsoft.com/office/drawing/2014/main" id="{7DFE1B2A-685D-52A5-199B-E0EA0FAD7923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200" dirty="0">
                <a:latin typeface="Arial" panose="020B0604020202020204" pitchFamily="34" charset="0"/>
              </a:rPr>
              <a:t>WB after EPPK1 KO</a:t>
            </a:r>
            <a:endParaRPr lang="ja-JP" altLang="en-US" sz="1200" dirty="0">
              <a:latin typeface="Arial" panose="020B0604020202020204" pitchFamily="34" charset="0"/>
            </a:endParaRPr>
          </a:p>
          <a:p>
            <a:endParaRPr lang="ja-JP" altLang="en-US" dirty="0"/>
          </a:p>
        </p:txBody>
      </p:sp>
      <p:sp>
        <p:nvSpPr>
          <p:cNvPr id="68612" name="Slide Number Placeholder 3">
            <a:extLst>
              <a:ext uri="{FF2B5EF4-FFF2-40B4-BE49-F238E27FC236}">
                <a16:creationId xmlns:a16="http://schemas.microsoft.com/office/drawing/2014/main" id="{EFCFDC6A-7A1E-4D4C-39E5-5A90C32AC817}"/>
              </a:ext>
            </a:extLst>
          </p:cNvPr>
          <p:cNvSpPr>
            <a:spLocks noGrp="1" noChangeArrowheads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BCCADFD7-4193-4CAF-89C6-731C0C78E0F6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3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667204777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610" name="Slide Image Placeholder 1">
            <a:extLst>
              <a:ext uri="{FF2B5EF4-FFF2-40B4-BE49-F238E27FC236}">
                <a16:creationId xmlns:a16="http://schemas.microsoft.com/office/drawing/2014/main" id="{8EEBFADC-50A2-7A8B-3387-668A0BA06EF2}"/>
              </a:ext>
            </a:extLst>
          </p:cNvPr>
          <p:cNvSpPr>
            <a:spLocks noGrp="1" noRot="1" noChangeAspect="1" noChangeArrowheads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68611" name="Notes Placeholder 2">
            <a:extLst>
              <a:ext uri="{FF2B5EF4-FFF2-40B4-BE49-F238E27FC236}">
                <a16:creationId xmlns:a16="http://schemas.microsoft.com/office/drawing/2014/main" id="{7DFE1B2A-685D-52A5-199B-E0EA0FAD7923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200" dirty="0">
                <a:latin typeface="Arial" panose="020B0604020202020204" pitchFamily="34" charset="0"/>
              </a:rPr>
              <a:t>WB after EPPK1 KO</a:t>
            </a:r>
            <a:endParaRPr lang="ja-JP" altLang="en-US" sz="1200" dirty="0">
              <a:latin typeface="Arial" panose="020B0604020202020204" pitchFamily="34" charset="0"/>
            </a:endParaRPr>
          </a:p>
          <a:p>
            <a:endParaRPr lang="ja-JP" altLang="en-US" dirty="0"/>
          </a:p>
        </p:txBody>
      </p:sp>
      <p:sp>
        <p:nvSpPr>
          <p:cNvPr id="68612" name="Slide Number Placeholder 3">
            <a:extLst>
              <a:ext uri="{FF2B5EF4-FFF2-40B4-BE49-F238E27FC236}">
                <a16:creationId xmlns:a16="http://schemas.microsoft.com/office/drawing/2014/main" id="{EFCFDC6A-7A1E-4D4C-39E5-5A90C32AC817}"/>
              </a:ext>
            </a:extLst>
          </p:cNvPr>
          <p:cNvSpPr>
            <a:spLocks noGrp="1" noChangeArrowheads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BCCADFD7-4193-4CAF-89C6-731C0C78E0F6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4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527055672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610" name="Slide Image Placeholder 1">
            <a:extLst>
              <a:ext uri="{FF2B5EF4-FFF2-40B4-BE49-F238E27FC236}">
                <a16:creationId xmlns:a16="http://schemas.microsoft.com/office/drawing/2014/main" id="{8EEBFADC-50A2-7A8B-3387-668A0BA06EF2}"/>
              </a:ext>
            </a:extLst>
          </p:cNvPr>
          <p:cNvSpPr>
            <a:spLocks noGrp="1" noRot="1" noChangeAspect="1" noChangeArrowheads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68611" name="Notes Placeholder 2">
            <a:extLst>
              <a:ext uri="{FF2B5EF4-FFF2-40B4-BE49-F238E27FC236}">
                <a16:creationId xmlns:a16="http://schemas.microsoft.com/office/drawing/2014/main" id="{7DFE1B2A-685D-52A5-199B-E0EA0FAD7923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200" dirty="0">
                <a:latin typeface="Arial" panose="020B0604020202020204" pitchFamily="34" charset="0"/>
              </a:rPr>
              <a:t>WB after EPPK1 KO</a:t>
            </a:r>
            <a:endParaRPr lang="ja-JP" altLang="en-US" sz="1200" dirty="0">
              <a:latin typeface="Arial" panose="020B0604020202020204" pitchFamily="34" charset="0"/>
            </a:endParaRPr>
          </a:p>
          <a:p>
            <a:endParaRPr lang="ja-JP" altLang="en-US" dirty="0"/>
          </a:p>
        </p:txBody>
      </p:sp>
      <p:sp>
        <p:nvSpPr>
          <p:cNvPr id="68612" name="Slide Number Placeholder 3">
            <a:extLst>
              <a:ext uri="{FF2B5EF4-FFF2-40B4-BE49-F238E27FC236}">
                <a16:creationId xmlns:a16="http://schemas.microsoft.com/office/drawing/2014/main" id="{EFCFDC6A-7A1E-4D4C-39E5-5A90C32AC817}"/>
              </a:ext>
            </a:extLst>
          </p:cNvPr>
          <p:cNvSpPr>
            <a:spLocks noGrp="1" noChangeArrowheads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BCCADFD7-4193-4CAF-89C6-731C0C78E0F6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5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48094653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610" name="Slide Image Placeholder 1">
            <a:extLst>
              <a:ext uri="{FF2B5EF4-FFF2-40B4-BE49-F238E27FC236}">
                <a16:creationId xmlns:a16="http://schemas.microsoft.com/office/drawing/2014/main" id="{8EEBFADC-50A2-7A8B-3387-668A0BA06EF2}"/>
              </a:ext>
            </a:extLst>
          </p:cNvPr>
          <p:cNvSpPr>
            <a:spLocks noGrp="1" noRot="1" noChangeAspect="1" noChangeArrowheads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68611" name="Notes Placeholder 2">
            <a:extLst>
              <a:ext uri="{FF2B5EF4-FFF2-40B4-BE49-F238E27FC236}">
                <a16:creationId xmlns:a16="http://schemas.microsoft.com/office/drawing/2014/main" id="{7DFE1B2A-685D-52A5-199B-E0EA0FAD7923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200" dirty="0">
                <a:latin typeface="Arial" panose="020B0604020202020204" pitchFamily="34" charset="0"/>
              </a:rPr>
              <a:t>WB after EPPK1 KO</a:t>
            </a:r>
            <a:endParaRPr lang="ja-JP" altLang="en-US" sz="1200" dirty="0">
              <a:latin typeface="Arial" panose="020B0604020202020204" pitchFamily="34" charset="0"/>
            </a:endParaRPr>
          </a:p>
          <a:p>
            <a:endParaRPr lang="ja-JP" altLang="en-US" dirty="0"/>
          </a:p>
        </p:txBody>
      </p:sp>
      <p:sp>
        <p:nvSpPr>
          <p:cNvPr id="68612" name="Slide Number Placeholder 3">
            <a:extLst>
              <a:ext uri="{FF2B5EF4-FFF2-40B4-BE49-F238E27FC236}">
                <a16:creationId xmlns:a16="http://schemas.microsoft.com/office/drawing/2014/main" id="{EFCFDC6A-7A1E-4D4C-39E5-5A90C32AC817}"/>
              </a:ext>
            </a:extLst>
          </p:cNvPr>
          <p:cNvSpPr>
            <a:spLocks noGrp="1" noChangeArrowheads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BCCADFD7-4193-4CAF-89C6-731C0C78E0F6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6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85741240"/>
      </p:ext>
    </p:extLst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610" name="Slide Image Placeholder 1">
            <a:extLst>
              <a:ext uri="{FF2B5EF4-FFF2-40B4-BE49-F238E27FC236}">
                <a16:creationId xmlns:a16="http://schemas.microsoft.com/office/drawing/2014/main" id="{8EEBFADC-50A2-7A8B-3387-668A0BA06EF2}"/>
              </a:ext>
            </a:extLst>
          </p:cNvPr>
          <p:cNvSpPr>
            <a:spLocks noGrp="1" noRot="1" noChangeAspect="1" noChangeArrowheads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68611" name="Notes Placeholder 2">
            <a:extLst>
              <a:ext uri="{FF2B5EF4-FFF2-40B4-BE49-F238E27FC236}">
                <a16:creationId xmlns:a16="http://schemas.microsoft.com/office/drawing/2014/main" id="{7DFE1B2A-685D-52A5-199B-E0EA0FAD7923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200" dirty="0">
                <a:latin typeface="Arial" panose="020B0604020202020204" pitchFamily="34" charset="0"/>
              </a:rPr>
              <a:t>WB after EPPK1 KO</a:t>
            </a:r>
            <a:endParaRPr lang="ja-JP" altLang="en-US" sz="1200" dirty="0">
              <a:latin typeface="Arial" panose="020B0604020202020204" pitchFamily="34" charset="0"/>
            </a:endParaRPr>
          </a:p>
          <a:p>
            <a:endParaRPr lang="ja-JP" altLang="en-US" dirty="0"/>
          </a:p>
        </p:txBody>
      </p:sp>
      <p:sp>
        <p:nvSpPr>
          <p:cNvPr id="68612" name="Slide Number Placeholder 3">
            <a:extLst>
              <a:ext uri="{FF2B5EF4-FFF2-40B4-BE49-F238E27FC236}">
                <a16:creationId xmlns:a16="http://schemas.microsoft.com/office/drawing/2014/main" id="{EFCFDC6A-7A1E-4D4C-39E5-5A90C32AC817}"/>
              </a:ext>
            </a:extLst>
          </p:cNvPr>
          <p:cNvSpPr>
            <a:spLocks noGrp="1" noChangeArrowheads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BCCADFD7-4193-4CAF-89C6-731C0C78E0F6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7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253386312"/>
      </p:ext>
    </p:extLst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610" name="Slide Image Placeholder 1">
            <a:extLst>
              <a:ext uri="{FF2B5EF4-FFF2-40B4-BE49-F238E27FC236}">
                <a16:creationId xmlns:a16="http://schemas.microsoft.com/office/drawing/2014/main" id="{8EEBFADC-50A2-7A8B-3387-668A0BA06EF2}"/>
              </a:ext>
            </a:extLst>
          </p:cNvPr>
          <p:cNvSpPr>
            <a:spLocks noGrp="1" noRot="1" noChangeAspect="1" noChangeArrowheads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68611" name="Notes Placeholder 2">
            <a:extLst>
              <a:ext uri="{FF2B5EF4-FFF2-40B4-BE49-F238E27FC236}">
                <a16:creationId xmlns:a16="http://schemas.microsoft.com/office/drawing/2014/main" id="{7DFE1B2A-685D-52A5-199B-E0EA0FAD7923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200" dirty="0">
                <a:latin typeface="Arial" panose="020B0604020202020204" pitchFamily="34" charset="0"/>
              </a:rPr>
              <a:t>WB after EPPK1 KO</a:t>
            </a:r>
            <a:endParaRPr lang="ja-JP" altLang="en-US" sz="1200" dirty="0">
              <a:latin typeface="Arial" panose="020B0604020202020204" pitchFamily="34" charset="0"/>
            </a:endParaRPr>
          </a:p>
          <a:p>
            <a:endParaRPr lang="ja-JP" altLang="en-US" dirty="0"/>
          </a:p>
        </p:txBody>
      </p:sp>
      <p:sp>
        <p:nvSpPr>
          <p:cNvPr id="68612" name="Slide Number Placeholder 3">
            <a:extLst>
              <a:ext uri="{FF2B5EF4-FFF2-40B4-BE49-F238E27FC236}">
                <a16:creationId xmlns:a16="http://schemas.microsoft.com/office/drawing/2014/main" id="{EFCFDC6A-7A1E-4D4C-39E5-5A90C32AC817}"/>
              </a:ext>
            </a:extLst>
          </p:cNvPr>
          <p:cNvSpPr>
            <a:spLocks noGrp="1" noChangeArrowheads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BCCADFD7-4193-4CAF-89C6-731C0C78E0F6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8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56159468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394" name="Slide Image Placeholder 1">
            <a:extLst>
              <a:ext uri="{FF2B5EF4-FFF2-40B4-BE49-F238E27FC236}">
                <a16:creationId xmlns:a16="http://schemas.microsoft.com/office/drawing/2014/main" id="{AE923F9B-7303-5F31-804F-2664C6ECA1D4}"/>
              </a:ext>
            </a:extLst>
          </p:cNvPr>
          <p:cNvSpPr>
            <a:spLocks noGrp="1" noRot="1" noChangeAspect="1" noChangeArrowheads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59395" name="Notes Placeholder 2">
            <a:extLst>
              <a:ext uri="{FF2B5EF4-FFF2-40B4-BE49-F238E27FC236}">
                <a16:creationId xmlns:a16="http://schemas.microsoft.com/office/drawing/2014/main" id="{241DEA4A-40F5-CFE7-A112-1088A1A0CB6E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ja-JP" altLang="en-US" dirty="0">
              <a:cs typeface="Arial" panose="020B0604020202020204" pitchFamily="34" charset="0"/>
            </a:endParaRPr>
          </a:p>
          <a:p>
            <a:endParaRPr lang="ja-JP" altLang="en-US" dirty="0"/>
          </a:p>
        </p:txBody>
      </p:sp>
      <p:sp>
        <p:nvSpPr>
          <p:cNvPr id="59396" name="Slide Number Placeholder 3">
            <a:extLst>
              <a:ext uri="{FF2B5EF4-FFF2-40B4-BE49-F238E27FC236}">
                <a16:creationId xmlns:a16="http://schemas.microsoft.com/office/drawing/2014/main" id="{7F8010BA-0BD1-54EE-2578-F3A677269D47}"/>
              </a:ext>
            </a:extLst>
          </p:cNvPr>
          <p:cNvSpPr>
            <a:spLocks noGrp="1" noChangeArrowheads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FB21D460-E1C5-47F8-9B61-DACD4C379470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3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394" name="Slide Image Placeholder 1">
            <a:extLst>
              <a:ext uri="{FF2B5EF4-FFF2-40B4-BE49-F238E27FC236}">
                <a16:creationId xmlns:a16="http://schemas.microsoft.com/office/drawing/2014/main" id="{AE923F9B-7303-5F31-804F-2664C6ECA1D4}"/>
              </a:ext>
            </a:extLst>
          </p:cNvPr>
          <p:cNvSpPr>
            <a:spLocks noGrp="1" noRot="1" noChangeAspect="1" noChangeArrowheads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59395" name="Notes Placeholder 2">
            <a:extLst>
              <a:ext uri="{FF2B5EF4-FFF2-40B4-BE49-F238E27FC236}">
                <a16:creationId xmlns:a16="http://schemas.microsoft.com/office/drawing/2014/main" id="{241DEA4A-40F5-CFE7-A112-1088A1A0CB6E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ja-JP" altLang="en-US" dirty="0">
              <a:cs typeface="Arial" panose="020B0604020202020204" pitchFamily="34" charset="0"/>
            </a:endParaRPr>
          </a:p>
          <a:p>
            <a:endParaRPr lang="ja-JP" altLang="en-US" dirty="0"/>
          </a:p>
        </p:txBody>
      </p:sp>
      <p:sp>
        <p:nvSpPr>
          <p:cNvPr id="59396" name="Slide Number Placeholder 3">
            <a:extLst>
              <a:ext uri="{FF2B5EF4-FFF2-40B4-BE49-F238E27FC236}">
                <a16:creationId xmlns:a16="http://schemas.microsoft.com/office/drawing/2014/main" id="{7F8010BA-0BD1-54EE-2578-F3A677269D47}"/>
              </a:ext>
            </a:extLst>
          </p:cNvPr>
          <p:cNvSpPr>
            <a:spLocks noGrp="1" noChangeArrowheads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FB21D460-E1C5-47F8-9B61-DACD4C379470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4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394" name="Slide Image Placeholder 1">
            <a:extLst>
              <a:ext uri="{FF2B5EF4-FFF2-40B4-BE49-F238E27FC236}">
                <a16:creationId xmlns:a16="http://schemas.microsoft.com/office/drawing/2014/main" id="{AE923F9B-7303-5F31-804F-2664C6ECA1D4}"/>
              </a:ext>
            </a:extLst>
          </p:cNvPr>
          <p:cNvSpPr>
            <a:spLocks noGrp="1" noRot="1" noChangeAspect="1" noChangeArrowheads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59395" name="Notes Placeholder 2">
            <a:extLst>
              <a:ext uri="{FF2B5EF4-FFF2-40B4-BE49-F238E27FC236}">
                <a16:creationId xmlns:a16="http://schemas.microsoft.com/office/drawing/2014/main" id="{241DEA4A-40F5-CFE7-A112-1088A1A0CB6E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ja-JP" altLang="en-US" dirty="0">
              <a:cs typeface="Arial" panose="020B0604020202020204" pitchFamily="34" charset="0"/>
            </a:endParaRPr>
          </a:p>
          <a:p>
            <a:endParaRPr lang="ja-JP" altLang="en-US" dirty="0"/>
          </a:p>
        </p:txBody>
      </p:sp>
      <p:sp>
        <p:nvSpPr>
          <p:cNvPr id="59396" name="Slide Number Placeholder 3">
            <a:extLst>
              <a:ext uri="{FF2B5EF4-FFF2-40B4-BE49-F238E27FC236}">
                <a16:creationId xmlns:a16="http://schemas.microsoft.com/office/drawing/2014/main" id="{7F8010BA-0BD1-54EE-2578-F3A677269D47}"/>
              </a:ext>
            </a:extLst>
          </p:cNvPr>
          <p:cNvSpPr>
            <a:spLocks noGrp="1" noChangeArrowheads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FB21D460-E1C5-47F8-9B61-DACD4C379470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5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394" name="Slide Image Placeholder 1">
            <a:extLst>
              <a:ext uri="{FF2B5EF4-FFF2-40B4-BE49-F238E27FC236}">
                <a16:creationId xmlns:a16="http://schemas.microsoft.com/office/drawing/2014/main" id="{AE923F9B-7303-5F31-804F-2664C6ECA1D4}"/>
              </a:ext>
            </a:extLst>
          </p:cNvPr>
          <p:cNvSpPr>
            <a:spLocks noGrp="1" noRot="1" noChangeAspect="1" noChangeArrowheads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59395" name="Notes Placeholder 2">
            <a:extLst>
              <a:ext uri="{FF2B5EF4-FFF2-40B4-BE49-F238E27FC236}">
                <a16:creationId xmlns:a16="http://schemas.microsoft.com/office/drawing/2014/main" id="{241DEA4A-40F5-CFE7-A112-1088A1A0CB6E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ja-JP" altLang="en-US" dirty="0">
              <a:cs typeface="Arial" panose="020B0604020202020204" pitchFamily="34" charset="0"/>
            </a:endParaRPr>
          </a:p>
          <a:p>
            <a:endParaRPr lang="ja-JP" altLang="en-US" dirty="0"/>
          </a:p>
        </p:txBody>
      </p:sp>
      <p:sp>
        <p:nvSpPr>
          <p:cNvPr id="59396" name="Slide Number Placeholder 3">
            <a:extLst>
              <a:ext uri="{FF2B5EF4-FFF2-40B4-BE49-F238E27FC236}">
                <a16:creationId xmlns:a16="http://schemas.microsoft.com/office/drawing/2014/main" id="{7F8010BA-0BD1-54EE-2578-F3A677269D47}"/>
              </a:ext>
            </a:extLst>
          </p:cNvPr>
          <p:cNvSpPr>
            <a:spLocks noGrp="1" noChangeArrowheads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FB21D460-E1C5-47F8-9B61-DACD4C379470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6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394" name="Slide Image Placeholder 1">
            <a:extLst>
              <a:ext uri="{FF2B5EF4-FFF2-40B4-BE49-F238E27FC236}">
                <a16:creationId xmlns:a16="http://schemas.microsoft.com/office/drawing/2014/main" id="{AE923F9B-7303-5F31-804F-2664C6ECA1D4}"/>
              </a:ext>
            </a:extLst>
          </p:cNvPr>
          <p:cNvSpPr>
            <a:spLocks noGrp="1" noRot="1" noChangeAspect="1" noChangeArrowheads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59395" name="Notes Placeholder 2">
            <a:extLst>
              <a:ext uri="{FF2B5EF4-FFF2-40B4-BE49-F238E27FC236}">
                <a16:creationId xmlns:a16="http://schemas.microsoft.com/office/drawing/2014/main" id="{241DEA4A-40F5-CFE7-A112-1088A1A0CB6E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ja-JP" altLang="en-US" dirty="0">
              <a:cs typeface="Arial" panose="020B0604020202020204" pitchFamily="34" charset="0"/>
            </a:endParaRPr>
          </a:p>
          <a:p>
            <a:endParaRPr lang="ja-JP" altLang="en-US" dirty="0"/>
          </a:p>
        </p:txBody>
      </p:sp>
      <p:sp>
        <p:nvSpPr>
          <p:cNvPr id="59396" name="Slide Number Placeholder 3">
            <a:extLst>
              <a:ext uri="{FF2B5EF4-FFF2-40B4-BE49-F238E27FC236}">
                <a16:creationId xmlns:a16="http://schemas.microsoft.com/office/drawing/2014/main" id="{7F8010BA-0BD1-54EE-2578-F3A677269D47}"/>
              </a:ext>
            </a:extLst>
          </p:cNvPr>
          <p:cNvSpPr>
            <a:spLocks noGrp="1" noChangeArrowheads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FB21D460-E1C5-47F8-9B61-DACD4C379470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7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394" name="Slide Image Placeholder 1">
            <a:extLst>
              <a:ext uri="{FF2B5EF4-FFF2-40B4-BE49-F238E27FC236}">
                <a16:creationId xmlns:a16="http://schemas.microsoft.com/office/drawing/2014/main" id="{AE923F9B-7303-5F31-804F-2664C6ECA1D4}"/>
              </a:ext>
            </a:extLst>
          </p:cNvPr>
          <p:cNvSpPr>
            <a:spLocks noGrp="1" noRot="1" noChangeAspect="1" noChangeArrowheads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59395" name="Notes Placeholder 2">
            <a:extLst>
              <a:ext uri="{FF2B5EF4-FFF2-40B4-BE49-F238E27FC236}">
                <a16:creationId xmlns:a16="http://schemas.microsoft.com/office/drawing/2014/main" id="{241DEA4A-40F5-CFE7-A112-1088A1A0CB6E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ja-JP" altLang="en-US" dirty="0">
              <a:cs typeface="Arial" panose="020B0604020202020204" pitchFamily="34" charset="0"/>
            </a:endParaRPr>
          </a:p>
          <a:p>
            <a:endParaRPr lang="ja-JP" altLang="en-US" dirty="0"/>
          </a:p>
        </p:txBody>
      </p:sp>
      <p:sp>
        <p:nvSpPr>
          <p:cNvPr id="59396" name="Slide Number Placeholder 3">
            <a:extLst>
              <a:ext uri="{FF2B5EF4-FFF2-40B4-BE49-F238E27FC236}">
                <a16:creationId xmlns:a16="http://schemas.microsoft.com/office/drawing/2014/main" id="{7F8010BA-0BD1-54EE-2578-F3A677269D47}"/>
              </a:ext>
            </a:extLst>
          </p:cNvPr>
          <p:cNvSpPr>
            <a:spLocks noGrp="1" noChangeArrowheads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FB21D460-E1C5-47F8-9B61-DACD4C379470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8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514" name="Slide Image Placeholder 1">
            <a:extLst>
              <a:ext uri="{FF2B5EF4-FFF2-40B4-BE49-F238E27FC236}">
                <a16:creationId xmlns:a16="http://schemas.microsoft.com/office/drawing/2014/main" id="{AF85B1C1-BD06-8A2F-5B30-341B72E045B5}"/>
              </a:ext>
            </a:extLst>
          </p:cNvPr>
          <p:cNvSpPr>
            <a:spLocks noGrp="1" noRot="1" noChangeAspect="1" noChangeArrowheads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64515" name="Notes Placeholder 2">
            <a:extLst>
              <a:ext uri="{FF2B5EF4-FFF2-40B4-BE49-F238E27FC236}">
                <a16:creationId xmlns:a16="http://schemas.microsoft.com/office/drawing/2014/main" id="{8E7F84B4-0122-191B-B135-C76EB8EBE01B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ja-JP" altLang="en-US" dirty="0"/>
          </a:p>
        </p:txBody>
      </p:sp>
      <p:sp>
        <p:nvSpPr>
          <p:cNvPr id="64516" name="Slide Number Placeholder 3">
            <a:extLst>
              <a:ext uri="{FF2B5EF4-FFF2-40B4-BE49-F238E27FC236}">
                <a16:creationId xmlns:a16="http://schemas.microsoft.com/office/drawing/2014/main" id="{D2B2E7EC-3F78-D867-E3B5-69DAA3BF069E}"/>
              </a:ext>
            </a:extLst>
          </p:cNvPr>
          <p:cNvSpPr>
            <a:spLocks noGrp="1" noChangeArrowheads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920F1843-78D5-4B64-AB3A-1904B8232678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9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514" name="Slide Image Placeholder 1">
            <a:extLst>
              <a:ext uri="{FF2B5EF4-FFF2-40B4-BE49-F238E27FC236}">
                <a16:creationId xmlns:a16="http://schemas.microsoft.com/office/drawing/2014/main" id="{AF85B1C1-BD06-8A2F-5B30-341B72E045B5}"/>
              </a:ext>
            </a:extLst>
          </p:cNvPr>
          <p:cNvSpPr>
            <a:spLocks noGrp="1" noRot="1" noChangeAspect="1" noChangeArrowheads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64515" name="Notes Placeholder 2">
            <a:extLst>
              <a:ext uri="{FF2B5EF4-FFF2-40B4-BE49-F238E27FC236}">
                <a16:creationId xmlns:a16="http://schemas.microsoft.com/office/drawing/2014/main" id="{8E7F84B4-0122-191B-B135-C76EB8EBE01B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ja-JP" altLang="en-US" dirty="0"/>
          </a:p>
        </p:txBody>
      </p:sp>
      <p:sp>
        <p:nvSpPr>
          <p:cNvPr id="64516" name="Slide Number Placeholder 3">
            <a:extLst>
              <a:ext uri="{FF2B5EF4-FFF2-40B4-BE49-F238E27FC236}">
                <a16:creationId xmlns:a16="http://schemas.microsoft.com/office/drawing/2014/main" id="{D2B2E7EC-3F78-D867-E3B5-69DAA3BF069E}"/>
              </a:ext>
            </a:extLst>
          </p:cNvPr>
          <p:cNvSpPr>
            <a:spLocks noGrp="1" noChangeArrowheads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920F1843-78D5-4B64-AB3A-1904B8232678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0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85220837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914400" y="2130430"/>
            <a:ext cx="10363200" cy="147002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37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5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9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1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3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7F4E6DA-E745-35F7-89E6-E347AD3BFA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fld id="{0A8E4F68-7FDB-4AF1-A458-49350E626BD4}" type="datetimeFigureOut">
              <a:rPr lang="ja-JP" altLang="en-US"/>
              <a:pPr>
                <a:defRPr/>
              </a:pPr>
              <a:t>2024/2/13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2C18907-761F-6FC5-8304-56D2032FC6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02FE326-E982-2801-A4E4-A9156243B5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eaLnBrk="0" hangingPunct="0">
              <a:defRPr>
                <a:latin typeface="Arial" panose="020B0604020202020204" pitchFamily="34" charset="0"/>
              </a:defRPr>
            </a:lvl1pPr>
          </a:lstStyle>
          <a:p>
            <a:pPr>
              <a:defRPr/>
            </a:pPr>
            <a:fld id="{48BD2DC3-9F44-4BBC-940B-EB31790CBB4D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6874905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7202FE0-32B1-39D0-DE26-A9ADCB5D74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fld id="{8A7027FF-EFB2-44B2-93F1-99759ADDC15A}" type="datetimeFigureOut">
              <a:rPr lang="ja-JP" altLang="en-US"/>
              <a:pPr>
                <a:defRPr/>
              </a:pPr>
              <a:t>2024/2/13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8668AA3-3BE3-38B7-47FE-AF30694E07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8CC5624-9FAF-E6D6-80C3-2CF57C59CD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eaLnBrk="0" hangingPunct="0">
              <a:defRPr>
                <a:latin typeface="Arial" panose="020B0604020202020204" pitchFamily="34" charset="0"/>
              </a:defRPr>
            </a:lvl1pPr>
          </a:lstStyle>
          <a:p>
            <a:pPr>
              <a:defRPr/>
            </a:pPr>
            <a:fld id="{0D1F98D0-D753-492B-9E0E-18859E771A3B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7044439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839200" y="274643"/>
            <a:ext cx="2743200" cy="5851525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609600" y="274643"/>
            <a:ext cx="8026400" cy="5851525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0A724C0-BFD7-31A4-7A9A-5C641C9250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fld id="{C450CAE5-67FC-4D2C-AC67-4047EA5BC620}" type="datetimeFigureOut">
              <a:rPr lang="ja-JP" altLang="en-US"/>
              <a:pPr>
                <a:defRPr/>
              </a:pPr>
              <a:t>2024/2/13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5F82656-5269-F060-AFB3-86477F9419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8B19F98-D886-4C95-963B-91128151A3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eaLnBrk="0" hangingPunct="0">
              <a:defRPr>
                <a:latin typeface="Arial" panose="020B0604020202020204" pitchFamily="34" charset="0"/>
              </a:defRPr>
            </a:lvl1pPr>
          </a:lstStyle>
          <a:p>
            <a:pPr>
              <a:defRPr/>
            </a:pPr>
            <a:fld id="{D5277312-F62B-420D-A892-50C91787E62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470561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136A464-8339-4FD0-FD13-29669F18DD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fld id="{1E68D03D-FF39-45F9-9B25-AF842284E23D}" type="datetimeFigureOut">
              <a:rPr lang="ja-JP" altLang="en-US"/>
              <a:pPr>
                <a:defRPr/>
              </a:pPr>
              <a:t>2024/2/13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E83DC29-53D2-B0CF-36E9-7055D48B01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187E2C9-CEEB-5A6B-010B-53EC4341E5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eaLnBrk="0" hangingPunct="0">
              <a:defRPr>
                <a:latin typeface="Arial" panose="020B0604020202020204" pitchFamily="34" charset="0"/>
              </a:defRPr>
            </a:lvl1pPr>
          </a:lstStyle>
          <a:p>
            <a:pPr>
              <a:defRPr/>
            </a:pPr>
            <a:fld id="{F672FC40-447F-4F51-9AF6-13875E8DF6E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2891359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963084" y="4406905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89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37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131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581612F-4D65-55AA-C855-0B871F0D8E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fld id="{5AD90DBB-7F35-4357-A384-6CE8F95DF3C9}" type="datetimeFigureOut">
              <a:rPr lang="ja-JP" altLang="en-US"/>
              <a:pPr>
                <a:defRPr/>
              </a:pPr>
              <a:t>2024/2/13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8693BC5-C38E-3ECA-C50F-2A023EB9C6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036F9BB-CABD-0514-A940-6EE449A84B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eaLnBrk="0" hangingPunct="0">
              <a:defRPr>
                <a:latin typeface="Arial" panose="020B0604020202020204" pitchFamily="34" charset="0"/>
              </a:defRPr>
            </a:lvl1pPr>
          </a:lstStyle>
          <a:p>
            <a:pPr>
              <a:defRPr/>
            </a:pPr>
            <a:fld id="{F94750D7-755F-4BFE-B622-B7808FC85166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9588196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609600" y="1600205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97600" y="1600205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3E7E42C-395E-B887-B391-951688288D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fld id="{77C01132-489D-4552-8D3D-B81DED5225E4}" type="datetimeFigureOut">
              <a:rPr lang="ja-JP" altLang="en-US"/>
              <a:pPr>
                <a:defRPr/>
              </a:pPr>
              <a:t>2024/2/13</a:t>
            </a:fld>
            <a:endParaRPr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7B8D8F1-615D-2E08-C868-DE67EF72E5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F9FB90F-3746-D1E1-0433-1A20F77EB4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eaLnBrk="0" hangingPunct="0">
              <a:defRPr>
                <a:latin typeface="Arial" panose="020B0604020202020204" pitchFamily="34" charset="0"/>
              </a:defRPr>
            </a:lvl1pPr>
          </a:lstStyle>
          <a:p>
            <a:pPr>
              <a:defRPr/>
            </a:pPr>
            <a:fld id="{CA4ECC1B-2B49-4986-914F-75D1EDD432CF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137081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93370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93370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49EA90F5-EDE2-EFA7-7ECE-DCA8B9BA61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fld id="{6A8EA810-D6E5-44BC-A0E7-A811DAE8DC10}" type="datetimeFigureOut">
              <a:rPr lang="ja-JP" altLang="en-US"/>
              <a:pPr>
                <a:defRPr/>
              </a:pPr>
              <a:t>2024/2/13</a:t>
            </a:fld>
            <a:endParaRPr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E624C7D3-2897-0D32-8ED4-F78A9A334C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BA1EB67C-A185-7DB7-31F4-0007714352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eaLnBrk="0" hangingPunct="0">
              <a:defRPr>
                <a:latin typeface="Arial" panose="020B0604020202020204" pitchFamily="34" charset="0"/>
              </a:defRPr>
            </a:lvl1pPr>
          </a:lstStyle>
          <a:p>
            <a:pPr>
              <a:defRPr/>
            </a:pPr>
            <a:fld id="{369457E3-1C3A-44E5-B1EC-DA998CC4046B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053016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BE9D86AF-F39E-DE4D-1972-B16887D0CA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fld id="{63CFC698-3CEB-4958-AC77-61C4EEA3E956}" type="datetimeFigureOut">
              <a:rPr lang="ja-JP" altLang="en-US"/>
              <a:pPr>
                <a:defRPr/>
              </a:pPr>
              <a:t>2024/2/13</a:t>
            </a:fld>
            <a:endParaRPr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0ADF98AB-C61C-0CFA-ABA9-90E3A041EC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6183E167-3A59-C759-0CC3-BC1B8D0CE9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eaLnBrk="0" hangingPunct="0">
              <a:defRPr>
                <a:latin typeface="Arial" panose="020B0604020202020204" pitchFamily="34" charset="0"/>
              </a:defRPr>
            </a:lvl1pPr>
          </a:lstStyle>
          <a:p>
            <a:pPr>
              <a:defRPr/>
            </a:pPr>
            <a:fld id="{BF01126C-3D25-4444-9FEC-303B67EC15C5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0089325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C9DAF865-D9D8-0DAF-9BAA-5641F981AF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fld id="{89FB0D41-A093-4EAA-B75F-6394C0C2FA9C}" type="datetimeFigureOut">
              <a:rPr lang="ja-JP" altLang="en-US"/>
              <a:pPr>
                <a:defRPr/>
              </a:pPr>
              <a:t>2024/2/13</a:t>
            </a:fld>
            <a:endParaRPr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EFE3A2AB-7225-E02C-9B7B-61180958CE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B7CAE267-BDE7-D9B3-1A40-3D1A47B438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eaLnBrk="0" hangingPunct="0">
              <a:defRPr>
                <a:latin typeface="Arial" panose="020B0604020202020204" pitchFamily="34" charset="0"/>
              </a:defRPr>
            </a:lvl1pPr>
          </a:lstStyle>
          <a:p>
            <a:pPr>
              <a:defRPr/>
            </a:pPr>
            <a:fld id="{D6BFF13A-9F48-42B5-A1A6-EB5281602E8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8008874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09603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4766733" y="273055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609603" y="1435103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7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1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35E0F46-E608-CE4C-A1A5-BC9E07B324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fld id="{5B107569-20DB-413E-AB2E-3C3A1B5DBC94}" type="datetimeFigureOut">
              <a:rPr lang="ja-JP" altLang="en-US"/>
              <a:pPr>
                <a:defRPr/>
              </a:pPr>
              <a:t>2024/2/13</a:t>
            </a:fld>
            <a:endParaRPr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EA9089E-B983-BC29-73F7-A83D74F4A4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4B4F61D-A884-015C-46B6-AF28E6A447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eaLnBrk="0" hangingPunct="0">
              <a:defRPr>
                <a:latin typeface="Arial" panose="020B0604020202020204" pitchFamily="34" charset="0"/>
              </a:defRPr>
            </a:lvl1pPr>
          </a:lstStyle>
          <a:p>
            <a:pPr>
              <a:defRPr/>
            </a:pPr>
            <a:fld id="{C2496869-E1E1-4F4F-9908-A4BF6D33F79F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7801577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7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1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7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1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0C971D3-2CD3-BC6E-EF06-60465C1720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fld id="{DB95304F-9F3A-4779-8CA2-C92E67292FA9}" type="datetimeFigureOut">
              <a:rPr lang="ja-JP" altLang="en-US"/>
              <a:pPr>
                <a:defRPr/>
              </a:pPr>
              <a:t>2024/2/13</a:t>
            </a:fld>
            <a:endParaRPr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B77F925-0626-1BC6-FFC8-4D6DE5C03C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31AB5A6-461B-52EB-14EF-B6D3BEE7F1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eaLnBrk="0" hangingPunct="0">
              <a:defRPr>
                <a:latin typeface="Arial" panose="020B0604020202020204" pitchFamily="34" charset="0"/>
              </a:defRPr>
            </a:lvl1pPr>
          </a:lstStyle>
          <a:p>
            <a:pPr>
              <a:defRPr/>
            </a:pPr>
            <a:fld id="{ECD5D206-E4BD-4BFB-B684-A2A2E92B02D5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7145666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ー 1">
            <a:extLst>
              <a:ext uri="{FF2B5EF4-FFF2-40B4-BE49-F238E27FC236}">
                <a16:creationId xmlns:a16="http://schemas.microsoft.com/office/drawing/2014/main" id="{2EA24FA0-9968-D6AC-7AD5-5DB30B3C0AF5}"/>
              </a:ext>
            </a:extLst>
          </p:cNvPr>
          <p:cNvSpPr>
            <a:spLocks noGrp="1"/>
          </p:cNvSpPr>
          <p:nvPr>
            <p:ph type="title"/>
          </p:nvPr>
        </p:nvSpPr>
        <p:spPr bwMode="auto">
          <a:xfrm>
            <a:off x="609600" y="274638"/>
            <a:ext cx="109728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ー タイトルの書式設定</a:t>
            </a:r>
          </a:p>
        </p:txBody>
      </p:sp>
      <p:sp>
        <p:nvSpPr>
          <p:cNvPr id="1027" name="テキスト プレースホルダー 2">
            <a:extLst>
              <a:ext uri="{FF2B5EF4-FFF2-40B4-BE49-F238E27FC236}">
                <a16:creationId xmlns:a16="http://schemas.microsoft.com/office/drawing/2014/main" id="{3E9927DA-8078-AAB0-49D7-DB82B35A09EC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xfrm>
            <a:off x="609600" y="1600200"/>
            <a:ext cx="109728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73D7998-E922-DF0D-7ED2-002C3188030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09600" y="6356350"/>
            <a:ext cx="28448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solidFill>
                  <a:srgbClr val="898989"/>
                </a:solidFill>
                <a:latin typeface="Calibri" pitchFamily="34" charset="0"/>
                <a:ea typeface="ＭＳ Ｐゴシック" panose="020B0600070205080204" pitchFamily="34" charset="-128"/>
              </a:defRPr>
            </a:lvl1pPr>
          </a:lstStyle>
          <a:p>
            <a:pPr>
              <a:defRPr/>
            </a:pPr>
            <a:fld id="{38FFB841-94FC-4D13-8D4A-881E0C1BA1F7}" type="datetimeFigureOut">
              <a:rPr lang="ja-JP" altLang="en-US"/>
              <a:pPr>
                <a:defRPr/>
              </a:pPr>
              <a:t>2024/2/13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0FDE345-93BB-0277-6A41-1681D57C929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165600" y="6356350"/>
            <a:ext cx="38608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eaLnBrk="1" hangingPunct="1">
              <a:defRPr sz="1200">
                <a:solidFill>
                  <a:srgbClr val="898989"/>
                </a:solidFill>
                <a:latin typeface="Calibri" pitchFamily="34" charset="0"/>
                <a:ea typeface="ＭＳ Ｐゴシック" panose="020B0600070205080204" pitchFamily="34" charset="-128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4006E4A-4CEC-6058-A1C7-BD801ED0EC3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737600" y="6356350"/>
            <a:ext cx="28448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solidFill>
                  <a:srgbClr val="898989"/>
                </a:solidFill>
                <a:latin typeface="Calibri" panose="020F0502020204030204" pitchFamily="34" charset="0"/>
              </a:defRPr>
            </a:lvl1pPr>
          </a:lstStyle>
          <a:p>
            <a:pPr>
              <a:defRPr/>
            </a:pPr>
            <a:fld id="{31BBD180-B25F-4BEA-9405-FB405435755A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7020955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anose="020F0502020204030204" pitchFamily="34" charset="0"/>
          <a:ea typeface="ＭＳ Ｐゴシック" panose="020B0600070205080204" pitchFamily="50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anose="020F0502020204030204" pitchFamily="34" charset="0"/>
          <a:ea typeface="ＭＳ Ｐゴシック" panose="020B0600070205080204" pitchFamily="50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anose="020F0502020204030204" pitchFamily="34" charset="0"/>
          <a:ea typeface="ＭＳ Ｐゴシック" panose="020B0600070205080204" pitchFamily="50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anose="020F0502020204030204" pitchFamily="34" charset="0"/>
          <a:ea typeface="ＭＳ Ｐゴシック" panose="020B0600070205080204" pitchFamily="50" charset="-128"/>
        </a:defRPr>
      </a:lvl5pPr>
      <a:lvl6pPr marL="457189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anose="020F0502020204030204" pitchFamily="34" charset="0"/>
          <a:ea typeface="ＭＳ Ｐゴシック" panose="020B0600070205080204" pitchFamily="50" charset="-128"/>
        </a:defRPr>
      </a:lvl6pPr>
      <a:lvl7pPr marL="914377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anose="020F0502020204030204" pitchFamily="34" charset="0"/>
          <a:ea typeface="ＭＳ Ｐゴシック" panose="020B0600070205080204" pitchFamily="50" charset="-128"/>
        </a:defRPr>
      </a:lvl7pPr>
      <a:lvl8pPr marL="1371566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anose="020F0502020204030204" pitchFamily="34" charset="0"/>
          <a:ea typeface="ＭＳ Ｐゴシック" panose="020B0600070205080204" pitchFamily="50" charset="-128"/>
        </a:defRPr>
      </a:lvl8pPr>
      <a:lvl9pPr marL="1828754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anose="020F0502020204030204" pitchFamily="34" charset="0"/>
          <a:ea typeface="ＭＳ Ｐゴシック" panose="020B0600070205080204" pitchFamily="50" charset="-128"/>
        </a:defRPr>
      </a:lvl9pPr>
    </p:titleStyle>
    <p:bodyStyle>
      <a:lvl1pPr marL="341313" indent="-341313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1363" indent="-284163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1413" indent="-227013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598613" indent="-227013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5813" indent="-227013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7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7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4" indent="-228594" algn="l" defTabSz="914377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7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7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1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f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tiff"/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228" name="Rectangle 7">
            <a:extLst>
              <a:ext uri="{FF2B5EF4-FFF2-40B4-BE49-F238E27FC236}">
                <a16:creationId xmlns:a16="http://schemas.microsoft.com/office/drawing/2014/main" id="{DE77173A-AC2A-88BA-5819-7C20D95E24F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74931" y="762095"/>
            <a:ext cx="66236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rPr>
              <a:t>γ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H2AX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52229" name="Rectangle 8">
            <a:extLst>
              <a:ext uri="{FF2B5EF4-FFF2-40B4-BE49-F238E27FC236}">
                <a16:creationId xmlns:a16="http://schemas.microsoft.com/office/drawing/2014/main" id="{09A3A6AF-DC83-603E-5C93-546AE7D7409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62251" y="3450925"/>
            <a:ext cx="64793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β-actin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52231" name="Rectangle 10">
            <a:extLst>
              <a:ext uri="{FF2B5EF4-FFF2-40B4-BE49-F238E27FC236}">
                <a16:creationId xmlns:a16="http://schemas.microsoft.com/office/drawing/2014/main" id="{1FD090C7-022D-D6D8-1B08-87EC798E18BE}"/>
              </a:ext>
            </a:extLst>
          </p:cNvPr>
          <p:cNvSpPr>
            <a:spLocks noChangeArrowheads="1"/>
          </p:cNvSpPr>
          <p:nvPr/>
        </p:nvSpPr>
        <p:spPr bwMode="auto">
          <a:xfrm rot="18900000">
            <a:off x="5799270" y="348851"/>
            <a:ext cx="87788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52232" name="Rectangle 11">
            <a:extLst>
              <a:ext uri="{FF2B5EF4-FFF2-40B4-BE49-F238E27FC236}">
                <a16:creationId xmlns:a16="http://schemas.microsoft.com/office/drawing/2014/main" id="{AD21C808-371A-F86F-BBCA-8E5339CF88DD}"/>
              </a:ext>
            </a:extLst>
          </p:cNvPr>
          <p:cNvSpPr>
            <a:spLocks noChangeArrowheads="1"/>
          </p:cNvSpPr>
          <p:nvPr/>
        </p:nvSpPr>
        <p:spPr bwMode="auto">
          <a:xfrm rot="18900000">
            <a:off x="6216782" y="272651"/>
            <a:ext cx="104298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smoking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pic>
        <p:nvPicPr>
          <p:cNvPr id="2" name="Picture 18">
            <a:extLst>
              <a:ext uri="{FF2B5EF4-FFF2-40B4-BE49-F238E27FC236}">
                <a16:creationId xmlns:a16="http://schemas.microsoft.com/office/drawing/2014/main" id="{0CB24A5D-77FC-4491-B80A-C09B529A6F06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71" t="267" r="10542" b="-497"/>
          <a:stretch/>
        </p:blipFill>
        <p:spPr bwMode="auto">
          <a:xfrm>
            <a:off x="2169334" y="0"/>
            <a:ext cx="8450318" cy="68737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343A0E6-301C-1C40-57EE-E8AAE8773A72}"/>
              </a:ext>
            </a:extLst>
          </p:cNvPr>
          <p:cNvSpPr txBox="1"/>
          <p:nvPr/>
        </p:nvSpPr>
        <p:spPr>
          <a:xfrm>
            <a:off x="3178328" y="6011363"/>
            <a:ext cx="6924417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Fig. 2  Exposure of normal bronchial epithelial cells to cigarette smoking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 High expression of γH2AX protein observed after 16 weeks of smoking exposure in BEAS2B cells</a:t>
            </a:r>
          </a:p>
        </p:txBody>
      </p:sp>
      <p:sp>
        <p:nvSpPr>
          <p:cNvPr id="5" name="Rectangle 10">
            <a:extLst>
              <a:ext uri="{FF2B5EF4-FFF2-40B4-BE49-F238E27FC236}">
                <a16:creationId xmlns:a16="http://schemas.microsoft.com/office/drawing/2014/main" id="{D5D66422-F331-6854-DD39-1FC26FE4AFA5}"/>
              </a:ext>
            </a:extLst>
          </p:cNvPr>
          <p:cNvSpPr>
            <a:spLocks noChangeArrowheads="1"/>
          </p:cNvSpPr>
          <p:nvPr/>
        </p:nvSpPr>
        <p:spPr bwMode="auto">
          <a:xfrm rot="18900000">
            <a:off x="4140737" y="191194"/>
            <a:ext cx="87788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6" name="Rectangle 11">
            <a:extLst>
              <a:ext uri="{FF2B5EF4-FFF2-40B4-BE49-F238E27FC236}">
                <a16:creationId xmlns:a16="http://schemas.microsoft.com/office/drawing/2014/main" id="{C5AD5A6C-912F-2008-5499-0A548D407994}"/>
              </a:ext>
            </a:extLst>
          </p:cNvPr>
          <p:cNvSpPr>
            <a:spLocks noChangeArrowheads="1"/>
          </p:cNvSpPr>
          <p:nvPr/>
        </p:nvSpPr>
        <p:spPr bwMode="auto">
          <a:xfrm rot="18900000">
            <a:off x="4558249" y="114994"/>
            <a:ext cx="104298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smoking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7" name="Rectangle 7">
            <a:extLst>
              <a:ext uri="{FF2B5EF4-FFF2-40B4-BE49-F238E27FC236}">
                <a16:creationId xmlns:a16="http://schemas.microsoft.com/office/drawing/2014/main" id="{796472BE-78A7-B953-F295-F538FB6C7C5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61905" y="3849108"/>
            <a:ext cx="66236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rPr>
              <a:t>γ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H2AX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2" name="Rectangle 10">
            <a:extLst>
              <a:ext uri="{FF2B5EF4-FFF2-40B4-BE49-F238E27FC236}">
                <a16:creationId xmlns:a16="http://schemas.microsoft.com/office/drawing/2014/main" id="{2DCFFEAE-1874-B31A-585A-806850F21AEC}"/>
              </a:ext>
            </a:extLst>
          </p:cNvPr>
          <p:cNvSpPr>
            <a:spLocks noChangeArrowheads="1"/>
          </p:cNvSpPr>
          <p:nvPr/>
        </p:nvSpPr>
        <p:spPr bwMode="auto">
          <a:xfrm rot="18900000">
            <a:off x="5154784" y="156026"/>
            <a:ext cx="87788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13" name="Rectangle 11">
            <a:extLst>
              <a:ext uri="{FF2B5EF4-FFF2-40B4-BE49-F238E27FC236}">
                <a16:creationId xmlns:a16="http://schemas.microsoft.com/office/drawing/2014/main" id="{363B15BD-E472-C917-0427-33EF0DD11328}"/>
              </a:ext>
            </a:extLst>
          </p:cNvPr>
          <p:cNvSpPr>
            <a:spLocks noChangeArrowheads="1"/>
          </p:cNvSpPr>
          <p:nvPr/>
        </p:nvSpPr>
        <p:spPr bwMode="auto">
          <a:xfrm rot="18900000">
            <a:off x="5572296" y="79826"/>
            <a:ext cx="104298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smoking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4" name="Rectangle 10">
            <a:extLst>
              <a:ext uri="{FF2B5EF4-FFF2-40B4-BE49-F238E27FC236}">
                <a16:creationId xmlns:a16="http://schemas.microsoft.com/office/drawing/2014/main" id="{E7DAF1F5-DEBA-813E-B7C9-8AB167A8B93D}"/>
              </a:ext>
            </a:extLst>
          </p:cNvPr>
          <p:cNvSpPr>
            <a:spLocks noChangeArrowheads="1"/>
          </p:cNvSpPr>
          <p:nvPr/>
        </p:nvSpPr>
        <p:spPr bwMode="auto">
          <a:xfrm rot="18900000">
            <a:off x="5998844" y="173608"/>
            <a:ext cx="87788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15" name="Rectangle 11">
            <a:extLst>
              <a:ext uri="{FF2B5EF4-FFF2-40B4-BE49-F238E27FC236}">
                <a16:creationId xmlns:a16="http://schemas.microsoft.com/office/drawing/2014/main" id="{D2712816-3EAE-ADA2-4C09-7F6C3199F05D}"/>
              </a:ext>
            </a:extLst>
          </p:cNvPr>
          <p:cNvSpPr>
            <a:spLocks noChangeArrowheads="1"/>
          </p:cNvSpPr>
          <p:nvPr/>
        </p:nvSpPr>
        <p:spPr bwMode="auto">
          <a:xfrm rot="18900000">
            <a:off x="6416356" y="97408"/>
            <a:ext cx="104298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smoking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6" name="Rectangle 5">
            <a:extLst>
              <a:ext uri="{FF2B5EF4-FFF2-40B4-BE49-F238E27FC236}">
                <a16:creationId xmlns:a16="http://schemas.microsoft.com/office/drawing/2014/main" id="{4F868022-F6DB-FB16-9EA5-11BF664BA627}"/>
              </a:ext>
            </a:extLst>
          </p:cNvPr>
          <p:cNvSpPr/>
          <p:nvPr/>
        </p:nvSpPr>
        <p:spPr>
          <a:xfrm>
            <a:off x="2993936" y="1195697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25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7" name="Rectangle 6">
            <a:extLst>
              <a:ext uri="{FF2B5EF4-FFF2-40B4-BE49-F238E27FC236}">
                <a16:creationId xmlns:a16="http://schemas.microsoft.com/office/drawing/2014/main" id="{519D8A1B-0C2D-4AB6-FC8F-00C05776CACE}"/>
              </a:ext>
            </a:extLst>
          </p:cNvPr>
          <p:cNvSpPr/>
          <p:nvPr/>
        </p:nvSpPr>
        <p:spPr>
          <a:xfrm>
            <a:off x="2989864" y="1450281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5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8" name="Rectangle 7">
            <a:extLst>
              <a:ext uri="{FF2B5EF4-FFF2-40B4-BE49-F238E27FC236}">
                <a16:creationId xmlns:a16="http://schemas.microsoft.com/office/drawing/2014/main" id="{C1FEB02F-22B1-CB3C-CA01-22AB96EED0FE}"/>
              </a:ext>
            </a:extLst>
          </p:cNvPr>
          <p:cNvSpPr/>
          <p:nvPr/>
        </p:nvSpPr>
        <p:spPr>
          <a:xfrm>
            <a:off x="2989864" y="1718176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0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9" name="Rectangle 8">
            <a:extLst>
              <a:ext uri="{FF2B5EF4-FFF2-40B4-BE49-F238E27FC236}">
                <a16:creationId xmlns:a16="http://schemas.microsoft.com/office/drawing/2014/main" id="{B3DD619A-5FA3-9795-2D12-5BE2FC0005E3}"/>
              </a:ext>
            </a:extLst>
          </p:cNvPr>
          <p:cNvSpPr/>
          <p:nvPr/>
        </p:nvSpPr>
        <p:spPr>
          <a:xfrm>
            <a:off x="3099087" y="2375768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5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0" name="Rectangle 9">
            <a:extLst>
              <a:ext uri="{FF2B5EF4-FFF2-40B4-BE49-F238E27FC236}">
                <a16:creationId xmlns:a16="http://schemas.microsoft.com/office/drawing/2014/main" id="{13F02173-29A8-2330-3446-48AEE3E22780}"/>
              </a:ext>
            </a:extLst>
          </p:cNvPr>
          <p:cNvSpPr/>
          <p:nvPr/>
        </p:nvSpPr>
        <p:spPr>
          <a:xfrm>
            <a:off x="3111115" y="2786445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37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1" name="Rectangle 10">
            <a:extLst>
              <a:ext uri="{FF2B5EF4-FFF2-40B4-BE49-F238E27FC236}">
                <a16:creationId xmlns:a16="http://schemas.microsoft.com/office/drawing/2014/main" id="{6B35776F-996E-C649-B314-A25DD7D418AD}"/>
              </a:ext>
            </a:extLst>
          </p:cNvPr>
          <p:cNvSpPr/>
          <p:nvPr/>
        </p:nvSpPr>
        <p:spPr>
          <a:xfrm>
            <a:off x="3068382" y="3281238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25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2" name="Rectangle 11">
            <a:extLst>
              <a:ext uri="{FF2B5EF4-FFF2-40B4-BE49-F238E27FC236}">
                <a16:creationId xmlns:a16="http://schemas.microsoft.com/office/drawing/2014/main" id="{1F395C5E-3BC0-5181-0EC1-2AF7009851AF}"/>
              </a:ext>
            </a:extLst>
          </p:cNvPr>
          <p:cNvSpPr/>
          <p:nvPr/>
        </p:nvSpPr>
        <p:spPr>
          <a:xfrm>
            <a:off x="3068382" y="3468649"/>
            <a:ext cx="47735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2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3" name="Rectangle 12">
            <a:extLst>
              <a:ext uri="{FF2B5EF4-FFF2-40B4-BE49-F238E27FC236}">
                <a16:creationId xmlns:a16="http://schemas.microsoft.com/office/drawing/2014/main" id="{212FD2D9-8A9F-B882-0135-73A1165CE7E8}"/>
              </a:ext>
            </a:extLst>
          </p:cNvPr>
          <p:cNvSpPr/>
          <p:nvPr/>
        </p:nvSpPr>
        <p:spPr>
          <a:xfrm>
            <a:off x="3100113" y="1995255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75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4" name="Rectangle 14">
            <a:extLst>
              <a:ext uri="{FF2B5EF4-FFF2-40B4-BE49-F238E27FC236}">
                <a16:creationId xmlns:a16="http://schemas.microsoft.com/office/drawing/2014/main" id="{99E4A98A-AE48-8B22-35D7-4802AFD03E38}"/>
              </a:ext>
            </a:extLst>
          </p:cNvPr>
          <p:cNvSpPr/>
          <p:nvPr/>
        </p:nvSpPr>
        <p:spPr>
          <a:xfrm>
            <a:off x="3068381" y="3746757"/>
            <a:ext cx="47735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5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5" name="Rectangle 14">
            <a:extLst>
              <a:ext uri="{FF2B5EF4-FFF2-40B4-BE49-F238E27FC236}">
                <a16:creationId xmlns:a16="http://schemas.microsoft.com/office/drawing/2014/main" id="{7D7927AA-1D77-C492-E1ED-6BC8B4BB877D}"/>
              </a:ext>
            </a:extLst>
          </p:cNvPr>
          <p:cNvSpPr/>
          <p:nvPr/>
        </p:nvSpPr>
        <p:spPr>
          <a:xfrm>
            <a:off x="3068381" y="4131059"/>
            <a:ext cx="47735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3500" name="Picture 13">
            <a:extLst>
              <a:ext uri="{FF2B5EF4-FFF2-40B4-BE49-F238E27FC236}">
                <a16:creationId xmlns:a16="http://schemas.microsoft.com/office/drawing/2014/main" id="{64D641AF-0B10-F26E-7E3D-E93705137493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55" t="-470" r="-293" b="-188"/>
          <a:stretch/>
        </p:blipFill>
        <p:spPr bwMode="auto">
          <a:xfrm>
            <a:off x="2502876" y="70340"/>
            <a:ext cx="9144000" cy="66352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3502" name="Rectangle 16">
            <a:extLst>
              <a:ext uri="{FF2B5EF4-FFF2-40B4-BE49-F238E27FC236}">
                <a16:creationId xmlns:a16="http://schemas.microsoft.com/office/drawing/2014/main" id="{163E4188-36C6-E7E1-6AFC-D43B235796A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83171" y="4565805"/>
            <a:ext cx="64793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rPr>
              <a:t>β-actin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AA252256-661D-43E3-C7DA-31F25B64B6AD}"/>
              </a:ext>
            </a:extLst>
          </p:cNvPr>
          <p:cNvSpPr txBox="1"/>
          <p:nvPr/>
        </p:nvSpPr>
        <p:spPr>
          <a:xfrm>
            <a:off x="2546860" y="5804204"/>
            <a:ext cx="9434084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Fig. 3  Targeting EPPK1 with CRISPR-Cas9 in A549 cells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rPr>
              <a:t>A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rPr>
              <a:t> EPPK1 protein expression in lung adenocarcinoma (LUAD), lung squamous cell carcinoma (LUSC), large cell neuroendocrine carcinoma (LCNEC), and non-small cell lung cancer (NSCLC)</a:t>
            </a:r>
            <a:endParaRPr kumimoji="1" lang="en-US" altLang="ja-JP" sz="12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" name="Rectangle 4">
            <a:extLst>
              <a:ext uri="{FF2B5EF4-FFF2-40B4-BE49-F238E27FC236}">
                <a16:creationId xmlns:a16="http://schemas.microsoft.com/office/drawing/2014/main" id="{781E7F9F-DF2C-D197-011E-4F50B029A8D0}"/>
              </a:ext>
            </a:extLst>
          </p:cNvPr>
          <p:cNvSpPr>
            <a:spLocks noChangeArrowheads="1"/>
          </p:cNvSpPr>
          <p:nvPr/>
        </p:nvSpPr>
        <p:spPr bwMode="auto">
          <a:xfrm rot="18420000">
            <a:off x="3879522" y="603069"/>
            <a:ext cx="118974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H2009 (LUAD)</a:t>
            </a:r>
          </a:p>
        </p:txBody>
      </p:sp>
      <p:sp>
        <p:nvSpPr>
          <p:cNvPr id="3" name="Rectangle 5">
            <a:extLst>
              <a:ext uri="{FF2B5EF4-FFF2-40B4-BE49-F238E27FC236}">
                <a16:creationId xmlns:a16="http://schemas.microsoft.com/office/drawing/2014/main" id="{B544B536-FCF6-1DAA-0A8B-F44D4B7D6BF2}"/>
              </a:ext>
            </a:extLst>
          </p:cNvPr>
          <p:cNvSpPr>
            <a:spLocks noChangeArrowheads="1"/>
          </p:cNvSpPr>
          <p:nvPr/>
        </p:nvSpPr>
        <p:spPr bwMode="auto">
          <a:xfrm rot="18420000">
            <a:off x="4215384" y="515376"/>
            <a:ext cx="142875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549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 (LUAD)</a:t>
            </a:r>
            <a:endParaRPr kumimoji="1" lang="en-US" altLang="ja-JP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4" name="Rectangle 6">
            <a:extLst>
              <a:ext uri="{FF2B5EF4-FFF2-40B4-BE49-F238E27FC236}">
                <a16:creationId xmlns:a16="http://schemas.microsoft.com/office/drawing/2014/main" id="{E50AD32C-7A93-4F6F-C97E-6280C3AC8671}"/>
              </a:ext>
            </a:extLst>
          </p:cNvPr>
          <p:cNvSpPr>
            <a:spLocks noChangeArrowheads="1"/>
          </p:cNvSpPr>
          <p:nvPr/>
        </p:nvSpPr>
        <p:spPr bwMode="auto">
          <a:xfrm rot="18420000">
            <a:off x="4623615" y="610387"/>
            <a:ext cx="118974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H1819 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(LUAD)</a:t>
            </a:r>
            <a:endParaRPr kumimoji="1" lang="en-US" altLang="ja-JP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5" name="Rectangle 7">
            <a:extLst>
              <a:ext uri="{FF2B5EF4-FFF2-40B4-BE49-F238E27FC236}">
                <a16:creationId xmlns:a16="http://schemas.microsoft.com/office/drawing/2014/main" id="{0DD51AE1-DC86-CD7C-02D5-7A2B5F0CFA94}"/>
              </a:ext>
            </a:extLst>
          </p:cNvPr>
          <p:cNvSpPr>
            <a:spLocks noChangeArrowheads="1"/>
          </p:cNvSpPr>
          <p:nvPr/>
        </p:nvSpPr>
        <p:spPr bwMode="auto">
          <a:xfrm rot="18420000">
            <a:off x="5030173" y="635080"/>
            <a:ext cx="113845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Calu3 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(LUAD)</a:t>
            </a:r>
            <a:endParaRPr kumimoji="1" lang="en-US" altLang="ja-JP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6" name="Rectangle 8">
            <a:extLst>
              <a:ext uri="{FF2B5EF4-FFF2-40B4-BE49-F238E27FC236}">
                <a16:creationId xmlns:a16="http://schemas.microsoft.com/office/drawing/2014/main" id="{CFBD30F8-3362-9F89-FA83-A0BD0488CCC5}"/>
              </a:ext>
            </a:extLst>
          </p:cNvPr>
          <p:cNvSpPr>
            <a:spLocks noChangeArrowheads="1"/>
          </p:cNvSpPr>
          <p:nvPr/>
        </p:nvSpPr>
        <p:spPr bwMode="auto">
          <a:xfrm rot="18420000">
            <a:off x="5481423" y="678116"/>
            <a:ext cx="101983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H23 (LUAD)</a:t>
            </a:r>
          </a:p>
        </p:txBody>
      </p:sp>
      <p:sp>
        <p:nvSpPr>
          <p:cNvPr id="7" name="Rectangle 9">
            <a:extLst>
              <a:ext uri="{FF2B5EF4-FFF2-40B4-BE49-F238E27FC236}">
                <a16:creationId xmlns:a16="http://schemas.microsoft.com/office/drawing/2014/main" id="{BFA0804A-68FF-08D3-3FC3-91D3C360778C}"/>
              </a:ext>
            </a:extLst>
          </p:cNvPr>
          <p:cNvSpPr>
            <a:spLocks noChangeArrowheads="1"/>
          </p:cNvSpPr>
          <p:nvPr/>
        </p:nvSpPr>
        <p:spPr bwMode="auto">
          <a:xfrm rot="18420000">
            <a:off x="5826853" y="612236"/>
            <a:ext cx="118974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H1993 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(LUAD)</a:t>
            </a:r>
            <a:endParaRPr kumimoji="1" lang="en-US" altLang="ja-JP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8" name="Rectangle 10">
            <a:extLst>
              <a:ext uri="{FF2B5EF4-FFF2-40B4-BE49-F238E27FC236}">
                <a16:creationId xmlns:a16="http://schemas.microsoft.com/office/drawing/2014/main" id="{1293950F-CFAA-9477-7B38-972C74D7FD5D}"/>
              </a:ext>
            </a:extLst>
          </p:cNvPr>
          <p:cNvSpPr>
            <a:spLocks noChangeArrowheads="1"/>
          </p:cNvSpPr>
          <p:nvPr/>
        </p:nvSpPr>
        <p:spPr bwMode="auto">
          <a:xfrm rot="18420000">
            <a:off x="6197822" y="628817"/>
            <a:ext cx="114807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H226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 (LUSC)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 </a:t>
            </a:r>
          </a:p>
        </p:txBody>
      </p:sp>
      <p:sp>
        <p:nvSpPr>
          <p:cNvPr id="9" name="Rectangle 11">
            <a:extLst>
              <a:ext uri="{FF2B5EF4-FFF2-40B4-BE49-F238E27FC236}">
                <a16:creationId xmlns:a16="http://schemas.microsoft.com/office/drawing/2014/main" id="{CFB7E709-CF1A-F848-D04A-88186B903877}"/>
              </a:ext>
            </a:extLst>
          </p:cNvPr>
          <p:cNvSpPr>
            <a:spLocks noChangeArrowheads="1"/>
          </p:cNvSpPr>
          <p:nvPr/>
        </p:nvSpPr>
        <p:spPr bwMode="auto">
          <a:xfrm rot="18420000">
            <a:off x="6563230" y="598753"/>
            <a:ext cx="121539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H460 (LCNEC)</a:t>
            </a:r>
          </a:p>
        </p:txBody>
      </p:sp>
      <p:sp>
        <p:nvSpPr>
          <p:cNvPr id="10" name="Rectangle 12">
            <a:extLst>
              <a:ext uri="{FF2B5EF4-FFF2-40B4-BE49-F238E27FC236}">
                <a16:creationId xmlns:a16="http://schemas.microsoft.com/office/drawing/2014/main" id="{D104A48A-BCA7-8032-C1E3-83C85093DCEC}"/>
              </a:ext>
            </a:extLst>
          </p:cNvPr>
          <p:cNvSpPr>
            <a:spLocks noChangeArrowheads="1"/>
          </p:cNvSpPr>
          <p:nvPr/>
        </p:nvSpPr>
        <p:spPr bwMode="auto">
          <a:xfrm rot="18420000">
            <a:off x="6925910" y="555631"/>
            <a:ext cx="130035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H1299 (NSCLC)</a:t>
            </a:r>
          </a:p>
        </p:txBody>
      </p:sp>
      <p:sp>
        <p:nvSpPr>
          <p:cNvPr id="21" name="Rectangle 5">
            <a:extLst>
              <a:ext uri="{FF2B5EF4-FFF2-40B4-BE49-F238E27FC236}">
                <a16:creationId xmlns:a16="http://schemas.microsoft.com/office/drawing/2014/main" id="{FAF50EE3-B5D7-FAD0-26A1-0C50E66C436B}"/>
              </a:ext>
            </a:extLst>
          </p:cNvPr>
          <p:cNvSpPr/>
          <p:nvPr/>
        </p:nvSpPr>
        <p:spPr>
          <a:xfrm>
            <a:off x="3103775" y="1178368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46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2" name="Rectangle 6">
            <a:extLst>
              <a:ext uri="{FF2B5EF4-FFF2-40B4-BE49-F238E27FC236}">
                <a16:creationId xmlns:a16="http://schemas.microsoft.com/office/drawing/2014/main" id="{CE8E61E0-2DD6-42DC-B44C-A4E022A1D6A6}"/>
              </a:ext>
            </a:extLst>
          </p:cNvPr>
          <p:cNvSpPr/>
          <p:nvPr/>
        </p:nvSpPr>
        <p:spPr>
          <a:xfrm>
            <a:off x="3131684" y="1675619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268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3" name="Rectangle 7">
            <a:extLst>
              <a:ext uri="{FF2B5EF4-FFF2-40B4-BE49-F238E27FC236}">
                <a16:creationId xmlns:a16="http://schemas.microsoft.com/office/drawing/2014/main" id="{CFCBF4C8-435D-B92F-EECE-13E4242B5BC3}"/>
              </a:ext>
            </a:extLst>
          </p:cNvPr>
          <p:cNvSpPr/>
          <p:nvPr/>
        </p:nvSpPr>
        <p:spPr>
          <a:xfrm>
            <a:off x="3131683" y="1869499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238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4" name="Rectangle 8">
            <a:extLst>
              <a:ext uri="{FF2B5EF4-FFF2-40B4-BE49-F238E27FC236}">
                <a16:creationId xmlns:a16="http://schemas.microsoft.com/office/drawing/2014/main" id="{1D6145EE-8DB2-3786-E5EF-296A39EAA8AD}"/>
              </a:ext>
            </a:extLst>
          </p:cNvPr>
          <p:cNvSpPr/>
          <p:nvPr/>
        </p:nvSpPr>
        <p:spPr>
          <a:xfrm>
            <a:off x="3120895" y="2898492"/>
            <a:ext cx="5522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17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5" name="Rectangle 9">
            <a:extLst>
              <a:ext uri="{FF2B5EF4-FFF2-40B4-BE49-F238E27FC236}">
                <a16:creationId xmlns:a16="http://schemas.microsoft.com/office/drawing/2014/main" id="{DF9E8C4D-FF37-4AE7-4836-71EF10451E1E}"/>
              </a:ext>
            </a:extLst>
          </p:cNvPr>
          <p:cNvSpPr/>
          <p:nvPr/>
        </p:nvSpPr>
        <p:spPr>
          <a:xfrm>
            <a:off x="3198638" y="3233388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7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6" name="Rectangle 10">
            <a:extLst>
              <a:ext uri="{FF2B5EF4-FFF2-40B4-BE49-F238E27FC236}">
                <a16:creationId xmlns:a16="http://schemas.microsoft.com/office/drawing/2014/main" id="{6356C274-4AFE-9DEF-B7E8-6FC757F5E636}"/>
              </a:ext>
            </a:extLst>
          </p:cNvPr>
          <p:cNvSpPr/>
          <p:nvPr/>
        </p:nvSpPr>
        <p:spPr>
          <a:xfrm>
            <a:off x="3195805" y="3896956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55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7" name="Rectangle 11">
            <a:extLst>
              <a:ext uri="{FF2B5EF4-FFF2-40B4-BE49-F238E27FC236}">
                <a16:creationId xmlns:a16="http://schemas.microsoft.com/office/drawing/2014/main" id="{5F2CB4D0-F27F-3C77-82ED-66E565C31B2A}"/>
              </a:ext>
            </a:extLst>
          </p:cNvPr>
          <p:cNvSpPr/>
          <p:nvPr/>
        </p:nvSpPr>
        <p:spPr>
          <a:xfrm>
            <a:off x="3213390" y="4548648"/>
            <a:ext cx="47735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4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8" name="Rectangle 12">
            <a:extLst>
              <a:ext uri="{FF2B5EF4-FFF2-40B4-BE49-F238E27FC236}">
                <a16:creationId xmlns:a16="http://schemas.microsoft.com/office/drawing/2014/main" id="{75B7755E-E7B1-5F40-402A-E27271DBD498}"/>
              </a:ext>
            </a:extLst>
          </p:cNvPr>
          <p:cNvSpPr/>
          <p:nvPr/>
        </p:nvSpPr>
        <p:spPr>
          <a:xfrm>
            <a:off x="3103775" y="2631177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7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9" name="Rectangle 14">
            <a:extLst>
              <a:ext uri="{FF2B5EF4-FFF2-40B4-BE49-F238E27FC236}">
                <a16:creationId xmlns:a16="http://schemas.microsoft.com/office/drawing/2014/main" id="{409F1D8B-B4DC-F368-7AB9-9FC47F30CDDD}"/>
              </a:ext>
            </a:extLst>
          </p:cNvPr>
          <p:cNvSpPr/>
          <p:nvPr/>
        </p:nvSpPr>
        <p:spPr>
          <a:xfrm>
            <a:off x="3250263" y="5072394"/>
            <a:ext cx="47735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3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9351648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図 9">
            <a:extLst>
              <a:ext uri="{FF2B5EF4-FFF2-40B4-BE49-F238E27FC236}">
                <a16:creationId xmlns:a16="http://schemas.microsoft.com/office/drawing/2014/main" id="{1D7D0622-5E66-06FA-8DBB-781D60482F2F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95" t="-563" r="-407" b="-618"/>
          <a:stretch/>
        </p:blipFill>
        <p:spPr>
          <a:xfrm>
            <a:off x="1400908" y="0"/>
            <a:ext cx="8745415" cy="6940062"/>
          </a:xfrm>
          <a:prstGeom prst="rect">
            <a:avLst/>
          </a:prstGeom>
        </p:spPr>
      </p:pic>
      <p:sp>
        <p:nvSpPr>
          <p:cNvPr id="4" name="Rectangle 6">
            <a:extLst>
              <a:ext uri="{FF2B5EF4-FFF2-40B4-BE49-F238E27FC236}">
                <a16:creationId xmlns:a16="http://schemas.microsoft.com/office/drawing/2014/main" id="{ED8CECC8-4841-FB15-423F-4F9A365EBA5E}"/>
              </a:ext>
            </a:extLst>
          </p:cNvPr>
          <p:cNvSpPr>
            <a:spLocks noChangeArrowheads="1"/>
          </p:cNvSpPr>
          <p:nvPr/>
        </p:nvSpPr>
        <p:spPr bwMode="auto">
          <a:xfrm rot="18420000">
            <a:off x="5279381" y="216895"/>
            <a:ext cx="80823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549</a:t>
            </a:r>
            <a:r>
              <a:rPr kumimoji="1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KO</a:t>
            </a:r>
          </a:p>
        </p:txBody>
      </p:sp>
      <p:sp>
        <p:nvSpPr>
          <p:cNvPr id="5" name="Rectangle 9">
            <a:extLst>
              <a:ext uri="{FF2B5EF4-FFF2-40B4-BE49-F238E27FC236}">
                <a16:creationId xmlns:a16="http://schemas.microsoft.com/office/drawing/2014/main" id="{BEF35982-6330-7D5A-D73E-358618D4245A}"/>
              </a:ext>
            </a:extLst>
          </p:cNvPr>
          <p:cNvSpPr>
            <a:spLocks noChangeArrowheads="1"/>
          </p:cNvSpPr>
          <p:nvPr/>
        </p:nvSpPr>
        <p:spPr bwMode="auto">
          <a:xfrm rot="18420000">
            <a:off x="4865938" y="229423"/>
            <a:ext cx="82586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549 WT</a:t>
            </a:r>
          </a:p>
        </p:txBody>
      </p:sp>
      <p:sp>
        <p:nvSpPr>
          <p:cNvPr id="9" name="Rectangle 10">
            <a:extLst>
              <a:ext uri="{FF2B5EF4-FFF2-40B4-BE49-F238E27FC236}">
                <a16:creationId xmlns:a16="http://schemas.microsoft.com/office/drawing/2014/main" id="{05855024-D36A-84E7-C1CF-602FEA1623F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13190" y="999619"/>
            <a:ext cx="67999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EPPK1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236FCF04-6281-6C16-C393-449410E3FF75}"/>
              </a:ext>
            </a:extLst>
          </p:cNvPr>
          <p:cNvSpPr txBox="1"/>
          <p:nvPr/>
        </p:nvSpPr>
        <p:spPr>
          <a:xfrm>
            <a:off x="3076986" y="6468422"/>
            <a:ext cx="500842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+mn-cs"/>
              </a:rPr>
              <a:t>b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+mn-cs"/>
              </a:rPr>
              <a:t> Western blotting results show that EPPK1 was knocked out in A549</a:t>
            </a:r>
          </a:p>
        </p:txBody>
      </p:sp>
      <p:sp>
        <p:nvSpPr>
          <p:cNvPr id="20" name="Rectangle 5">
            <a:extLst>
              <a:ext uri="{FF2B5EF4-FFF2-40B4-BE49-F238E27FC236}">
                <a16:creationId xmlns:a16="http://schemas.microsoft.com/office/drawing/2014/main" id="{D9E7E5C3-4E9D-709F-2E7E-E8987461EF48}"/>
              </a:ext>
            </a:extLst>
          </p:cNvPr>
          <p:cNvSpPr/>
          <p:nvPr/>
        </p:nvSpPr>
        <p:spPr>
          <a:xfrm>
            <a:off x="3619591" y="885292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46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1" name="Rectangle 6">
            <a:extLst>
              <a:ext uri="{FF2B5EF4-FFF2-40B4-BE49-F238E27FC236}">
                <a16:creationId xmlns:a16="http://schemas.microsoft.com/office/drawing/2014/main" id="{F17694AB-0C5A-C8EA-FE44-498E5D662743}"/>
              </a:ext>
            </a:extLst>
          </p:cNvPr>
          <p:cNvSpPr/>
          <p:nvPr/>
        </p:nvSpPr>
        <p:spPr>
          <a:xfrm>
            <a:off x="3647500" y="1458743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268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2" name="Rectangle 7">
            <a:extLst>
              <a:ext uri="{FF2B5EF4-FFF2-40B4-BE49-F238E27FC236}">
                <a16:creationId xmlns:a16="http://schemas.microsoft.com/office/drawing/2014/main" id="{6B911C2F-EEDC-AD31-3E36-3A8B850B3533}"/>
              </a:ext>
            </a:extLst>
          </p:cNvPr>
          <p:cNvSpPr/>
          <p:nvPr/>
        </p:nvSpPr>
        <p:spPr>
          <a:xfrm>
            <a:off x="3647499" y="1652623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238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3" name="Rectangle 8">
            <a:extLst>
              <a:ext uri="{FF2B5EF4-FFF2-40B4-BE49-F238E27FC236}">
                <a16:creationId xmlns:a16="http://schemas.microsoft.com/office/drawing/2014/main" id="{53247645-2DE6-D50B-0DF9-554A2D915BA3}"/>
              </a:ext>
            </a:extLst>
          </p:cNvPr>
          <p:cNvSpPr/>
          <p:nvPr/>
        </p:nvSpPr>
        <p:spPr>
          <a:xfrm>
            <a:off x="3636711" y="2681616"/>
            <a:ext cx="5522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17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4" name="Rectangle 9">
            <a:extLst>
              <a:ext uri="{FF2B5EF4-FFF2-40B4-BE49-F238E27FC236}">
                <a16:creationId xmlns:a16="http://schemas.microsoft.com/office/drawing/2014/main" id="{4D11BEF6-388E-7713-1330-C30080001D95}"/>
              </a:ext>
            </a:extLst>
          </p:cNvPr>
          <p:cNvSpPr/>
          <p:nvPr/>
        </p:nvSpPr>
        <p:spPr>
          <a:xfrm>
            <a:off x="3714454" y="3016512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7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5" name="Rectangle 10">
            <a:extLst>
              <a:ext uri="{FF2B5EF4-FFF2-40B4-BE49-F238E27FC236}">
                <a16:creationId xmlns:a16="http://schemas.microsoft.com/office/drawing/2014/main" id="{AA421A17-6E88-AE6E-6709-2E862DC0882A}"/>
              </a:ext>
            </a:extLst>
          </p:cNvPr>
          <p:cNvSpPr/>
          <p:nvPr/>
        </p:nvSpPr>
        <p:spPr>
          <a:xfrm>
            <a:off x="3711621" y="3680080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55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6" name="Rectangle 11">
            <a:extLst>
              <a:ext uri="{FF2B5EF4-FFF2-40B4-BE49-F238E27FC236}">
                <a16:creationId xmlns:a16="http://schemas.microsoft.com/office/drawing/2014/main" id="{D06F64C5-11D7-E3A4-4C3E-60B1B824DAD9}"/>
              </a:ext>
            </a:extLst>
          </p:cNvPr>
          <p:cNvSpPr/>
          <p:nvPr/>
        </p:nvSpPr>
        <p:spPr>
          <a:xfrm>
            <a:off x="3729206" y="4331772"/>
            <a:ext cx="47735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4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7" name="Rectangle 12">
            <a:extLst>
              <a:ext uri="{FF2B5EF4-FFF2-40B4-BE49-F238E27FC236}">
                <a16:creationId xmlns:a16="http://schemas.microsoft.com/office/drawing/2014/main" id="{B78E70DC-1BCD-EA61-7D0F-1CA8A5DA2BA1}"/>
              </a:ext>
            </a:extLst>
          </p:cNvPr>
          <p:cNvSpPr/>
          <p:nvPr/>
        </p:nvSpPr>
        <p:spPr>
          <a:xfrm>
            <a:off x="3619591" y="2414301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7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8" name="Rectangle 14">
            <a:extLst>
              <a:ext uri="{FF2B5EF4-FFF2-40B4-BE49-F238E27FC236}">
                <a16:creationId xmlns:a16="http://schemas.microsoft.com/office/drawing/2014/main" id="{0FE555E2-295B-14D2-48E6-21BFEC6FFFEF}"/>
              </a:ext>
            </a:extLst>
          </p:cNvPr>
          <p:cNvSpPr/>
          <p:nvPr/>
        </p:nvSpPr>
        <p:spPr>
          <a:xfrm>
            <a:off x="3719186" y="4937579"/>
            <a:ext cx="47735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3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40" name="Rectangle 5">
            <a:extLst>
              <a:ext uri="{FF2B5EF4-FFF2-40B4-BE49-F238E27FC236}">
                <a16:creationId xmlns:a16="http://schemas.microsoft.com/office/drawing/2014/main" id="{BD7C8839-D036-2B0D-1F8B-00A8C44E7190}"/>
              </a:ext>
            </a:extLst>
          </p:cNvPr>
          <p:cNvSpPr/>
          <p:nvPr/>
        </p:nvSpPr>
        <p:spPr>
          <a:xfrm>
            <a:off x="3199090" y="1635312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25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41" name="Rectangle 6">
            <a:extLst>
              <a:ext uri="{FF2B5EF4-FFF2-40B4-BE49-F238E27FC236}">
                <a16:creationId xmlns:a16="http://schemas.microsoft.com/office/drawing/2014/main" id="{A900DF9D-FECC-25BB-35D8-032B3673A2F9}"/>
              </a:ext>
            </a:extLst>
          </p:cNvPr>
          <p:cNvSpPr/>
          <p:nvPr/>
        </p:nvSpPr>
        <p:spPr>
          <a:xfrm>
            <a:off x="3189156" y="2317788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5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42" name="Rectangle 7">
            <a:extLst>
              <a:ext uri="{FF2B5EF4-FFF2-40B4-BE49-F238E27FC236}">
                <a16:creationId xmlns:a16="http://schemas.microsoft.com/office/drawing/2014/main" id="{DDA571BC-077E-3781-BFBC-F7BA5EFF31BB}"/>
              </a:ext>
            </a:extLst>
          </p:cNvPr>
          <p:cNvSpPr/>
          <p:nvPr/>
        </p:nvSpPr>
        <p:spPr>
          <a:xfrm>
            <a:off x="3236048" y="2878760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0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43" name="Rectangle 8">
            <a:extLst>
              <a:ext uri="{FF2B5EF4-FFF2-40B4-BE49-F238E27FC236}">
                <a16:creationId xmlns:a16="http://schemas.microsoft.com/office/drawing/2014/main" id="{C4E523D2-576A-8900-1255-25C3DE9D144D}"/>
              </a:ext>
            </a:extLst>
          </p:cNvPr>
          <p:cNvSpPr/>
          <p:nvPr/>
        </p:nvSpPr>
        <p:spPr>
          <a:xfrm>
            <a:off x="3333548" y="3829429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5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44" name="Rectangle 9">
            <a:extLst>
              <a:ext uri="{FF2B5EF4-FFF2-40B4-BE49-F238E27FC236}">
                <a16:creationId xmlns:a16="http://schemas.microsoft.com/office/drawing/2014/main" id="{571D1C59-91FA-2B6E-2084-A252682BC2FD}"/>
              </a:ext>
            </a:extLst>
          </p:cNvPr>
          <p:cNvSpPr/>
          <p:nvPr/>
        </p:nvSpPr>
        <p:spPr>
          <a:xfrm>
            <a:off x="3357299" y="4626968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37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45" name="Rectangle 10">
            <a:extLst>
              <a:ext uri="{FF2B5EF4-FFF2-40B4-BE49-F238E27FC236}">
                <a16:creationId xmlns:a16="http://schemas.microsoft.com/office/drawing/2014/main" id="{13530685-1934-7BF2-1BF1-AFBC0763D82E}"/>
              </a:ext>
            </a:extLst>
          </p:cNvPr>
          <p:cNvSpPr/>
          <p:nvPr/>
        </p:nvSpPr>
        <p:spPr>
          <a:xfrm>
            <a:off x="3338012" y="5051423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25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46" name="Rectangle 11">
            <a:extLst>
              <a:ext uri="{FF2B5EF4-FFF2-40B4-BE49-F238E27FC236}">
                <a16:creationId xmlns:a16="http://schemas.microsoft.com/office/drawing/2014/main" id="{AFA1B348-C90A-98F3-572C-A3FA17F91FA2}"/>
              </a:ext>
            </a:extLst>
          </p:cNvPr>
          <p:cNvSpPr/>
          <p:nvPr/>
        </p:nvSpPr>
        <p:spPr>
          <a:xfrm>
            <a:off x="3338012" y="5238834"/>
            <a:ext cx="47735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2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47" name="Rectangle 12">
            <a:extLst>
              <a:ext uri="{FF2B5EF4-FFF2-40B4-BE49-F238E27FC236}">
                <a16:creationId xmlns:a16="http://schemas.microsoft.com/office/drawing/2014/main" id="{9E8417C9-E9AF-A5D1-A1E2-F65C59279D95}"/>
              </a:ext>
            </a:extLst>
          </p:cNvPr>
          <p:cNvSpPr/>
          <p:nvPr/>
        </p:nvSpPr>
        <p:spPr>
          <a:xfrm>
            <a:off x="3311128" y="3314101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75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48" name="Rectangle 14">
            <a:extLst>
              <a:ext uri="{FF2B5EF4-FFF2-40B4-BE49-F238E27FC236}">
                <a16:creationId xmlns:a16="http://schemas.microsoft.com/office/drawing/2014/main" id="{2291053B-0753-AE21-2FC7-7EE1E3B41163}"/>
              </a:ext>
            </a:extLst>
          </p:cNvPr>
          <p:cNvSpPr/>
          <p:nvPr/>
        </p:nvSpPr>
        <p:spPr>
          <a:xfrm>
            <a:off x="3314565" y="5434881"/>
            <a:ext cx="47735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5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49" name="Rectangle 14">
            <a:extLst>
              <a:ext uri="{FF2B5EF4-FFF2-40B4-BE49-F238E27FC236}">
                <a16:creationId xmlns:a16="http://schemas.microsoft.com/office/drawing/2014/main" id="{5E9C8DCE-C8CC-9461-2EE7-84764D72DBED}"/>
              </a:ext>
            </a:extLst>
          </p:cNvPr>
          <p:cNvSpPr/>
          <p:nvPr/>
        </p:nvSpPr>
        <p:spPr>
          <a:xfrm>
            <a:off x="3326288" y="5619891"/>
            <a:ext cx="47735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図 10">
            <a:extLst>
              <a:ext uri="{FF2B5EF4-FFF2-40B4-BE49-F238E27FC236}">
                <a16:creationId xmlns:a16="http://schemas.microsoft.com/office/drawing/2014/main" id="{CE69E172-204C-3A9C-9FEF-D3C00EC15674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522" t="-377" r="-438" b="-735"/>
          <a:stretch/>
        </p:blipFill>
        <p:spPr>
          <a:xfrm>
            <a:off x="1570893" y="0"/>
            <a:ext cx="8768862" cy="6934200"/>
          </a:xfrm>
          <a:prstGeom prst="rect">
            <a:avLst/>
          </a:prstGeom>
        </p:spPr>
      </p:pic>
      <p:sp>
        <p:nvSpPr>
          <p:cNvPr id="4" name="Rectangle 6">
            <a:extLst>
              <a:ext uri="{FF2B5EF4-FFF2-40B4-BE49-F238E27FC236}">
                <a16:creationId xmlns:a16="http://schemas.microsoft.com/office/drawing/2014/main" id="{5F2B1A0A-0769-C52F-09A6-90E93506A3F9}"/>
              </a:ext>
            </a:extLst>
          </p:cNvPr>
          <p:cNvSpPr>
            <a:spLocks noChangeArrowheads="1"/>
          </p:cNvSpPr>
          <p:nvPr/>
        </p:nvSpPr>
        <p:spPr bwMode="auto">
          <a:xfrm rot="18420000">
            <a:off x="5689689" y="267594"/>
            <a:ext cx="80823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549</a:t>
            </a:r>
            <a:r>
              <a: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KO</a:t>
            </a:r>
          </a:p>
        </p:txBody>
      </p:sp>
      <p:sp>
        <p:nvSpPr>
          <p:cNvPr id="5" name="Rectangle 9">
            <a:extLst>
              <a:ext uri="{FF2B5EF4-FFF2-40B4-BE49-F238E27FC236}">
                <a16:creationId xmlns:a16="http://schemas.microsoft.com/office/drawing/2014/main" id="{684C9B90-C1F0-FD23-7825-A38B83434D3D}"/>
              </a:ext>
            </a:extLst>
          </p:cNvPr>
          <p:cNvSpPr>
            <a:spLocks noChangeArrowheads="1"/>
          </p:cNvSpPr>
          <p:nvPr/>
        </p:nvSpPr>
        <p:spPr bwMode="auto">
          <a:xfrm rot="18420000">
            <a:off x="5276246" y="280122"/>
            <a:ext cx="82586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549 WT</a:t>
            </a:r>
          </a:p>
        </p:txBody>
      </p:sp>
      <p:sp>
        <p:nvSpPr>
          <p:cNvPr id="9" name="Rectangle 16">
            <a:extLst>
              <a:ext uri="{FF2B5EF4-FFF2-40B4-BE49-F238E27FC236}">
                <a16:creationId xmlns:a16="http://schemas.microsoft.com/office/drawing/2014/main" id="{F3DA73FF-AF63-D193-E3EB-A8A72597912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29804" y="3851116"/>
            <a:ext cx="64793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β-actin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7588817A-8E7E-0BFA-8EFF-3D9062AF51B9}"/>
              </a:ext>
            </a:extLst>
          </p:cNvPr>
          <p:cNvSpPr txBox="1"/>
          <p:nvPr/>
        </p:nvSpPr>
        <p:spPr>
          <a:xfrm>
            <a:off x="3076986" y="6468422"/>
            <a:ext cx="500842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+mn-cs"/>
              </a:rPr>
              <a:t>b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+mn-cs"/>
              </a:rPr>
              <a:t> Western blotting results show that EPPK1 was knocked out in A549</a:t>
            </a:r>
          </a:p>
        </p:txBody>
      </p:sp>
      <p:sp>
        <p:nvSpPr>
          <p:cNvPr id="20" name="Rectangle 5">
            <a:extLst>
              <a:ext uri="{FF2B5EF4-FFF2-40B4-BE49-F238E27FC236}">
                <a16:creationId xmlns:a16="http://schemas.microsoft.com/office/drawing/2014/main" id="{5C9CE36B-7C8A-E43D-5FA4-F78D5CC79387}"/>
              </a:ext>
            </a:extLst>
          </p:cNvPr>
          <p:cNvSpPr/>
          <p:nvPr/>
        </p:nvSpPr>
        <p:spPr>
          <a:xfrm>
            <a:off x="4035760" y="322584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46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1" name="Rectangle 6">
            <a:extLst>
              <a:ext uri="{FF2B5EF4-FFF2-40B4-BE49-F238E27FC236}">
                <a16:creationId xmlns:a16="http://schemas.microsoft.com/office/drawing/2014/main" id="{B0777788-F802-9E07-36B2-BB3FD6AC19CA}"/>
              </a:ext>
            </a:extLst>
          </p:cNvPr>
          <p:cNvSpPr/>
          <p:nvPr/>
        </p:nvSpPr>
        <p:spPr>
          <a:xfrm>
            <a:off x="4063669" y="896035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268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2" name="Rectangle 7">
            <a:extLst>
              <a:ext uri="{FF2B5EF4-FFF2-40B4-BE49-F238E27FC236}">
                <a16:creationId xmlns:a16="http://schemas.microsoft.com/office/drawing/2014/main" id="{99A18A19-A7C9-2CB8-8826-4DFEEF8D2FEF}"/>
              </a:ext>
            </a:extLst>
          </p:cNvPr>
          <p:cNvSpPr/>
          <p:nvPr/>
        </p:nvSpPr>
        <p:spPr>
          <a:xfrm>
            <a:off x="4063668" y="1089915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238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3" name="Rectangle 8">
            <a:extLst>
              <a:ext uri="{FF2B5EF4-FFF2-40B4-BE49-F238E27FC236}">
                <a16:creationId xmlns:a16="http://schemas.microsoft.com/office/drawing/2014/main" id="{326487C1-5385-D22D-2613-39EF55159D6A}"/>
              </a:ext>
            </a:extLst>
          </p:cNvPr>
          <p:cNvSpPr/>
          <p:nvPr/>
        </p:nvSpPr>
        <p:spPr>
          <a:xfrm>
            <a:off x="4058741" y="2077877"/>
            <a:ext cx="5522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17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4" name="Rectangle 9">
            <a:extLst>
              <a:ext uri="{FF2B5EF4-FFF2-40B4-BE49-F238E27FC236}">
                <a16:creationId xmlns:a16="http://schemas.microsoft.com/office/drawing/2014/main" id="{3788CDC5-81BD-DE55-16D8-CE4EAD693F4F}"/>
              </a:ext>
            </a:extLst>
          </p:cNvPr>
          <p:cNvSpPr/>
          <p:nvPr/>
        </p:nvSpPr>
        <p:spPr>
          <a:xfrm>
            <a:off x="4130623" y="2453804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7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5" name="Rectangle 10">
            <a:extLst>
              <a:ext uri="{FF2B5EF4-FFF2-40B4-BE49-F238E27FC236}">
                <a16:creationId xmlns:a16="http://schemas.microsoft.com/office/drawing/2014/main" id="{6E755739-4451-0082-412C-2CAABF7B5711}"/>
              </a:ext>
            </a:extLst>
          </p:cNvPr>
          <p:cNvSpPr/>
          <p:nvPr/>
        </p:nvSpPr>
        <p:spPr>
          <a:xfrm>
            <a:off x="4127790" y="3117372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55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6" name="Rectangle 11">
            <a:extLst>
              <a:ext uri="{FF2B5EF4-FFF2-40B4-BE49-F238E27FC236}">
                <a16:creationId xmlns:a16="http://schemas.microsoft.com/office/drawing/2014/main" id="{7550BC7B-F58D-2CF4-8912-4C5E533EEC3F}"/>
              </a:ext>
            </a:extLst>
          </p:cNvPr>
          <p:cNvSpPr/>
          <p:nvPr/>
        </p:nvSpPr>
        <p:spPr>
          <a:xfrm>
            <a:off x="4145375" y="3769064"/>
            <a:ext cx="47735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4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7" name="Rectangle 12">
            <a:extLst>
              <a:ext uri="{FF2B5EF4-FFF2-40B4-BE49-F238E27FC236}">
                <a16:creationId xmlns:a16="http://schemas.microsoft.com/office/drawing/2014/main" id="{942FA94B-B178-ED2A-0D29-30D5C7BA2FE0}"/>
              </a:ext>
            </a:extLst>
          </p:cNvPr>
          <p:cNvSpPr/>
          <p:nvPr/>
        </p:nvSpPr>
        <p:spPr>
          <a:xfrm>
            <a:off x="4035760" y="1722639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7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8" name="Rectangle 14">
            <a:extLst>
              <a:ext uri="{FF2B5EF4-FFF2-40B4-BE49-F238E27FC236}">
                <a16:creationId xmlns:a16="http://schemas.microsoft.com/office/drawing/2014/main" id="{F3EA7732-CB84-92E5-320B-217346AD5ADB}"/>
              </a:ext>
            </a:extLst>
          </p:cNvPr>
          <p:cNvSpPr/>
          <p:nvPr/>
        </p:nvSpPr>
        <p:spPr>
          <a:xfrm>
            <a:off x="4135355" y="4374871"/>
            <a:ext cx="47735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3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9" name="Rectangle 5">
            <a:extLst>
              <a:ext uri="{FF2B5EF4-FFF2-40B4-BE49-F238E27FC236}">
                <a16:creationId xmlns:a16="http://schemas.microsoft.com/office/drawing/2014/main" id="{C4F1EA96-1FDC-1F07-DA26-DBCC6B5109A3}"/>
              </a:ext>
            </a:extLst>
          </p:cNvPr>
          <p:cNvSpPr/>
          <p:nvPr/>
        </p:nvSpPr>
        <p:spPr>
          <a:xfrm>
            <a:off x="3615259" y="1072604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25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0" name="Rectangle 6">
            <a:extLst>
              <a:ext uri="{FF2B5EF4-FFF2-40B4-BE49-F238E27FC236}">
                <a16:creationId xmlns:a16="http://schemas.microsoft.com/office/drawing/2014/main" id="{42761B03-AF7E-B091-E8D2-162197FE8AC2}"/>
              </a:ext>
            </a:extLst>
          </p:cNvPr>
          <p:cNvSpPr/>
          <p:nvPr/>
        </p:nvSpPr>
        <p:spPr>
          <a:xfrm>
            <a:off x="3605325" y="1755080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5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1" name="Rectangle 7">
            <a:extLst>
              <a:ext uri="{FF2B5EF4-FFF2-40B4-BE49-F238E27FC236}">
                <a16:creationId xmlns:a16="http://schemas.microsoft.com/office/drawing/2014/main" id="{5CB4AC81-DBA1-B801-22E4-F4E96BC72413}"/>
              </a:ext>
            </a:extLst>
          </p:cNvPr>
          <p:cNvSpPr/>
          <p:nvPr/>
        </p:nvSpPr>
        <p:spPr>
          <a:xfrm>
            <a:off x="3652217" y="2316052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0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2" name="Rectangle 8">
            <a:extLst>
              <a:ext uri="{FF2B5EF4-FFF2-40B4-BE49-F238E27FC236}">
                <a16:creationId xmlns:a16="http://schemas.microsoft.com/office/drawing/2014/main" id="{9C7B4F3E-8DD5-5012-6415-F273B353E6C6}"/>
              </a:ext>
            </a:extLst>
          </p:cNvPr>
          <p:cNvSpPr/>
          <p:nvPr/>
        </p:nvSpPr>
        <p:spPr>
          <a:xfrm>
            <a:off x="3749717" y="3266721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5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3" name="Rectangle 9">
            <a:extLst>
              <a:ext uri="{FF2B5EF4-FFF2-40B4-BE49-F238E27FC236}">
                <a16:creationId xmlns:a16="http://schemas.microsoft.com/office/drawing/2014/main" id="{EDDAD08E-B1DC-99A9-2EE6-9068EB2996BD}"/>
              </a:ext>
            </a:extLst>
          </p:cNvPr>
          <p:cNvSpPr/>
          <p:nvPr/>
        </p:nvSpPr>
        <p:spPr>
          <a:xfrm>
            <a:off x="3773468" y="4064260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37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4" name="Rectangle 10">
            <a:extLst>
              <a:ext uri="{FF2B5EF4-FFF2-40B4-BE49-F238E27FC236}">
                <a16:creationId xmlns:a16="http://schemas.microsoft.com/office/drawing/2014/main" id="{A863BDC2-8BBE-2032-354C-7A0ED1755D72}"/>
              </a:ext>
            </a:extLst>
          </p:cNvPr>
          <p:cNvSpPr/>
          <p:nvPr/>
        </p:nvSpPr>
        <p:spPr>
          <a:xfrm>
            <a:off x="3777627" y="4594223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25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5" name="Rectangle 11">
            <a:extLst>
              <a:ext uri="{FF2B5EF4-FFF2-40B4-BE49-F238E27FC236}">
                <a16:creationId xmlns:a16="http://schemas.microsoft.com/office/drawing/2014/main" id="{9AC43161-8136-3ED4-5D35-85A7A29AD68A}"/>
              </a:ext>
            </a:extLst>
          </p:cNvPr>
          <p:cNvSpPr/>
          <p:nvPr/>
        </p:nvSpPr>
        <p:spPr>
          <a:xfrm>
            <a:off x="3777627" y="4781634"/>
            <a:ext cx="47735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2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7" name="Rectangle 12">
            <a:extLst>
              <a:ext uri="{FF2B5EF4-FFF2-40B4-BE49-F238E27FC236}">
                <a16:creationId xmlns:a16="http://schemas.microsoft.com/office/drawing/2014/main" id="{95862DC4-24D8-4AC4-3E8B-F3DE207A7804}"/>
              </a:ext>
            </a:extLst>
          </p:cNvPr>
          <p:cNvSpPr/>
          <p:nvPr/>
        </p:nvSpPr>
        <p:spPr>
          <a:xfrm>
            <a:off x="3727297" y="2751393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75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8" name="Rectangle 14">
            <a:extLst>
              <a:ext uri="{FF2B5EF4-FFF2-40B4-BE49-F238E27FC236}">
                <a16:creationId xmlns:a16="http://schemas.microsoft.com/office/drawing/2014/main" id="{2F9B246D-37F8-5FAE-D048-FFD0E21B9E0B}"/>
              </a:ext>
            </a:extLst>
          </p:cNvPr>
          <p:cNvSpPr/>
          <p:nvPr/>
        </p:nvSpPr>
        <p:spPr>
          <a:xfrm>
            <a:off x="3754180" y="4977681"/>
            <a:ext cx="47735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5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9" name="Rectangle 14">
            <a:extLst>
              <a:ext uri="{FF2B5EF4-FFF2-40B4-BE49-F238E27FC236}">
                <a16:creationId xmlns:a16="http://schemas.microsoft.com/office/drawing/2014/main" id="{7D2561A7-C8DA-5FF2-F165-EDD33EB417A6}"/>
              </a:ext>
            </a:extLst>
          </p:cNvPr>
          <p:cNvSpPr/>
          <p:nvPr/>
        </p:nvSpPr>
        <p:spPr>
          <a:xfrm>
            <a:off x="3765903" y="5162691"/>
            <a:ext cx="47735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8235172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図 16">
            <a:extLst>
              <a:ext uri="{FF2B5EF4-FFF2-40B4-BE49-F238E27FC236}">
                <a16:creationId xmlns:a16="http://schemas.microsoft.com/office/drawing/2014/main" id="{C0EB30A8-2B98-DADF-4F16-FD01A4EC146C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20" t="-431" r="-380" b="-512"/>
          <a:stretch/>
        </p:blipFill>
        <p:spPr>
          <a:xfrm>
            <a:off x="1699847" y="0"/>
            <a:ext cx="8745414" cy="6922477"/>
          </a:xfrm>
          <a:prstGeom prst="rect">
            <a:avLst/>
          </a:prstGeom>
        </p:spPr>
      </p:pic>
      <p:sp>
        <p:nvSpPr>
          <p:cNvPr id="4" name="Rectangle 6">
            <a:extLst>
              <a:ext uri="{FF2B5EF4-FFF2-40B4-BE49-F238E27FC236}">
                <a16:creationId xmlns:a16="http://schemas.microsoft.com/office/drawing/2014/main" id="{B5A427EC-AFF0-9851-1998-4F0E7AF290D2}"/>
              </a:ext>
            </a:extLst>
          </p:cNvPr>
          <p:cNvSpPr>
            <a:spLocks noChangeArrowheads="1"/>
          </p:cNvSpPr>
          <p:nvPr/>
        </p:nvSpPr>
        <p:spPr bwMode="auto">
          <a:xfrm rot="18420000">
            <a:off x="6641885" y="1427391"/>
            <a:ext cx="80823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549</a:t>
            </a:r>
            <a:r>
              <a:rPr kumimoji="1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KO</a:t>
            </a:r>
          </a:p>
        </p:txBody>
      </p:sp>
      <p:sp>
        <p:nvSpPr>
          <p:cNvPr id="5" name="Rectangle 9">
            <a:extLst>
              <a:ext uri="{FF2B5EF4-FFF2-40B4-BE49-F238E27FC236}">
                <a16:creationId xmlns:a16="http://schemas.microsoft.com/office/drawing/2014/main" id="{7999406E-6ABD-5CBF-9BE5-495E4921B965}"/>
              </a:ext>
            </a:extLst>
          </p:cNvPr>
          <p:cNvSpPr>
            <a:spLocks noChangeArrowheads="1"/>
          </p:cNvSpPr>
          <p:nvPr/>
        </p:nvSpPr>
        <p:spPr bwMode="auto">
          <a:xfrm rot="18420000">
            <a:off x="6220417" y="1421130"/>
            <a:ext cx="82586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549 WT</a:t>
            </a:r>
          </a:p>
        </p:txBody>
      </p:sp>
      <p:sp>
        <p:nvSpPr>
          <p:cNvPr id="9" name="Rectangle 11">
            <a:extLst>
              <a:ext uri="{FF2B5EF4-FFF2-40B4-BE49-F238E27FC236}">
                <a16:creationId xmlns:a16="http://schemas.microsoft.com/office/drawing/2014/main" id="{17983E61-C754-CCA6-4444-43E6E569443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17604" y="3319779"/>
            <a:ext cx="92231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E-cadherin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D071AF6F-4DB6-BC8C-A887-21F69492A095}"/>
              </a:ext>
            </a:extLst>
          </p:cNvPr>
          <p:cNvSpPr txBox="1"/>
          <p:nvPr/>
        </p:nvSpPr>
        <p:spPr>
          <a:xfrm>
            <a:off x="4296187" y="6345329"/>
            <a:ext cx="500842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+mn-cs"/>
              </a:rPr>
              <a:t>b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+mn-cs"/>
              </a:rPr>
              <a:t> Western blotting results show that EPPK1 was knocked out in A549</a:t>
            </a:r>
          </a:p>
        </p:txBody>
      </p:sp>
      <p:sp>
        <p:nvSpPr>
          <p:cNvPr id="23" name="Rectangle 5">
            <a:extLst>
              <a:ext uri="{FF2B5EF4-FFF2-40B4-BE49-F238E27FC236}">
                <a16:creationId xmlns:a16="http://schemas.microsoft.com/office/drawing/2014/main" id="{A5276AA6-E3B0-A3CD-CDCB-8C25CC9C143A}"/>
              </a:ext>
            </a:extLst>
          </p:cNvPr>
          <p:cNvSpPr/>
          <p:nvPr/>
        </p:nvSpPr>
        <p:spPr>
          <a:xfrm>
            <a:off x="3983006" y="1535923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46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4" name="Rectangle 6">
            <a:extLst>
              <a:ext uri="{FF2B5EF4-FFF2-40B4-BE49-F238E27FC236}">
                <a16:creationId xmlns:a16="http://schemas.microsoft.com/office/drawing/2014/main" id="{8537A4BD-6258-22BC-B251-682F92D970B4}"/>
              </a:ext>
            </a:extLst>
          </p:cNvPr>
          <p:cNvSpPr/>
          <p:nvPr/>
        </p:nvSpPr>
        <p:spPr>
          <a:xfrm>
            <a:off x="4010915" y="2109374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268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5" name="Rectangle 7">
            <a:extLst>
              <a:ext uri="{FF2B5EF4-FFF2-40B4-BE49-F238E27FC236}">
                <a16:creationId xmlns:a16="http://schemas.microsoft.com/office/drawing/2014/main" id="{F6FBF934-5DBA-476A-9358-5EAA68A2793F}"/>
              </a:ext>
            </a:extLst>
          </p:cNvPr>
          <p:cNvSpPr/>
          <p:nvPr/>
        </p:nvSpPr>
        <p:spPr>
          <a:xfrm>
            <a:off x="4010914" y="2303254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238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6" name="Rectangle 8">
            <a:extLst>
              <a:ext uri="{FF2B5EF4-FFF2-40B4-BE49-F238E27FC236}">
                <a16:creationId xmlns:a16="http://schemas.microsoft.com/office/drawing/2014/main" id="{03BDAB94-A2AC-931E-72CC-B282E48F4487}"/>
              </a:ext>
            </a:extLst>
          </p:cNvPr>
          <p:cNvSpPr/>
          <p:nvPr/>
        </p:nvSpPr>
        <p:spPr>
          <a:xfrm>
            <a:off x="4005987" y="3291216"/>
            <a:ext cx="5522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17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7" name="Rectangle 9">
            <a:extLst>
              <a:ext uri="{FF2B5EF4-FFF2-40B4-BE49-F238E27FC236}">
                <a16:creationId xmlns:a16="http://schemas.microsoft.com/office/drawing/2014/main" id="{F11C3413-F9A9-8AE8-7DD3-FEBA478A42D6}"/>
              </a:ext>
            </a:extLst>
          </p:cNvPr>
          <p:cNvSpPr/>
          <p:nvPr/>
        </p:nvSpPr>
        <p:spPr>
          <a:xfrm>
            <a:off x="4077869" y="3667143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7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8" name="Rectangle 10">
            <a:extLst>
              <a:ext uri="{FF2B5EF4-FFF2-40B4-BE49-F238E27FC236}">
                <a16:creationId xmlns:a16="http://schemas.microsoft.com/office/drawing/2014/main" id="{1F32F1BC-055D-F07E-3214-0BC69FFFC7C1}"/>
              </a:ext>
            </a:extLst>
          </p:cNvPr>
          <p:cNvSpPr/>
          <p:nvPr/>
        </p:nvSpPr>
        <p:spPr>
          <a:xfrm>
            <a:off x="4075036" y="4330711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55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9" name="Rectangle 11">
            <a:extLst>
              <a:ext uri="{FF2B5EF4-FFF2-40B4-BE49-F238E27FC236}">
                <a16:creationId xmlns:a16="http://schemas.microsoft.com/office/drawing/2014/main" id="{5A6A8D45-25C2-79DB-8AA2-0A603D5C10A9}"/>
              </a:ext>
            </a:extLst>
          </p:cNvPr>
          <p:cNvSpPr/>
          <p:nvPr/>
        </p:nvSpPr>
        <p:spPr>
          <a:xfrm>
            <a:off x="4092621" y="4812418"/>
            <a:ext cx="47735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4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0" name="Rectangle 12">
            <a:extLst>
              <a:ext uri="{FF2B5EF4-FFF2-40B4-BE49-F238E27FC236}">
                <a16:creationId xmlns:a16="http://schemas.microsoft.com/office/drawing/2014/main" id="{9AB418C8-22F0-F4ED-8951-B27308C7F8DC}"/>
              </a:ext>
            </a:extLst>
          </p:cNvPr>
          <p:cNvSpPr/>
          <p:nvPr/>
        </p:nvSpPr>
        <p:spPr>
          <a:xfrm>
            <a:off x="3983006" y="2935978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7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1" name="Rectangle 14">
            <a:extLst>
              <a:ext uri="{FF2B5EF4-FFF2-40B4-BE49-F238E27FC236}">
                <a16:creationId xmlns:a16="http://schemas.microsoft.com/office/drawing/2014/main" id="{1553872E-A6CF-8133-29BC-0481A1547331}"/>
              </a:ext>
            </a:extLst>
          </p:cNvPr>
          <p:cNvSpPr/>
          <p:nvPr/>
        </p:nvSpPr>
        <p:spPr>
          <a:xfrm>
            <a:off x="4111908" y="5254102"/>
            <a:ext cx="47735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3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2" name="Rectangle 5">
            <a:extLst>
              <a:ext uri="{FF2B5EF4-FFF2-40B4-BE49-F238E27FC236}">
                <a16:creationId xmlns:a16="http://schemas.microsoft.com/office/drawing/2014/main" id="{8B19ECFE-45CF-B9A8-515E-446FB6728DC5}"/>
              </a:ext>
            </a:extLst>
          </p:cNvPr>
          <p:cNvSpPr/>
          <p:nvPr/>
        </p:nvSpPr>
        <p:spPr>
          <a:xfrm>
            <a:off x="4535521" y="2274219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25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3" name="Rectangle 6">
            <a:extLst>
              <a:ext uri="{FF2B5EF4-FFF2-40B4-BE49-F238E27FC236}">
                <a16:creationId xmlns:a16="http://schemas.microsoft.com/office/drawing/2014/main" id="{8F2304A2-01AA-0525-4D21-5B6F8349A448}"/>
              </a:ext>
            </a:extLst>
          </p:cNvPr>
          <p:cNvSpPr/>
          <p:nvPr/>
        </p:nvSpPr>
        <p:spPr>
          <a:xfrm>
            <a:off x="4525587" y="2956695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5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4" name="Rectangle 7">
            <a:extLst>
              <a:ext uri="{FF2B5EF4-FFF2-40B4-BE49-F238E27FC236}">
                <a16:creationId xmlns:a16="http://schemas.microsoft.com/office/drawing/2014/main" id="{ECFDE676-2B56-B61D-D82F-0ACDE0091BFD}"/>
              </a:ext>
            </a:extLst>
          </p:cNvPr>
          <p:cNvSpPr/>
          <p:nvPr/>
        </p:nvSpPr>
        <p:spPr>
          <a:xfrm>
            <a:off x="4572479" y="3517667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0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5" name="Rectangle 8">
            <a:extLst>
              <a:ext uri="{FF2B5EF4-FFF2-40B4-BE49-F238E27FC236}">
                <a16:creationId xmlns:a16="http://schemas.microsoft.com/office/drawing/2014/main" id="{DA0CAA9A-0FEC-437F-4E7E-4CF0675771D1}"/>
              </a:ext>
            </a:extLst>
          </p:cNvPr>
          <p:cNvSpPr/>
          <p:nvPr/>
        </p:nvSpPr>
        <p:spPr>
          <a:xfrm>
            <a:off x="4669979" y="4609013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5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7" name="Rectangle 9">
            <a:extLst>
              <a:ext uri="{FF2B5EF4-FFF2-40B4-BE49-F238E27FC236}">
                <a16:creationId xmlns:a16="http://schemas.microsoft.com/office/drawing/2014/main" id="{F7CDC4D4-1A3C-8DB4-AD39-5C0FC4AF2069}"/>
              </a:ext>
            </a:extLst>
          </p:cNvPr>
          <p:cNvSpPr/>
          <p:nvPr/>
        </p:nvSpPr>
        <p:spPr>
          <a:xfrm>
            <a:off x="4646837" y="5066583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37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8" name="Rectangle 10">
            <a:extLst>
              <a:ext uri="{FF2B5EF4-FFF2-40B4-BE49-F238E27FC236}">
                <a16:creationId xmlns:a16="http://schemas.microsoft.com/office/drawing/2014/main" id="{70B963A4-5DAF-F89E-8F7C-85FDBFF4B99B}"/>
              </a:ext>
            </a:extLst>
          </p:cNvPr>
          <p:cNvSpPr/>
          <p:nvPr/>
        </p:nvSpPr>
        <p:spPr>
          <a:xfrm>
            <a:off x="4656858" y="5420700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25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9" name="Rectangle 11">
            <a:extLst>
              <a:ext uri="{FF2B5EF4-FFF2-40B4-BE49-F238E27FC236}">
                <a16:creationId xmlns:a16="http://schemas.microsoft.com/office/drawing/2014/main" id="{AF048637-F8AE-0D3E-CC3F-5A49F64EDC92}"/>
              </a:ext>
            </a:extLst>
          </p:cNvPr>
          <p:cNvSpPr/>
          <p:nvPr/>
        </p:nvSpPr>
        <p:spPr>
          <a:xfrm>
            <a:off x="4656858" y="5608111"/>
            <a:ext cx="47735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2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40" name="Rectangle 12">
            <a:extLst>
              <a:ext uri="{FF2B5EF4-FFF2-40B4-BE49-F238E27FC236}">
                <a16:creationId xmlns:a16="http://schemas.microsoft.com/office/drawing/2014/main" id="{6616003F-8317-45E2-1466-E0394C48D9F1}"/>
              </a:ext>
            </a:extLst>
          </p:cNvPr>
          <p:cNvSpPr/>
          <p:nvPr/>
        </p:nvSpPr>
        <p:spPr>
          <a:xfrm>
            <a:off x="4647559" y="3953008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75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41" name="Rectangle 14">
            <a:extLst>
              <a:ext uri="{FF2B5EF4-FFF2-40B4-BE49-F238E27FC236}">
                <a16:creationId xmlns:a16="http://schemas.microsoft.com/office/drawing/2014/main" id="{95D799DE-FBEB-C164-099E-F7E4DAAEA887}"/>
              </a:ext>
            </a:extLst>
          </p:cNvPr>
          <p:cNvSpPr/>
          <p:nvPr/>
        </p:nvSpPr>
        <p:spPr>
          <a:xfrm>
            <a:off x="4633411" y="5804158"/>
            <a:ext cx="47735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5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56491928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図 18">
            <a:extLst>
              <a:ext uri="{FF2B5EF4-FFF2-40B4-BE49-F238E27FC236}">
                <a16:creationId xmlns:a16="http://schemas.microsoft.com/office/drawing/2014/main" id="{D4C68862-0108-4329-7EB4-6C778F9F7C3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-630" t="-312" r="-713" b="-977"/>
          <a:stretch/>
        </p:blipFill>
        <p:spPr>
          <a:xfrm>
            <a:off x="1764323" y="0"/>
            <a:ext cx="8804031" cy="6945922"/>
          </a:xfrm>
          <a:prstGeom prst="rect">
            <a:avLst/>
          </a:prstGeom>
        </p:spPr>
      </p:pic>
      <p:sp>
        <p:nvSpPr>
          <p:cNvPr id="4" name="Rectangle 13">
            <a:extLst>
              <a:ext uri="{FF2B5EF4-FFF2-40B4-BE49-F238E27FC236}">
                <a16:creationId xmlns:a16="http://schemas.microsoft.com/office/drawing/2014/main" id="{82ED8F00-3FA9-5BC2-2C52-1B68AC5622A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34241" y="4541581"/>
            <a:ext cx="7782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Vimentin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CDB26EE1-B64E-383C-1D87-EEF672904E40}"/>
              </a:ext>
            </a:extLst>
          </p:cNvPr>
          <p:cNvSpPr txBox="1"/>
          <p:nvPr/>
        </p:nvSpPr>
        <p:spPr>
          <a:xfrm>
            <a:off x="4296187" y="6345329"/>
            <a:ext cx="500842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+mn-cs"/>
              </a:rPr>
              <a:t>b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+mn-cs"/>
              </a:rPr>
              <a:t> Western blotting results show that EPPK1 was knocked out in A549</a:t>
            </a:r>
          </a:p>
        </p:txBody>
      </p:sp>
      <p:sp>
        <p:nvSpPr>
          <p:cNvPr id="9" name="Rectangle 6">
            <a:extLst>
              <a:ext uri="{FF2B5EF4-FFF2-40B4-BE49-F238E27FC236}">
                <a16:creationId xmlns:a16="http://schemas.microsoft.com/office/drawing/2014/main" id="{2151261A-D5B5-CC57-911C-0B69A88F4DA7}"/>
              </a:ext>
            </a:extLst>
          </p:cNvPr>
          <p:cNvSpPr>
            <a:spLocks noChangeArrowheads="1"/>
          </p:cNvSpPr>
          <p:nvPr/>
        </p:nvSpPr>
        <p:spPr bwMode="auto">
          <a:xfrm rot="18420000">
            <a:off x="6413285" y="899852"/>
            <a:ext cx="80823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549</a:t>
            </a:r>
            <a:r>
              <a:rPr kumimoji="1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KO</a:t>
            </a:r>
          </a:p>
        </p:txBody>
      </p:sp>
      <p:sp>
        <p:nvSpPr>
          <p:cNvPr id="18" name="Rectangle 9">
            <a:extLst>
              <a:ext uri="{FF2B5EF4-FFF2-40B4-BE49-F238E27FC236}">
                <a16:creationId xmlns:a16="http://schemas.microsoft.com/office/drawing/2014/main" id="{C27C21B5-0482-E1CB-8BAE-164A167CBFDD}"/>
              </a:ext>
            </a:extLst>
          </p:cNvPr>
          <p:cNvSpPr>
            <a:spLocks noChangeArrowheads="1"/>
          </p:cNvSpPr>
          <p:nvPr/>
        </p:nvSpPr>
        <p:spPr bwMode="auto">
          <a:xfrm rot="18420000">
            <a:off x="5991817" y="893591"/>
            <a:ext cx="82586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549 WT</a:t>
            </a:r>
          </a:p>
        </p:txBody>
      </p:sp>
      <p:sp>
        <p:nvSpPr>
          <p:cNvPr id="20" name="Rectangle 5">
            <a:extLst>
              <a:ext uri="{FF2B5EF4-FFF2-40B4-BE49-F238E27FC236}">
                <a16:creationId xmlns:a16="http://schemas.microsoft.com/office/drawing/2014/main" id="{CD38B26B-A37C-C411-C1A0-20C7637C14C7}"/>
              </a:ext>
            </a:extLst>
          </p:cNvPr>
          <p:cNvSpPr/>
          <p:nvPr/>
        </p:nvSpPr>
        <p:spPr>
          <a:xfrm>
            <a:off x="3771991" y="1096307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46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1" name="Rectangle 6">
            <a:extLst>
              <a:ext uri="{FF2B5EF4-FFF2-40B4-BE49-F238E27FC236}">
                <a16:creationId xmlns:a16="http://schemas.microsoft.com/office/drawing/2014/main" id="{A76F1ED6-6450-CF74-1700-52922E413A44}"/>
              </a:ext>
            </a:extLst>
          </p:cNvPr>
          <p:cNvSpPr/>
          <p:nvPr/>
        </p:nvSpPr>
        <p:spPr>
          <a:xfrm>
            <a:off x="3799900" y="1669758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268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2" name="Rectangle 7">
            <a:extLst>
              <a:ext uri="{FF2B5EF4-FFF2-40B4-BE49-F238E27FC236}">
                <a16:creationId xmlns:a16="http://schemas.microsoft.com/office/drawing/2014/main" id="{8A653603-A6AF-374A-A9BC-86AC40F6B87E}"/>
              </a:ext>
            </a:extLst>
          </p:cNvPr>
          <p:cNvSpPr/>
          <p:nvPr/>
        </p:nvSpPr>
        <p:spPr>
          <a:xfrm>
            <a:off x="3799899" y="1863638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238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3" name="Rectangle 8">
            <a:extLst>
              <a:ext uri="{FF2B5EF4-FFF2-40B4-BE49-F238E27FC236}">
                <a16:creationId xmlns:a16="http://schemas.microsoft.com/office/drawing/2014/main" id="{1C20AF26-2909-B23B-8042-54BFFF9A4191}"/>
              </a:ext>
            </a:extLst>
          </p:cNvPr>
          <p:cNvSpPr/>
          <p:nvPr/>
        </p:nvSpPr>
        <p:spPr>
          <a:xfrm>
            <a:off x="3794972" y="2851600"/>
            <a:ext cx="5522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17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4" name="Rectangle 9">
            <a:extLst>
              <a:ext uri="{FF2B5EF4-FFF2-40B4-BE49-F238E27FC236}">
                <a16:creationId xmlns:a16="http://schemas.microsoft.com/office/drawing/2014/main" id="{C4B5CBB0-DDDA-BAE8-2FE0-8C403BBFB03E}"/>
              </a:ext>
            </a:extLst>
          </p:cNvPr>
          <p:cNvSpPr/>
          <p:nvPr/>
        </p:nvSpPr>
        <p:spPr>
          <a:xfrm>
            <a:off x="3866854" y="3227527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7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5" name="Rectangle 10">
            <a:extLst>
              <a:ext uri="{FF2B5EF4-FFF2-40B4-BE49-F238E27FC236}">
                <a16:creationId xmlns:a16="http://schemas.microsoft.com/office/drawing/2014/main" id="{DB072C2A-4A43-1FD4-7C48-4D7F8DCFB095}"/>
              </a:ext>
            </a:extLst>
          </p:cNvPr>
          <p:cNvSpPr/>
          <p:nvPr/>
        </p:nvSpPr>
        <p:spPr>
          <a:xfrm>
            <a:off x="3864021" y="3891095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55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6" name="Rectangle 11">
            <a:extLst>
              <a:ext uri="{FF2B5EF4-FFF2-40B4-BE49-F238E27FC236}">
                <a16:creationId xmlns:a16="http://schemas.microsoft.com/office/drawing/2014/main" id="{EB099BAB-A761-021B-48A9-C169A689BEB1}"/>
              </a:ext>
            </a:extLst>
          </p:cNvPr>
          <p:cNvSpPr/>
          <p:nvPr/>
        </p:nvSpPr>
        <p:spPr>
          <a:xfrm>
            <a:off x="3881606" y="4372802"/>
            <a:ext cx="47735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4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7" name="Rectangle 12">
            <a:extLst>
              <a:ext uri="{FF2B5EF4-FFF2-40B4-BE49-F238E27FC236}">
                <a16:creationId xmlns:a16="http://schemas.microsoft.com/office/drawing/2014/main" id="{DC3C0450-3ADD-9007-4BCF-10A7FDBA3D18}"/>
              </a:ext>
            </a:extLst>
          </p:cNvPr>
          <p:cNvSpPr/>
          <p:nvPr/>
        </p:nvSpPr>
        <p:spPr>
          <a:xfrm>
            <a:off x="3771991" y="2496362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7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8" name="Rectangle 14">
            <a:extLst>
              <a:ext uri="{FF2B5EF4-FFF2-40B4-BE49-F238E27FC236}">
                <a16:creationId xmlns:a16="http://schemas.microsoft.com/office/drawing/2014/main" id="{498B98C9-98F1-377E-BA1D-484F4AD065AA}"/>
              </a:ext>
            </a:extLst>
          </p:cNvPr>
          <p:cNvSpPr/>
          <p:nvPr/>
        </p:nvSpPr>
        <p:spPr>
          <a:xfrm>
            <a:off x="3900893" y="4814486"/>
            <a:ext cx="47735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3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9" name="Rectangle 5">
            <a:extLst>
              <a:ext uri="{FF2B5EF4-FFF2-40B4-BE49-F238E27FC236}">
                <a16:creationId xmlns:a16="http://schemas.microsoft.com/office/drawing/2014/main" id="{B1C4FAFB-1FCC-7979-FDA2-82AE1D44C811}"/>
              </a:ext>
            </a:extLst>
          </p:cNvPr>
          <p:cNvSpPr/>
          <p:nvPr/>
        </p:nvSpPr>
        <p:spPr>
          <a:xfrm>
            <a:off x="4324506" y="1834603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25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0" name="Rectangle 6">
            <a:extLst>
              <a:ext uri="{FF2B5EF4-FFF2-40B4-BE49-F238E27FC236}">
                <a16:creationId xmlns:a16="http://schemas.microsoft.com/office/drawing/2014/main" id="{9AC43C8F-69F9-B8AB-D6CA-41E8F145628C}"/>
              </a:ext>
            </a:extLst>
          </p:cNvPr>
          <p:cNvSpPr/>
          <p:nvPr/>
        </p:nvSpPr>
        <p:spPr>
          <a:xfrm>
            <a:off x="4314572" y="2517079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5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1" name="Rectangle 7">
            <a:extLst>
              <a:ext uri="{FF2B5EF4-FFF2-40B4-BE49-F238E27FC236}">
                <a16:creationId xmlns:a16="http://schemas.microsoft.com/office/drawing/2014/main" id="{16DDA340-DAC2-8115-3517-E9CCAFC55C23}"/>
              </a:ext>
            </a:extLst>
          </p:cNvPr>
          <p:cNvSpPr/>
          <p:nvPr/>
        </p:nvSpPr>
        <p:spPr>
          <a:xfrm>
            <a:off x="4361464" y="3078051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0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2" name="Rectangle 8">
            <a:extLst>
              <a:ext uri="{FF2B5EF4-FFF2-40B4-BE49-F238E27FC236}">
                <a16:creationId xmlns:a16="http://schemas.microsoft.com/office/drawing/2014/main" id="{679F1C4D-CDAD-E564-4920-8698D3E85F5F}"/>
              </a:ext>
            </a:extLst>
          </p:cNvPr>
          <p:cNvSpPr/>
          <p:nvPr/>
        </p:nvSpPr>
        <p:spPr>
          <a:xfrm>
            <a:off x="4458964" y="4169397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5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3" name="Rectangle 9">
            <a:extLst>
              <a:ext uri="{FF2B5EF4-FFF2-40B4-BE49-F238E27FC236}">
                <a16:creationId xmlns:a16="http://schemas.microsoft.com/office/drawing/2014/main" id="{57BBB141-A505-8332-9A86-3DE46A155818}"/>
              </a:ext>
            </a:extLst>
          </p:cNvPr>
          <p:cNvSpPr/>
          <p:nvPr/>
        </p:nvSpPr>
        <p:spPr>
          <a:xfrm>
            <a:off x="4435822" y="4626967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37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4" name="Rectangle 10">
            <a:extLst>
              <a:ext uri="{FF2B5EF4-FFF2-40B4-BE49-F238E27FC236}">
                <a16:creationId xmlns:a16="http://schemas.microsoft.com/office/drawing/2014/main" id="{7078E09C-2B33-C9F9-755F-A44DFCEE279D}"/>
              </a:ext>
            </a:extLst>
          </p:cNvPr>
          <p:cNvSpPr/>
          <p:nvPr/>
        </p:nvSpPr>
        <p:spPr>
          <a:xfrm>
            <a:off x="4445843" y="4981084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25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5" name="Rectangle 11">
            <a:extLst>
              <a:ext uri="{FF2B5EF4-FFF2-40B4-BE49-F238E27FC236}">
                <a16:creationId xmlns:a16="http://schemas.microsoft.com/office/drawing/2014/main" id="{A1477414-C2DC-D58A-ECF2-8A5EC572E9F3}"/>
              </a:ext>
            </a:extLst>
          </p:cNvPr>
          <p:cNvSpPr/>
          <p:nvPr/>
        </p:nvSpPr>
        <p:spPr>
          <a:xfrm>
            <a:off x="4445843" y="5168495"/>
            <a:ext cx="47735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2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7" name="Rectangle 12">
            <a:extLst>
              <a:ext uri="{FF2B5EF4-FFF2-40B4-BE49-F238E27FC236}">
                <a16:creationId xmlns:a16="http://schemas.microsoft.com/office/drawing/2014/main" id="{DDCB4882-8AF3-C0E0-8AC0-34360B5C7B33}"/>
              </a:ext>
            </a:extLst>
          </p:cNvPr>
          <p:cNvSpPr/>
          <p:nvPr/>
        </p:nvSpPr>
        <p:spPr>
          <a:xfrm>
            <a:off x="4436544" y="3513392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75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8" name="Rectangle 14">
            <a:extLst>
              <a:ext uri="{FF2B5EF4-FFF2-40B4-BE49-F238E27FC236}">
                <a16:creationId xmlns:a16="http://schemas.microsoft.com/office/drawing/2014/main" id="{1424CC0C-0219-A8D1-9E88-AABD990A9448}"/>
              </a:ext>
            </a:extLst>
          </p:cNvPr>
          <p:cNvSpPr/>
          <p:nvPr/>
        </p:nvSpPr>
        <p:spPr>
          <a:xfrm>
            <a:off x="4422396" y="5364542"/>
            <a:ext cx="47735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5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92851320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図 14">
            <a:extLst>
              <a:ext uri="{FF2B5EF4-FFF2-40B4-BE49-F238E27FC236}">
                <a16:creationId xmlns:a16="http://schemas.microsoft.com/office/drawing/2014/main" id="{7F16115A-430C-642B-65D6-4F4BE2D54F59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47" t="-539" r="-425" b="-428"/>
          <a:stretch/>
        </p:blipFill>
        <p:spPr>
          <a:xfrm>
            <a:off x="1676399" y="-64477"/>
            <a:ext cx="8763000" cy="6922477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E85CAD18-61C2-8735-1882-9D17A8D5D8AE}"/>
              </a:ext>
            </a:extLst>
          </p:cNvPr>
          <p:cNvSpPr txBox="1"/>
          <p:nvPr/>
        </p:nvSpPr>
        <p:spPr>
          <a:xfrm>
            <a:off x="3827264" y="6252755"/>
            <a:ext cx="500842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+mn-cs"/>
              </a:rPr>
              <a:t>b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+mn-cs"/>
              </a:rPr>
              <a:t> Western blotting results show that EPPK1 was knocked out in A549</a:t>
            </a:r>
          </a:p>
        </p:txBody>
      </p:sp>
      <p:sp>
        <p:nvSpPr>
          <p:cNvPr id="9" name="Rectangle 16">
            <a:extLst>
              <a:ext uri="{FF2B5EF4-FFF2-40B4-BE49-F238E27FC236}">
                <a16:creationId xmlns:a16="http://schemas.microsoft.com/office/drawing/2014/main" id="{35B69205-61EC-0DEB-6533-CACD6099724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02758" y="4827866"/>
            <a:ext cx="64793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β-actin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8" name="Rectangle 6">
            <a:extLst>
              <a:ext uri="{FF2B5EF4-FFF2-40B4-BE49-F238E27FC236}">
                <a16:creationId xmlns:a16="http://schemas.microsoft.com/office/drawing/2014/main" id="{79A37013-7E1F-0FAF-E220-F10896796247}"/>
              </a:ext>
            </a:extLst>
          </p:cNvPr>
          <p:cNvSpPr>
            <a:spLocks noChangeArrowheads="1"/>
          </p:cNvSpPr>
          <p:nvPr/>
        </p:nvSpPr>
        <p:spPr bwMode="auto">
          <a:xfrm rot="18420000">
            <a:off x="6014702" y="1163620"/>
            <a:ext cx="80823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549</a:t>
            </a:r>
            <a:r>
              <a:rPr kumimoji="1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KO</a:t>
            </a:r>
          </a:p>
        </p:txBody>
      </p:sp>
      <p:sp>
        <p:nvSpPr>
          <p:cNvPr id="20" name="Rectangle 9">
            <a:extLst>
              <a:ext uri="{FF2B5EF4-FFF2-40B4-BE49-F238E27FC236}">
                <a16:creationId xmlns:a16="http://schemas.microsoft.com/office/drawing/2014/main" id="{B512562C-87A3-D467-3FAB-095640588EB0}"/>
              </a:ext>
            </a:extLst>
          </p:cNvPr>
          <p:cNvSpPr>
            <a:spLocks noChangeArrowheads="1"/>
          </p:cNvSpPr>
          <p:nvPr/>
        </p:nvSpPr>
        <p:spPr bwMode="auto">
          <a:xfrm rot="18420000">
            <a:off x="5593234" y="1157359"/>
            <a:ext cx="82586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549 WT</a:t>
            </a:r>
          </a:p>
        </p:txBody>
      </p:sp>
      <p:sp>
        <p:nvSpPr>
          <p:cNvPr id="21" name="Rectangle 5">
            <a:extLst>
              <a:ext uri="{FF2B5EF4-FFF2-40B4-BE49-F238E27FC236}">
                <a16:creationId xmlns:a16="http://schemas.microsoft.com/office/drawing/2014/main" id="{E59D8D69-DAC2-FB31-B077-1A2B91102662}"/>
              </a:ext>
            </a:extLst>
          </p:cNvPr>
          <p:cNvSpPr/>
          <p:nvPr/>
        </p:nvSpPr>
        <p:spPr>
          <a:xfrm>
            <a:off x="3443744" y="1412830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46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2" name="Rectangle 6">
            <a:extLst>
              <a:ext uri="{FF2B5EF4-FFF2-40B4-BE49-F238E27FC236}">
                <a16:creationId xmlns:a16="http://schemas.microsoft.com/office/drawing/2014/main" id="{80514A7F-233D-6376-9237-365BA52E8613}"/>
              </a:ext>
            </a:extLst>
          </p:cNvPr>
          <p:cNvSpPr/>
          <p:nvPr/>
        </p:nvSpPr>
        <p:spPr>
          <a:xfrm>
            <a:off x="3471653" y="1986281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268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3" name="Rectangle 7">
            <a:extLst>
              <a:ext uri="{FF2B5EF4-FFF2-40B4-BE49-F238E27FC236}">
                <a16:creationId xmlns:a16="http://schemas.microsoft.com/office/drawing/2014/main" id="{3819C890-0629-6EA3-C780-C72609239317}"/>
              </a:ext>
            </a:extLst>
          </p:cNvPr>
          <p:cNvSpPr/>
          <p:nvPr/>
        </p:nvSpPr>
        <p:spPr>
          <a:xfrm>
            <a:off x="3471652" y="2180161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238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4" name="Rectangle 8">
            <a:extLst>
              <a:ext uri="{FF2B5EF4-FFF2-40B4-BE49-F238E27FC236}">
                <a16:creationId xmlns:a16="http://schemas.microsoft.com/office/drawing/2014/main" id="{1B2FE3C0-0905-EEEC-D899-57F72E0831D3}"/>
              </a:ext>
            </a:extLst>
          </p:cNvPr>
          <p:cNvSpPr/>
          <p:nvPr/>
        </p:nvSpPr>
        <p:spPr>
          <a:xfrm>
            <a:off x="3466725" y="3168123"/>
            <a:ext cx="5522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17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5" name="Rectangle 9">
            <a:extLst>
              <a:ext uri="{FF2B5EF4-FFF2-40B4-BE49-F238E27FC236}">
                <a16:creationId xmlns:a16="http://schemas.microsoft.com/office/drawing/2014/main" id="{06819DE9-6AAD-5EB1-D002-70BD4CC28AFC}"/>
              </a:ext>
            </a:extLst>
          </p:cNvPr>
          <p:cNvSpPr/>
          <p:nvPr/>
        </p:nvSpPr>
        <p:spPr>
          <a:xfrm>
            <a:off x="3538607" y="3544050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7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6" name="Rectangle 10">
            <a:extLst>
              <a:ext uri="{FF2B5EF4-FFF2-40B4-BE49-F238E27FC236}">
                <a16:creationId xmlns:a16="http://schemas.microsoft.com/office/drawing/2014/main" id="{D08CFC69-DEF9-2B1D-54F2-A011FFD52C36}"/>
              </a:ext>
            </a:extLst>
          </p:cNvPr>
          <p:cNvSpPr/>
          <p:nvPr/>
        </p:nvSpPr>
        <p:spPr>
          <a:xfrm>
            <a:off x="3535774" y="4207618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55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7" name="Rectangle 11">
            <a:extLst>
              <a:ext uri="{FF2B5EF4-FFF2-40B4-BE49-F238E27FC236}">
                <a16:creationId xmlns:a16="http://schemas.microsoft.com/office/drawing/2014/main" id="{1F659978-C56C-D4DC-5D32-BCB670616A60}"/>
              </a:ext>
            </a:extLst>
          </p:cNvPr>
          <p:cNvSpPr/>
          <p:nvPr/>
        </p:nvSpPr>
        <p:spPr>
          <a:xfrm>
            <a:off x="3553359" y="4689325"/>
            <a:ext cx="47735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4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8" name="Rectangle 12">
            <a:extLst>
              <a:ext uri="{FF2B5EF4-FFF2-40B4-BE49-F238E27FC236}">
                <a16:creationId xmlns:a16="http://schemas.microsoft.com/office/drawing/2014/main" id="{B2FFB6CD-B4E9-C102-BFE3-74A5A0EBC4F0}"/>
              </a:ext>
            </a:extLst>
          </p:cNvPr>
          <p:cNvSpPr/>
          <p:nvPr/>
        </p:nvSpPr>
        <p:spPr>
          <a:xfrm>
            <a:off x="3443744" y="2812885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7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9" name="Rectangle 14">
            <a:extLst>
              <a:ext uri="{FF2B5EF4-FFF2-40B4-BE49-F238E27FC236}">
                <a16:creationId xmlns:a16="http://schemas.microsoft.com/office/drawing/2014/main" id="{76DD5D50-9276-EB7A-E2E1-A6494D82B793}"/>
              </a:ext>
            </a:extLst>
          </p:cNvPr>
          <p:cNvSpPr/>
          <p:nvPr/>
        </p:nvSpPr>
        <p:spPr>
          <a:xfrm>
            <a:off x="3572646" y="5131009"/>
            <a:ext cx="47735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3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0" name="Rectangle 5">
            <a:extLst>
              <a:ext uri="{FF2B5EF4-FFF2-40B4-BE49-F238E27FC236}">
                <a16:creationId xmlns:a16="http://schemas.microsoft.com/office/drawing/2014/main" id="{D08FE585-1E18-9390-3B98-8A2693F8CDA5}"/>
              </a:ext>
            </a:extLst>
          </p:cNvPr>
          <p:cNvSpPr/>
          <p:nvPr/>
        </p:nvSpPr>
        <p:spPr>
          <a:xfrm>
            <a:off x="3996259" y="2151126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25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1" name="Rectangle 6">
            <a:extLst>
              <a:ext uri="{FF2B5EF4-FFF2-40B4-BE49-F238E27FC236}">
                <a16:creationId xmlns:a16="http://schemas.microsoft.com/office/drawing/2014/main" id="{DCFC4CF4-7EB8-DDA4-E6C4-2B61D889BDE7}"/>
              </a:ext>
            </a:extLst>
          </p:cNvPr>
          <p:cNvSpPr/>
          <p:nvPr/>
        </p:nvSpPr>
        <p:spPr>
          <a:xfrm>
            <a:off x="3986325" y="2833602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5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2" name="Rectangle 7">
            <a:extLst>
              <a:ext uri="{FF2B5EF4-FFF2-40B4-BE49-F238E27FC236}">
                <a16:creationId xmlns:a16="http://schemas.microsoft.com/office/drawing/2014/main" id="{7ECC183D-A442-FB92-158E-33A7C178FE5C}"/>
              </a:ext>
            </a:extLst>
          </p:cNvPr>
          <p:cNvSpPr/>
          <p:nvPr/>
        </p:nvSpPr>
        <p:spPr>
          <a:xfrm>
            <a:off x="4033217" y="3394574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0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3" name="Rectangle 8">
            <a:extLst>
              <a:ext uri="{FF2B5EF4-FFF2-40B4-BE49-F238E27FC236}">
                <a16:creationId xmlns:a16="http://schemas.microsoft.com/office/drawing/2014/main" id="{1335C7B8-8672-BAED-EC8B-F3EFE539AD2F}"/>
              </a:ext>
            </a:extLst>
          </p:cNvPr>
          <p:cNvSpPr/>
          <p:nvPr/>
        </p:nvSpPr>
        <p:spPr>
          <a:xfrm>
            <a:off x="4130717" y="4485920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5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4" name="Rectangle 9">
            <a:extLst>
              <a:ext uri="{FF2B5EF4-FFF2-40B4-BE49-F238E27FC236}">
                <a16:creationId xmlns:a16="http://schemas.microsoft.com/office/drawing/2014/main" id="{BDD2D59C-4F8A-0CAB-4A4C-58AD9F172081}"/>
              </a:ext>
            </a:extLst>
          </p:cNvPr>
          <p:cNvSpPr/>
          <p:nvPr/>
        </p:nvSpPr>
        <p:spPr>
          <a:xfrm>
            <a:off x="4107575" y="4943490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37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5" name="Rectangle 10">
            <a:extLst>
              <a:ext uri="{FF2B5EF4-FFF2-40B4-BE49-F238E27FC236}">
                <a16:creationId xmlns:a16="http://schemas.microsoft.com/office/drawing/2014/main" id="{F7F7ECD6-5C58-42F2-B2FA-EA2D0495DB5F}"/>
              </a:ext>
            </a:extLst>
          </p:cNvPr>
          <p:cNvSpPr/>
          <p:nvPr/>
        </p:nvSpPr>
        <p:spPr>
          <a:xfrm>
            <a:off x="4117596" y="5297607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25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7" name="Rectangle 11">
            <a:extLst>
              <a:ext uri="{FF2B5EF4-FFF2-40B4-BE49-F238E27FC236}">
                <a16:creationId xmlns:a16="http://schemas.microsoft.com/office/drawing/2014/main" id="{BA47DC2A-3FC9-C9E3-F235-E8D0B1F3BFCA}"/>
              </a:ext>
            </a:extLst>
          </p:cNvPr>
          <p:cNvSpPr/>
          <p:nvPr/>
        </p:nvSpPr>
        <p:spPr>
          <a:xfrm>
            <a:off x="4117596" y="5485018"/>
            <a:ext cx="47735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2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8" name="Rectangle 12">
            <a:extLst>
              <a:ext uri="{FF2B5EF4-FFF2-40B4-BE49-F238E27FC236}">
                <a16:creationId xmlns:a16="http://schemas.microsoft.com/office/drawing/2014/main" id="{7C7889A1-6A07-C507-F701-860D3D088380}"/>
              </a:ext>
            </a:extLst>
          </p:cNvPr>
          <p:cNvSpPr/>
          <p:nvPr/>
        </p:nvSpPr>
        <p:spPr>
          <a:xfrm>
            <a:off x="4108297" y="3829915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75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9" name="Rectangle 14">
            <a:extLst>
              <a:ext uri="{FF2B5EF4-FFF2-40B4-BE49-F238E27FC236}">
                <a16:creationId xmlns:a16="http://schemas.microsoft.com/office/drawing/2014/main" id="{0606C279-3CB5-0A2A-DC56-DA4E470086FC}"/>
              </a:ext>
            </a:extLst>
          </p:cNvPr>
          <p:cNvSpPr/>
          <p:nvPr/>
        </p:nvSpPr>
        <p:spPr>
          <a:xfrm>
            <a:off x="4094149" y="5681065"/>
            <a:ext cx="47735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5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21532409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図 13">
            <a:extLst>
              <a:ext uri="{FF2B5EF4-FFF2-40B4-BE49-F238E27FC236}">
                <a16:creationId xmlns:a16="http://schemas.microsoft.com/office/drawing/2014/main" id="{6C39FBDF-D5C0-80F0-FC3D-7EFF3C0BA848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77" t="-95" r="-277" b="-403"/>
          <a:stretch/>
        </p:blipFill>
        <p:spPr>
          <a:xfrm>
            <a:off x="1758462" y="0"/>
            <a:ext cx="8716107" cy="6893169"/>
          </a:xfrm>
          <a:prstGeom prst="rect">
            <a:avLst/>
          </a:prstGeom>
        </p:spPr>
      </p:pic>
      <p:sp>
        <p:nvSpPr>
          <p:cNvPr id="4" name="Rectangle 9">
            <a:extLst>
              <a:ext uri="{FF2B5EF4-FFF2-40B4-BE49-F238E27FC236}">
                <a16:creationId xmlns:a16="http://schemas.microsoft.com/office/drawing/2014/main" id="{381F2A84-6109-4299-A23B-43F1D1BD5D2D}"/>
              </a:ext>
            </a:extLst>
          </p:cNvPr>
          <p:cNvSpPr>
            <a:spLocks noChangeArrowheads="1"/>
          </p:cNvSpPr>
          <p:nvPr/>
        </p:nvSpPr>
        <p:spPr bwMode="auto">
          <a:xfrm rot="-3180000">
            <a:off x="6263304" y="980213"/>
            <a:ext cx="82586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549 WT</a:t>
            </a:r>
          </a:p>
        </p:txBody>
      </p:sp>
      <p:sp>
        <p:nvSpPr>
          <p:cNvPr id="5" name="Rectangle 6">
            <a:extLst>
              <a:ext uri="{FF2B5EF4-FFF2-40B4-BE49-F238E27FC236}">
                <a16:creationId xmlns:a16="http://schemas.microsoft.com/office/drawing/2014/main" id="{0A90B9EA-8BA9-1D80-3FF0-A313104BDB51}"/>
              </a:ext>
            </a:extLst>
          </p:cNvPr>
          <p:cNvSpPr>
            <a:spLocks noChangeArrowheads="1"/>
          </p:cNvSpPr>
          <p:nvPr/>
        </p:nvSpPr>
        <p:spPr bwMode="auto">
          <a:xfrm rot="18420000">
            <a:off x="6694038" y="986214"/>
            <a:ext cx="80823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549</a:t>
            </a:r>
            <a:r>
              <a:rPr kumimoji="1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KO</a:t>
            </a:r>
          </a:p>
        </p:txBody>
      </p:sp>
      <p:sp>
        <p:nvSpPr>
          <p:cNvPr id="20" name="Rectangle 16">
            <a:extLst>
              <a:ext uri="{FF2B5EF4-FFF2-40B4-BE49-F238E27FC236}">
                <a16:creationId xmlns:a16="http://schemas.microsoft.com/office/drawing/2014/main" id="{8170D971-A18B-43BE-54A6-647538998BC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28614" y="3453350"/>
            <a:ext cx="68800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C-MYC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EA9708BA-7471-746F-3539-A3F547F7C48C}"/>
              </a:ext>
            </a:extLst>
          </p:cNvPr>
          <p:cNvSpPr txBox="1"/>
          <p:nvPr/>
        </p:nvSpPr>
        <p:spPr>
          <a:xfrm>
            <a:off x="3827264" y="6252755"/>
            <a:ext cx="500842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+mn-cs"/>
              </a:rPr>
              <a:t>b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+mn-cs"/>
              </a:rPr>
              <a:t> Western blotting results show that EPPK1 was knocked out in A549</a:t>
            </a:r>
          </a:p>
        </p:txBody>
      </p:sp>
      <p:sp>
        <p:nvSpPr>
          <p:cNvPr id="22" name="Rectangle 5">
            <a:extLst>
              <a:ext uri="{FF2B5EF4-FFF2-40B4-BE49-F238E27FC236}">
                <a16:creationId xmlns:a16="http://schemas.microsoft.com/office/drawing/2014/main" id="{4C7AB5E2-A0C3-3055-D1FB-D4AFF1BE4539}"/>
              </a:ext>
            </a:extLst>
          </p:cNvPr>
          <p:cNvSpPr/>
          <p:nvPr/>
        </p:nvSpPr>
        <p:spPr>
          <a:xfrm>
            <a:off x="4769982" y="1260172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25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3" name="Rectangle 6">
            <a:extLst>
              <a:ext uri="{FF2B5EF4-FFF2-40B4-BE49-F238E27FC236}">
                <a16:creationId xmlns:a16="http://schemas.microsoft.com/office/drawing/2014/main" id="{BF02973F-EB7E-7A64-7824-4A67F1A87ABA}"/>
              </a:ext>
            </a:extLst>
          </p:cNvPr>
          <p:cNvSpPr/>
          <p:nvPr/>
        </p:nvSpPr>
        <p:spPr>
          <a:xfrm>
            <a:off x="4760048" y="1942648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5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4" name="Rectangle 7">
            <a:extLst>
              <a:ext uri="{FF2B5EF4-FFF2-40B4-BE49-F238E27FC236}">
                <a16:creationId xmlns:a16="http://schemas.microsoft.com/office/drawing/2014/main" id="{55C8F6BB-798C-83E1-034D-6CB9307E610B}"/>
              </a:ext>
            </a:extLst>
          </p:cNvPr>
          <p:cNvSpPr/>
          <p:nvPr/>
        </p:nvSpPr>
        <p:spPr>
          <a:xfrm>
            <a:off x="4806940" y="2503620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0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5" name="Rectangle 8">
            <a:extLst>
              <a:ext uri="{FF2B5EF4-FFF2-40B4-BE49-F238E27FC236}">
                <a16:creationId xmlns:a16="http://schemas.microsoft.com/office/drawing/2014/main" id="{2C02C94A-05BD-13FB-BA88-E3054AAD1BB9}"/>
              </a:ext>
            </a:extLst>
          </p:cNvPr>
          <p:cNvSpPr/>
          <p:nvPr/>
        </p:nvSpPr>
        <p:spPr>
          <a:xfrm>
            <a:off x="4904440" y="3594966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5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6" name="Rectangle 9">
            <a:extLst>
              <a:ext uri="{FF2B5EF4-FFF2-40B4-BE49-F238E27FC236}">
                <a16:creationId xmlns:a16="http://schemas.microsoft.com/office/drawing/2014/main" id="{50406CB4-535B-3888-B552-67E0C500A6B7}"/>
              </a:ext>
            </a:extLst>
          </p:cNvPr>
          <p:cNvSpPr/>
          <p:nvPr/>
        </p:nvSpPr>
        <p:spPr>
          <a:xfrm>
            <a:off x="4881298" y="4052536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37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7" name="Rectangle 10">
            <a:extLst>
              <a:ext uri="{FF2B5EF4-FFF2-40B4-BE49-F238E27FC236}">
                <a16:creationId xmlns:a16="http://schemas.microsoft.com/office/drawing/2014/main" id="{C9870F94-9BE2-F9E1-ED95-A17423E47CF6}"/>
              </a:ext>
            </a:extLst>
          </p:cNvPr>
          <p:cNvSpPr/>
          <p:nvPr/>
        </p:nvSpPr>
        <p:spPr>
          <a:xfrm>
            <a:off x="4873735" y="4570776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25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8" name="Rectangle 11">
            <a:extLst>
              <a:ext uri="{FF2B5EF4-FFF2-40B4-BE49-F238E27FC236}">
                <a16:creationId xmlns:a16="http://schemas.microsoft.com/office/drawing/2014/main" id="{52013037-D02D-AC3A-17C5-ED6BEF616592}"/>
              </a:ext>
            </a:extLst>
          </p:cNvPr>
          <p:cNvSpPr/>
          <p:nvPr/>
        </p:nvSpPr>
        <p:spPr>
          <a:xfrm>
            <a:off x="4873735" y="4758187"/>
            <a:ext cx="47735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2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9" name="Rectangle 12">
            <a:extLst>
              <a:ext uri="{FF2B5EF4-FFF2-40B4-BE49-F238E27FC236}">
                <a16:creationId xmlns:a16="http://schemas.microsoft.com/office/drawing/2014/main" id="{06310741-A2D9-D59B-FC21-EC1D37972C22}"/>
              </a:ext>
            </a:extLst>
          </p:cNvPr>
          <p:cNvSpPr/>
          <p:nvPr/>
        </p:nvSpPr>
        <p:spPr>
          <a:xfrm>
            <a:off x="4882020" y="2938961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75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0" name="Rectangle 14">
            <a:extLst>
              <a:ext uri="{FF2B5EF4-FFF2-40B4-BE49-F238E27FC236}">
                <a16:creationId xmlns:a16="http://schemas.microsoft.com/office/drawing/2014/main" id="{C2BB712D-205F-DE61-308E-82F83DBB1295}"/>
              </a:ext>
            </a:extLst>
          </p:cNvPr>
          <p:cNvSpPr/>
          <p:nvPr/>
        </p:nvSpPr>
        <p:spPr>
          <a:xfrm>
            <a:off x="4850288" y="4954234"/>
            <a:ext cx="47735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5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54405518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図 12">
            <a:extLst>
              <a:ext uri="{FF2B5EF4-FFF2-40B4-BE49-F238E27FC236}">
                <a16:creationId xmlns:a16="http://schemas.microsoft.com/office/drawing/2014/main" id="{4B4D32F6-24A1-94CD-D048-0210B0B7A8C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96" t="-490" r="-449" b="-405"/>
          <a:stretch/>
        </p:blipFill>
        <p:spPr>
          <a:xfrm>
            <a:off x="1570891" y="-64476"/>
            <a:ext cx="8768861" cy="6922476"/>
          </a:xfrm>
          <a:prstGeom prst="rect">
            <a:avLst/>
          </a:prstGeom>
        </p:spPr>
      </p:pic>
      <p:sp>
        <p:nvSpPr>
          <p:cNvPr id="4" name="Rectangle 8">
            <a:extLst>
              <a:ext uri="{FF2B5EF4-FFF2-40B4-BE49-F238E27FC236}">
                <a16:creationId xmlns:a16="http://schemas.microsoft.com/office/drawing/2014/main" id="{23016204-2C02-1585-3C5F-E6FAE1F082C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50425" y="4437240"/>
            <a:ext cx="43954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p53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5" name="Rectangle 9">
            <a:extLst>
              <a:ext uri="{FF2B5EF4-FFF2-40B4-BE49-F238E27FC236}">
                <a16:creationId xmlns:a16="http://schemas.microsoft.com/office/drawing/2014/main" id="{B44A4275-726E-1B9C-B702-62087D59ACF2}"/>
              </a:ext>
            </a:extLst>
          </p:cNvPr>
          <p:cNvSpPr>
            <a:spLocks noChangeArrowheads="1"/>
          </p:cNvSpPr>
          <p:nvPr/>
        </p:nvSpPr>
        <p:spPr bwMode="auto">
          <a:xfrm rot="-3180000">
            <a:off x="5788519" y="1525336"/>
            <a:ext cx="82586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549 WT</a:t>
            </a:r>
          </a:p>
        </p:txBody>
      </p:sp>
      <p:sp>
        <p:nvSpPr>
          <p:cNvPr id="9" name="Rectangle 6">
            <a:extLst>
              <a:ext uri="{FF2B5EF4-FFF2-40B4-BE49-F238E27FC236}">
                <a16:creationId xmlns:a16="http://schemas.microsoft.com/office/drawing/2014/main" id="{CA9FB2EA-C462-0D86-372E-8B9B669D36EB}"/>
              </a:ext>
            </a:extLst>
          </p:cNvPr>
          <p:cNvSpPr>
            <a:spLocks noChangeArrowheads="1"/>
          </p:cNvSpPr>
          <p:nvPr/>
        </p:nvSpPr>
        <p:spPr bwMode="auto">
          <a:xfrm rot="18420000">
            <a:off x="6219253" y="1531337"/>
            <a:ext cx="80823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549</a:t>
            </a:r>
            <a:r>
              <a:rPr kumimoji="1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KO</a:t>
            </a: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9A1A022D-3182-6078-1955-EAE189E050F9}"/>
              </a:ext>
            </a:extLst>
          </p:cNvPr>
          <p:cNvSpPr txBox="1"/>
          <p:nvPr/>
        </p:nvSpPr>
        <p:spPr>
          <a:xfrm>
            <a:off x="3827264" y="6252755"/>
            <a:ext cx="500842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+mn-cs"/>
              </a:rPr>
              <a:t>b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+mn-cs"/>
              </a:rPr>
              <a:t> Western blotting results show that EPPK1 was knocked out in A549</a:t>
            </a:r>
          </a:p>
        </p:txBody>
      </p:sp>
      <p:sp>
        <p:nvSpPr>
          <p:cNvPr id="29" name="Rectangle 5">
            <a:extLst>
              <a:ext uri="{FF2B5EF4-FFF2-40B4-BE49-F238E27FC236}">
                <a16:creationId xmlns:a16="http://schemas.microsoft.com/office/drawing/2014/main" id="{931F0108-7C6C-4408-1579-07E00A5067EB}"/>
              </a:ext>
            </a:extLst>
          </p:cNvPr>
          <p:cNvSpPr/>
          <p:nvPr/>
        </p:nvSpPr>
        <p:spPr>
          <a:xfrm>
            <a:off x="4377259" y="2016310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25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0" name="Rectangle 6">
            <a:extLst>
              <a:ext uri="{FF2B5EF4-FFF2-40B4-BE49-F238E27FC236}">
                <a16:creationId xmlns:a16="http://schemas.microsoft.com/office/drawing/2014/main" id="{E0B27F99-C8EA-EC94-3DD5-75ACE6CB4EB9}"/>
              </a:ext>
            </a:extLst>
          </p:cNvPr>
          <p:cNvSpPr/>
          <p:nvPr/>
        </p:nvSpPr>
        <p:spPr>
          <a:xfrm>
            <a:off x="4367325" y="2698786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5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1" name="Rectangle 7">
            <a:extLst>
              <a:ext uri="{FF2B5EF4-FFF2-40B4-BE49-F238E27FC236}">
                <a16:creationId xmlns:a16="http://schemas.microsoft.com/office/drawing/2014/main" id="{4328A18D-4284-BA97-E482-A6E25546B2D2}"/>
              </a:ext>
            </a:extLst>
          </p:cNvPr>
          <p:cNvSpPr/>
          <p:nvPr/>
        </p:nvSpPr>
        <p:spPr>
          <a:xfrm>
            <a:off x="4414217" y="3259758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0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2" name="Rectangle 8">
            <a:extLst>
              <a:ext uri="{FF2B5EF4-FFF2-40B4-BE49-F238E27FC236}">
                <a16:creationId xmlns:a16="http://schemas.microsoft.com/office/drawing/2014/main" id="{39BDA4D5-043B-6B7B-44DB-329D8E1E0066}"/>
              </a:ext>
            </a:extLst>
          </p:cNvPr>
          <p:cNvSpPr/>
          <p:nvPr/>
        </p:nvSpPr>
        <p:spPr>
          <a:xfrm>
            <a:off x="4511717" y="4351104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5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3" name="Rectangle 9">
            <a:extLst>
              <a:ext uri="{FF2B5EF4-FFF2-40B4-BE49-F238E27FC236}">
                <a16:creationId xmlns:a16="http://schemas.microsoft.com/office/drawing/2014/main" id="{778CC99D-F5B7-2DD8-1A3F-6A06696FA69F}"/>
              </a:ext>
            </a:extLst>
          </p:cNvPr>
          <p:cNvSpPr/>
          <p:nvPr/>
        </p:nvSpPr>
        <p:spPr>
          <a:xfrm>
            <a:off x="4488575" y="4808674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37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4" name="Rectangle 10">
            <a:extLst>
              <a:ext uri="{FF2B5EF4-FFF2-40B4-BE49-F238E27FC236}">
                <a16:creationId xmlns:a16="http://schemas.microsoft.com/office/drawing/2014/main" id="{755114AC-A684-D553-C199-F173D50FA00B}"/>
              </a:ext>
            </a:extLst>
          </p:cNvPr>
          <p:cNvSpPr/>
          <p:nvPr/>
        </p:nvSpPr>
        <p:spPr>
          <a:xfrm>
            <a:off x="4481012" y="5326914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25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5" name="Rectangle 11">
            <a:extLst>
              <a:ext uri="{FF2B5EF4-FFF2-40B4-BE49-F238E27FC236}">
                <a16:creationId xmlns:a16="http://schemas.microsoft.com/office/drawing/2014/main" id="{5518A00D-5525-E318-F1BD-E3F326466615}"/>
              </a:ext>
            </a:extLst>
          </p:cNvPr>
          <p:cNvSpPr/>
          <p:nvPr/>
        </p:nvSpPr>
        <p:spPr>
          <a:xfrm>
            <a:off x="4481012" y="5514325"/>
            <a:ext cx="47735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2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7" name="Rectangle 12">
            <a:extLst>
              <a:ext uri="{FF2B5EF4-FFF2-40B4-BE49-F238E27FC236}">
                <a16:creationId xmlns:a16="http://schemas.microsoft.com/office/drawing/2014/main" id="{8256494A-EEE2-87F8-760D-3F92261B25C0}"/>
              </a:ext>
            </a:extLst>
          </p:cNvPr>
          <p:cNvSpPr/>
          <p:nvPr/>
        </p:nvSpPr>
        <p:spPr>
          <a:xfrm>
            <a:off x="4489297" y="3695099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75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8" name="Rectangle 14">
            <a:extLst>
              <a:ext uri="{FF2B5EF4-FFF2-40B4-BE49-F238E27FC236}">
                <a16:creationId xmlns:a16="http://schemas.microsoft.com/office/drawing/2014/main" id="{C43C3DBC-C008-B8C6-F6AC-546B282F146E}"/>
              </a:ext>
            </a:extLst>
          </p:cNvPr>
          <p:cNvSpPr/>
          <p:nvPr/>
        </p:nvSpPr>
        <p:spPr>
          <a:xfrm>
            <a:off x="4457565" y="5710372"/>
            <a:ext cx="47735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5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47386846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図 11">
            <a:extLst>
              <a:ext uri="{FF2B5EF4-FFF2-40B4-BE49-F238E27FC236}">
                <a16:creationId xmlns:a16="http://schemas.microsoft.com/office/drawing/2014/main" id="{28543234-8173-5BD4-7C37-4F014CBD4F03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63" t="-372" r="-377" b="-556"/>
          <a:stretch/>
        </p:blipFill>
        <p:spPr>
          <a:xfrm>
            <a:off x="1547447" y="0"/>
            <a:ext cx="8739554" cy="6922477"/>
          </a:xfrm>
          <a:prstGeom prst="rect">
            <a:avLst/>
          </a:prstGeom>
        </p:spPr>
      </p:pic>
      <p:sp>
        <p:nvSpPr>
          <p:cNvPr id="4" name="Rectangle 8">
            <a:extLst>
              <a:ext uri="{FF2B5EF4-FFF2-40B4-BE49-F238E27FC236}">
                <a16:creationId xmlns:a16="http://schemas.microsoft.com/office/drawing/2014/main" id="{8A5473B4-35B6-4FBC-1ED4-181AC9185A9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35566" y="3677240"/>
            <a:ext cx="64793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β-actin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5" name="Rectangle 9">
            <a:extLst>
              <a:ext uri="{FF2B5EF4-FFF2-40B4-BE49-F238E27FC236}">
                <a16:creationId xmlns:a16="http://schemas.microsoft.com/office/drawing/2014/main" id="{B9719BC4-2541-8034-E0C4-81FF6264D902}"/>
              </a:ext>
            </a:extLst>
          </p:cNvPr>
          <p:cNvSpPr>
            <a:spLocks noChangeArrowheads="1"/>
          </p:cNvSpPr>
          <p:nvPr/>
        </p:nvSpPr>
        <p:spPr bwMode="auto">
          <a:xfrm rot="-3180000">
            <a:off x="6908073" y="569905"/>
            <a:ext cx="82586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549 WT</a:t>
            </a:r>
          </a:p>
        </p:txBody>
      </p:sp>
      <p:sp>
        <p:nvSpPr>
          <p:cNvPr id="9" name="Rectangle 6">
            <a:extLst>
              <a:ext uri="{FF2B5EF4-FFF2-40B4-BE49-F238E27FC236}">
                <a16:creationId xmlns:a16="http://schemas.microsoft.com/office/drawing/2014/main" id="{13C4FD28-C8C7-2546-201D-9C0DE7C37C5E}"/>
              </a:ext>
            </a:extLst>
          </p:cNvPr>
          <p:cNvSpPr>
            <a:spLocks noChangeArrowheads="1"/>
          </p:cNvSpPr>
          <p:nvPr/>
        </p:nvSpPr>
        <p:spPr bwMode="auto">
          <a:xfrm rot="18420000">
            <a:off x="7338807" y="575906"/>
            <a:ext cx="80823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549</a:t>
            </a:r>
            <a:r>
              <a:rPr kumimoji="1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KO</a:t>
            </a: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2ADF272C-9946-BEE7-020D-51B83A9E4A41}"/>
              </a:ext>
            </a:extLst>
          </p:cNvPr>
          <p:cNvSpPr txBox="1"/>
          <p:nvPr/>
        </p:nvSpPr>
        <p:spPr>
          <a:xfrm>
            <a:off x="3827264" y="6252755"/>
            <a:ext cx="500842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+mn-cs"/>
              </a:rPr>
              <a:t>b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+mn-cs"/>
              </a:rPr>
              <a:t> Western blotting results show that EPPK1 was knocked out in A549</a:t>
            </a:r>
          </a:p>
        </p:txBody>
      </p:sp>
      <p:sp>
        <p:nvSpPr>
          <p:cNvPr id="20" name="Rectangle 5">
            <a:extLst>
              <a:ext uri="{FF2B5EF4-FFF2-40B4-BE49-F238E27FC236}">
                <a16:creationId xmlns:a16="http://schemas.microsoft.com/office/drawing/2014/main" id="{8D08A382-EB1A-FF3B-700B-F6AF9972FA24}"/>
              </a:ext>
            </a:extLst>
          </p:cNvPr>
          <p:cNvSpPr/>
          <p:nvPr/>
        </p:nvSpPr>
        <p:spPr>
          <a:xfrm>
            <a:off x="5426474" y="955372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25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1" name="Rectangle 6">
            <a:extLst>
              <a:ext uri="{FF2B5EF4-FFF2-40B4-BE49-F238E27FC236}">
                <a16:creationId xmlns:a16="http://schemas.microsoft.com/office/drawing/2014/main" id="{E6E03EAC-75D4-EDC2-3DFA-B11C965551CE}"/>
              </a:ext>
            </a:extLst>
          </p:cNvPr>
          <p:cNvSpPr/>
          <p:nvPr/>
        </p:nvSpPr>
        <p:spPr>
          <a:xfrm>
            <a:off x="5416540" y="1637848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5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2" name="Rectangle 7">
            <a:extLst>
              <a:ext uri="{FF2B5EF4-FFF2-40B4-BE49-F238E27FC236}">
                <a16:creationId xmlns:a16="http://schemas.microsoft.com/office/drawing/2014/main" id="{E61D6082-F94D-559A-4626-0C47C31A54DA}"/>
              </a:ext>
            </a:extLst>
          </p:cNvPr>
          <p:cNvSpPr/>
          <p:nvPr/>
        </p:nvSpPr>
        <p:spPr>
          <a:xfrm>
            <a:off x="5463432" y="2198820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0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3" name="Rectangle 8">
            <a:extLst>
              <a:ext uri="{FF2B5EF4-FFF2-40B4-BE49-F238E27FC236}">
                <a16:creationId xmlns:a16="http://schemas.microsoft.com/office/drawing/2014/main" id="{89B36D89-A1E7-6749-96C0-453062AFCA27}"/>
              </a:ext>
            </a:extLst>
          </p:cNvPr>
          <p:cNvSpPr/>
          <p:nvPr/>
        </p:nvSpPr>
        <p:spPr>
          <a:xfrm>
            <a:off x="5560932" y="3290166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5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4" name="Rectangle 9">
            <a:extLst>
              <a:ext uri="{FF2B5EF4-FFF2-40B4-BE49-F238E27FC236}">
                <a16:creationId xmlns:a16="http://schemas.microsoft.com/office/drawing/2014/main" id="{B42E76E2-DCB8-1D5F-39C8-23697719706F}"/>
              </a:ext>
            </a:extLst>
          </p:cNvPr>
          <p:cNvSpPr/>
          <p:nvPr/>
        </p:nvSpPr>
        <p:spPr>
          <a:xfrm>
            <a:off x="5537790" y="3747736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37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5" name="Rectangle 10">
            <a:extLst>
              <a:ext uri="{FF2B5EF4-FFF2-40B4-BE49-F238E27FC236}">
                <a16:creationId xmlns:a16="http://schemas.microsoft.com/office/drawing/2014/main" id="{468F3A61-C227-BFF6-9AA9-AA54CAA3D10F}"/>
              </a:ext>
            </a:extLst>
          </p:cNvPr>
          <p:cNvSpPr/>
          <p:nvPr/>
        </p:nvSpPr>
        <p:spPr>
          <a:xfrm>
            <a:off x="5530227" y="4265976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25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6" name="Rectangle 11">
            <a:extLst>
              <a:ext uri="{FF2B5EF4-FFF2-40B4-BE49-F238E27FC236}">
                <a16:creationId xmlns:a16="http://schemas.microsoft.com/office/drawing/2014/main" id="{36129346-0931-0BB4-2A28-6C0858AAD3A6}"/>
              </a:ext>
            </a:extLst>
          </p:cNvPr>
          <p:cNvSpPr/>
          <p:nvPr/>
        </p:nvSpPr>
        <p:spPr>
          <a:xfrm>
            <a:off x="5530227" y="4453387"/>
            <a:ext cx="47735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2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7" name="Rectangle 12">
            <a:extLst>
              <a:ext uri="{FF2B5EF4-FFF2-40B4-BE49-F238E27FC236}">
                <a16:creationId xmlns:a16="http://schemas.microsoft.com/office/drawing/2014/main" id="{BD3B104D-94F1-7655-219F-1E288ECCA072}"/>
              </a:ext>
            </a:extLst>
          </p:cNvPr>
          <p:cNvSpPr/>
          <p:nvPr/>
        </p:nvSpPr>
        <p:spPr>
          <a:xfrm>
            <a:off x="5538512" y="2634161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75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8" name="Rectangle 14">
            <a:extLst>
              <a:ext uri="{FF2B5EF4-FFF2-40B4-BE49-F238E27FC236}">
                <a16:creationId xmlns:a16="http://schemas.microsoft.com/office/drawing/2014/main" id="{9E9EB115-378B-8CBD-6A80-9B8B613C1714}"/>
              </a:ext>
            </a:extLst>
          </p:cNvPr>
          <p:cNvSpPr/>
          <p:nvPr/>
        </p:nvSpPr>
        <p:spPr>
          <a:xfrm>
            <a:off x="5506780" y="4649434"/>
            <a:ext cx="47735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5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11126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3">
            <a:extLst>
              <a:ext uri="{FF2B5EF4-FFF2-40B4-BE49-F238E27FC236}">
                <a16:creationId xmlns:a16="http://schemas.microsoft.com/office/drawing/2014/main" id="{FA7AAB78-1FCF-E80A-36C7-6CC5D2207F56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64" t="-653" r="-241" b="-416"/>
          <a:stretch/>
        </p:blipFill>
        <p:spPr bwMode="auto">
          <a:xfrm>
            <a:off x="1160342" y="0"/>
            <a:ext cx="9497148" cy="69305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76019B3F-B100-9FB4-E000-A2A8D37BFEB3}"/>
              </a:ext>
            </a:extLst>
          </p:cNvPr>
          <p:cNvSpPr txBox="1"/>
          <p:nvPr/>
        </p:nvSpPr>
        <p:spPr>
          <a:xfrm>
            <a:off x="2856712" y="6396335"/>
            <a:ext cx="6924417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Fig. 2  Exposure of normal bronchial epithelial cells to cigarette smoking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 High expression of γH2AX protein observed after 16 weeks of smoking exposure in BEAS2B cells</a:t>
            </a:r>
          </a:p>
        </p:txBody>
      </p:sp>
      <p:sp>
        <p:nvSpPr>
          <p:cNvPr id="6" name="Rectangle 8">
            <a:extLst>
              <a:ext uri="{FF2B5EF4-FFF2-40B4-BE49-F238E27FC236}">
                <a16:creationId xmlns:a16="http://schemas.microsoft.com/office/drawing/2014/main" id="{F1122AE7-A591-4ADC-DD94-AD1A688CA71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70552" y="3458282"/>
            <a:ext cx="64793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β-actin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7" name="Rectangle 10">
            <a:extLst>
              <a:ext uri="{FF2B5EF4-FFF2-40B4-BE49-F238E27FC236}">
                <a16:creationId xmlns:a16="http://schemas.microsoft.com/office/drawing/2014/main" id="{FA7AD3CA-42F4-4B3D-B470-A2E8F4198A68}"/>
              </a:ext>
            </a:extLst>
          </p:cNvPr>
          <p:cNvSpPr>
            <a:spLocks noChangeArrowheads="1"/>
          </p:cNvSpPr>
          <p:nvPr/>
        </p:nvSpPr>
        <p:spPr bwMode="auto">
          <a:xfrm rot="18900000">
            <a:off x="4222718" y="897490"/>
            <a:ext cx="87788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8" name="Rectangle 11">
            <a:extLst>
              <a:ext uri="{FF2B5EF4-FFF2-40B4-BE49-F238E27FC236}">
                <a16:creationId xmlns:a16="http://schemas.microsoft.com/office/drawing/2014/main" id="{A4DAB8C3-44E0-6545-857F-DCB97E9C5228}"/>
              </a:ext>
            </a:extLst>
          </p:cNvPr>
          <p:cNvSpPr>
            <a:spLocks noChangeArrowheads="1"/>
          </p:cNvSpPr>
          <p:nvPr/>
        </p:nvSpPr>
        <p:spPr bwMode="auto">
          <a:xfrm rot="18900000">
            <a:off x="4640230" y="821290"/>
            <a:ext cx="104298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smoking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9" name="Rectangle 5">
            <a:extLst>
              <a:ext uri="{FF2B5EF4-FFF2-40B4-BE49-F238E27FC236}">
                <a16:creationId xmlns:a16="http://schemas.microsoft.com/office/drawing/2014/main" id="{DD644DB0-429C-B855-57EF-A1A08E2FF19B}"/>
              </a:ext>
            </a:extLst>
          </p:cNvPr>
          <p:cNvSpPr/>
          <p:nvPr/>
        </p:nvSpPr>
        <p:spPr>
          <a:xfrm>
            <a:off x="3204951" y="1987004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25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0" name="Rectangle 6">
            <a:extLst>
              <a:ext uri="{FF2B5EF4-FFF2-40B4-BE49-F238E27FC236}">
                <a16:creationId xmlns:a16="http://schemas.microsoft.com/office/drawing/2014/main" id="{306D2DAB-9FA8-8A65-178B-D0CF191C01EF}"/>
              </a:ext>
            </a:extLst>
          </p:cNvPr>
          <p:cNvSpPr/>
          <p:nvPr/>
        </p:nvSpPr>
        <p:spPr>
          <a:xfrm>
            <a:off x="3200879" y="2241588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5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1" name="Rectangle 7">
            <a:extLst>
              <a:ext uri="{FF2B5EF4-FFF2-40B4-BE49-F238E27FC236}">
                <a16:creationId xmlns:a16="http://schemas.microsoft.com/office/drawing/2014/main" id="{EA7A85E0-D6B0-A56B-8334-6CB091DBC73A}"/>
              </a:ext>
            </a:extLst>
          </p:cNvPr>
          <p:cNvSpPr/>
          <p:nvPr/>
        </p:nvSpPr>
        <p:spPr>
          <a:xfrm>
            <a:off x="3200879" y="2509483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0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2" name="Rectangle 8">
            <a:extLst>
              <a:ext uri="{FF2B5EF4-FFF2-40B4-BE49-F238E27FC236}">
                <a16:creationId xmlns:a16="http://schemas.microsoft.com/office/drawing/2014/main" id="{FB147BB7-6874-1B2E-3AA3-24E3EF6AEAE3}"/>
              </a:ext>
            </a:extLst>
          </p:cNvPr>
          <p:cNvSpPr/>
          <p:nvPr/>
        </p:nvSpPr>
        <p:spPr>
          <a:xfrm>
            <a:off x="3310102" y="3167075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5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3" name="Rectangle 9">
            <a:extLst>
              <a:ext uri="{FF2B5EF4-FFF2-40B4-BE49-F238E27FC236}">
                <a16:creationId xmlns:a16="http://schemas.microsoft.com/office/drawing/2014/main" id="{CCB244F1-35E7-6307-5689-93863DA2ED3A}"/>
              </a:ext>
            </a:extLst>
          </p:cNvPr>
          <p:cNvSpPr/>
          <p:nvPr/>
        </p:nvSpPr>
        <p:spPr>
          <a:xfrm>
            <a:off x="3322130" y="3577752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37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4" name="Rectangle 10">
            <a:extLst>
              <a:ext uri="{FF2B5EF4-FFF2-40B4-BE49-F238E27FC236}">
                <a16:creationId xmlns:a16="http://schemas.microsoft.com/office/drawing/2014/main" id="{C57EBE06-D079-6DEB-E1B3-480B82C54828}"/>
              </a:ext>
            </a:extLst>
          </p:cNvPr>
          <p:cNvSpPr/>
          <p:nvPr/>
        </p:nvSpPr>
        <p:spPr>
          <a:xfrm>
            <a:off x="3279397" y="4072545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25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5" name="Rectangle 11">
            <a:extLst>
              <a:ext uri="{FF2B5EF4-FFF2-40B4-BE49-F238E27FC236}">
                <a16:creationId xmlns:a16="http://schemas.microsoft.com/office/drawing/2014/main" id="{8598776A-1588-4B52-06AD-099B05C12EC2}"/>
              </a:ext>
            </a:extLst>
          </p:cNvPr>
          <p:cNvSpPr/>
          <p:nvPr/>
        </p:nvSpPr>
        <p:spPr>
          <a:xfrm>
            <a:off x="3279397" y="4259956"/>
            <a:ext cx="47735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2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6" name="Rectangle 12">
            <a:extLst>
              <a:ext uri="{FF2B5EF4-FFF2-40B4-BE49-F238E27FC236}">
                <a16:creationId xmlns:a16="http://schemas.microsoft.com/office/drawing/2014/main" id="{F9A5297B-43F5-1EE4-815C-C2DAA9825202}"/>
              </a:ext>
            </a:extLst>
          </p:cNvPr>
          <p:cNvSpPr/>
          <p:nvPr/>
        </p:nvSpPr>
        <p:spPr>
          <a:xfrm>
            <a:off x="3311128" y="2786562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75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7" name="Rectangle 14">
            <a:extLst>
              <a:ext uri="{FF2B5EF4-FFF2-40B4-BE49-F238E27FC236}">
                <a16:creationId xmlns:a16="http://schemas.microsoft.com/office/drawing/2014/main" id="{C3A7BBAD-40E2-8409-BAD4-47C3E332BACA}"/>
              </a:ext>
            </a:extLst>
          </p:cNvPr>
          <p:cNvSpPr/>
          <p:nvPr/>
        </p:nvSpPr>
        <p:spPr>
          <a:xfrm>
            <a:off x="3279396" y="4538064"/>
            <a:ext cx="47735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5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8" name="Rectangle 14">
            <a:extLst>
              <a:ext uri="{FF2B5EF4-FFF2-40B4-BE49-F238E27FC236}">
                <a16:creationId xmlns:a16="http://schemas.microsoft.com/office/drawing/2014/main" id="{16322B70-4E14-B136-F99E-5BD4793E37FF}"/>
              </a:ext>
            </a:extLst>
          </p:cNvPr>
          <p:cNvSpPr/>
          <p:nvPr/>
        </p:nvSpPr>
        <p:spPr>
          <a:xfrm>
            <a:off x="3279396" y="4922366"/>
            <a:ext cx="47735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4924192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3">
            <a:extLst>
              <a:ext uri="{FF2B5EF4-FFF2-40B4-BE49-F238E27FC236}">
                <a16:creationId xmlns:a16="http://schemas.microsoft.com/office/drawing/2014/main" id="{6B2DF8D8-59E4-4677-2BDA-DA81934F749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28" t="-1785" r="-2273" b="-3854"/>
          <a:stretch/>
        </p:blipFill>
        <p:spPr bwMode="auto">
          <a:xfrm>
            <a:off x="1436076" y="-112323"/>
            <a:ext cx="9665677" cy="72448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93A019F2-80FA-282F-37CF-DE8F92EF67FD}"/>
              </a:ext>
            </a:extLst>
          </p:cNvPr>
          <p:cNvSpPr txBox="1"/>
          <p:nvPr/>
        </p:nvSpPr>
        <p:spPr>
          <a:xfrm>
            <a:off x="2892965" y="5919423"/>
            <a:ext cx="709756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D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 EPPK1 protein is highly expressed in BEAS2B after 16 weeks of smoking exposure</a:t>
            </a:r>
          </a:p>
        </p:txBody>
      </p:sp>
      <p:sp>
        <p:nvSpPr>
          <p:cNvPr id="13" name="Rectangle 14">
            <a:extLst>
              <a:ext uri="{FF2B5EF4-FFF2-40B4-BE49-F238E27FC236}">
                <a16:creationId xmlns:a16="http://schemas.microsoft.com/office/drawing/2014/main" id="{DD17B9F7-FA33-F56D-D853-1F393E4B41F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45712" y="668009"/>
            <a:ext cx="67999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rPr>
              <a:t>EPPK1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19" name="Rectangle 5">
            <a:extLst>
              <a:ext uri="{FF2B5EF4-FFF2-40B4-BE49-F238E27FC236}">
                <a16:creationId xmlns:a16="http://schemas.microsoft.com/office/drawing/2014/main" id="{27FB0E14-9FDF-F29A-E2B7-4F0D3E4D0A71}"/>
              </a:ext>
            </a:extLst>
          </p:cNvPr>
          <p:cNvSpPr/>
          <p:nvPr/>
        </p:nvSpPr>
        <p:spPr>
          <a:xfrm>
            <a:off x="2800884" y="649058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46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0" name="Rectangle 6">
            <a:extLst>
              <a:ext uri="{FF2B5EF4-FFF2-40B4-BE49-F238E27FC236}">
                <a16:creationId xmlns:a16="http://schemas.microsoft.com/office/drawing/2014/main" id="{1A3A66FF-D077-2DE7-513A-EA6E8B267C13}"/>
              </a:ext>
            </a:extLst>
          </p:cNvPr>
          <p:cNvSpPr/>
          <p:nvPr/>
        </p:nvSpPr>
        <p:spPr>
          <a:xfrm>
            <a:off x="2828793" y="1222509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268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1" name="Rectangle 7">
            <a:extLst>
              <a:ext uri="{FF2B5EF4-FFF2-40B4-BE49-F238E27FC236}">
                <a16:creationId xmlns:a16="http://schemas.microsoft.com/office/drawing/2014/main" id="{559B75D8-E446-E8A0-E901-C1782B2970FE}"/>
              </a:ext>
            </a:extLst>
          </p:cNvPr>
          <p:cNvSpPr/>
          <p:nvPr/>
        </p:nvSpPr>
        <p:spPr>
          <a:xfrm>
            <a:off x="2828792" y="1416389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238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2" name="Rectangle 8">
            <a:extLst>
              <a:ext uri="{FF2B5EF4-FFF2-40B4-BE49-F238E27FC236}">
                <a16:creationId xmlns:a16="http://schemas.microsoft.com/office/drawing/2014/main" id="{3B7FFEB4-516B-A7E1-8812-45C9156A7891}"/>
              </a:ext>
            </a:extLst>
          </p:cNvPr>
          <p:cNvSpPr/>
          <p:nvPr/>
        </p:nvSpPr>
        <p:spPr>
          <a:xfrm>
            <a:off x="2818004" y="2445382"/>
            <a:ext cx="5522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17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3" name="Rectangle 9">
            <a:extLst>
              <a:ext uri="{FF2B5EF4-FFF2-40B4-BE49-F238E27FC236}">
                <a16:creationId xmlns:a16="http://schemas.microsoft.com/office/drawing/2014/main" id="{4241914D-68D9-435B-BBF1-4BF4287BE254}"/>
              </a:ext>
            </a:extLst>
          </p:cNvPr>
          <p:cNvSpPr/>
          <p:nvPr/>
        </p:nvSpPr>
        <p:spPr>
          <a:xfrm>
            <a:off x="2895747" y="2780278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7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4" name="Rectangle 10">
            <a:extLst>
              <a:ext uri="{FF2B5EF4-FFF2-40B4-BE49-F238E27FC236}">
                <a16:creationId xmlns:a16="http://schemas.microsoft.com/office/drawing/2014/main" id="{88238B6D-DD67-ABCB-55A0-F54954EEA6F3}"/>
              </a:ext>
            </a:extLst>
          </p:cNvPr>
          <p:cNvSpPr/>
          <p:nvPr/>
        </p:nvSpPr>
        <p:spPr>
          <a:xfrm>
            <a:off x="2892914" y="3443846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55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5" name="Rectangle 11">
            <a:extLst>
              <a:ext uri="{FF2B5EF4-FFF2-40B4-BE49-F238E27FC236}">
                <a16:creationId xmlns:a16="http://schemas.microsoft.com/office/drawing/2014/main" id="{6DAFB587-A883-93D1-F51A-1420DD980936}"/>
              </a:ext>
            </a:extLst>
          </p:cNvPr>
          <p:cNvSpPr/>
          <p:nvPr/>
        </p:nvSpPr>
        <p:spPr>
          <a:xfrm>
            <a:off x="2910499" y="4095538"/>
            <a:ext cx="47735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4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6" name="Rectangle 12">
            <a:extLst>
              <a:ext uri="{FF2B5EF4-FFF2-40B4-BE49-F238E27FC236}">
                <a16:creationId xmlns:a16="http://schemas.microsoft.com/office/drawing/2014/main" id="{3E3EB8DD-8F6A-F096-2E16-3A89EB4E2279}"/>
              </a:ext>
            </a:extLst>
          </p:cNvPr>
          <p:cNvSpPr/>
          <p:nvPr/>
        </p:nvSpPr>
        <p:spPr>
          <a:xfrm>
            <a:off x="2800884" y="2178067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7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7" name="Rectangle 14">
            <a:extLst>
              <a:ext uri="{FF2B5EF4-FFF2-40B4-BE49-F238E27FC236}">
                <a16:creationId xmlns:a16="http://schemas.microsoft.com/office/drawing/2014/main" id="{28F5866D-2F14-4056-4673-945F41A295CC}"/>
              </a:ext>
            </a:extLst>
          </p:cNvPr>
          <p:cNvSpPr/>
          <p:nvPr/>
        </p:nvSpPr>
        <p:spPr>
          <a:xfrm>
            <a:off x="2900479" y="4701345"/>
            <a:ext cx="47735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3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9" name="Rectangle 10">
            <a:extLst>
              <a:ext uri="{FF2B5EF4-FFF2-40B4-BE49-F238E27FC236}">
                <a16:creationId xmlns:a16="http://schemas.microsoft.com/office/drawing/2014/main" id="{57E66AEC-8505-7289-0EE6-7F98D010940B}"/>
              </a:ext>
            </a:extLst>
          </p:cNvPr>
          <p:cNvSpPr>
            <a:spLocks noChangeArrowheads="1"/>
          </p:cNvSpPr>
          <p:nvPr/>
        </p:nvSpPr>
        <p:spPr bwMode="auto">
          <a:xfrm rot="18900000">
            <a:off x="3932094" y="68149"/>
            <a:ext cx="87788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30" name="Rectangle 11">
            <a:extLst>
              <a:ext uri="{FF2B5EF4-FFF2-40B4-BE49-F238E27FC236}">
                <a16:creationId xmlns:a16="http://schemas.microsoft.com/office/drawing/2014/main" id="{A722DF3B-A79C-BC1A-1131-568D18CA2F44}"/>
              </a:ext>
            </a:extLst>
          </p:cNvPr>
          <p:cNvSpPr>
            <a:spLocks noChangeArrowheads="1"/>
          </p:cNvSpPr>
          <p:nvPr/>
        </p:nvSpPr>
        <p:spPr bwMode="auto">
          <a:xfrm rot="18900000">
            <a:off x="4349606" y="-8051"/>
            <a:ext cx="104298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smoking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1" name="Rectangle 17">
            <a:extLst>
              <a:ext uri="{FF2B5EF4-FFF2-40B4-BE49-F238E27FC236}">
                <a16:creationId xmlns:a16="http://schemas.microsoft.com/office/drawing/2014/main" id="{D98FC3FB-D6DF-0680-B8E3-4179B5042A9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08607" y="5512663"/>
            <a:ext cx="393272" cy="2785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#1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6">
            <a:extLst>
              <a:ext uri="{FF2B5EF4-FFF2-40B4-BE49-F238E27FC236}">
                <a16:creationId xmlns:a16="http://schemas.microsoft.com/office/drawing/2014/main" id="{1D33BA9F-25E9-DC8C-D408-B32276364C2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624" t="-1177" r="-782" b="-1265"/>
          <a:stretch/>
        </p:blipFill>
        <p:spPr bwMode="auto">
          <a:xfrm>
            <a:off x="1368057" y="-85062"/>
            <a:ext cx="9562214" cy="70245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0" name="Rectangle 5">
            <a:extLst>
              <a:ext uri="{FF2B5EF4-FFF2-40B4-BE49-F238E27FC236}">
                <a16:creationId xmlns:a16="http://schemas.microsoft.com/office/drawing/2014/main" id="{F2046509-8524-33BC-3866-7DA0C6EB144E}"/>
              </a:ext>
            </a:extLst>
          </p:cNvPr>
          <p:cNvSpPr/>
          <p:nvPr/>
        </p:nvSpPr>
        <p:spPr>
          <a:xfrm>
            <a:off x="2354317" y="1379159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46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1" name="Rectangle 6">
            <a:extLst>
              <a:ext uri="{FF2B5EF4-FFF2-40B4-BE49-F238E27FC236}">
                <a16:creationId xmlns:a16="http://schemas.microsoft.com/office/drawing/2014/main" id="{5DA82ED2-4396-FF76-B39C-2B2EB37616DD}"/>
              </a:ext>
            </a:extLst>
          </p:cNvPr>
          <p:cNvSpPr/>
          <p:nvPr/>
        </p:nvSpPr>
        <p:spPr>
          <a:xfrm>
            <a:off x="2382226" y="1952610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268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2" name="Rectangle 7">
            <a:extLst>
              <a:ext uri="{FF2B5EF4-FFF2-40B4-BE49-F238E27FC236}">
                <a16:creationId xmlns:a16="http://schemas.microsoft.com/office/drawing/2014/main" id="{40CAC06B-0EFC-0F1A-DD0E-EE560F070DD5}"/>
              </a:ext>
            </a:extLst>
          </p:cNvPr>
          <p:cNvSpPr/>
          <p:nvPr/>
        </p:nvSpPr>
        <p:spPr>
          <a:xfrm>
            <a:off x="2382225" y="2146490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238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3" name="Rectangle 8">
            <a:extLst>
              <a:ext uri="{FF2B5EF4-FFF2-40B4-BE49-F238E27FC236}">
                <a16:creationId xmlns:a16="http://schemas.microsoft.com/office/drawing/2014/main" id="{786B20BB-8868-E4FE-E198-A9DC3D79904E}"/>
              </a:ext>
            </a:extLst>
          </p:cNvPr>
          <p:cNvSpPr/>
          <p:nvPr/>
        </p:nvSpPr>
        <p:spPr>
          <a:xfrm>
            <a:off x="2371437" y="3175483"/>
            <a:ext cx="5522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17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4" name="Rectangle 9">
            <a:extLst>
              <a:ext uri="{FF2B5EF4-FFF2-40B4-BE49-F238E27FC236}">
                <a16:creationId xmlns:a16="http://schemas.microsoft.com/office/drawing/2014/main" id="{FFDE4A29-CBB1-705A-3908-BC683010A959}"/>
              </a:ext>
            </a:extLst>
          </p:cNvPr>
          <p:cNvSpPr/>
          <p:nvPr/>
        </p:nvSpPr>
        <p:spPr>
          <a:xfrm>
            <a:off x="2449180" y="3510379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7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5" name="Rectangle 10">
            <a:extLst>
              <a:ext uri="{FF2B5EF4-FFF2-40B4-BE49-F238E27FC236}">
                <a16:creationId xmlns:a16="http://schemas.microsoft.com/office/drawing/2014/main" id="{C8D5DA48-EC68-D5BB-5F61-2A35D716779B}"/>
              </a:ext>
            </a:extLst>
          </p:cNvPr>
          <p:cNvSpPr/>
          <p:nvPr/>
        </p:nvSpPr>
        <p:spPr>
          <a:xfrm>
            <a:off x="2446347" y="4173947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55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6" name="Rectangle 11">
            <a:extLst>
              <a:ext uri="{FF2B5EF4-FFF2-40B4-BE49-F238E27FC236}">
                <a16:creationId xmlns:a16="http://schemas.microsoft.com/office/drawing/2014/main" id="{5B19AF19-5B88-C375-86BF-3A6522451871}"/>
              </a:ext>
            </a:extLst>
          </p:cNvPr>
          <p:cNvSpPr/>
          <p:nvPr/>
        </p:nvSpPr>
        <p:spPr>
          <a:xfrm>
            <a:off x="2463932" y="4825639"/>
            <a:ext cx="47735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4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7" name="Rectangle 12">
            <a:extLst>
              <a:ext uri="{FF2B5EF4-FFF2-40B4-BE49-F238E27FC236}">
                <a16:creationId xmlns:a16="http://schemas.microsoft.com/office/drawing/2014/main" id="{DAA11407-F5CA-AC3D-F380-3B87E256D684}"/>
              </a:ext>
            </a:extLst>
          </p:cNvPr>
          <p:cNvSpPr/>
          <p:nvPr/>
        </p:nvSpPr>
        <p:spPr>
          <a:xfrm>
            <a:off x="2354317" y="2823107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7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8" name="Rectangle 14">
            <a:extLst>
              <a:ext uri="{FF2B5EF4-FFF2-40B4-BE49-F238E27FC236}">
                <a16:creationId xmlns:a16="http://schemas.microsoft.com/office/drawing/2014/main" id="{09F2A593-FE87-D289-D44F-9600D5A483AA}"/>
              </a:ext>
            </a:extLst>
          </p:cNvPr>
          <p:cNvSpPr/>
          <p:nvPr/>
        </p:nvSpPr>
        <p:spPr>
          <a:xfrm>
            <a:off x="2453912" y="5431446"/>
            <a:ext cx="47735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3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9" name="Rectangle 10">
            <a:extLst>
              <a:ext uri="{FF2B5EF4-FFF2-40B4-BE49-F238E27FC236}">
                <a16:creationId xmlns:a16="http://schemas.microsoft.com/office/drawing/2014/main" id="{B897C2EB-73AE-4215-FBB6-AC899CE51750}"/>
              </a:ext>
            </a:extLst>
          </p:cNvPr>
          <p:cNvSpPr>
            <a:spLocks noChangeArrowheads="1"/>
          </p:cNvSpPr>
          <p:nvPr/>
        </p:nvSpPr>
        <p:spPr bwMode="auto">
          <a:xfrm rot="18900000">
            <a:off x="3485527" y="798250"/>
            <a:ext cx="87788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40" name="Rectangle 11">
            <a:extLst>
              <a:ext uri="{FF2B5EF4-FFF2-40B4-BE49-F238E27FC236}">
                <a16:creationId xmlns:a16="http://schemas.microsoft.com/office/drawing/2014/main" id="{368E38BF-FC7D-5477-C31A-03AF2692CDF6}"/>
              </a:ext>
            </a:extLst>
          </p:cNvPr>
          <p:cNvSpPr>
            <a:spLocks noChangeArrowheads="1"/>
          </p:cNvSpPr>
          <p:nvPr/>
        </p:nvSpPr>
        <p:spPr bwMode="auto">
          <a:xfrm rot="18900000">
            <a:off x="3903039" y="722050"/>
            <a:ext cx="104298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smoking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41" name="Rectangle 17">
            <a:extLst>
              <a:ext uri="{FF2B5EF4-FFF2-40B4-BE49-F238E27FC236}">
                <a16:creationId xmlns:a16="http://schemas.microsoft.com/office/drawing/2014/main" id="{8B9A9BA4-7BA6-49DA-3747-43F9257BE0A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62040" y="6242764"/>
            <a:ext cx="393272" cy="2785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#1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42" name="Rectangle 8">
            <a:extLst>
              <a:ext uri="{FF2B5EF4-FFF2-40B4-BE49-F238E27FC236}">
                <a16:creationId xmlns:a16="http://schemas.microsoft.com/office/drawing/2014/main" id="{93DE11AF-661B-52DC-AB72-B1C2794F4D0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62478" y="4953928"/>
            <a:ext cx="64793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β-actin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EA088187-24A8-490C-D8CE-6F37058029AD}"/>
              </a:ext>
            </a:extLst>
          </p:cNvPr>
          <p:cNvSpPr txBox="1"/>
          <p:nvPr/>
        </p:nvSpPr>
        <p:spPr>
          <a:xfrm>
            <a:off x="2834350" y="6493854"/>
            <a:ext cx="709756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D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 EPPK1 protein is highly expressed in BEAS2B after 16 weeks of smoking exposure</a:t>
            </a: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8BF3C505-B0AB-4BD5-CC25-84B4936150E0}"/>
              </a:ext>
            </a:extLst>
          </p:cNvPr>
          <p:cNvSpPr txBox="1"/>
          <p:nvPr/>
        </p:nvSpPr>
        <p:spPr>
          <a:xfrm>
            <a:off x="3180045" y="5596902"/>
            <a:ext cx="709756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D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 EPPK1 protein is highly expressed in BEAS2B after 16 weeks of smoking exposure</a:t>
            </a:r>
          </a:p>
        </p:txBody>
      </p:sp>
      <p:pic>
        <p:nvPicPr>
          <p:cNvPr id="4" name="Picture 10">
            <a:extLst>
              <a:ext uri="{FF2B5EF4-FFF2-40B4-BE49-F238E27FC236}">
                <a16:creationId xmlns:a16="http://schemas.microsoft.com/office/drawing/2014/main" id="{C0F8890E-D55A-FD5A-4F31-56346117171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303" t="-1040" r="-1245" b="2236"/>
          <a:stretch/>
        </p:blipFill>
        <p:spPr bwMode="auto">
          <a:xfrm>
            <a:off x="1459523" y="-709246"/>
            <a:ext cx="9583615" cy="842889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4295CC42-4274-4255-7378-6BA4C021D96C}"/>
              </a:ext>
            </a:extLst>
          </p:cNvPr>
          <p:cNvSpPr txBox="1"/>
          <p:nvPr/>
        </p:nvSpPr>
        <p:spPr>
          <a:xfrm>
            <a:off x="2482657" y="6529023"/>
            <a:ext cx="709756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D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 EPPK1 protein is highly expressed in BEAS2B after 16 weeks of smoking exposure</a:t>
            </a:r>
          </a:p>
        </p:txBody>
      </p:sp>
      <p:sp>
        <p:nvSpPr>
          <p:cNvPr id="31" name="Rectangle 14">
            <a:extLst>
              <a:ext uri="{FF2B5EF4-FFF2-40B4-BE49-F238E27FC236}">
                <a16:creationId xmlns:a16="http://schemas.microsoft.com/office/drawing/2014/main" id="{F6D906FD-E1BB-61AE-67FC-C8B578B69F0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47127" y="949363"/>
            <a:ext cx="67999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rPr>
              <a:t>EPPK1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32" name="Rectangle 5">
            <a:extLst>
              <a:ext uri="{FF2B5EF4-FFF2-40B4-BE49-F238E27FC236}">
                <a16:creationId xmlns:a16="http://schemas.microsoft.com/office/drawing/2014/main" id="{AEB4DCEC-9F2D-C5AB-A96A-DB69908CC4AD}"/>
              </a:ext>
            </a:extLst>
          </p:cNvPr>
          <p:cNvSpPr/>
          <p:nvPr/>
        </p:nvSpPr>
        <p:spPr>
          <a:xfrm>
            <a:off x="2402299" y="930412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46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3" name="Rectangle 6">
            <a:extLst>
              <a:ext uri="{FF2B5EF4-FFF2-40B4-BE49-F238E27FC236}">
                <a16:creationId xmlns:a16="http://schemas.microsoft.com/office/drawing/2014/main" id="{32F86DF8-CDA7-BF80-DCAF-96B265B70E8F}"/>
              </a:ext>
            </a:extLst>
          </p:cNvPr>
          <p:cNvSpPr/>
          <p:nvPr/>
        </p:nvSpPr>
        <p:spPr>
          <a:xfrm>
            <a:off x="2430208" y="1503863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268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4" name="Rectangle 7">
            <a:extLst>
              <a:ext uri="{FF2B5EF4-FFF2-40B4-BE49-F238E27FC236}">
                <a16:creationId xmlns:a16="http://schemas.microsoft.com/office/drawing/2014/main" id="{BF63F29A-17C5-7C7C-0938-7EF94A544D46}"/>
              </a:ext>
            </a:extLst>
          </p:cNvPr>
          <p:cNvSpPr/>
          <p:nvPr/>
        </p:nvSpPr>
        <p:spPr>
          <a:xfrm>
            <a:off x="2430207" y="1697743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238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5" name="Rectangle 8">
            <a:extLst>
              <a:ext uri="{FF2B5EF4-FFF2-40B4-BE49-F238E27FC236}">
                <a16:creationId xmlns:a16="http://schemas.microsoft.com/office/drawing/2014/main" id="{65930E23-735E-132A-A161-4D5714325FFC}"/>
              </a:ext>
            </a:extLst>
          </p:cNvPr>
          <p:cNvSpPr/>
          <p:nvPr/>
        </p:nvSpPr>
        <p:spPr>
          <a:xfrm>
            <a:off x="2413557" y="3101875"/>
            <a:ext cx="5522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17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6" name="Rectangle 9">
            <a:extLst>
              <a:ext uri="{FF2B5EF4-FFF2-40B4-BE49-F238E27FC236}">
                <a16:creationId xmlns:a16="http://schemas.microsoft.com/office/drawing/2014/main" id="{BDD675A0-FE05-1CD9-A23E-34C42E470C57}"/>
              </a:ext>
            </a:extLst>
          </p:cNvPr>
          <p:cNvSpPr/>
          <p:nvPr/>
        </p:nvSpPr>
        <p:spPr>
          <a:xfrm>
            <a:off x="2497162" y="3583309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7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7" name="Rectangle 10">
            <a:extLst>
              <a:ext uri="{FF2B5EF4-FFF2-40B4-BE49-F238E27FC236}">
                <a16:creationId xmlns:a16="http://schemas.microsoft.com/office/drawing/2014/main" id="{8EA5FF96-101B-B726-E381-C3F32219AFBA}"/>
              </a:ext>
            </a:extLst>
          </p:cNvPr>
          <p:cNvSpPr/>
          <p:nvPr/>
        </p:nvSpPr>
        <p:spPr>
          <a:xfrm>
            <a:off x="2476744" y="4346524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55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8" name="Rectangle 11">
            <a:extLst>
              <a:ext uri="{FF2B5EF4-FFF2-40B4-BE49-F238E27FC236}">
                <a16:creationId xmlns:a16="http://schemas.microsoft.com/office/drawing/2014/main" id="{A8FA56C9-AEAC-343D-DE28-720BB48C0126}"/>
              </a:ext>
            </a:extLst>
          </p:cNvPr>
          <p:cNvSpPr/>
          <p:nvPr/>
        </p:nvSpPr>
        <p:spPr>
          <a:xfrm>
            <a:off x="2488468" y="5015799"/>
            <a:ext cx="47735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4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9" name="Rectangle 12">
            <a:extLst>
              <a:ext uri="{FF2B5EF4-FFF2-40B4-BE49-F238E27FC236}">
                <a16:creationId xmlns:a16="http://schemas.microsoft.com/office/drawing/2014/main" id="{1829E3E9-57A3-022B-1D42-006D071A5146}"/>
              </a:ext>
            </a:extLst>
          </p:cNvPr>
          <p:cNvSpPr/>
          <p:nvPr/>
        </p:nvSpPr>
        <p:spPr>
          <a:xfrm>
            <a:off x="2402299" y="2652851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7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40" name="Rectangle 14">
            <a:extLst>
              <a:ext uri="{FF2B5EF4-FFF2-40B4-BE49-F238E27FC236}">
                <a16:creationId xmlns:a16="http://schemas.microsoft.com/office/drawing/2014/main" id="{14316BA1-509A-5B14-B838-98EFCE5268C2}"/>
              </a:ext>
            </a:extLst>
          </p:cNvPr>
          <p:cNvSpPr/>
          <p:nvPr/>
        </p:nvSpPr>
        <p:spPr>
          <a:xfrm>
            <a:off x="2484309" y="5703668"/>
            <a:ext cx="47735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3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41" name="Rectangle 10">
            <a:extLst>
              <a:ext uri="{FF2B5EF4-FFF2-40B4-BE49-F238E27FC236}">
                <a16:creationId xmlns:a16="http://schemas.microsoft.com/office/drawing/2014/main" id="{0913F22B-5359-CAF6-451B-B7030E9EEA58}"/>
              </a:ext>
            </a:extLst>
          </p:cNvPr>
          <p:cNvSpPr>
            <a:spLocks noChangeArrowheads="1"/>
          </p:cNvSpPr>
          <p:nvPr/>
        </p:nvSpPr>
        <p:spPr bwMode="auto">
          <a:xfrm rot="18900000">
            <a:off x="4090355" y="50564"/>
            <a:ext cx="87788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42" name="Rectangle 11">
            <a:extLst>
              <a:ext uri="{FF2B5EF4-FFF2-40B4-BE49-F238E27FC236}">
                <a16:creationId xmlns:a16="http://schemas.microsoft.com/office/drawing/2014/main" id="{EF85B832-D571-F6C8-EED1-A7A26D5637A9}"/>
              </a:ext>
            </a:extLst>
          </p:cNvPr>
          <p:cNvSpPr>
            <a:spLocks noChangeArrowheads="1"/>
          </p:cNvSpPr>
          <p:nvPr/>
        </p:nvSpPr>
        <p:spPr bwMode="auto">
          <a:xfrm rot="18900000">
            <a:off x="4466836" y="9534"/>
            <a:ext cx="104298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smoking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43" name="Rectangle 17">
            <a:extLst>
              <a:ext uri="{FF2B5EF4-FFF2-40B4-BE49-F238E27FC236}">
                <a16:creationId xmlns:a16="http://schemas.microsoft.com/office/drawing/2014/main" id="{D1B3D840-66C7-8F9F-9CBA-6A3A8D3B2C2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95114" y="6371493"/>
            <a:ext cx="393272" cy="2785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#2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8BF3C505-B0AB-4BD5-CC25-84B4936150E0}"/>
              </a:ext>
            </a:extLst>
          </p:cNvPr>
          <p:cNvSpPr txBox="1"/>
          <p:nvPr/>
        </p:nvSpPr>
        <p:spPr>
          <a:xfrm>
            <a:off x="3180045" y="5596902"/>
            <a:ext cx="709756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D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 EPPK1 protein is highly expressed in BEAS2B after 16 weeks of smoking exposure</a:t>
            </a:r>
          </a:p>
        </p:txBody>
      </p:sp>
      <p:pic>
        <p:nvPicPr>
          <p:cNvPr id="5" name="Picture 11">
            <a:extLst>
              <a:ext uri="{FF2B5EF4-FFF2-40B4-BE49-F238E27FC236}">
                <a16:creationId xmlns:a16="http://schemas.microsoft.com/office/drawing/2014/main" id="{7DEA53E0-EFC9-EC63-D3EE-ACD43EDA7E9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515" t="-1136" r="-756" b="-2591"/>
          <a:stretch/>
        </p:blipFill>
        <p:spPr bwMode="auto">
          <a:xfrm>
            <a:off x="2145324" y="-211015"/>
            <a:ext cx="9413630" cy="71217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DF5065EB-1978-B3C5-F76F-5E77E28F3424}"/>
              </a:ext>
            </a:extLst>
          </p:cNvPr>
          <p:cNvSpPr txBox="1"/>
          <p:nvPr/>
        </p:nvSpPr>
        <p:spPr>
          <a:xfrm>
            <a:off x="4035830" y="6382349"/>
            <a:ext cx="709756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D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 EPPK1 protein is highly expressed in BEAS2B after 16 weeks of smoking exposure</a:t>
            </a:r>
          </a:p>
        </p:txBody>
      </p:sp>
      <p:sp>
        <p:nvSpPr>
          <p:cNvPr id="19" name="Rectangle 5">
            <a:extLst>
              <a:ext uri="{FF2B5EF4-FFF2-40B4-BE49-F238E27FC236}">
                <a16:creationId xmlns:a16="http://schemas.microsoft.com/office/drawing/2014/main" id="{3C399493-D608-CCA3-66D0-3AD8EA5AD85C}"/>
              </a:ext>
            </a:extLst>
          </p:cNvPr>
          <p:cNvSpPr/>
          <p:nvPr/>
        </p:nvSpPr>
        <p:spPr>
          <a:xfrm>
            <a:off x="3973191" y="1487259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46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0" name="Rectangle 6">
            <a:extLst>
              <a:ext uri="{FF2B5EF4-FFF2-40B4-BE49-F238E27FC236}">
                <a16:creationId xmlns:a16="http://schemas.microsoft.com/office/drawing/2014/main" id="{8AB64E9B-D264-6A0F-4E43-A9E1F71873B3}"/>
              </a:ext>
            </a:extLst>
          </p:cNvPr>
          <p:cNvSpPr/>
          <p:nvPr/>
        </p:nvSpPr>
        <p:spPr>
          <a:xfrm>
            <a:off x="4001100" y="2060710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268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1" name="Rectangle 7">
            <a:extLst>
              <a:ext uri="{FF2B5EF4-FFF2-40B4-BE49-F238E27FC236}">
                <a16:creationId xmlns:a16="http://schemas.microsoft.com/office/drawing/2014/main" id="{903D8738-C04F-FE57-849E-B398E955E4B9}"/>
              </a:ext>
            </a:extLst>
          </p:cNvPr>
          <p:cNvSpPr/>
          <p:nvPr/>
        </p:nvSpPr>
        <p:spPr>
          <a:xfrm>
            <a:off x="4001099" y="2254590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238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2" name="Rectangle 8">
            <a:extLst>
              <a:ext uri="{FF2B5EF4-FFF2-40B4-BE49-F238E27FC236}">
                <a16:creationId xmlns:a16="http://schemas.microsoft.com/office/drawing/2014/main" id="{4E9CEB30-D61A-A8E2-0FFE-74F3241AA30D}"/>
              </a:ext>
            </a:extLst>
          </p:cNvPr>
          <p:cNvSpPr/>
          <p:nvPr/>
        </p:nvSpPr>
        <p:spPr>
          <a:xfrm>
            <a:off x="3990310" y="3324615"/>
            <a:ext cx="5522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17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3" name="Rectangle 9">
            <a:extLst>
              <a:ext uri="{FF2B5EF4-FFF2-40B4-BE49-F238E27FC236}">
                <a16:creationId xmlns:a16="http://schemas.microsoft.com/office/drawing/2014/main" id="{744CC600-8969-EE86-C253-D7C5471A8670}"/>
              </a:ext>
            </a:extLst>
          </p:cNvPr>
          <p:cNvSpPr/>
          <p:nvPr/>
        </p:nvSpPr>
        <p:spPr>
          <a:xfrm>
            <a:off x="4073916" y="3694679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7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4" name="Rectangle 10">
            <a:extLst>
              <a:ext uri="{FF2B5EF4-FFF2-40B4-BE49-F238E27FC236}">
                <a16:creationId xmlns:a16="http://schemas.microsoft.com/office/drawing/2014/main" id="{C4BBD316-9BC6-58D4-7594-86324DE94247}"/>
              </a:ext>
            </a:extLst>
          </p:cNvPr>
          <p:cNvSpPr/>
          <p:nvPr/>
        </p:nvSpPr>
        <p:spPr>
          <a:xfrm>
            <a:off x="4065220" y="4299632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55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5" name="Rectangle 11">
            <a:extLst>
              <a:ext uri="{FF2B5EF4-FFF2-40B4-BE49-F238E27FC236}">
                <a16:creationId xmlns:a16="http://schemas.microsoft.com/office/drawing/2014/main" id="{231F2EAF-13FA-CD34-3183-8C27295B1ED7}"/>
              </a:ext>
            </a:extLst>
          </p:cNvPr>
          <p:cNvSpPr/>
          <p:nvPr/>
        </p:nvSpPr>
        <p:spPr>
          <a:xfrm>
            <a:off x="4076945" y="4839954"/>
            <a:ext cx="47735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4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6" name="Rectangle 12">
            <a:extLst>
              <a:ext uri="{FF2B5EF4-FFF2-40B4-BE49-F238E27FC236}">
                <a16:creationId xmlns:a16="http://schemas.microsoft.com/office/drawing/2014/main" id="{5F97B13A-447C-E6D6-7035-A69DA747C58A}"/>
              </a:ext>
            </a:extLst>
          </p:cNvPr>
          <p:cNvSpPr/>
          <p:nvPr/>
        </p:nvSpPr>
        <p:spPr>
          <a:xfrm>
            <a:off x="4002499" y="2910760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7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7" name="Rectangle 14">
            <a:extLst>
              <a:ext uri="{FF2B5EF4-FFF2-40B4-BE49-F238E27FC236}">
                <a16:creationId xmlns:a16="http://schemas.microsoft.com/office/drawing/2014/main" id="{78BF8D5F-B9E2-3FAB-26AC-7B6B00D51D81}"/>
              </a:ext>
            </a:extLst>
          </p:cNvPr>
          <p:cNvSpPr/>
          <p:nvPr/>
        </p:nvSpPr>
        <p:spPr>
          <a:xfrm>
            <a:off x="4043478" y="5434038"/>
            <a:ext cx="47735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3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8" name="Rectangle 10">
            <a:extLst>
              <a:ext uri="{FF2B5EF4-FFF2-40B4-BE49-F238E27FC236}">
                <a16:creationId xmlns:a16="http://schemas.microsoft.com/office/drawing/2014/main" id="{FD5AC384-7249-DBFC-5B47-AF21D4F4CD57}"/>
              </a:ext>
            </a:extLst>
          </p:cNvPr>
          <p:cNvSpPr>
            <a:spLocks noChangeArrowheads="1"/>
          </p:cNvSpPr>
          <p:nvPr/>
        </p:nvSpPr>
        <p:spPr bwMode="auto">
          <a:xfrm rot="18900000">
            <a:off x="5661247" y="607411"/>
            <a:ext cx="87788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29" name="Rectangle 11">
            <a:extLst>
              <a:ext uri="{FF2B5EF4-FFF2-40B4-BE49-F238E27FC236}">
                <a16:creationId xmlns:a16="http://schemas.microsoft.com/office/drawing/2014/main" id="{4FEFC079-F923-2CA2-16DC-37C9FCCC4304}"/>
              </a:ext>
            </a:extLst>
          </p:cNvPr>
          <p:cNvSpPr>
            <a:spLocks noChangeArrowheads="1"/>
          </p:cNvSpPr>
          <p:nvPr/>
        </p:nvSpPr>
        <p:spPr bwMode="auto">
          <a:xfrm rot="18900000">
            <a:off x="6037728" y="566381"/>
            <a:ext cx="104298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smoking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0" name="Rectangle 17">
            <a:extLst>
              <a:ext uri="{FF2B5EF4-FFF2-40B4-BE49-F238E27FC236}">
                <a16:creationId xmlns:a16="http://schemas.microsoft.com/office/drawing/2014/main" id="{3121B95D-59F1-66CC-07DC-4FBA93B6423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13606" y="5990494"/>
            <a:ext cx="393272" cy="2785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#2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1" name="Rectangle 8">
            <a:extLst>
              <a:ext uri="{FF2B5EF4-FFF2-40B4-BE49-F238E27FC236}">
                <a16:creationId xmlns:a16="http://schemas.microsoft.com/office/drawing/2014/main" id="{24AE7B42-C560-2BDD-A8A0-353C40E2783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15078" y="4936343"/>
            <a:ext cx="64793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β-actin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8BF3C505-B0AB-4BD5-CC25-84B4936150E0}"/>
              </a:ext>
            </a:extLst>
          </p:cNvPr>
          <p:cNvSpPr txBox="1"/>
          <p:nvPr/>
        </p:nvSpPr>
        <p:spPr>
          <a:xfrm>
            <a:off x="3391061" y="6265117"/>
            <a:ext cx="709756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D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 EPPK1 protein is highly expressed in BEAS2B after 16 weeks of smoking exposure</a:t>
            </a:r>
          </a:p>
        </p:txBody>
      </p:sp>
      <p:pic>
        <p:nvPicPr>
          <p:cNvPr id="9" name="Picture 20">
            <a:extLst>
              <a:ext uri="{FF2B5EF4-FFF2-40B4-BE49-F238E27FC236}">
                <a16:creationId xmlns:a16="http://schemas.microsoft.com/office/drawing/2014/main" id="{1ADAC768-0E7D-2B47-7402-D670FC8A5BE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272" t="-712" r="-825" b="-2200"/>
          <a:stretch/>
        </p:blipFill>
        <p:spPr bwMode="auto">
          <a:xfrm>
            <a:off x="2227383" y="293077"/>
            <a:ext cx="8241323" cy="60491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4" name="Rectangle 29">
            <a:extLst>
              <a:ext uri="{FF2B5EF4-FFF2-40B4-BE49-F238E27FC236}">
                <a16:creationId xmlns:a16="http://schemas.microsoft.com/office/drawing/2014/main" id="{1E6054F4-0257-BB5F-DFBE-94548D7E0C1C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82394" y="5773654"/>
            <a:ext cx="35458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#3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9" name="Rectangle 5">
            <a:extLst>
              <a:ext uri="{FF2B5EF4-FFF2-40B4-BE49-F238E27FC236}">
                <a16:creationId xmlns:a16="http://schemas.microsoft.com/office/drawing/2014/main" id="{EBB524C8-B651-045F-D8AA-872C0FF77629}"/>
              </a:ext>
            </a:extLst>
          </p:cNvPr>
          <p:cNvSpPr/>
          <p:nvPr/>
        </p:nvSpPr>
        <p:spPr>
          <a:xfrm>
            <a:off x="3129131" y="1401462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46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0" name="Rectangle 6">
            <a:extLst>
              <a:ext uri="{FF2B5EF4-FFF2-40B4-BE49-F238E27FC236}">
                <a16:creationId xmlns:a16="http://schemas.microsoft.com/office/drawing/2014/main" id="{6C1479B7-A39F-8610-F0E4-9A9C5360AC85}"/>
              </a:ext>
            </a:extLst>
          </p:cNvPr>
          <p:cNvSpPr/>
          <p:nvPr/>
        </p:nvSpPr>
        <p:spPr>
          <a:xfrm>
            <a:off x="3157040" y="1974913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268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1" name="Rectangle 7">
            <a:extLst>
              <a:ext uri="{FF2B5EF4-FFF2-40B4-BE49-F238E27FC236}">
                <a16:creationId xmlns:a16="http://schemas.microsoft.com/office/drawing/2014/main" id="{AC056766-72B8-05D2-4BA0-8AC9C0C7DFE9}"/>
              </a:ext>
            </a:extLst>
          </p:cNvPr>
          <p:cNvSpPr/>
          <p:nvPr/>
        </p:nvSpPr>
        <p:spPr>
          <a:xfrm>
            <a:off x="3157039" y="2168793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238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2" name="Rectangle 8">
            <a:extLst>
              <a:ext uri="{FF2B5EF4-FFF2-40B4-BE49-F238E27FC236}">
                <a16:creationId xmlns:a16="http://schemas.microsoft.com/office/drawing/2014/main" id="{EF9BF1B6-6F6A-216F-04F8-8E88D5985CCB}"/>
              </a:ext>
            </a:extLst>
          </p:cNvPr>
          <p:cNvSpPr/>
          <p:nvPr/>
        </p:nvSpPr>
        <p:spPr>
          <a:xfrm>
            <a:off x="3134527" y="3121586"/>
            <a:ext cx="5522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17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3" name="Rectangle 9">
            <a:extLst>
              <a:ext uri="{FF2B5EF4-FFF2-40B4-BE49-F238E27FC236}">
                <a16:creationId xmlns:a16="http://schemas.microsoft.com/office/drawing/2014/main" id="{A60F4196-9298-6ADF-160A-79C562A25374}"/>
              </a:ext>
            </a:extLst>
          </p:cNvPr>
          <p:cNvSpPr/>
          <p:nvPr/>
        </p:nvSpPr>
        <p:spPr>
          <a:xfrm>
            <a:off x="3259163" y="3368559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7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4" name="Rectangle 10">
            <a:extLst>
              <a:ext uri="{FF2B5EF4-FFF2-40B4-BE49-F238E27FC236}">
                <a16:creationId xmlns:a16="http://schemas.microsoft.com/office/drawing/2014/main" id="{A28BC106-5B39-F478-BA3D-E37D199D01BE}"/>
              </a:ext>
            </a:extLst>
          </p:cNvPr>
          <p:cNvSpPr/>
          <p:nvPr/>
        </p:nvSpPr>
        <p:spPr>
          <a:xfrm>
            <a:off x="3238745" y="3656989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55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5" name="Rectangle 11">
            <a:extLst>
              <a:ext uri="{FF2B5EF4-FFF2-40B4-BE49-F238E27FC236}">
                <a16:creationId xmlns:a16="http://schemas.microsoft.com/office/drawing/2014/main" id="{9C9A0725-0089-7257-3A69-266BDBF79CDE}"/>
              </a:ext>
            </a:extLst>
          </p:cNvPr>
          <p:cNvSpPr/>
          <p:nvPr/>
        </p:nvSpPr>
        <p:spPr>
          <a:xfrm>
            <a:off x="3268054" y="4091803"/>
            <a:ext cx="47735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4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6" name="Rectangle 12">
            <a:extLst>
              <a:ext uri="{FF2B5EF4-FFF2-40B4-BE49-F238E27FC236}">
                <a16:creationId xmlns:a16="http://schemas.microsoft.com/office/drawing/2014/main" id="{539D840E-A7B7-FFDB-8490-846090766F7C}"/>
              </a:ext>
            </a:extLst>
          </p:cNvPr>
          <p:cNvSpPr/>
          <p:nvPr/>
        </p:nvSpPr>
        <p:spPr>
          <a:xfrm>
            <a:off x="3129131" y="2643255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7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7" name="Rectangle 14">
            <a:extLst>
              <a:ext uri="{FF2B5EF4-FFF2-40B4-BE49-F238E27FC236}">
                <a16:creationId xmlns:a16="http://schemas.microsoft.com/office/drawing/2014/main" id="{ADE52049-6EDC-7B11-1135-1F78DF8F7E51}"/>
              </a:ext>
            </a:extLst>
          </p:cNvPr>
          <p:cNvSpPr/>
          <p:nvPr/>
        </p:nvSpPr>
        <p:spPr>
          <a:xfrm>
            <a:off x="3222864" y="4808979"/>
            <a:ext cx="47735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3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8" name="Rectangle 10">
            <a:extLst>
              <a:ext uri="{FF2B5EF4-FFF2-40B4-BE49-F238E27FC236}">
                <a16:creationId xmlns:a16="http://schemas.microsoft.com/office/drawing/2014/main" id="{68F679D1-50B9-FB3C-27A5-8A31FBB12767}"/>
              </a:ext>
            </a:extLst>
          </p:cNvPr>
          <p:cNvSpPr>
            <a:spLocks noChangeArrowheads="1"/>
          </p:cNvSpPr>
          <p:nvPr/>
        </p:nvSpPr>
        <p:spPr bwMode="auto">
          <a:xfrm rot="18900000">
            <a:off x="5227491" y="685737"/>
            <a:ext cx="87788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39" name="Rectangle 11">
            <a:extLst>
              <a:ext uri="{FF2B5EF4-FFF2-40B4-BE49-F238E27FC236}">
                <a16:creationId xmlns:a16="http://schemas.microsoft.com/office/drawing/2014/main" id="{55B32A40-7B36-6056-A628-552FA2D3A6AD}"/>
              </a:ext>
            </a:extLst>
          </p:cNvPr>
          <p:cNvSpPr>
            <a:spLocks noChangeArrowheads="1"/>
          </p:cNvSpPr>
          <p:nvPr/>
        </p:nvSpPr>
        <p:spPr bwMode="auto">
          <a:xfrm rot="18900000">
            <a:off x="5709481" y="632985"/>
            <a:ext cx="104298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smoking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40" name="Rectangle 8">
            <a:extLst>
              <a:ext uri="{FF2B5EF4-FFF2-40B4-BE49-F238E27FC236}">
                <a16:creationId xmlns:a16="http://schemas.microsoft.com/office/drawing/2014/main" id="{52085C58-CB61-2923-DFF1-C05BC0C03A0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35848" y="1554234"/>
            <a:ext cx="67999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EPPK1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8BF3C505-B0AB-4BD5-CC25-84B4936150E0}"/>
              </a:ext>
            </a:extLst>
          </p:cNvPr>
          <p:cNvSpPr txBox="1"/>
          <p:nvPr/>
        </p:nvSpPr>
        <p:spPr>
          <a:xfrm>
            <a:off x="2998337" y="6440963"/>
            <a:ext cx="709756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D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 EPPK1 protein is highly expressed in BEAS2B after 16 weeks of smoking exposure</a:t>
            </a:r>
          </a:p>
        </p:txBody>
      </p:sp>
      <p:pic>
        <p:nvPicPr>
          <p:cNvPr id="15" name="Picture 21">
            <a:extLst>
              <a:ext uri="{FF2B5EF4-FFF2-40B4-BE49-F238E27FC236}">
                <a16:creationId xmlns:a16="http://schemas.microsoft.com/office/drawing/2014/main" id="{A463C926-21C0-0334-9C06-118ED04BB2D2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349" t="-2034" r="-1384" b="-2941"/>
          <a:stretch/>
        </p:blipFill>
        <p:spPr bwMode="auto">
          <a:xfrm>
            <a:off x="2291862" y="521676"/>
            <a:ext cx="7461738" cy="55391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9" name="Rectangle 5">
            <a:extLst>
              <a:ext uri="{FF2B5EF4-FFF2-40B4-BE49-F238E27FC236}">
                <a16:creationId xmlns:a16="http://schemas.microsoft.com/office/drawing/2014/main" id="{36AFDC76-50E6-AA23-4941-CCC512433FDE}"/>
              </a:ext>
            </a:extLst>
          </p:cNvPr>
          <p:cNvSpPr/>
          <p:nvPr/>
        </p:nvSpPr>
        <p:spPr>
          <a:xfrm>
            <a:off x="3428069" y="1835217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46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0" name="Rectangle 6">
            <a:extLst>
              <a:ext uri="{FF2B5EF4-FFF2-40B4-BE49-F238E27FC236}">
                <a16:creationId xmlns:a16="http://schemas.microsoft.com/office/drawing/2014/main" id="{B56CC086-8018-E7C9-6768-60BD34753FA6}"/>
              </a:ext>
            </a:extLst>
          </p:cNvPr>
          <p:cNvSpPr/>
          <p:nvPr/>
        </p:nvSpPr>
        <p:spPr>
          <a:xfrm>
            <a:off x="3455978" y="2408668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268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1" name="Rectangle 7">
            <a:extLst>
              <a:ext uri="{FF2B5EF4-FFF2-40B4-BE49-F238E27FC236}">
                <a16:creationId xmlns:a16="http://schemas.microsoft.com/office/drawing/2014/main" id="{ADBFA29E-BB2E-9BD4-0DB4-7F609F0862CD}"/>
              </a:ext>
            </a:extLst>
          </p:cNvPr>
          <p:cNvSpPr/>
          <p:nvPr/>
        </p:nvSpPr>
        <p:spPr>
          <a:xfrm>
            <a:off x="3455977" y="2602548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238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2" name="Rectangle 8">
            <a:extLst>
              <a:ext uri="{FF2B5EF4-FFF2-40B4-BE49-F238E27FC236}">
                <a16:creationId xmlns:a16="http://schemas.microsoft.com/office/drawing/2014/main" id="{89E9A01D-EEA8-151C-0A4E-B9C7B073711A}"/>
              </a:ext>
            </a:extLst>
          </p:cNvPr>
          <p:cNvSpPr/>
          <p:nvPr/>
        </p:nvSpPr>
        <p:spPr>
          <a:xfrm>
            <a:off x="3439327" y="3397080"/>
            <a:ext cx="5522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17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3" name="Rectangle 9">
            <a:extLst>
              <a:ext uri="{FF2B5EF4-FFF2-40B4-BE49-F238E27FC236}">
                <a16:creationId xmlns:a16="http://schemas.microsoft.com/office/drawing/2014/main" id="{F7527FAF-A9DD-C671-B671-3F84A12A9A47}"/>
              </a:ext>
            </a:extLst>
          </p:cNvPr>
          <p:cNvSpPr/>
          <p:nvPr/>
        </p:nvSpPr>
        <p:spPr>
          <a:xfrm>
            <a:off x="3558101" y="3708529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7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4" name="Rectangle 10">
            <a:extLst>
              <a:ext uri="{FF2B5EF4-FFF2-40B4-BE49-F238E27FC236}">
                <a16:creationId xmlns:a16="http://schemas.microsoft.com/office/drawing/2014/main" id="{6141C39C-96DC-AF52-DDD0-40AD7DED5F24}"/>
              </a:ext>
            </a:extLst>
          </p:cNvPr>
          <p:cNvSpPr/>
          <p:nvPr/>
        </p:nvSpPr>
        <p:spPr>
          <a:xfrm>
            <a:off x="3537683" y="4090744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55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5" name="Rectangle 11">
            <a:extLst>
              <a:ext uri="{FF2B5EF4-FFF2-40B4-BE49-F238E27FC236}">
                <a16:creationId xmlns:a16="http://schemas.microsoft.com/office/drawing/2014/main" id="{DF32C69E-3FB4-33E3-A010-94D8E14EF861}"/>
              </a:ext>
            </a:extLst>
          </p:cNvPr>
          <p:cNvSpPr/>
          <p:nvPr/>
        </p:nvSpPr>
        <p:spPr>
          <a:xfrm>
            <a:off x="3566992" y="4525558"/>
            <a:ext cx="47735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4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6" name="Rectangle 12">
            <a:extLst>
              <a:ext uri="{FF2B5EF4-FFF2-40B4-BE49-F238E27FC236}">
                <a16:creationId xmlns:a16="http://schemas.microsoft.com/office/drawing/2014/main" id="{70D1452E-A5C2-5874-9DFF-2B6F0CC3889B}"/>
              </a:ext>
            </a:extLst>
          </p:cNvPr>
          <p:cNvSpPr/>
          <p:nvPr/>
        </p:nvSpPr>
        <p:spPr>
          <a:xfrm>
            <a:off x="3428069" y="3077010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7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7" name="Rectangle 14">
            <a:extLst>
              <a:ext uri="{FF2B5EF4-FFF2-40B4-BE49-F238E27FC236}">
                <a16:creationId xmlns:a16="http://schemas.microsoft.com/office/drawing/2014/main" id="{2C0EFCAE-0DFF-59BC-F51E-84E71D2BA676}"/>
              </a:ext>
            </a:extLst>
          </p:cNvPr>
          <p:cNvSpPr/>
          <p:nvPr/>
        </p:nvSpPr>
        <p:spPr>
          <a:xfrm>
            <a:off x="3551110" y="4990688"/>
            <a:ext cx="47735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3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8" name="Rectangle 10">
            <a:extLst>
              <a:ext uri="{FF2B5EF4-FFF2-40B4-BE49-F238E27FC236}">
                <a16:creationId xmlns:a16="http://schemas.microsoft.com/office/drawing/2014/main" id="{BD77B7BE-8F01-9A88-7612-C40DCF029C2D}"/>
              </a:ext>
            </a:extLst>
          </p:cNvPr>
          <p:cNvSpPr>
            <a:spLocks noChangeArrowheads="1"/>
          </p:cNvSpPr>
          <p:nvPr/>
        </p:nvSpPr>
        <p:spPr bwMode="auto">
          <a:xfrm rot="18900000">
            <a:off x="5409200" y="1154663"/>
            <a:ext cx="87788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39" name="Rectangle 11">
            <a:extLst>
              <a:ext uri="{FF2B5EF4-FFF2-40B4-BE49-F238E27FC236}">
                <a16:creationId xmlns:a16="http://schemas.microsoft.com/office/drawing/2014/main" id="{359AE8A4-BBE8-F0DC-6275-37742AB38AD2}"/>
              </a:ext>
            </a:extLst>
          </p:cNvPr>
          <p:cNvSpPr>
            <a:spLocks noChangeArrowheads="1"/>
          </p:cNvSpPr>
          <p:nvPr/>
        </p:nvSpPr>
        <p:spPr bwMode="auto">
          <a:xfrm rot="18900000">
            <a:off x="5785681" y="1113633"/>
            <a:ext cx="104298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smoking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40" name="Rectangle 8">
            <a:extLst>
              <a:ext uri="{FF2B5EF4-FFF2-40B4-BE49-F238E27FC236}">
                <a16:creationId xmlns:a16="http://schemas.microsoft.com/office/drawing/2014/main" id="{A4BE0F69-DDD6-D219-82BB-E7DFB85831D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05478" y="4666712"/>
            <a:ext cx="64793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β-actin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41" name="Rectangle 29">
            <a:extLst>
              <a:ext uri="{FF2B5EF4-FFF2-40B4-BE49-F238E27FC236}">
                <a16:creationId xmlns:a16="http://schemas.microsoft.com/office/drawing/2014/main" id="{A8566B00-B1F9-4F36-0311-D49A1CE4828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32012" y="6078455"/>
            <a:ext cx="35458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#3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3490" name="Picture 3">
            <a:extLst>
              <a:ext uri="{FF2B5EF4-FFF2-40B4-BE49-F238E27FC236}">
                <a16:creationId xmlns:a16="http://schemas.microsoft.com/office/drawing/2014/main" id="{CA18F3D0-5B41-E49E-89BC-FF2D07233FA6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12" t="-332" r="-160" b="-356"/>
          <a:stretch/>
        </p:blipFill>
        <p:spPr bwMode="auto">
          <a:xfrm>
            <a:off x="1604513" y="-54635"/>
            <a:ext cx="9466053" cy="691263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3491" name="Rectangle 4">
            <a:extLst>
              <a:ext uri="{FF2B5EF4-FFF2-40B4-BE49-F238E27FC236}">
                <a16:creationId xmlns:a16="http://schemas.microsoft.com/office/drawing/2014/main" id="{4FAAB3F9-BA1F-AB15-5AA8-738302F358D8}"/>
              </a:ext>
            </a:extLst>
          </p:cNvPr>
          <p:cNvSpPr>
            <a:spLocks noChangeArrowheads="1"/>
          </p:cNvSpPr>
          <p:nvPr/>
        </p:nvSpPr>
        <p:spPr bwMode="auto">
          <a:xfrm rot="18420000">
            <a:off x="3969750" y="312202"/>
            <a:ext cx="118974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H2009 (LUAD)</a:t>
            </a:r>
          </a:p>
        </p:txBody>
      </p:sp>
      <p:sp>
        <p:nvSpPr>
          <p:cNvPr id="63492" name="Rectangle 5">
            <a:extLst>
              <a:ext uri="{FF2B5EF4-FFF2-40B4-BE49-F238E27FC236}">
                <a16:creationId xmlns:a16="http://schemas.microsoft.com/office/drawing/2014/main" id="{FDD54200-E6A6-C8EB-0D82-1D4EC79057BA}"/>
              </a:ext>
            </a:extLst>
          </p:cNvPr>
          <p:cNvSpPr>
            <a:spLocks noChangeArrowheads="1"/>
          </p:cNvSpPr>
          <p:nvPr/>
        </p:nvSpPr>
        <p:spPr bwMode="auto">
          <a:xfrm rot="18420000">
            <a:off x="4305612" y="224509"/>
            <a:ext cx="142875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549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 (LUAD)</a:t>
            </a:r>
            <a:endParaRPr kumimoji="1" lang="en-US" altLang="ja-JP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63493" name="Rectangle 6">
            <a:extLst>
              <a:ext uri="{FF2B5EF4-FFF2-40B4-BE49-F238E27FC236}">
                <a16:creationId xmlns:a16="http://schemas.microsoft.com/office/drawing/2014/main" id="{72DA9384-39DB-587C-E620-1A6A177197A9}"/>
              </a:ext>
            </a:extLst>
          </p:cNvPr>
          <p:cNvSpPr>
            <a:spLocks noChangeArrowheads="1"/>
          </p:cNvSpPr>
          <p:nvPr/>
        </p:nvSpPr>
        <p:spPr bwMode="auto">
          <a:xfrm rot="18420000">
            <a:off x="4713843" y="319520"/>
            <a:ext cx="118974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H1819 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(LUAD)</a:t>
            </a:r>
            <a:endParaRPr kumimoji="1" lang="en-US" altLang="ja-JP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63494" name="Rectangle 7">
            <a:extLst>
              <a:ext uri="{FF2B5EF4-FFF2-40B4-BE49-F238E27FC236}">
                <a16:creationId xmlns:a16="http://schemas.microsoft.com/office/drawing/2014/main" id="{048471BD-9F2B-AFE8-63D2-57CD63346838}"/>
              </a:ext>
            </a:extLst>
          </p:cNvPr>
          <p:cNvSpPr>
            <a:spLocks noChangeArrowheads="1"/>
          </p:cNvSpPr>
          <p:nvPr/>
        </p:nvSpPr>
        <p:spPr bwMode="auto">
          <a:xfrm rot="18420000">
            <a:off x="5120401" y="344213"/>
            <a:ext cx="113845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Calu3 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(LUAD)</a:t>
            </a:r>
            <a:endParaRPr kumimoji="1" lang="en-US" altLang="ja-JP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63495" name="Rectangle 8">
            <a:extLst>
              <a:ext uri="{FF2B5EF4-FFF2-40B4-BE49-F238E27FC236}">
                <a16:creationId xmlns:a16="http://schemas.microsoft.com/office/drawing/2014/main" id="{A97A4A31-490B-3641-89A3-721443FC0202}"/>
              </a:ext>
            </a:extLst>
          </p:cNvPr>
          <p:cNvSpPr>
            <a:spLocks noChangeArrowheads="1"/>
          </p:cNvSpPr>
          <p:nvPr/>
        </p:nvSpPr>
        <p:spPr bwMode="auto">
          <a:xfrm rot="18420000">
            <a:off x="5571651" y="387249"/>
            <a:ext cx="101983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H23 (LUAD)</a:t>
            </a:r>
          </a:p>
        </p:txBody>
      </p:sp>
      <p:sp>
        <p:nvSpPr>
          <p:cNvPr id="63496" name="Rectangle 9">
            <a:extLst>
              <a:ext uri="{FF2B5EF4-FFF2-40B4-BE49-F238E27FC236}">
                <a16:creationId xmlns:a16="http://schemas.microsoft.com/office/drawing/2014/main" id="{C876A898-D2F5-A21E-25A0-B7AB8722D011}"/>
              </a:ext>
            </a:extLst>
          </p:cNvPr>
          <p:cNvSpPr>
            <a:spLocks noChangeArrowheads="1"/>
          </p:cNvSpPr>
          <p:nvPr/>
        </p:nvSpPr>
        <p:spPr bwMode="auto">
          <a:xfrm rot="18420000">
            <a:off x="5917081" y="321369"/>
            <a:ext cx="118974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H1993 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(LUAD)</a:t>
            </a:r>
            <a:endParaRPr kumimoji="1" lang="en-US" altLang="ja-JP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63497" name="Rectangle 10">
            <a:extLst>
              <a:ext uri="{FF2B5EF4-FFF2-40B4-BE49-F238E27FC236}">
                <a16:creationId xmlns:a16="http://schemas.microsoft.com/office/drawing/2014/main" id="{415AA340-7310-16C0-C51A-C87EEF44E6B0}"/>
              </a:ext>
            </a:extLst>
          </p:cNvPr>
          <p:cNvSpPr>
            <a:spLocks noChangeArrowheads="1"/>
          </p:cNvSpPr>
          <p:nvPr/>
        </p:nvSpPr>
        <p:spPr bwMode="auto">
          <a:xfrm rot="18420000">
            <a:off x="6288050" y="337950"/>
            <a:ext cx="114807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H226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 (LUSC)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 </a:t>
            </a:r>
          </a:p>
        </p:txBody>
      </p:sp>
      <p:sp>
        <p:nvSpPr>
          <p:cNvPr id="63498" name="Rectangle 11">
            <a:extLst>
              <a:ext uri="{FF2B5EF4-FFF2-40B4-BE49-F238E27FC236}">
                <a16:creationId xmlns:a16="http://schemas.microsoft.com/office/drawing/2014/main" id="{0A03B33F-16AE-1F38-BF76-D3C387A27317}"/>
              </a:ext>
            </a:extLst>
          </p:cNvPr>
          <p:cNvSpPr>
            <a:spLocks noChangeArrowheads="1"/>
          </p:cNvSpPr>
          <p:nvPr/>
        </p:nvSpPr>
        <p:spPr bwMode="auto">
          <a:xfrm rot="18420000">
            <a:off x="6653458" y="307886"/>
            <a:ext cx="121539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H460 (LCNEC)</a:t>
            </a:r>
          </a:p>
        </p:txBody>
      </p:sp>
      <p:sp>
        <p:nvSpPr>
          <p:cNvPr id="63499" name="Rectangle 12">
            <a:extLst>
              <a:ext uri="{FF2B5EF4-FFF2-40B4-BE49-F238E27FC236}">
                <a16:creationId xmlns:a16="http://schemas.microsoft.com/office/drawing/2014/main" id="{28BDF79F-971C-47A5-42EE-BE1DF942BDF0}"/>
              </a:ext>
            </a:extLst>
          </p:cNvPr>
          <p:cNvSpPr>
            <a:spLocks noChangeArrowheads="1"/>
          </p:cNvSpPr>
          <p:nvPr/>
        </p:nvSpPr>
        <p:spPr bwMode="auto">
          <a:xfrm rot="18420000">
            <a:off x="7016138" y="264764"/>
            <a:ext cx="130035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H1299 (NSCLC)</a:t>
            </a:r>
          </a:p>
        </p:txBody>
      </p:sp>
      <p:sp>
        <p:nvSpPr>
          <p:cNvPr id="63501" name="Rectangle 14">
            <a:extLst>
              <a:ext uri="{FF2B5EF4-FFF2-40B4-BE49-F238E27FC236}">
                <a16:creationId xmlns:a16="http://schemas.microsoft.com/office/drawing/2014/main" id="{64377BC9-A173-C62F-ED20-A8447C077DE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82680" y="731804"/>
            <a:ext cx="67999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rPr>
              <a:t>EPPK1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63502" name="Rectangle 16">
            <a:extLst>
              <a:ext uri="{FF2B5EF4-FFF2-40B4-BE49-F238E27FC236}">
                <a16:creationId xmlns:a16="http://schemas.microsoft.com/office/drawing/2014/main" id="{163E4188-36C6-E7E1-6AFC-D43B235796A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8221" y="7373118"/>
            <a:ext cx="64793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rPr>
              <a:t>β-actin</a:t>
            </a:r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AA252256-661D-43E3-C7DA-31F25B64B6AD}"/>
              </a:ext>
            </a:extLst>
          </p:cNvPr>
          <p:cNvSpPr txBox="1"/>
          <p:nvPr/>
        </p:nvSpPr>
        <p:spPr>
          <a:xfrm>
            <a:off x="2157002" y="5735439"/>
            <a:ext cx="9434084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Fig. 3  Targeting EPPK1 with CRISPR-Cas9 in A549 cells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rPr>
              <a:t>A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rPr>
              <a:t> EPPK1 protein expression in lung adenocarcinoma (LUAD), lung squamous cell carcinoma (LUSC), large cell neuroendocrine carcinoma (LCNEC), and non-small cell lung cancer (NSCLC)</a:t>
            </a:r>
            <a:endParaRPr kumimoji="1" lang="en-US" altLang="ja-JP" sz="12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" name="Rectangle 5">
            <a:extLst>
              <a:ext uri="{FF2B5EF4-FFF2-40B4-BE49-F238E27FC236}">
                <a16:creationId xmlns:a16="http://schemas.microsoft.com/office/drawing/2014/main" id="{7CBEAB9C-94F4-5356-D7B8-C9492F6A6AEB}"/>
              </a:ext>
            </a:extLst>
          </p:cNvPr>
          <p:cNvSpPr/>
          <p:nvPr/>
        </p:nvSpPr>
        <p:spPr>
          <a:xfrm>
            <a:off x="3162391" y="727030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460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" name="Rectangle 6">
            <a:extLst>
              <a:ext uri="{FF2B5EF4-FFF2-40B4-BE49-F238E27FC236}">
                <a16:creationId xmlns:a16="http://schemas.microsoft.com/office/drawing/2014/main" id="{BDF89421-B87D-DD71-D124-939ED3686714}"/>
              </a:ext>
            </a:extLst>
          </p:cNvPr>
          <p:cNvSpPr/>
          <p:nvPr/>
        </p:nvSpPr>
        <p:spPr>
          <a:xfrm>
            <a:off x="3190300" y="1300481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268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4" name="Rectangle 7">
            <a:extLst>
              <a:ext uri="{FF2B5EF4-FFF2-40B4-BE49-F238E27FC236}">
                <a16:creationId xmlns:a16="http://schemas.microsoft.com/office/drawing/2014/main" id="{6E59D919-7FCA-6C8C-F26B-29C528CBC870}"/>
              </a:ext>
            </a:extLst>
          </p:cNvPr>
          <p:cNvSpPr/>
          <p:nvPr/>
        </p:nvSpPr>
        <p:spPr>
          <a:xfrm>
            <a:off x="3190299" y="1494361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238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5" name="Rectangle 8">
            <a:extLst>
              <a:ext uri="{FF2B5EF4-FFF2-40B4-BE49-F238E27FC236}">
                <a16:creationId xmlns:a16="http://schemas.microsoft.com/office/drawing/2014/main" id="{302124B8-FDD1-2FDD-F3D2-9276A6C635AC}"/>
              </a:ext>
            </a:extLst>
          </p:cNvPr>
          <p:cNvSpPr/>
          <p:nvPr/>
        </p:nvSpPr>
        <p:spPr>
          <a:xfrm>
            <a:off x="3179511" y="2523354"/>
            <a:ext cx="5522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17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6" name="Rectangle 9">
            <a:extLst>
              <a:ext uri="{FF2B5EF4-FFF2-40B4-BE49-F238E27FC236}">
                <a16:creationId xmlns:a16="http://schemas.microsoft.com/office/drawing/2014/main" id="{5DADCBFF-C02B-CA3E-417D-9AA540184663}"/>
              </a:ext>
            </a:extLst>
          </p:cNvPr>
          <p:cNvSpPr/>
          <p:nvPr/>
        </p:nvSpPr>
        <p:spPr>
          <a:xfrm>
            <a:off x="3257254" y="2858250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7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7" name="Rectangle 10">
            <a:extLst>
              <a:ext uri="{FF2B5EF4-FFF2-40B4-BE49-F238E27FC236}">
                <a16:creationId xmlns:a16="http://schemas.microsoft.com/office/drawing/2014/main" id="{D956942A-DAF5-EBCF-1CF6-9A8EEED17834}"/>
              </a:ext>
            </a:extLst>
          </p:cNvPr>
          <p:cNvSpPr/>
          <p:nvPr/>
        </p:nvSpPr>
        <p:spPr>
          <a:xfrm>
            <a:off x="3254421" y="3521818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55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8" name="Rectangle 11">
            <a:extLst>
              <a:ext uri="{FF2B5EF4-FFF2-40B4-BE49-F238E27FC236}">
                <a16:creationId xmlns:a16="http://schemas.microsoft.com/office/drawing/2014/main" id="{810F1D31-00DB-EC85-E51D-B59CBD33C807}"/>
              </a:ext>
            </a:extLst>
          </p:cNvPr>
          <p:cNvSpPr/>
          <p:nvPr/>
        </p:nvSpPr>
        <p:spPr>
          <a:xfrm>
            <a:off x="3272006" y="4173510"/>
            <a:ext cx="47735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4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9" name="Rectangle 12">
            <a:extLst>
              <a:ext uri="{FF2B5EF4-FFF2-40B4-BE49-F238E27FC236}">
                <a16:creationId xmlns:a16="http://schemas.microsoft.com/office/drawing/2014/main" id="{789658E6-0F8C-114B-480F-594A7BAA11EE}"/>
              </a:ext>
            </a:extLst>
          </p:cNvPr>
          <p:cNvSpPr/>
          <p:nvPr/>
        </p:nvSpPr>
        <p:spPr>
          <a:xfrm>
            <a:off x="3162391" y="2256039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7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0" name="Rectangle 14">
            <a:extLst>
              <a:ext uri="{FF2B5EF4-FFF2-40B4-BE49-F238E27FC236}">
                <a16:creationId xmlns:a16="http://schemas.microsoft.com/office/drawing/2014/main" id="{9FBCE774-21DF-9249-74F2-E9BBBA6D3D18}"/>
              </a:ext>
            </a:extLst>
          </p:cNvPr>
          <p:cNvSpPr/>
          <p:nvPr/>
        </p:nvSpPr>
        <p:spPr>
          <a:xfrm>
            <a:off x="3261986" y="4779317"/>
            <a:ext cx="47735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3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1_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noFill/>
        <a:ln>
          <a:noFill/>
        </a:ln>
        <a:extLst>
          <a:ext uri="{909E8E84-426E-40DD-AFC4-6F175D3DCCD1}">
            <a14:hiddenFill xmlns:a14="http://schemas.microsoft.com/office/drawing/2010/main">
              <a:solidFill>
                <a:srgbClr val="FFFFFF"/>
              </a:solidFill>
            </a14:hiddenFill>
          </a:ext>
          <a:ext uri="{91240B29-F687-4F45-9708-019B960494DF}">
            <a14:hiddenLine xmlns:a14="http://schemas.microsoft.com/office/drawing/2010/main" w="9525">
              <a:solidFill>
                <a:srgbClr val="000000"/>
              </a:solidFill>
              <a:miter lim="800000"/>
              <a:headEnd/>
              <a:tailEnd/>
            </a14:hiddenLine>
          </a:ext>
        </a:extLst>
      </a:spPr>
      <a:bodyPr>
        <a:spAutoFit/>
      </a:bodyPr>
      <a:lstStyle>
        <a:defPPr algn="l">
          <a:defRPr dirty="0">
            <a:cs typeface="Arial" panose="020B0604020202020204" pitchFamily="34" charset="0"/>
          </a:defRPr>
        </a:defPPr>
      </a:lstStyle>
    </a:spDef>
  </a:objectDefaults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3</TotalTime>
  <Words>767</Words>
  <Application>Microsoft Office PowerPoint</Application>
  <PresentationFormat>ワイド画面</PresentationFormat>
  <Paragraphs>343</Paragraphs>
  <Slides>18</Slides>
  <Notes>17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8</vt:i4>
      </vt:variant>
    </vt:vector>
  </HeadingPairs>
  <TitlesOfParts>
    <vt:vector size="22" baseType="lpstr">
      <vt:lpstr>游ゴシック</vt:lpstr>
      <vt:lpstr>Arial</vt:lpstr>
      <vt:lpstr>Calibri</vt:lpstr>
      <vt:lpstr>1_Office ​​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健</dc:creator>
  <cp:lastModifiedBy>健 有村</cp:lastModifiedBy>
  <cp:revision>1</cp:revision>
  <dcterms:created xsi:type="dcterms:W3CDTF">2023-11-14T21:55:57Z</dcterms:created>
  <dcterms:modified xsi:type="dcterms:W3CDTF">2024-02-12T23:47:47Z</dcterms:modified>
</cp:coreProperties>
</file>